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590" r:id="rId2"/>
    <p:sldId id="588" r:id="rId3"/>
    <p:sldId id="300" r:id="rId4"/>
    <p:sldId id="589" r:id="rId5"/>
    <p:sldId id="301" r:id="rId6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94" userDrawn="1">
          <p15:clr>
            <a:srgbClr val="A4A3A4"/>
          </p15:clr>
        </p15:guide>
        <p15:guide id="2" pos="892" userDrawn="1">
          <p15:clr>
            <a:srgbClr val="A4A3A4"/>
          </p15:clr>
        </p15:guide>
        <p15:guide id="3" orient="horz" pos="3748" userDrawn="1">
          <p15:clr>
            <a:srgbClr val="A4A3A4"/>
          </p15:clr>
        </p15:guide>
        <p15:guide id="4" pos="4588" userDrawn="1">
          <p15:clr>
            <a:srgbClr val="A4A3A4"/>
          </p15:clr>
        </p15:guide>
        <p15:guide id="5" pos="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 Ni Moe Myint" initials="NNMM" lastIdx="2" clrIdx="0">
    <p:extLst>
      <p:ext uri="{19B8F6BF-5375-455C-9EA6-DF929625EA0E}">
        <p15:presenceInfo xmlns:p15="http://schemas.microsoft.com/office/powerpoint/2012/main" userId="0be8e8ec41ad61f2" providerId="Windows Live"/>
      </p:ext>
    </p:extLst>
  </p:cmAuthor>
  <p:cmAuthor id="2" name="SUGIMOTO KOTARO / 杉本 光太郎" initials="SK/杉光" lastIdx="29" clrIdx="1">
    <p:extLst>
      <p:ext uri="{19B8F6BF-5375-455C-9EA6-DF929625EA0E}">
        <p15:presenceInfo xmlns:p15="http://schemas.microsoft.com/office/powerpoint/2012/main" userId="SUGIMOTO KOTARO / 杉本 光太郎" providerId="None"/>
      </p:ext>
    </p:extLst>
  </p:cmAuthor>
  <p:cmAuthor id="3" name="TOMOYA SAIKA" initials="TS" lastIdx="10" clrIdx="2">
    <p:extLst>
      <p:ext uri="{19B8F6BF-5375-455C-9EA6-DF929625EA0E}">
        <p15:presenceInfo xmlns:p15="http://schemas.microsoft.com/office/powerpoint/2012/main" userId="TOMOYA SAIKA" providerId="None"/>
      </p:ext>
    </p:extLst>
  </p:cmAuthor>
  <p:cmAuthor id="4" name="HR" initials="HR" lastIdx="1" clrIdx="3">
    <p:extLst>
      <p:ext uri="{19B8F6BF-5375-455C-9EA6-DF929625EA0E}">
        <p15:presenceInfo xmlns:p15="http://schemas.microsoft.com/office/powerpoint/2012/main" userId="HR" providerId="None"/>
      </p:ext>
    </p:extLst>
  </p:cmAuthor>
  <p:cmAuthor id="5" name="QC" initials="QC" lastIdx="13" clrIdx="4">
    <p:extLst>
      <p:ext uri="{19B8F6BF-5375-455C-9EA6-DF929625EA0E}">
        <p15:presenceInfo xmlns:p15="http://schemas.microsoft.com/office/powerpoint/2012/main" userId="Q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BE5D6"/>
    <a:srgbClr val="BFBFBF"/>
    <a:srgbClr val="FF9E1B"/>
    <a:srgbClr val="FF6D13"/>
    <a:srgbClr val="FF6A13"/>
    <a:srgbClr val="FFA671"/>
    <a:srgbClr val="ED7D31"/>
    <a:srgbClr val="FF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96" autoAdjust="0"/>
    <p:restoredTop sz="87881" autoAdjust="0"/>
  </p:normalViewPr>
  <p:slideViewPr>
    <p:cSldViewPr snapToGrid="0" showGuides="1">
      <p:cViewPr varScale="1">
        <p:scale>
          <a:sx n="75" d="100"/>
          <a:sy n="75" d="100"/>
        </p:scale>
        <p:origin x="984" y="58"/>
      </p:cViewPr>
      <p:guideLst>
        <p:guide orient="horz" pos="1094"/>
        <p:guide pos="892"/>
        <p:guide orient="horz" pos="3748"/>
        <p:guide pos="4588"/>
        <p:guide pos="7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1D294AA5-23D0-44AB-ABA5-3CF55D63FCE8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805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52D407AE-E4D7-45B0-BBA9-225303847A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565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D407AE-E4D7-45B0-BBA9-225303847A8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04123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D407AE-E4D7-45B0-BBA9-225303847A8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7707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D407AE-E4D7-45B0-BBA9-225303847A8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7690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D407AE-E4D7-45B0-BBA9-225303847A8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3448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GB" altLang="ja-JP" sz="1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D407AE-E4D7-45B0-BBA9-225303847A8E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2653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4345D1-2E4C-00DF-7CBA-7237FFF95C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9DFA138-A7AC-6B0B-D68C-B5B338BCF0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5CAA27-B716-EF42-59D9-110DC497D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1951F5-51C5-52A0-7916-C73F1D619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DB614B-FCC3-4895-AB6B-F743791F1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64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08CDCC-E7F4-1328-5BA6-ED7DD263B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8872D34-C05A-0B12-822B-F26C56E892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A0E471-9110-3862-149B-A7FED3316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13F3DD-32DA-19A0-9707-A66471772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0C5402-501B-38DF-6C6B-7B7088FE3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54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41DAB65-C694-06D2-1540-4F0170D643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7D389CE-C0D0-5CED-D172-8986029069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105AFC-615B-C363-CC11-6B664D9F0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B04F67-8E60-B629-9C05-2A321DA32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5B4C8C-2B44-C3DF-17CE-B9A45AE42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873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B0313A-8A9C-AB7A-6152-D981362F8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89D55B0-1F5D-25ED-E514-350B8128EE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854686-2B53-2FE6-5756-DC54D3C6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475CE2-7AAE-C10D-409A-BA29C7A9A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3128CD-ECEC-D8B0-F8A2-5E3C73ABA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3519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2F3AA3-254F-325E-D405-3037B42ED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9177F2-FC2F-8668-EAE3-408EF43851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6A4241-C69E-F0B2-DF63-1B1A63AEC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332145-90BF-F08C-3EF5-C5B2AF7BC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34F719-E506-5765-1634-03BCE9117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28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1FF390-70E4-54D6-2B22-28804D280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AF57C87-394C-6501-030F-DC28B7C8BA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263818-590F-2658-9AE8-BBF8DCCF0F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EEC758-7CF2-D84F-D2E7-F594219CD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7803BB-2D2B-AD5B-221E-9DA1B1C82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199399-0D4E-EC68-5357-ED691EE9B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015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707667-E1AF-D562-CD70-0C8071042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54645A-AB15-7E7C-DDD2-9F844D0D52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8811375-61E8-907D-66EF-F53A0AC9F8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090FC51-79FA-A16C-8CBD-3D9B446DE9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6FEC9FD-E564-AF7F-08CB-7F09450532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C3A5DE2-9A97-8353-D7E9-A679FB426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8FA7B8A-4835-9121-5813-93C8309AD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5FC5C72-322C-01C2-13D7-996899F17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6400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5AFB4B-C02C-1ACD-BFFB-4DA5E333D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98FF84A-232C-9239-044E-539A3C7A8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F3A1AC8-0274-88B5-3BAD-CDA530E10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37E609E-1093-7BA6-A5BD-C4C5AB11B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62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0F766A0-B0C3-0C21-3E8B-93D21EB13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0F2D8EC-C9C3-E545-BB4A-12976F63B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BC0A6A5-C256-EB29-57CF-14E608F72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508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7B19C8-FFD6-E1D3-5CD2-509FC9E5A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38ECD5-8FB4-C507-05B6-5CD1A512D7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F0356A7-0265-D0C5-EA51-95A1300A6F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23FD5C-CDA6-05FD-FF85-C9F918EBF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E06EEC-60B8-1E7D-6DE0-0938371AC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F7BBF-8218-DCA2-B9C5-0818175B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876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8F2797-7E68-A81F-E41D-F44FCE032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5B4B46-89CB-D0A1-1DF2-AA4514D96C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08CDD4-E700-DF67-5BB8-D217A113C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6EB711-8EB3-88E3-309C-D93ED6429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8ABD19-BFF9-2F40-AD0F-0A479139F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8C51E28-E983-BCAE-3926-4CD97A98B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713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E935FB-FEB0-DC27-2261-8ADCD294F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183F8B-9754-D470-1252-07CBDE68E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0D80CD-FEEC-032D-1F32-24125FE629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E47E4-9BE4-46C5-9D05-70B27C0C07FF}" type="datetimeFigureOut">
              <a:rPr kumimoji="1" lang="ja-JP" altLang="en-US" smtClean="0"/>
              <a:t>2023/5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505ADC-4291-7BBD-2F44-A2BF5E0C27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A9AA53-3F98-F791-FC10-64613FD322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509B5-9E2E-499A-925F-7FEA23C256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2645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表 86">
            <a:extLst>
              <a:ext uri="{FF2B5EF4-FFF2-40B4-BE49-F238E27FC236}">
                <a16:creationId xmlns:a16="http://schemas.microsoft.com/office/drawing/2014/main" id="{5AD321EA-CB23-4198-9C7D-E15ABCFE7B5F}"/>
              </a:ext>
            </a:extLst>
          </p:cNvPr>
          <p:cNvGraphicFramePr>
            <a:graphicFrameLocks noGrp="1"/>
          </p:cNvGraphicFramePr>
          <p:nvPr/>
        </p:nvGraphicFramePr>
        <p:xfrm>
          <a:off x="129653" y="5412743"/>
          <a:ext cx="11419201" cy="1280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19201">
                  <a:extLst>
                    <a:ext uri="{9D8B030D-6E8A-4147-A177-3AD203B41FA5}">
                      <a16:colId xmlns:a16="http://schemas.microsoft.com/office/drawing/2014/main" val="26091128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886136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367717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390948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223707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276910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4467984"/>
                  </a:ext>
                </a:extLst>
              </a:tr>
            </a:tbl>
          </a:graphicData>
        </a:graphic>
      </p:graphicFrame>
      <p:sp>
        <p:nvSpPr>
          <p:cNvPr id="2" name="正方形/長方形 9">
            <a:extLst>
              <a:ext uri="{FF2B5EF4-FFF2-40B4-BE49-F238E27FC236}">
                <a16:creationId xmlns:a16="http://schemas.microsoft.com/office/drawing/2014/main" id="{1A550608-50F5-4811-A7BA-C197F7DF623F}"/>
              </a:ext>
            </a:extLst>
          </p:cNvPr>
          <p:cNvSpPr/>
          <p:nvPr/>
        </p:nvSpPr>
        <p:spPr>
          <a:xfrm>
            <a:off x="0" y="0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F3D108A-4D87-494A-BE92-7944A0088837}"/>
              </a:ext>
            </a:extLst>
          </p:cNvPr>
          <p:cNvSpPr txBox="1"/>
          <p:nvPr/>
        </p:nvSpPr>
        <p:spPr>
          <a:xfrm>
            <a:off x="1427193" y="4972698"/>
            <a:ext cx="373500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ja-JP" altLang="en-US" sz="14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</a:p>
        </p:txBody>
      </p:sp>
      <p:sp>
        <p:nvSpPr>
          <p:cNvPr id="4" name="Text Box 24">
            <a:extLst>
              <a:ext uri="{FF2B5EF4-FFF2-40B4-BE49-F238E27FC236}">
                <a16:creationId xmlns:a16="http://schemas.microsoft.com/office/drawing/2014/main" id="{7DF051C2-551C-4CD2-9B7F-EF3F11D80C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88" y="5412975"/>
            <a:ext cx="1838580" cy="1292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 anchorCtr="0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Arial" charset="0"/>
                <a:ea typeface="HGP創英角ｺﾞｼｯｸUB" pitchFamily="50" charset="-128"/>
              </a:defRPr>
            </a:lvl9pPr>
          </a:lstStyle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Nighttime BP (brachial)</a:t>
            </a:r>
          </a:p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Nighttime BP (wrist)</a:t>
            </a:r>
          </a:p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Home BP</a:t>
            </a:r>
            <a:r>
              <a:rPr lang="ja-JP" altLang="en-US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 </a:t>
            </a:r>
            <a:endParaRPr lang="en-US" altLang="ja-JP" dirty="0"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Office</a:t>
            </a:r>
            <a:r>
              <a:rPr lang="ja-JP" altLang="en-US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BP</a:t>
            </a:r>
          </a:p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Serum</a:t>
            </a:r>
            <a:r>
              <a:rPr lang="ja-JP" altLang="en-US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K</a:t>
            </a:r>
          </a:p>
          <a:p>
            <a:pPr defTabSz="457200" eaLnBrk="1" hangingPunct="1"/>
            <a:r>
              <a:rPr lang="en-US" altLang="ja-JP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Biomarkers</a:t>
            </a:r>
            <a:r>
              <a:rPr lang="ja-JP" altLang="en-US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 </a:t>
            </a:r>
            <a:endParaRPr lang="en-US" altLang="ja-JP" baseline="30000" dirty="0"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565806F-2FC7-4582-9A5B-99966C89FF65}"/>
              </a:ext>
            </a:extLst>
          </p:cNvPr>
          <p:cNvSpPr txBox="1"/>
          <p:nvPr/>
        </p:nvSpPr>
        <p:spPr>
          <a:xfrm>
            <a:off x="3654722" y="4972698"/>
            <a:ext cx="785471" cy="430887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W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aseline)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0AAE59B-3DE0-440D-8576-EEF09EFE6806}"/>
              </a:ext>
            </a:extLst>
          </p:cNvPr>
          <p:cNvSpPr txBox="1"/>
          <p:nvPr/>
        </p:nvSpPr>
        <p:spPr>
          <a:xfrm>
            <a:off x="5130734" y="4972698"/>
            <a:ext cx="269304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FB37A87-9C18-4BC1-B511-192AF7516176}"/>
              </a:ext>
            </a:extLst>
          </p:cNvPr>
          <p:cNvSpPr txBox="1"/>
          <p:nvPr/>
        </p:nvSpPr>
        <p:spPr>
          <a:xfrm>
            <a:off x="6351505" y="4972698"/>
            <a:ext cx="269304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5CE96CC-26A8-4BDD-BAC7-FA44A4532CAE}"/>
              </a:ext>
            </a:extLst>
          </p:cNvPr>
          <p:cNvSpPr txBox="1"/>
          <p:nvPr/>
        </p:nvSpPr>
        <p:spPr>
          <a:xfrm>
            <a:off x="7511150" y="4972698"/>
            <a:ext cx="387928" cy="215444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6W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AF465F1-34F3-45AB-A9AE-39B79CA39971}"/>
              </a:ext>
            </a:extLst>
          </p:cNvPr>
          <p:cNvSpPr txBox="1"/>
          <p:nvPr/>
        </p:nvSpPr>
        <p:spPr>
          <a:xfrm>
            <a:off x="9898376" y="4972698"/>
            <a:ext cx="487313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10W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A7C3027-8FC1-443F-8DDF-CD836F8FF7D2}"/>
              </a:ext>
            </a:extLst>
          </p:cNvPr>
          <p:cNvSpPr txBox="1"/>
          <p:nvPr/>
        </p:nvSpPr>
        <p:spPr>
          <a:xfrm>
            <a:off x="11294194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2" name="テキスト プレースホルダー 2">
            <a:extLst>
              <a:ext uri="{FF2B5EF4-FFF2-40B4-BE49-F238E27FC236}">
                <a16:creationId xmlns:a16="http://schemas.microsoft.com/office/drawing/2014/main" id="{109F7919-F03A-490E-8BF5-574618BFE267}"/>
              </a:ext>
            </a:extLst>
          </p:cNvPr>
          <p:cNvSpPr txBox="1">
            <a:spLocks/>
          </p:cNvSpPr>
          <p:nvPr/>
        </p:nvSpPr>
        <p:spPr>
          <a:xfrm>
            <a:off x="9724989" y="2490431"/>
            <a:ext cx="646010" cy="21544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25 mg</a:t>
            </a:r>
          </a:p>
        </p:txBody>
      </p:sp>
      <p:sp>
        <p:nvSpPr>
          <p:cNvPr id="13" name="テキスト プレースホルダー 2">
            <a:extLst>
              <a:ext uri="{FF2B5EF4-FFF2-40B4-BE49-F238E27FC236}">
                <a16:creationId xmlns:a16="http://schemas.microsoft.com/office/drawing/2014/main" id="{0ABBE716-CB3C-42A3-A74D-EEDBC6DA0900}"/>
              </a:ext>
            </a:extLst>
          </p:cNvPr>
          <p:cNvSpPr txBox="1">
            <a:spLocks/>
          </p:cNvSpPr>
          <p:nvPr/>
        </p:nvSpPr>
        <p:spPr>
          <a:xfrm>
            <a:off x="9824377" y="2097356"/>
            <a:ext cx="546623" cy="21544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.5 mg</a:t>
            </a:r>
          </a:p>
        </p:txBody>
      </p:sp>
      <p:sp>
        <p:nvSpPr>
          <p:cNvPr id="14" name="テキスト プレースホルダー 2">
            <a:extLst>
              <a:ext uri="{FF2B5EF4-FFF2-40B4-BE49-F238E27FC236}">
                <a16:creationId xmlns:a16="http://schemas.microsoft.com/office/drawing/2014/main" id="{CA197E49-6279-49D5-8018-CD8C103C27A9}"/>
              </a:ext>
            </a:extLst>
          </p:cNvPr>
          <p:cNvSpPr txBox="1">
            <a:spLocks/>
          </p:cNvSpPr>
          <p:nvPr/>
        </p:nvSpPr>
        <p:spPr>
          <a:xfrm>
            <a:off x="9824377" y="3708542"/>
            <a:ext cx="546623" cy="21544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.5 mg</a:t>
            </a:r>
          </a:p>
        </p:txBody>
      </p:sp>
      <p:sp>
        <p:nvSpPr>
          <p:cNvPr id="15" name="テキスト プレースホルダー 2">
            <a:extLst>
              <a:ext uri="{FF2B5EF4-FFF2-40B4-BE49-F238E27FC236}">
                <a16:creationId xmlns:a16="http://schemas.microsoft.com/office/drawing/2014/main" id="{64CBEAEB-C639-4611-B899-7EDD79D82EDD}"/>
              </a:ext>
            </a:extLst>
          </p:cNvPr>
          <p:cNvSpPr txBox="1">
            <a:spLocks/>
          </p:cNvSpPr>
          <p:nvPr/>
        </p:nvSpPr>
        <p:spPr>
          <a:xfrm>
            <a:off x="9973455" y="3315265"/>
            <a:ext cx="397545" cy="21544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mg</a:t>
            </a:r>
          </a:p>
        </p:txBody>
      </p:sp>
      <p:sp>
        <p:nvSpPr>
          <p:cNvPr id="16" name="テキスト プレースホルダー 2">
            <a:extLst>
              <a:ext uri="{FF2B5EF4-FFF2-40B4-BE49-F238E27FC236}">
                <a16:creationId xmlns:a16="http://schemas.microsoft.com/office/drawing/2014/main" id="{A43C2371-6620-4867-A2A5-A48429F6AF4A}"/>
              </a:ext>
            </a:extLst>
          </p:cNvPr>
          <p:cNvSpPr txBox="1">
            <a:spLocks/>
          </p:cNvSpPr>
          <p:nvPr/>
        </p:nvSpPr>
        <p:spPr>
          <a:xfrm>
            <a:off x="4220649" y="2511975"/>
            <a:ext cx="1935145" cy="193899"/>
          </a:xfrm>
          <a:prstGeom prst="rect">
            <a:avLst/>
          </a:prstGeom>
          <a:noFill/>
        </p:spPr>
        <p:txBody>
          <a:bodyPr wrap="none" tIns="0" bIns="0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90000"/>
              </a:lnSpc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saxerenone 1.25 mg</a:t>
            </a:r>
          </a:p>
        </p:txBody>
      </p:sp>
      <p:sp>
        <p:nvSpPr>
          <p:cNvPr id="17" name="テキスト プレースホルダー 2">
            <a:extLst>
              <a:ext uri="{FF2B5EF4-FFF2-40B4-BE49-F238E27FC236}">
                <a16:creationId xmlns:a16="http://schemas.microsoft.com/office/drawing/2014/main" id="{684486FF-B269-4816-8E7F-F71A5AE0FA7A}"/>
              </a:ext>
            </a:extLst>
          </p:cNvPr>
          <p:cNvSpPr txBox="1">
            <a:spLocks/>
          </p:cNvSpPr>
          <p:nvPr/>
        </p:nvSpPr>
        <p:spPr>
          <a:xfrm>
            <a:off x="4220649" y="3708542"/>
            <a:ext cx="1835759" cy="215444"/>
          </a:xfrm>
          <a:prstGeom prst="rect">
            <a:avLst/>
          </a:prstGeom>
          <a:noFill/>
        </p:spPr>
        <p:txBody>
          <a:bodyPr wrap="none" tIns="0" bIns="0">
            <a:spAutoFit/>
          </a:bodyPr>
          <a:lstStyle>
            <a:defPPr>
              <a:defRPr lang="ja-JP"/>
            </a:defPPr>
            <a:lvl1pPr indent="0" algn="just" defTabSz="914400">
              <a:lnSpc>
                <a:spcPct val="120000"/>
              </a:lnSpc>
              <a:spcBef>
                <a:spcPts val="600"/>
              </a:spcBef>
              <a:buFont typeface="Arial" panose="020B0604020202020204" pitchFamily="34" charset="0"/>
              <a:buNone/>
              <a:defRPr sz="1400">
                <a:solidFill>
                  <a:schemeClr val="tx1">
                    <a:lumMod val="50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lvl1pPr>
            <a:lvl2pPr marL="742950" indent="-285750" defTabSz="91440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 defTabSz="9144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 defTabSz="9144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 defTabSz="9144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defTabSz="914400">
              <a:spcBef>
                <a:spcPct val="20000"/>
              </a:spcBef>
              <a:buFont typeface="Arial" panose="020B0604020202020204" pitchFamily="34" charset="0"/>
              <a:buChar char="•"/>
              <a:defRPr sz="2000"/>
            </a:lvl6pPr>
            <a:lvl7pPr marL="2971800" indent="-228600" defTabSz="914400">
              <a:spcBef>
                <a:spcPct val="20000"/>
              </a:spcBef>
              <a:buFont typeface="Arial" panose="020B0604020202020204" pitchFamily="34" charset="0"/>
              <a:buChar char="•"/>
              <a:defRPr sz="2000"/>
            </a:lvl7pPr>
            <a:lvl8pPr marL="3429000" indent="-228600" defTabSz="914400">
              <a:spcBef>
                <a:spcPct val="20000"/>
              </a:spcBef>
              <a:buFont typeface="Arial" panose="020B0604020202020204" pitchFamily="34" charset="0"/>
              <a:buChar char="•"/>
              <a:defRPr sz="2000"/>
            </a:lvl8pPr>
            <a:lvl9pPr marL="3886200" indent="-228600" defTabSz="914400">
              <a:spcBef>
                <a:spcPct val="20000"/>
              </a:spcBef>
              <a:buFont typeface="Arial" panose="020B0604020202020204" pitchFamily="34" charset="0"/>
              <a:buChar char="•"/>
              <a:defRPr sz="2000"/>
            </a:lvl9pPr>
          </a:lstStyle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kumimoji="0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Esaxerenone 2.5 mg</a:t>
            </a: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1B813DE4-B7FE-4968-AC26-532966F5488E}"/>
              </a:ext>
            </a:extLst>
          </p:cNvPr>
          <p:cNvCxnSpPr>
            <a:cxnSpLocks/>
          </p:cNvCxnSpPr>
          <p:nvPr/>
        </p:nvCxnSpPr>
        <p:spPr>
          <a:xfrm>
            <a:off x="89265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15DA7C5C-E42C-4074-94EA-62AA46F8346D}"/>
              </a:ext>
            </a:extLst>
          </p:cNvPr>
          <p:cNvCxnSpPr>
            <a:cxnSpLocks/>
          </p:cNvCxnSpPr>
          <p:nvPr/>
        </p:nvCxnSpPr>
        <p:spPr>
          <a:xfrm>
            <a:off x="113655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80A8866C-2894-4A5D-B325-485C59303F21}"/>
              </a:ext>
            </a:extLst>
          </p:cNvPr>
          <p:cNvCxnSpPr>
            <a:cxnSpLocks/>
          </p:cNvCxnSpPr>
          <p:nvPr/>
        </p:nvCxnSpPr>
        <p:spPr>
          <a:xfrm>
            <a:off x="16095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62056201-B12B-452A-B21D-538729D4F641}"/>
              </a:ext>
            </a:extLst>
          </p:cNvPr>
          <p:cNvCxnSpPr>
            <a:cxnSpLocks/>
          </p:cNvCxnSpPr>
          <p:nvPr/>
        </p:nvCxnSpPr>
        <p:spPr>
          <a:xfrm>
            <a:off x="40485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C611E1F0-BE84-4027-A4E4-B701C8E61028}"/>
              </a:ext>
            </a:extLst>
          </p:cNvPr>
          <p:cNvCxnSpPr>
            <a:cxnSpLocks/>
          </p:cNvCxnSpPr>
          <p:nvPr/>
        </p:nvCxnSpPr>
        <p:spPr>
          <a:xfrm>
            <a:off x="77070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E7F8E73F-E255-4A3A-B530-020C1F332F6F}"/>
              </a:ext>
            </a:extLst>
          </p:cNvPr>
          <p:cNvCxnSpPr>
            <a:cxnSpLocks/>
          </p:cNvCxnSpPr>
          <p:nvPr/>
        </p:nvCxnSpPr>
        <p:spPr>
          <a:xfrm>
            <a:off x="101460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C366CFD-49CA-4A21-B228-9BAA7C91E970}"/>
              </a:ext>
            </a:extLst>
          </p:cNvPr>
          <p:cNvCxnSpPr>
            <a:cxnSpLocks/>
          </p:cNvCxnSpPr>
          <p:nvPr/>
        </p:nvCxnSpPr>
        <p:spPr>
          <a:xfrm>
            <a:off x="52680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ED7D0146-1E83-4546-9C76-55D75AA7B8D3}"/>
              </a:ext>
            </a:extLst>
          </p:cNvPr>
          <p:cNvCxnSpPr>
            <a:cxnSpLocks/>
          </p:cNvCxnSpPr>
          <p:nvPr/>
        </p:nvCxnSpPr>
        <p:spPr>
          <a:xfrm>
            <a:off x="64875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0C9BB5E5-5CAE-4412-93AD-D6A067F1120B}"/>
              </a:ext>
            </a:extLst>
          </p:cNvPr>
          <p:cNvGrpSpPr/>
          <p:nvPr/>
        </p:nvGrpSpPr>
        <p:grpSpPr>
          <a:xfrm>
            <a:off x="4122173" y="3552014"/>
            <a:ext cx="7252105" cy="432000"/>
            <a:chOff x="4122173" y="3552014"/>
            <a:chExt cx="7252105" cy="432000"/>
          </a:xfrm>
        </p:grpSpPr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D02FDFA0-D84E-4083-81E9-A7BA3DFD81A8}"/>
                </a:ext>
              </a:extLst>
            </p:cNvPr>
            <p:cNvCxnSpPr>
              <a:cxnSpLocks/>
            </p:cNvCxnSpPr>
            <p:nvPr/>
          </p:nvCxnSpPr>
          <p:spPr>
            <a:xfrm>
              <a:off x="6504740" y="3552014"/>
              <a:ext cx="0" cy="432000"/>
            </a:xfrm>
            <a:prstGeom prst="line">
              <a:avLst/>
            </a:prstGeom>
            <a:noFill/>
            <a:ln w="57150" cap="flat" cmpd="sng" algn="ctr">
              <a:solidFill>
                <a:srgbClr val="FF6D13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2F6FDD34-D614-424D-87C9-4F3B2AFCB34B}"/>
                </a:ext>
              </a:extLst>
            </p:cNvPr>
            <p:cNvCxnSpPr>
              <a:cxnSpLocks/>
            </p:cNvCxnSpPr>
            <p:nvPr/>
          </p:nvCxnSpPr>
          <p:spPr>
            <a:xfrm>
              <a:off x="8937419" y="3552014"/>
              <a:ext cx="0" cy="432000"/>
            </a:xfrm>
            <a:prstGeom prst="line">
              <a:avLst/>
            </a:prstGeom>
            <a:noFill/>
            <a:ln w="57150" cap="flat" cmpd="sng" algn="ctr">
              <a:solidFill>
                <a:srgbClr val="FF6D13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489482AA-0EAE-4354-8E0E-89EE1E915F97}"/>
                </a:ext>
              </a:extLst>
            </p:cNvPr>
            <p:cNvCxnSpPr>
              <a:cxnSpLocks/>
            </p:cNvCxnSpPr>
            <p:nvPr/>
          </p:nvCxnSpPr>
          <p:spPr>
            <a:xfrm>
              <a:off x="4122173" y="3962905"/>
              <a:ext cx="7252104" cy="0"/>
            </a:xfrm>
            <a:prstGeom prst="line">
              <a:avLst/>
            </a:prstGeom>
            <a:noFill/>
            <a:ln w="57150" cap="flat" cmpd="sng" algn="ctr">
              <a:solidFill>
                <a:srgbClr val="FF9E1B"/>
              </a:solidFill>
              <a:prstDash val="solid"/>
              <a:miter lim="800000"/>
              <a:headEnd type="none" w="med" len="med"/>
              <a:tailEnd type="triangle" w="med" len="med"/>
            </a:ln>
            <a:effectLst/>
          </p:spPr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54127202-51A6-4CB5-83DD-2B94EAFB18B6}"/>
                </a:ext>
              </a:extLst>
            </p:cNvPr>
            <p:cNvCxnSpPr>
              <a:cxnSpLocks/>
            </p:cNvCxnSpPr>
            <p:nvPr/>
          </p:nvCxnSpPr>
          <p:spPr>
            <a:xfrm>
              <a:off x="6478278" y="3568194"/>
              <a:ext cx="4896000" cy="0"/>
            </a:xfrm>
            <a:prstGeom prst="line">
              <a:avLst/>
            </a:prstGeom>
            <a:noFill/>
            <a:ln w="57150" cap="flat" cmpd="sng" algn="ctr">
              <a:solidFill>
                <a:srgbClr val="FF6D13"/>
              </a:solidFill>
              <a:prstDash val="solid"/>
              <a:miter lim="800000"/>
              <a:headEnd type="none" w="med" len="med"/>
              <a:tailEnd type="triangle" w="med" len="med"/>
            </a:ln>
            <a:effectLst/>
          </p:spPr>
        </p:cxnSp>
      </p:grp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8A8DBB2B-C981-4D72-8692-82B0B21887D4}"/>
              </a:ext>
            </a:extLst>
          </p:cNvPr>
          <p:cNvSpPr/>
          <p:nvPr/>
        </p:nvSpPr>
        <p:spPr>
          <a:xfrm>
            <a:off x="1609508" y="4390833"/>
            <a:ext cx="9756000" cy="360000"/>
          </a:xfrm>
          <a:prstGeom prst="rect">
            <a:avLst/>
          </a:prstGeom>
          <a:solidFill>
            <a:srgbClr val="BFBFBF"/>
          </a:solidFill>
          <a:ln w="1905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457200">
              <a:defRPr/>
            </a:pPr>
            <a:r>
              <a:rPr kumimoji="0" lang="en-US" altLang="ja-JP" sz="1600" b="1" kern="0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ARB or </a:t>
            </a:r>
            <a:r>
              <a:rPr kumimoji="0" lang="en-US" altLang="ja-JP" sz="1600" b="1" kern="0" dirty="0" err="1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CCB</a:t>
            </a:r>
            <a:r>
              <a:rPr kumimoji="0" lang="en-US" altLang="ja-JP" sz="1600" b="1" kern="0" baseline="30000" dirty="0" err="1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a</a:t>
            </a:r>
            <a:r>
              <a:rPr kumimoji="0" lang="ja-JP" altLang="en-US" sz="1600" kern="0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　</a:t>
            </a:r>
            <a:endParaRPr kumimoji="0" lang="en-US" altLang="ja-JP" sz="5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6F8ACAC-1BCB-4139-A8AD-2D49C6A93757}"/>
              </a:ext>
            </a:extLst>
          </p:cNvPr>
          <p:cNvSpPr txBox="1"/>
          <p:nvPr/>
        </p:nvSpPr>
        <p:spPr>
          <a:xfrm>
            <a:off x="8731242" y="4972698"/>
            <a:ext cx="387928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8W)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64C06A2-84CA-47B3-BF8A-7E4D22462C3D}"/>
              </a:ext>
            </a:extLst>
          </p:cNvPr>
          <p:cNvSpPr txBox="1"/>
          <p:nvPr/>
        </p:nvSpPr>
        <p:spPr>
          <a:xfrm>
            <a:off x="10075748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C0D6E5B-299A-4A4D-84D0-EE5EB8CB8F02}"/>
              </a:ext>
            </a:extLst>
          </p:cNvPr>
          <p:cNvSpPr txBox="1"/>
          <p:nvPr/>
        </p:nvSpPr>
        <p:spPr>
          <a:xfrm>
            <a:off x="8857302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0B25C04-502E-4DCE-871F-8396CCA0F0B7}"/>
              </a:ext>
            </a:extLst>
          </p:cNvPr>
          <p:cNvSpPr txBox="1"/>
          <p:nvPr/>
        </p:nvSpPr>
        <p:spPr>
          <a:xfrm>
            <a:off x="7638856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E962640-0E8C-4F69-ABB2-2B933CE36B76}"/>
              </a:ext>
            </a:extLst>
          </p:cNvPr>
          <p:cNvSpPr txBox="1"/>
          <p:nvPr/>
        </p:nvSpPr>
        <p:spPr>
          <a:xfrm>
            <a:off x="6420410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C80FE9D-3C52-4706-90C5-88DB04B1E91F}"/>
              </a:ext>
            </a:extLst>
          </p:cNvPr>
          <p:cNvSpPr txBox="1"/>
          <p:nvPr/>
        </p:nvSpPr>
        <p:spPr>
          <a:xfrm>
            <a:off x="5201964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75C0BF6-952E-43FE-80BE-599E61022416}"/>
              </a:ext>
            </a:extLst>
          </p:cNvPr>
          <p:cNvSpPr txBox="1"/>
          <p:nvPr/>
        </p:nvSpPr>
        <p:spPr>
          <a:xfrm>
            <a:off x="3983518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30D63EA-F87B-4E9D-BEE5-24EED1F1D1CF}"/>
              </a:ext>
            </a:extLst>
          </p:cNvPr>
          <p:cNvSpPr txBox="1"/>
          <p:nvPr/>
        </p:nvSpPr>
        <p:spPr>
          <a:xfrm>
            <a:off x="11180164" y="4972698"/>
            <a:ext cx="368691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2W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6FB4B92-07E1-496C-9330-EB154CB65E13}"/>
              </a:ext>
            </a:extLst>
          </p:cNvPr>
          <p:cNvSpPr txBox="1"/>
          <p:nvPr/>
        </p:nvSpPr>
        <p:spPr>
          <a:xfrm>
            <a:off x="4205290" y="1488297"/>
            <a:ext cx="6091411" cy="215444"/>
          </a:xfrm>
          <a:prstGeom prst="rect">
            <a:avLst/>
          </a:prstGeom>
          <a:ln w="28575">
            <a:noFill/>
          </a:ln>
        </p:spPr>
        <p:txBody>
          <a:bodyPr vert="horz" wrap="none" lIns="0" tIns="0" rIns="0" bIns="0" rtlCol="0" anchor="ctr" anchorCtr="0">
            <a:spAutoFit/>
          </a:bodyPr>
          <a:lstStyle/>
          <a:p>
            <a:pPr defTabSz="457200">
              <a:defRPr/>
            </a:pPr>
            <a:r>
              <a:rPr kumimoji="0" lang="en-US" altLang="ja-JP" sz="1400" b="1" i="0" u="sng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GFRcreat</a:t>
            </a:r>
            <a:r>
              <a:rPr kumimoji="0" lang="en-US" altLang="ja-JP" sz="1400" b="1" i="0" u="sng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30 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kumimoji="0" lang="ja-JP" altLang="en-US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ja-JP" sz="1400" b="1" i="0" u="sng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60 ml/min/1.73 m</a:t>
            </a:r>
            <a:r>
              <a:rPr kumimoji="0" lang="en-US" altLang="ja-JP" sz="1400" b="1" u="sng" kern="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 or diabetes with UACR </a:t>
            </a:r>
            <a:r>
              <a:rPr kumimoji="0" lang="ja-JP" altLang="en-US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30 mg/</a:t>
            </a:r>
            <a:r>
              <a:rPr kumimoji="0" lang="en-US" altLang="ja-JP" sz="1400" b="1" u="sng" kern="0" dirty="0" err="1">
                <a:latin typeface="Arial" panose="020B0604020202020204" pitchFamily="34" charset="0"/>
                <a:cs typeface="Arial" panose="020B0604020202020204" pitchFamily="34" charset="0"/>
              </a:rPr>
              <a:t>gCr</a:t>
            </a:r>
            <a:endParaRPr kumimoji="0" lang="en-US" altLang="ja-JP" sz="1400" b="1" u="sng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4896656-0AF7-47BE-9DDD-4E5A50525D31}"/>
              </a:ext>
            </a:extLst>
          </p:cNvPr>
          <p:cNvSpPr txBox="1"/>
          <p:nvPr/>
        </p:nvSpPr>
        <p:spPr>
          <a:xfrm>
            <a:off x="4205290" y="3062277"/>
            <a:ext cx="6957033" cy="215444"/>
          </a:xfrm>
          <a:prstGeom prst="rect">
            <a:avLst/>
          </a:prstGeom>
          <a:ln w="28575">
            <a:noFill/>
          </a:ln>
        </p:spPr>
        <p:txBody>
          <a:bodyPr vert="horz" wrap="none" lIns="0" tIns="0" rIns="0" bIns="0" rtlCol="0" anchor="ctr" anchorCtr="0">
            <a:spAutoFit/>
          </a:bodyPr>
          <a:lstStyle/>
          <a:p>
            <a:pPr defTabSz="457200">
              <a:defRPr/>
            </a:pP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Except for </a:t>
            </a:r>
            <a:r>
              <a:rPr kumimoji="0" lang="en-US" altLang="ja-JP" sz="1400" b="1" u="sng" kern="0" dirty="0" err="1">
                <a:latin typeface="Arial" panose="020B0604020202020204" pitchFamily="34" charset="0"/>
                <a:cs typeface="Arial" panose="020B0604020202020204" pitchFamily="34" charset="0"/>
              </a:rPr>
              <a:t>eGFRcreat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 30 to &lt;60 ml/min/1.73 m</a:t>
            </a:r>
            <a:r>
              <a:rPr kumimoji="0" lang="en-US" altLang="ja-JP" sz="1400" b="1" u="sng" kern="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en-US" altLang="ja-JP" sz="1400" b="1" u="sng" kern="0" dirty="0">
                <a:latin typeface="Arial" panose="020B0604020202020204" pitchFamily="34" charset="0"/>
                <a:cs typeface="Arial" panose="020B0604020202020204" pitchFamily="34" charset="0"/>
              </a:rPr>
              <a:t> or diabetes with UACR ≥30 mg/gCr</a:t>
            </a: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633708E5-34C8-487A-8F13-74CEA82C8A1F}"/>
              </a:ext>
            </a:extLst>
          </p:cNvPr>
          <p:cNvGrpSpPr/>
          <p:nvPr/>
        </p:nvGrpSpPr>
        <p:grpSpPr>
          <a:xfrm>
            <a:off x="1607120" y="1448582"/>
            <a:ext cx="2419189" cy="2700000"/>
            <a:chOff x="1607121" y="1555161"/>
            <a:chExt cx="1682179" cy="2700000"/>
          </a:xfrm>
        </p:grpSpPr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FC709352-0A91-4CDA-A057-D8BCE794C7AE}"/>
                </a:ext>
              </a:extLst>
            </p:cNvPr>
            <p:cNvSpPr/>
            <p:nvPr/>
          </p:nvSpPr>
          <p:spPr>
            <a:xfrm>
              <a:off x="1607121" y="1555161"/>
              <a:ext cx="1682179" cy="2700000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2000" b="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eiryo UI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EF5FB2AE-29DF-4BD4-8620-F6BA8A22F5B5}"/>
                </a:ext>
              </a:extLst>
            </p:cNvPr>
            <p:cNvSpPr txBox="1"/>
            <p:nvPr/>
          </p:nvSpPr>
          <p:spPr>
            <a:xfrm>
              <a:off x="1748111" y="2664597"/>
              <a:ext cx="1400198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un</a:t>
              </a:r>
              <a:r>
                <a:rPr kumimoji="0" lang="en-US" altLang="ja-JP" sz="1400" kern="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0" lang="en-US" altLang="ja-JP" sz="14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kumimoji="0" lang="en-US" altLang="ja-JP" sz="1400" kern="0" dirty="0">
                  <a:latin typeface="Arial" panose="020B0604020202020204" pitchFamily="34" charset="0"/>
                  <a:cs typeface="Arial" panose="020B0604020202020204" pitchFamily="34" charset="0"/>
                </a:rPr>
                <a:t>period</a:t>
              </a:r>
              <a:endParaRPr kumimoji="0" lang="ja-JP" altLang="en-US" sz="1400" b="0" i="0" u="none" strike="noStrike" kern="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テキスト プレースホルダー 2">
            <a:extLst>
              <a:ext uri="{FF2B5EF4-FFF2-40B4-BE49-F238E27FC236}">
                <a16:creationId xmlns:a16="http://schemas.microsoft.com/office/drawing/2014/main" id="{DEF48D57-5377-4F35-AF47-414A5606792A}"/>
              </a:ext>
            </a:extLst>
          </p:cNvPr>
          <p:cNvSpPr txBox="1">
            <a:spLocks/>
          </p:cNvSpPr>
          <p:nvPr/>
        </p:nvSpPr>
        <p:spPr>
          <a:xfrm>
            <a:off x="9973455" y="1704281"/>
            <a:ext cx="397545" cy="21544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Font typeface="Arial" panose="020B0604020202020204" pitchFamily="34" charset="0"/>
              <a:buNone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4BC5F14-F08C-4610-953B-D850FC541C3E}"/>
              </a:ext>
            </a:extLst>
          </p:cNvPr>
          <p:cNvSpPr txBox="1"/>
          <p:nvPr/>
        </p:nvSpPr>
        <p:spPr>
          <a:xfrm>
            <a:off x="2335037" y="864000"/>
            <a:ext cx="971740" cy="338554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</a:t>
            </a:r>
            <a:r>
              <a:rPr kumimoji="1" lang="ja-JP" altLang="en-US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weeks</a:t>
            </a:r>
            <a:endParaRPr kumimoji="1" lang="ja-JP" altLang="en-US" sz="16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0D6EB784-A130-4769-B6B2-D73AC148069F}"/>
              </a:ext>
            </a:extLst>
          </p:cNvPr>
          <p:cNvCxnSpPr>
            <a:cxnSpLocks/>
          </p:cNvCxnSpPr>
          <p:nvPr/>
        </p:nvCxnSpPr>
        <p:spPr>
          <a:xfrm>
            <a:off x="1640107" y="1235646"/>
            <a:ext cx="2361600" cy="0"/>
          </a:xfrm>
          <a:prstGeom prst="line">
            <a:avLst/>
          </a:prstGeom>
          <a:ln>
            <a:solidFill>
              <a:schemeClr val="tx1"/>
            </a:solidFill>
            <a:headEnd type="oval" w="lg" len="lg"/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7FCAF26-1F04-4C86-A919-C9F6CB734187}"/>
              </a:ext>
            </a:extLst>
          </p:cNvPr>
          <p:cNvSpPr txBox="1"/>
          <p:nvPr/>
        </p:nvSpPr>
        <p:spPr>
          <a:xfrm>
            <a:off x="5646038" y="864000"/>
            <a:ext cx="4211409" cy="338554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2</a:t>
            </a: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weeks (esaxerenone treatment period)</a:t>
            </a:r>
            <a:endParaRPr kumimoji="1" lang="ja-JP" altLang="en-US" sz="16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28C59BC1-93FB-4428-9EC5-325E8E23C884}"/>
              </a:ext>
            </a:extLst>
          </p:cNvPr>
          <p:cNvCxnSpPr>
            <a:cxnSpLocks/>
          </p:cNvCxnSpPr>
          <p:nvPr/>
        </p:nvCxnSpPr>
        <p:spPr>
          <a:xfrm>
            <a:off x="4151671" y="1235646"/>
            <a:ext cx="7200142" cy="0"/>
          </a:xfrm>
          <a:prstGeom prst="line">
            <a:avLst/>
          </a:prstGeom>
          <a:ln>
            <a:solidFill>
              <a:schemeClr val="tx1"/>
            </a:solidFill>
            <a:headEnd type="oval" w="lg" len="lg"/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A4A8662-40E6-4917-8A08-2AEBA0832BCE}"/>
              </a:ext>
            </a:extLst>
          </p:cNvPr>
          <p:cNvSpPr txBox="1"/>
          <p:nvPr/>
        </p:nvSpPr>
        <p:spPr>
          <a:xfrm>
            <a:off x="5105692" y="305244"/>
            <a:ext cx="2230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ARLY-NH study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C3017129-2FCF-414A-B5F6-E29D48E26B3B}"/>
              </a:ext>
            </a:extLst>
          </p:cNvPr>
          <p:cNvCxnSpPr>
            <a:cxnSpLocks/>
          </p:cNvCxnSpPr>
          <p:nvPr/>
        </p:nvCxnSpPr>
        <p:spPr>
          <a:xfrm>
            <a:off x="1619250" y="5955907"/>
            <a:ext cx="9756775" cy="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miter lim="800000"/>
            <a:headEnd type="triangle" w="med" len="med"/>
            <a:tailEnd type="triangle" w="med" len="med"/>
          </a:ln>
          <a:effectLst/>
        </p:spPr>
      </p:cxn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F994309E-CA81-49B8-ABFC-1E8A9ECA008C}"/>
              </a:ext>
            </a:extLst>
          </p:cNvPr>
          <p:cNvSpPr/>
          <p:nvPr/>
        </p:nvSpPr>
        <p:spPr>
          <a:xfrm>
            <a:off x="4122174" y="3022216"/>
            <a:ext cx="7252104" cy="1126365"/>
          </a:xfrm>
          <a:prstGeom prst="rect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2000" b="0" i="0" u="none" strike="noStrike" kern="0" cap="none" spc="0" normalizeH="0" baseline="0" noProof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E7FC643-1312-437B-9E25-FA856E70F4B8}"/>
              </a:ext>
            </a:extLst>
          </p:cNvPr>
          <p:cNvSpPr txBox="1"/>
          <p:nvPr/>
        </p:nvSpPr>
        <p:spPr>
          <a:xfrm>
            <a:off x="5789075" y="4114509"/>
            <a:ext cx="14590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ose escalation</a:t>
            </a:r>
            <a:endParaRPr kumimoji="1" lang="ja-JP" altLang="en-US" sz="14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1185DA8-55E7-4732-A867-AD1A958CF13F}"/>
              </a:ext>
            </a:extLst>
          </p:cNvPr>
          <p:cNvSpPr txBox="1"/>
          <p:nvPr/>
        </p:nvSpPr>
        <p:spPr>
          <a:xfrm>
            <a:off x="8220236" y="4114509"/>
            <a:ext cx="14590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ose escalation</a:t>
            </a:r>
            <a:endParaRPr kumimoji="1" lang="ja-JP" altLang="en-US" sz="14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10D03A80-8680-41A6-8B6C-AB5CFEF7BBED}"/>
              </a:ext>
            </a:extLst>
          </p:cNvPr>
          <p:cNvCxnSpPr>
            <a:cxnSpLocks/>
          </p:cNvCxnSpPr>
          <p:nvPr/>
        </p:nvCxnSpPr>
        <p:spPr>
          <a:xfrm>
            <a:off x="2829008" y="4742798"/>
            <a:ext cx="0" cy="180000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miter lim="800000"/>
          </a:ln>
          <a:effectLst/>
        </p:spPr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7927E51-4F67-422F-880C-98B9D2BEED03}"/>
              </a:ext>
            </a:extLst>
          </p:cNvPr>
          <p:cNvSpPr txBox="1"/>
          <p:nvPr/>
        </p:nvSpPr>
        <p:spPr>
          <a:xfrm>
            <a:off x="2646034" y="4972698"/>
            <a:ext cx="373500" cy="21544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/>
          <a:p>
            <a:pPr algn="ctr" defTabSz="457200"/>
            <a:r>
              <a:rPr kumimoji="0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D0E4CC64-819B-47C7-B482-971C1C1A0A4A}"/>
              </a:ext>
            </a:extLst>
          </p:cNvPr>
          <p:cNvGrpSpPr/>
          <p:nvPr/>
        </p:nvGrpSpPr>
        <p:grpSpPr>
          <a:xfrm>
            <a:off x="4122174" y="1943046"/>
            <a:ext cx="7252104" cy="810954"/>
            <a:chOff x="4122174" y="1943046"/>
            <a:chExt cx="7252104" cy="810954"/>
          </a:xfrm>
        </p:grpSpPr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09CA60C0-A5FF-4E21-93CB-0FA3FCEFE73E}"/>
                </a:ext>
              </a:extLst>
            </p:cNvPr>
            <p:cNvCxnSpPr>
              <a:cxnSpLocks/>
            </p:cNvCxnSpPr>
            <p:nvPr/>
          </p:nvCxnSpPr>
          <p:spPr>
            <a:xfrm>
              <a:off x="8937419" y="1943046"/>
              <a:ext cx="0" cy="432000"/>
            </a:xfrm>
            <a:prstGeom prst="line">
              <a:avLst/>
            </a:prstGeom>
            <a:noFill/>
            <a:ln w="57150" cap="flat" cmpd="sng" algn="ctr">
              <a:solidFill>
                <a:srgbClr val="FF6D13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60361C9F-C7B9-4DA4-A028-DA6EB84EB13C}"/>
                </a:ext>
              </a:extLst>
            </p:cNvPr>
            <p:cNvCxnSpPr>
              <a:cxnSpLocks/>
            </p:cNvCxnSpPr>
            <p:nvPr/>
          </p:nvCxnSpPr>
          <p:spPr>
            <a:xfrm>
              <a:off x="8937419" y="2322000"/>
              <a:ext cx="0" cy="432000"/>
            </a:xfrm>
            <a:prstGeom prst="line">
              <a:avLst/>
            </a:prstGeom>
            <a:noFill/>
            <a:ln w="57150" cap="flat" cmpd="sng" algn="ctr">
              <a:solidFill>
                <a:srgbClr val="FF9E1B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BB6459C2-49F1-49FE-8748-DB226C4583C5}"/>
                </a:ext>
              </a:extLst>
            </p:cNvPr>
            <p:cNvCxnSpPr>
              <a:cxnSpLocks/>
            </p:cNvCxnSpPr>
            <p:nvPr/>
          </p:nvCxnSpPr>
          <p:spPr>
            <a:xfrm>
              <a:off x="8911878" y="1956086"/>
              <a:ext cx="2462400" cy="0"/>
            </a:xfrm>
            <a:prstGeom prst="line">
              <a:avLst/>
            </a:prstGeom>
            <a:noFill/>
            <a:ln w="57150" cap="flat" cmpd="sng" algn="ctr">
              <a:solidFill>
                <a:srgbClr val="FF6D13"/>
              </a:solidFill>
              <a:prstDash val="solid"/>
              <a:miter lim="800000"/>
              <a:headEnd type="none" w="med" len="med"/>
              <a:tailEnd type="triangle" w="med" len="med"/>
            </a:ln>
            <a:effectLst/>
          </p:spPr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CBBC5288-818A-48B9-AF10-243E605E377F}"/>
                </a:ext>
              </a:extLst>
            </p:cNvPr>
            <p:cNvCxnSpPr>
              <a:cxnSpLocks/>
            </p:cNvCxnSpPr>
            <p:nvPr/>
          </p:nvCxnSpPr>
          <p:spPr>
            <a:xfrm>
              <a:off x="6478278" y="2350798"/>
              <a:ext cx="4896000" cy="0"/>
            </a:xfrm>
            <a:prstGeom prst="line">
              <a:avLst/>
            </a:prstGeom>
            <a:noFill/>
            <a:ln w="57150" cap="flat" cmpd="sng" algn="ctr">
              <a:solidFill>
                <a:srgbClr val="FF9E1B"/>
              </a:solidFill>
              <a:prstDash val="solid"/>
              <a:miter lim="800000"/>
              <a:headEnd type="none" w="med" len="med"/>
              <a:tailEnd type="triangle" w="med" len="med"/>
            </a:ln>
            <a:effectLst/>
          </p:spPr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C18632A4-D3C1-4E75-9566-BD387EA815F1}"/>
                </a:ext>
              </a:extLst>
            </p:cNvPr>
            <p:cNvCxnSpPr>
              <a:cxnSpLocks/>
            </p:cNvCxnSpPr>
            <p:nvPr/>
          </p:nvCxnSpPr>
          <p:spPr>
            <a:xfrm>
              <a:off x="6504740" y="2358000"/>
              <a:ext cx="0" cy="396000"/>
            </a:xfrm>
            <a:prstGeom prst="line">
              <a:avLst/>
            </a:prstGeom>
            <a:noFill/>
            <a:ln w="57150" cap="flat" cmpd="sng" algn="ctr">
              <a:solidFill>
                <a:srgbClr val="FF9E1B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62C5912E-7C3B-4E1D-B02F-0201A3CAF07C}"/>
                </a:ext>
              </a:extLst>
            </p:cNvPr>
            <p:cNvCxnSpPr>
              <a:cxnSpLocks/>
            </p:cNvCxnSpPr>
            <p:nvPr/>
          </p:nvCxnSpPr>
          <p:spPr>
            <a:xfrm>
              <a:off x="4122174" y="2745510"/>
              <a:ext cx="7252104" cy="0"/>
            </a:xfrm>
            <a:prstGeom prst="line">
              <a:avLst/>
            </a:prstGeom>
            <a:noFill/>
            <a:ln w="57150" cap="flat" cmpd="sng" algn="ctr">
              <a:solidFill>
                <a:srgbClr val="FBE5D6"/>
              </a:solidFill>
              <a:prstDash val="solid"/>
              <a:miter lim="800000"/>
              <a:headEnd type="none" w="med" len="med"/>
              <a:tailEnd type="triangle" w="med" len="med"/>
            </a:ln>
            <a:effectLst/>
          </p:spPr>
        </p:cxnSp>
      </p:grp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B5FE6DAE-2685-41AA-991A-73DB6A9BA46B}"/>
              </a:ext>
            </a:extLst>
          </p:cNvPr>
          <p:cNvSpPr/>
          <p:nvPr/>
        </p:nvSpPr>
        <p:spPr>
          <a:xfrm>
            <a:off x="4122174" y="1448582"/>
            <a:ext cx="7252104" cy="1477458"/>
          </a:xfrm>
          <a:prstGeom prst="rect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2000" b="0" i="0" u="none" strike="noStrike" kern="0" cap="none" spc="0" normalizeH="0" baseline="0" noProof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cxnSp>
        <p:nvCxnSpPr>
          <p:cNvPr id="72" name="直線矢印コネクタ 71">
            <a:extLst>
              <a:ext uri="{FF2B5EF4-FFF2-40B4-BE49-F238E27FC236}">
                <a16:creationId xmlns:a16="http://schemas.microsoft.com/office/drawing/2014/main" id="{525DBC75-A23E-4B0F-B4D5-D25EBC1CDB5D}"/>
              </a:ext>
            </a:extLst>
          </p:cNvPr>
          <p:cNvCxnSpPr>
            <a:cxnSpLocks/>
          </p:cNvCxnSpPr>
          <p:nvPr/>
        </p:nvCxnSpPr>
        <p:spPr>
          <a:xfrm>
            <a:off x="2828620" y="5746904"/>
            <a:ext cx="612000" cy="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miter lim="800000"/>
            <a:headEnd type="triangle" w="med" len="med"/>
            <a:tailEnd type="triangle" w="med" len="med"/>
          </a:ln>
          <a:effectLst/>
        </p:spPr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EADFBC39-51AB-477D-BFC1-8ECE7B08E847}"/>
              </a:ext>
            </a:extLst>
          </p:cNvPr>
          <p:cNvCxnSpPr>
            <a:cxnSpLocks/>
          </p:cNvCxnSpPr>
          <p:nvPr/>
        </p:nvCxnSpPr>
        <p:spPr>
          <a:xfrm>
            <a:off x="3438758" y="5544000"/>
            <a:ext cx="612000" cy="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miter lim="800000"/>
            <a:headEnd type="triangle" w="med" len="med"/>
            <a:tailEnd type="triangle" w="med" len="med"/>
          </a:ln>
          <a:effectLst/>
        </p:spPr>
      </p:cxnSp>
      <p:cxnSp>
        <p:nvCxnSpPr>
          <p:cNvPr id="76" name="直線矢印コネクタ 75">
            <a:extLst>
              <a:ext uri="{FF2B5EF4-FFF2-40B4-BE49-F238E27FC236}">
                <a16:creationId xmlns:a16="http://schemas.microsoft.com/office/drawing/2014/main" id="{FDE47710-714D-4783-8AFF-D6C7365F0F6D}"/>
              </a:ext>
            </a:extLst>
          </p:cNvPr>
          <p:cNvCxnSpPr>
            <a:cxnSpLocks/>
          </p:cNvCxnSpPr>
          <p:nvPr/>
        </p:nvCxnSpPr>
        <p:spPr>
          <a:xfrm>
            <a:off x="10149929" y="5746904"/>
            <a:ext cx="612000" cy="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miter lim="800000"/>
            <a:headEnd type="triangle" w="med" len="med"/>
            <a:tailEnd type="triangle" w="med" len="med"/>
          </a:ln>
          <a:effectLst/>
        </p:spPr>
      </p:cxnSp>
      <p:cxnSp>
        <p:nvCxnSpPr>
          <p:cNvPr id="77" name="直線矢印コネクタ 76">
            <a:extLst>
              <a:ext uri="{FF2B5EF4-FFF2-40B4-BE49-F238E27FC236}">
                <a16:creationId xmlns:a16="http://schemas.microsoft.com/office/drawing/2014/main" id="{91B79163-D1E6-4E82-818E-ABD3F0F7642A}"/>
              </a:ext>
            </a:extLst>
          </p:cNvPr>
          <p:cNvCxnSpPr>
            <a:cxnSpLocks/>
          </p:cNvCxnSpPr>
          <p:nvPr/>
        </p:nvCxnSpPr>
        <p:spPr>
          <a:xfrm>
            <a:off x="10760067" y="5537176"/>
            <a:ext cx="612000" cy="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miter lim="800000"/>
            <a:headEnd type="triangle" w="med" len="med"/>
            <a:tailEnd type="triangle" w="med" len="med"/>
          </a:ln>
          <a:effectLst/>
        </p:spPr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5C6EB40-576E-4AA3-B12A-3350538B0B32}"/>
              </a:ext>
            </a:extLst>
          </p:cNvPr>
          <p:cNvSpPr txBox="1"/>
          <p:nvPr/>
        </p:nvSpPr>
        <p:spPr>
          <a:xfrm>
            <a:off x="1544212" y="6060029"/>
            <a:ext cx="139462" cy="64633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 defTabSz="457200"/>
            <a:r>
              <a:rPr kumimoji="0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A20F861-69F2-1001-0036-2A8514EB2922}"/>
              </a:ext>
            </a:extLst>
          </p:cNvPr>
          <p:cNvSpPr txBox="1"/>
          <p:nvPr/>
        </p:nvSpPr>
        <p:spPr>
          <a:xfrm>
            <a:off x="1627209" y="6433591"/>
            <a:ext cx="43634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aseline="30000" dirty="0"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b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344549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正方形/長方形 526">
            <a:extLst>
              <a:ext uri="{FF2B5EF4-FFF2-40B4-BE49-F238E27FC236}">
                <a16:creationId xmlns:a16="http://schemas.microsoft.com/office/drawing/2014/main" id="{CCEC1816-5CB0-2CC4-42F6-6D7C5A559E51}"/>
              </a:ext>
            </a:extLst>
          </p:cNvPr>
          <p:cNvSpPr/>
          <p:nvPr/>
        </p:nvSpPr>
        <p:spPr>
          <a:xfrm>
            <a:off x="0" y="0"/>
            <a:ext cx="2993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</a:t>
            </a:r>
            <a:r>
              <a:rPr lang="en-US" altLang="ja-JP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2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9019865D-8442-9A56-9E9B-297A6384A51B}"/>
              </a:ext>
            </a:extLst>
          </p:cNvPr>
          <p:cNvGrpSpPr/>
          <p:nvPr/>
        </p:nvGrpSpPr>
        <p:grpSpPr>
          <a:xfrm>
            <a:off x="1960172" y="811319"/>
            <a:ext cx="8206361" cy="5235363"/>
            <a:chOff x="1960172" y="811319"/>
            <a:chExt cx="8206361" cy="5235363"/>
          </a:xfrm>
        </p:grpSpPr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69A2C387-B2D9-5768-D6A4-7D3173AFA483}"/>
                </a:ext>
              </a:extLst>
            </p:cNvPr>
            <p:cNvGrpSpPr/>
            <p:nvPr/>
          </p:nvGrpSpPr>
          <p:grpSpPr>
            <a:xfrm>
              <a:off x="4146738" y="5594224"/>
              <a:ext cx="5093346" cy="452458"/>
              <a:chOff x="14358031" y="770856"/>
              <a:chExt cx="5093346" cy="452458"/>
            </a:xfrm>
          </p:grpSpPr>
          <p:grpSp>
            <p:nvGrpSpPr>
              <p:cNvPr id="500" name="グループ化 499">
                <a:extLst>
                  <a:ext uri="{FF2B5EF4-FFF2-40B4-BE49-F238E27FC236}">
                    <a16:creationId xmlns:a16="http://schemas.microsoft.com/office/drawing/2014/main" id="{67D1ACEC-D8AA-2E4F-FE01-A21AD543CD65}"/>
                  </a:ext>
                </a:extLst>
              </p:cNvPr>
              <p:cNvGrpSpPr/>
              <p:nvPr/>
            </p:nvGrpSpPr>
            <p:grpSpPr>
              <a:xfrm>
                <a:off x="16427188" y="806578"/>
                <a:ext cx="1463497" cy="381014"/>
                <a:chOff x="16427188" y="806578"/>
                <a:chExt cx="1463497" cy="381014"/>
              </a:xfrm>
            </p:grpSpPr>
            <p:sp>
              <p:nvSpPr>
                <p:cNvPr id="520" name="正方形/長方形 519">
                  <a:extLst>
                    <a:ext uri="{FF2B5EF4-FFF2-40B4-BE49-F238E27FC236}">
                      <a16:creationId xmlns:a16="http://schemas.microsoft.com/office/drawing/2014/main" id="{6077B6F6-34E3-7ADD-7063-06A1FDA671EA}"/>
                    </a:ext>
                  </a:extLst>
                </p:cNvPr>
                <p:cNvSpPr/>
                <p:nvPr/>
              </p:nvSpPr>
              <p:spPr>
                <a:xfrm>
                  <a:off x="16813984" y="893799"/>
                  <a:ext cx="1076701" cy="215444"/>
                </a:xfrm>
                <a:prstGeom prst="rect">
                  <a:avLst/>
                </a:prstGeom>
                <a:noFill/>
              </p:spPr>
              <p:txBody>
                <a:bodyPr wrap="none" lIns="36000" tIns="0" rIns="0" bIns="0" anchor="ctr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ARB (</a:t>
                  </a:r>
                  <a:r>
                    <a:rPr lang="en-US" altLang="ja-JP" sz="14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n </a:t>
                  </a: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= 42)</a:t>
                  </a:r>
                </a:p>
              </p:txBody>
            </p:sp>
            <p:grpSp>
              <p:nvGrpSpPr>
                <p:cNvPr id="521" name="グループ化 520">
                  <a:extLst>
                    <a:ext uri="{FF2B5EF4-FFF2-40B4-BE49-F238E27FC236}">
                      <a16:creationId xmlns:a16="http://schemas.microsoft.com/office/drawing/2014/main" id="{FF9D4CF4-ECB6-558F-03B4-374662216AF0}"/>
                    </a:ext>
                  </a:extLst>
                </p:cNvPr>
                <p:cNvGrpSpPr/>
                <p:nvPr/>
              </p:nvGrpSpPr>
              <p:grpSpPr>
                <a:xfrm>
                  <a:off x="16427188" y="806578"/>
                  <a:ext cx="360000" cy="144000"/>
                  <a:chOff x="4090696" y="4907843"/>
                  <a:chExt cx="360000" cy="144000"/>
                </a:xfrm>
              </p:grpSpPr>
              <p:cxnSp>
                <p:nvCxnSpPr>
                  <p:cNvPr id="525" name="直線コネクタ 524">
                    <a:extLst>
                      <a:ext uri="{FF2B5EF4-FFF2-40B4-BE49-F238E27FC236}">
                        <a16:creationId xmlns:a16="http://schemas.microsoft.com/office/drawing/2014/main" id="{414DD036-37DF-3D95-1317-9A03AAFB00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90696" y="4979843"/>
                    <a:ext cx="360000" cy="0"/>
                  </a:xfrm>
                  <a:prstGeom prst="line">
                    <a:avLst/>
                  </a:prstGeom>
                  <a:noFill/>
                  <a:ln w="38100" cap="flat">
                    <a:solidFill>
                      <a:srgbClr val="FF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26" name="楕円 525">
                    <a:extLst>
                      <a:ext uri="{FF2B5EF4-FFF2-40B4-BE49-F238E27FC236}">
                        <a16:creationId xmlns:a16="http://schemas.microsoft.com/office/drawing/2014/main" id="{6AC1B3EA-C234-3DFD-C49C-DD0A611235CF}"/>
                      </a:ext>
                    </a:extLst>
                  </p:cNvPr>
                  <p:cNvSpPr/>
                  <p:nvPr/>
                </p:nvSpPr>
                <p:spPr>
                  <a:xfrm>
                    <a:off x="4198696" y="4907843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22" name="グループ化 521">
                  <a:extLst>
                    <a:ext uri="{FF2B5EF4-FFF2-40B4-BE49-F238E27FC236}">
                      <a16:creationId xmlns:a16="http://schemas.microsoft.com/office/drawing/2014/main" id="{FB8B9643-5976-2533-0CD6-AAF63BBA8A47}"/>
                    </a:ext>
                  </a:extLst>
                </p:cNvPr>
                <p:cNvGrpSpPr/>
                <p:nvPr/>
              </p:nvGrpSpPr>
              <p:grpSpPr>
                <a:xfrm>
                  <a:off x="16427188" y="1043592"/>
                  <a:ext cx="360000" cy="144000"/>
                  <a:chOff x="4090696" y="4907843"/>
                  <a:chExt cx="360000" cy="144000"/>
                </a:xfrm>
              </p:grpSpPr>
              <p:cxnSp>
                <p:nvCxnSpPr>
                  <p:cNvPr id="523" name="直線コネクタ 522">
                    <a:extLst>
                      <a:ext uri="{FF2B5EF4-FFF2-40B4-BE49-F238E27FC236}">
                        <a16:creationId xmlns:a16="http://schemas.microsoft.com/office/drawing/2014/main" id="{722F5568-A21D-476C-2028-A1E55BA4512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90696" y="4979843"/>
                    <a:ext cx="360000" cy="0"/>
                  </a:xfrm>
                  <a:prstGeom prst="line">
                    <a:avLst/>
                  </a:prstGeom>
                  <a:noFill/>
                  <a:ln w="38100" cap="flat">
                    <a:solidFill>
                      <a:srgbClr val="FF0000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24" name="楕円 523">
                    <a:extLst>
                      <a:ext uri="{FF2B5EF4-FFF2-40B4-BE49-F238E27FC236}">
                        <a16:creationId xmlns:a16="http://schemas.microsoft.com/office/drawing/2014/main" id="{A909DE6B-D255-2831-86E4-51592E347D83}"/>
                      </a:ext>
                    </a:extLst>
                  </p:cNvPr>
                  <p:cNvSpPr/>
                  <p:nvPr/>
                </p:nvSpPr>
                <p:spPr>
                  <a:xfrm>
                    <a:off x="4198696" y="4907843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01" name="グループ化 500">
                <a:extLst>
                  <a:ext uri="{FF2B5EF4-FFF2-40B4-BE49-F238E27FC236}">
                    <a16:creationId xmlns:a16="http://schemas.microsoft.com/office/drawing/2014/main" id="{A99F91F2-65AB-218B-C8A6-0DEB42919ED9}"/>
                  </a:ext>
                </a:extLst>
              </p:cNvPr>
              <p:cNvGrpSpPr/>
              <p:nvPr/>
            </p:nvGrpSpPr>
            <p:grpSpPr>
              <a:xfrm>
                <a:off x="17978262" y="806578"/>
                <a:ext cx="1473115" cy="381014"/>
                <a:chOff x="17978262" y="806578"/>
                <a:chExt cx="1473115" cy="381014"/>
              </a:xfrm>
            </p:grpSpPr>
            <p:sp>
              <p:nvSpPr>
                <p:cNvPr id="513" name="正方形/長方形 512">
                  <a:extLst>
                    <a:ext uri="{FF2B5EF4-FFF2-40B4-BE49-F238E27FC236}">
                      <a16:creationId xmlns:a16="http://schemas.microsoft.com/office/drawing/2014/main" id="{4972508B-B65F-68B9-1E18-0ED423C92BB8}"/>
                    </a:ext>
                  </a:extLst>
                </p:cNvPr>
                <p:cNvSpPr/>
                <p:nvPr/>
              </p:nvSpPr>
              <p:spPr>
                <a:xfrm>
                  <a:off x="18365058" y="889676"/>
                  <a:ext cx="1086319" cy="215444"/>
                </a:xfrm>
                <a:prstGeom prst="rect">
                  <a:avLst/>
                </a:prstGeom>
                <a:noFill/>
              </p:spPr>
              <p:txBody>
                <a:bodyPr wrap="none" lIns="36000" tIns="0" rIns="0" bIns="0" anchor="ctr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CCB (</a:t>
                  </a:r>
                  <a:r>
                    <a:rPr lang="en-US" altLang="ja-JP" sz="14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n </a:t>
                  </a: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= 47)</a:t>
                  </a:r>
                </a:p>
              </p:txBody>
            </p:sp>
            <p:grpSp>
              <p:nvGrpSpPr>
                <p:cNvPr id="514" name="グループ化 513">
                  <a:extLst>
                    <a:ext uri="{FF2B5EF4-FFF2-40B4-BE49-F238E27FC236}">
                      <a16:creationId xmlns:a16="http://schemas.microsoft.com/office/drawing/2014/main" id="{30BE509F-B4C0-1D83-07F0-118FF2AF8A2C}"/>
                    </a:ext>
                  </a:extLst>
                </p:cNvPr>
                <p:cNvGrpSpPr/>
                <p:nvPr/>
              </p:nvGrpSpPr>
              <p:grpSpPr>
                <a:xfrm>
                  <a:off x="17978262" y="1043592"/>
                  <a:ext cx="360000" cy="144000"/>
                  <a:chOff x="4188937" y="4907843"/>
                  <a:chExt cx="360000" cy="144000"/>
                </a:xfrm>
              </p:grpSpPr>
              <p:cxnSp>
                <p:nvCxnSpPr>
                  <p:cNvPr id="518" name="直線コネクタ 517">
                    <a:extLst>
                      <a:ext uri="{FF2B5EF4-FFF2-40B4-BE49-F238E27FC236}">
                        <a16:creationId xmlns:a16="http://schemas.microsoft.com/office/drawing/2014/main" id="{56E0F920-2395-E15A-5ECB-D2B456702F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88937" y="4979843"/>
                    <a:ext cx="360000" cy="0"/>
                  </a:xfrm>
                  <a:prstGeom prst="line">
                    <a:avLst/>
                  </a:prstGeom>
                  <a:noFill/>
                  <a:ln w="38100" cap="flat">
                    <a:solidFill>
                      <a:srgbClr val="0000FF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19" name="楕円 518">
                    <a:extLst>
                      <a:ext uri="{FF2B5EF4-FFF2-40B4-BE49-F238E27FC236}">
                        <a16:creationId xmlns:a16="http://schemas.microsoft.com/office/drawing/2014/main" id="{D23FEDDF-28BC-ED88-1F35-070CA8C3B077}"/>
                      </a:ext>
                    </a:extLst>
                  </p:cNvPr>
                  <p:cNvSpPr/>
                  <p:nvPr/>
                </p:nvSpPr>
                <p:spPr>
                  <a:xfrm>
                    <a:off x="4296937" y="4907843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15" name="グループ化 514">
                  <a:extLst>
                    <a:ext uri="{FF2B5EF4-FFF2-40B4-BE49-F238E27FC236}">
                      <a16:creationId xmlns:a16="http://schemas.microsoft.com/office/drawing/2014/main" id="{9517CE63-D1C9-DEF0-1AF4-201F3AD97BEB}"/>
                    </a:ext>
                  </a:extLst>
                </p:cNvPr>
                <p:cNvGrpSpPr/>
                <p:nvPr/>
              </p:nvGrpSpPr>
              <p:grpSpPr>
                <a:xfrm>
                  <a:off x="17978262" y="806578"/>
                  <a:ext cx="360000" cy="144000"/>
                  <a:chOff x="4188937" y="4907843"/>
                  <a:chExt cx="360000" cy="144000"/>
                </a:xfrm>
              </p:grpSpPr>
              <p:cxnSp>
                <p:nvCxnSpPr>
                  <p:cNvPr id="516" name="直線コネクタ 515">
                    <a:extLst>
                      <a:ext uri="{FF2B5EF4-FFF2-40B4-BE49-F238E27FC236}">
                        <a16:creationId xmlns:a16="http://schemas.microsoft.com/office/drawing/2014/main" id="{E2E27656-0EC6-BCFB-AEED-1A472164B47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88937" y="4979843"/>
                    <a:ext cx="360000" cy="0"/>
                  </a:xfrm>
                  <a:prstGeom prst="line">
                    <a:avLst/>
                  </a:prstGeom>
                  <a:solidFill>
                    <a:srgbClr val="00B050"/>
                  </a:solidFill>
                  <a:ln w="38100" cap="flat">
                    <a:solidFill>
                      <a:srgbClr val="0000FF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17" name="楕円 516">
                    <a:extLst>
                      <a:ext uri="{FF2B5EF4-FFF2-40B4-BE49-F238E27FC236}">
                        <a16:creationId xmlns:a16="http://schemas.microsoft.com/office/drawing/2014/main" id="{83795276-71CB-C1E5-61E7-F9A09893B6B3}"/>
                      </a:ext>
                    </a:extLst>
                  </p:cNvPr>
                  <p:cNvSpPr/>
                  <p:nvPr/>
                </p:nvSpPr>
                <p:spPr>
                  <a:xfrm>
                    <a:off x="4296937" y="4907843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02" name="グループ化 501">
                <a:extLst>
                  <a:ext uri="{FF2B5EF4-FFF2-40B4-BE49-F238E27FC236}">
                    <a16:creationId xmlns:a16="http://schemas.microsoft.com/office/drawing/2014/main" id="{74B89440-A558-2253-BFD6-4D0B6BB75742}"/>
                  </a:ext>
                </a:extLst>
              </p:cNvPr>
              <p:cNvGrpSpPr/>
              <p:nvPr/>
            </p:nvGrpSpPr>
            <p:grpSpPr>
              <a:xfrm>
                <a:off x="14853398" y="806578"/>
                <a:ext cx="1501328" cy="381014"/>
                <a:chOff x="14853398" y="806578"/>
                <a:chExt cx="1501328" cy="381014"/>
              </a:xfrm>
            </p:grpSpPr>
            <p:sp>
              <p:nvSpPr>
                <p:cNvPr id="506" name="正方形/長方形 505">
                  <a:extLst>
                    <a:ext uri="{FF2B5EF4-FFF2-40B4-BE49-F238E27FC236}">
                      <a16:creationId xmlns:a16="http://schemas.microsoft.com/office/drawing/2014/main" id="{01BAE174-75EA-A913-4B88-3A6AF1ACE502}"/>
                    </a:ext>
                  </a:extLst>
                </p:cNvPr>
                <p:cNvSpPr/>
                <p:nvPr/>
              </p:nvSpPr>
              <p:spPr>
                <a:xfrm>
                  <a:off x="15240194" y="893799"/>
                  <a:ext cx="1114532" cy="215444"/>
                </a:xfrm>
                <a:prstGeom prst="rect">
                  <a:avLst/>
                </a:prstGeom>
                <a:noFill/>
              </p:spPr>
              <p:txBody>
                <a:bodyPr wrap="none" lIns="36000" tIns="0" rIns="0" bIns="0" anchor="ctr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Total</a:t>
                  </a:r>
                  <a:r>
                    <a:rPr lang="ja-JP" altLang="en-US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(</a:t>
                  </a:r>
                  <a:r>
                    <a:rPr lang="en-US" altLang="ja-JP" sz="14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N </a:t>
                  </a: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= 89)</a:t>
                  </a:r>
                </a:p>
              </p:txBody>
            </p:sp>
            <p:grpSp>
              <p:nvGrpSpPr>
                <p:cNvPr id="507" name="グループ化 506">
                  <a:extLst>
                    <a:ext uri="{FF2B5EF4-FFF2-40B4-BE49-F238E27FC236}">
                      <a16:creationId xmlns:a16="http://schemas.microsoft.com/office/drawing/2014/main" id="{FE317ABD-BFC3-F7A9-4406-9F7FBDCF40A1}"/>
                    </a:ext>
                  </a:extLst>
                </p:cNvPr>
                <p:cNvGrpSpPr/>
                <p:nvPr/>
              </p:nvGrpSpPr>
              <p:grpSpPr>
                <a:xfrm>
                  <a:off x="14853398" y="806578"/>
                  <a:ext cx="360000" cy="144000"/>
                  <a:chOff x="4007569" y="4907843"/>
                  <a:chExt cx="360000" cy="144000"/>
                </a:xfrm>
              </p:grpSpPr>
              <p:cxnSp>
                <p:nvCxnSpPr>
                  <p:cNvPr id="511" name="直線コネクタ 510">
                    <a:extLst>
                      <a:ext uri="{FF2B5EF4-FFF2-40B4-BE49-F238E27FC236}">
                        <a16:creationId xmlns:a16="http://schemas.microsoft.com/office/drawing/2014/main" id="{4375FB83-990C-A459-DFB5-CB20BD8BB5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07569" y="4979843"/>
                    <a:ext cx="360000" cy="0"/>
                  </a:xfrm>
                  <a:prstGeom prst="line">
                    <a:avLst/>
                  </a:prstGeom>
                  <a:noFill/>
                  <a:ln w="38100" cap="flat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12" name="楕円 511">
                    <a:extLst>
                      <a:ext uri="{FF2B5EF4-FFF2-40B4-BE49-F238E27FC236}">
                        <a16:creationId xmlns:a16="http://schemas.microsoft.com/office/drawing/2014/main" id="{1A3C1D85-C58D-599C-7246-53DD7DFED97A}"/>
                      </a:ext>
                    </a:extLst>
                  </p:cNvPr>
                  <p:cNvSpPr/>
                  <p:nvPr/>
                </p:nvSpPr>
                <p:spPr>
                  <a:xfrm>
                    <a:off x="4115569" y="4907843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08" name="グループ化 507">
                  <a:extLst>
                    <a:ext uri="{FF2B5EF4-FFF2-40B4-BE49-F238E27FC236}">
                      <a16:creationId xmlns:a16="http://schemas.microsoft.com/office/drawing/2014/main" id="{DD772472-176F-89CA-011B-14B3EFEA5D01}"/>
                    </a:ext>
                  </a:extLst>
                </p:cNvPr>
                <p:cNvGrpSpPr/>
                <p:nvPr/>
              </p:nvGrpSpPr>
              <p:grpSpPr>
                <a:xfrm>
                  <a:off x="14853398" y="1043592"/>
                  <a:ext cx="360000" cy="144000"/>
                  <a:chOff x="4007569" y="4907843"/>
                  <a:chExt cx="360000" cy="144000"/>
                </a:xfrm>
              </p:grpSpPr>
              <p:cxnSp>
                <p:nvCxnSpPr>
                  <p:cNvPr id="509" name="直線コネクタ 508">
                    <a:extLst>
                      <a:ext uri="{FF2B5EF4-FFF2-40B4-BE49-F238E27FC236}">
                        <a16:creationId xmlns:a16="http://schemas.microsoft.com/office/drawing/2014/main" id="{53BAEE69-7327-A509-2EDB-A84522E25C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07569" y="4979843"/>
                    <a:ext cx="360000" cy="0"/>
                  </a:xfrm>
                  <a:prstGeom prst="line">
                    <a:avLst/>
                  </a:prstGeom>
                  <a:noFill/>
                  <a:ln w="38100" cap="flat"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510" name="楕円 509">
                    <a:extLst>
                      <a:ext uri="{FF2B5EF4-FFF2-40B4-BE49-F238E27FC236}">
                        <a16:creationId xmlns:a16="http://schemas.microsoft.com/office/drawing/2014/main" id="{72077F07-DA5E-747F-5C3A-00555463D00A}"/>
                      </a:ext>
                    </a:extLst>
                  </p:cNvPr>
                  <p:cNvSpPr/>
                  <p:nvPr/>
                </p:nvSpPr>
                <p:spPr>
                  <a:xfrm>
                    <a:off x="4115569" y="4907843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03" name="グループ化 502">
                <a:extLst>
                  <a:ext uri="{FF2B5EF4-FFF2-40B4-BE49-F238E27FC236}">
                    <a16:creationId xmlns:a16="http://schemas.microsoft.com/office/drawing/2014/main" id="{F2B8D2B0-DC00-7DD4-BB1B-A2771E878630}"/>
                  </a:ext>
                </a:extLst>
              </p:cNvPr>
              <p:cNvGrpSpPr/>
              <p:nvPr/>
            </p:nvGrpSpPr>
            <p:grpSpPr>
              <a:xfrm>
                <a:off x="14358031" y="770856"/>
                <a:ext cx="406646" cy="452458"/>
                <a:chOff x="14358031" y="770856"/>
                <a:chExt cx="406646" cy="452458"/>
              </a:xfrm>
            </p:grpSpPr>
            <p:sp>
              <p:nvSpPr>
                <p:cNvPr id="504" name="正方形/長方形 503">
                  <a:extLst>
                    <a:ext uri="{FF2B5EF4-FFF2-40B4-BE49-F238E27FC236}">
                      <a16:creationId xmlns:a16="http://schemas.microsoft.com/office/drawing/2014/main" id="{F4F3AED5-C86F-FF3A-AC07-0B03CE55B409}"/>
                    </a:ext>
                  </a:extLst>
                </p:cNvPr>
                <p:cNvSpPr/>
                <p:nvPr/>
              </p:nvSpPr>
              <p:spPr>
                <a:xfrm>
                  <a:off x="14363398" y="770856"/>
                  <a:ext cx="397028" cy="215444"/>
                </a:xfrm>
                <a:prstGeom prst="rect">
                  <a:avLst/>
                </a:prstGeom>
                <a:noFill/>
              </p:spPr>
              <p:txBody>
                <a:bodyPr wrap="none" lIns="36000" tIns="0" rIns="0" bIns="0" anchor="ctr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SBP</a:t>
                  </a:r>
                </a:p>
              </p:txBody>
            </p:sp>
            <p:sp>
              <p:nvSpPr>
                <p:cNvPr id="505" name="正方形/長方形 504">
                  <a:extLst>
                    <a:ext uri="{FF2B5EF4-FFF2-40B4-BE49-F238E27FC236}">
                      <a16:creationId xmlns:a16="http://schemas.microsoft.com/office/drawing/2014/main" id="{F3C687EF-B2E4-06A6-9D4B-41CA5ECA2BEB}"/>
                    </a:ext>
                  </a:extLst>
                </p:cNvPr>
                <p:cNvSpPr/>
                <p:nvPr/>
              </p:nvSpPr>
              <p:spPr>
                <a:xfrm>
                  <a:off x="14358031" y="1007870"/>
                  <a:ext cx="406646" cy="215444"/>
                </a:xfrm>
                <a:prstGeom prst="rect">
                  <a:avLst/>
                </a:prstGeom>
                <a:noFill/>
              </p:spPr>
              <p:txBody>
                <a:bodyPr wrap="none" lIns="36000" tIns="0" rIns="0" bIns="0" anchor="ctr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ja-JP" sz="14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rPr>
                    <a:t>DBP</a:t>
                  </a:r>
                </a:p>
              </p:txBody>
            </p:sp>
          </p:grpSp>
        </p:grp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AA17FF8E-0834-CA22-36A3-85F2CB111140}"/>
                </a:ext>
              </a:extLst>
            </p:cNvPr>
            <p:cNvSpPr txBox="1"/>
            <p:nvPr/>
          </p:nvSpPr>
          <p:spPr>
            <a:xfrm rot="16200000">
              <a:off x="818288" y="2839552"/>
              <a:ext cx="2622321" cy="338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Bedtime home BP (mmHg)</a:t>
              </a:r>
            </a:p>
          </p:txBody>
        </p:sp>
        <p:cxnSp>
          <p:nvCxnSpPr>
            <p:cNvPr id="210" name="直線コネクタ 209">
              <a:extLst>
                <a:ext uri="{FF2B5EF4-FFF2-40B4-BE49-F238E27FC236}">
                  <a16:creationId xmlns:a16="http://schemas.microsoft.com/office/drawing/2014/main" id="{8F4B3D75-E770-1D94-3632-6CD8705D64D5}"/>
                </a:ext>
              </a:extLst>
            </p:cNvPr>
            <p:cNvCxnSpPr>
              <a:cxnSpLocks/>
            </p:cNvCxnSpPr>
            <p:nvPr/>
          </p:nvCxnSpPr>
          <p:spPr>
            <a:xfrm>
              <a:off x="2966432" y="811319"/>
              <a:ext cx="0" cy="4168757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正方形/長方形 210">
              <a:extLst>
                <a:ext uri="{FF2B5EF4-FFF2-40B4-BE49-F238E27FC236}">
                  <a16:creationId xmlns:a16="http://schemas.microsoft.com/office/drawing/2014/main" id="{515BA671-619C-9F9D-B8D7-20BDC43317C8}"/>
                </a:ext>
              </a:extLst>
            </p:cNvPr>
            <p:cNvSpPr/>
            <p:nvPr/>
          </p:nvSpPr>
          <p:spPr>
            <a:xfrm>
              <a:off x="3048837" y="5050256"/>
              <a:ext cx="783869" cy="24622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Baseline</a:t>
              </a:r>
            </a:p>
          </p:txBody>
        </p:sp>
        <p:sp>
          <p:nvSpPr>
            <p:cNvPr id="212" name="正方形/長方形 211">
              <a:extLst>
                <a:ext uri="{FF2B5EF4-FFF2-40B4-BE49-F238E27FC236}">
                  <a16:creationId xmlns:a16="http://schemas.microsoft.com/office/drawing/2014/main" id="{241AF3D0-F633-D2AD-BCDE-C3FDE6A01151}"/>
                </a:ext>
              </a:extLst>
            </p:cNvPr>
            <p:cNvSpPr/>
            <p:nvPr/>
          </p:nvSpPr>
          <p:spPr>
            <a:xfrm>
              <a:off x="4693011" y="5050256"/>
              <a:ext cx="691984" cy="24622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Week 4</a:t>
              </a:r>
            </a:p>
          </p:txBody>
        </p:sp>
        <p:sp>
          <p:nvSpPr>
            <p:cNvPr id="213" name="正方形/長方形 212">
              <a:extLst>
                <a:ext uri="{FF2B5EF4-FFF2-40B4-BE49-F238E27FC236}">
                  <a16:creationId xmlns:a16="http://schemas.microsoft.com/office/drawing/2014/main" id="{DEC81AB8-2A3D-7A51-C81D-A4B32E70DA04}"/>
                </a:ext>
              </a:extLst>
            </p:cNvPr>
            <p:cNvSpPr/>
            <p:nvPr/>
          </p:nvSpPr>
          <p:spPr>
            <a:xfrm>
              <a:off x="6289556" y="5050256"/>
              <a:ext cx="691984" cy="24622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Week 8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4" name="正方形/長方形 213">
              <a:extLst>
                <a:ext uri="{FF2B5EF4-FFF2-40B4-BE49-F238E27FC236}">
                  <a16:creationId xmlns:a16="http://schemas.microsoft.com/office/drawing/2014/main" id="{E13169AF-4702-88A3-4735-276755358A36}"/>
                </a:ext>
              </a:extLst>
            </p:cNvPr>
            <p:cNvSpPr/>
            <p:nvPr/>
          </p:nvSpPr>
          <p:spPr>
            <a:xfrm>
              <a:off x="7830844" y="5050256"/>
              <a:ext cx="805798" cy="24622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Week 12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15" name="直線コネクタ 214">
              <a:extLst>
                <a:ext uri="{FF2B5EF4-FFF2-40B4-BE49-F238E27FC236}">
                  <a16:creationId xmlns:a16="http://schemas.microsoft.com/office/drawing/2014/main" id="{82F17BE7-DCF0-A7FC-3E3E-2F016227E5CC}"/>
                </a:ext>
              </a:extLst>
            </p:cNvPr>
            <p:cNvCxnSpPr>
              <a:cxnSpLocks/>
            </p:cNvCxnSpPr>
            <p:nvPr/>
          </p:nvCxnSpPr>
          <p:spPr>
            <a:xfrm>
              <a:off x="3440771" y="498007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直線コネクタ 215">
              <a:extLst>
                <a:ext uri="{FF2B5EF4-FFF2-40B4-BE49-F238E27FC236}">
                  <a16:creationId xmlns:a16="http://schemas.microsoft.com/office/drawing/2014/main" id="{E1179242-7D47-224B-F1BD-9D39CE3C6E9F}"/>
                </a:ext>
              </a:extLst>
            </p:cNvPr>
            <p:cNvCxnSpPr>
              <a:cxnSpLocks/>
            </p:cNvCxnSpPr>
            <p:nvPr/>
          </p:nvCxnSpPr>
          <p:spPr>
            <a:xfrm>
              <a:off x="6635548" y="498007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直線コネクタ 216">
              <a:extLst>
                <a:ext uri="{FF2B5EF4-FFF2-40B4-BE49-F238E27FC236}">
                  <a16:creationId xmlns:a16="http://schemas.microsoft.com/office/drawing/2014/main" id="{5F74245F-65D0-72CF-012A-763817CF89DD}"/>
                </a:ext>
              </a:extLst>
            </p:cNvPr>
            <p:cNvCxnSpPr>
              <a:cxnSpLocks/>
            </p:cNvCxnSpPr>
            <p:nvPr/>
          </p:nvCxnSpPr>
          <p:spPr>
            <a:xfrm>
              <a:off x="8233743" y="498007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直線コネクタ 217">
              <a:extLst>
                <a:ext uri="{FF2B5EF4-FFF2-40B4-BE49-F238E27FC236}">
                  <a16:creationId xmlns:a16="http://schemas.microsoft.com/office/drawing/2014/main" id="{3E8424E3-A521-F37C-9D58-C5562AFD94FD}"/>
                </a:ext>
              </a:extLst>
            </p:cNvPr>
            <p:cNvCxnSpPr>
              <a:cxnSpLocks/>
            </p:cNvCxnSpPr>
            <p:nvPr/>
          </p:nvCxnSpPr>
          <p:spPr>
            <a:xfrm>
              <a:off x="9828929" y="498007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9" name="正方形/長方形 218">
              <a:extLst>
                <a:ext uri="{FF2B5EF4-FFF2-40B4-BE49-F238E27FC236}">
                  <a16:creationId xmlns:a16="http://schemas.microsoft.com/office/drawing/2014/main" id="{33AF3511-1CF0-1E6A-6D55-5D9B8CD144ED}"/>
                </a:ext>
              </a:extLst>
            </p:cNvPr>
            <p:cNvSpPr/>
            <p:nvPr/>
          </p:nvSpPr>
          <p:spPr>
            <a:xfrm>
              <a:off x="9618134" y="5050256"/>
              <a:ext cx="421590" cy="24622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EOT</a:t>
              </a:r>
            </a:p>
          </p:txBody>
        </p:sp>
        <p:cxnSp>
          <p:nvCxnSpPr>
            <p:cNvPr id="220" name="直線コネクタ 219">
              <a:extLst>
                <a:ext uri="{FF2B5EF4-FFF2-40B4-BE49-F238E27FC236}">
                  <a16:creationId xmlns:a16="http://schemas.microsoft.com/office/drawing/2014/main" id="{C2ADFA3F-40EF-3D63-B82A-DD6A1F2800C9}"/>
                </a:ext>
              </a:extLst>
            </p:cNvPr>
            <p:cNvCxnSpPr>
              <a:cxnSpLocks/>
            </p:cNvCxnSpPr>
            <p:nvPr/>
          </p:nvCxnSpPr>
          <p:spPr>
            <a:xfrm>
              <a:off x="5039003" y="498007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直線コネクタ 220">
              <a:extLst>
                <a:ext uri="{FF2B5EF4-FFF2-40B4-BE49-F238E27FC236}">
                  <a16:creationId xmlns:a16="http://schemas.microsoft.com/office/drawing/2014/main" id="{31D1E17A-90FA-FA0C-BFD9-2E76B1184B2C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484261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正方形/長方形 221">
              <a:extLst>
                <a:ext uri="{FF2B5EF4-FFF2-40B4-BE49-F238E27FC236}">
                  <a16:creationId xmlns:a16="http://schemas.microsoft.com/office/drawing/2014/main" id="{42BFFB9C-3E56-75ED-C1E9-2888F25899E1}"/>
                </a:ext>
              </a:extLst>
            </p:cNvPr>
            <p:cNvSpPr/>
            <p:nvPr/>
          </p:nvSpPr>
          <p:spPr>
            <a:xfrm>
              <a:off x="2623292" y="4717722"/>
              <a:ext cx="227627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6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23" name="直線コネクタ 222">
              <a:extLst>
                <a:ext uri="{FF2B5EF4-FFF2-40B4-BE49-F238E27FC236}">
                  <a16:creationId xmlns:a16="http://schemas.microsoft.com/office/drawing/2014/main" id="{E4A9E2C8-185F-5C54-2D27-F7C2D733CFE5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3376364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正方形/長方形 223">
              <a:extLst>
                <a:ext uri="{FF2B5EF4-FFF2-40B4-BE49-F238E27FC236}">
                  <a16:creationId xmlns:a16="http://schemas.microsoft.com/office/drawing/2014/main" id="{1F047A1D-66F7-5D45-E4D8-62D8F612A249}"/>
                </a:ext>
              </a:extLst>
            </p:cNvPr>
            <p:cNvSpPr/>
            <p:nvPr/>
          </p:nvSpPr>
          <p:spPr>
            <a:xfrm>
              <a:off x="2509479" y="3252120"/>
              <a:ext cx="341440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0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25" name="直線コネクタ 224">
              <a:extLst>
                <a:ext uri="{FF2B5EF4-FFF2-40B4-BE49-F238E27FC236}">
                  <a16:creationId xmlns:a16="http://schemas.microsoft.com/office/drawing/2014/main" id="{AF1C7B3D-F06B-CCF4-57F9-7A6B9E6934E2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1910112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正方形/長方形 225">
              <a:extLst>
                <a:ext uri="{FF2B5EF4-FFF2-40B4-BE49-F238E27FC236}">
                  <a16:creationId xmlns:a16="http://schemas.microsoft.com/office/drawing/2014/main" id="{EA57F1DE-AB17-3A82-B2EB-A7B1766BF641}"/>
                </a:ext>
              </a:extLst>
            </p:cNvPr>
            <p:cNvSpPr/>
            <p:nvPr/>
          </p:nvSpPr>
          <p:spPr>
            <a:xfrm>
              <a:off x="2509479" y="1786516"/>
              <a:ext cx="341440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4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27" name="直線コネクタ 226">
              <a:extLst>
                <a:ext uri="{FF2B5EF4-FFF2-40B4-BE49-F238E27FC236}">
                  <a16:creationId xmlns:a16="http://schemas.microsoft.com/office/drawing/2014/main" id="{2BCCB21A-6EA9-2C0F-929D-C5187B72565E}"/>
                </a:ext>
              </a:extLst>
            </p:cNvPr>
            <p:cNvCxnSpPr>
              <a:cxnSpLocks/>
            </p:cNvCxnSpPr>
            <p:nvPr/>
          </p:nvCxnSpPr>
          <p:spPr>
            <a:xfrm>
              <a:off x="2966432" y="4980076"/>
              <a:ext cx="7200101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直線コネクタ 227">
              <a:extLst>
                <a:ext uri="{FF2B5EF4-FFF2-40B4-BE49-F238E27FC236}">
                  <a16:creationId xmlns:a16="http://schemas.microsoft.com/office/drawing/2014/main" id="{F34DB71E-1249-D080-793A-11A482E5137E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4109490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正方形/長方形 228">
              <a:extLst>
                <a:ext uri="{FF2B5EF4-FFF2-40B4-BE49-F238E27FC236}">
                  <a16:creationId xmlns:a16="http://schemas.microsoft.com/office/drawing/2014/main" id="{DA0AEB56-6D88-3A54-CB2F-B8FBC929CAD7}"/>
                </a:ext>
              </a:extLst>
            </p:cNvPr>
            <p:cNvSpPr/>
            <p:nvPr/>
          </p:nvSpPr>
          <p:spPr>
            <a:xfrm>
              <a:off x="2623292" y="3984922"/>
              <a:ext cx="227627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8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30" name="直線コネクタ 229">
              <a:extLst>
                <a:ext uri="{FF2B5EF4-FFF2-40B4-BE49-F238E27FC236}">
                  <a16:creationId xmlns:a16="http://schemas.microsoft.com/office/drawing/2014/main" id="{E9548CC7-10F9-AADA-D231-B2F875297625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2643238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正方形/長方形 230">
              <a:extLst>
                <a:ext uri="{FF2B5EF4-FFF2-40B4-BE49-F238E27FC236}">
                  <a16:creationId xmlns:a16="http://schemas.microsoft.com/office/drawing/2014/main" id="{1899E426-B143-3EA9-5447-92BF89B5A4FA}"/>
                </a:ext>
              </a:extLst>
            </p:cNvPr>
            <p:cNvSpPr/>
            <p:nvPr/>
          </p:nvSpPr>
          <p:spPr>
            <a:xfrm>
              <a:off x="2509479" y="2519318"/>
              <a:ext cx="341440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2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32" name="直線コネクタ 231">
              <a:extLst>
                <a:ext uri="{FF2B5EF4-FFF2-40B4-BE49-F238E27FC236}">
                  <a16:creationId xmlns:a16="http://schemas.microsoft.com/office/drawing/2014/main" id="{A959D33C-5E3E-A4F2-1C80-CF2BBDDD8D3E}"/>
                </a:ext>
              </a:extLst>
            </p:cNvPr>
            <p:cNvCxnSpPr>
              <a:cxnSpLocks/>
            </p:cNvCxnSpPr>
            <p:nvPr/>
          </p:nvCxnSpPr>
          <p:spPr>
            <a:xfrm>
              <a:off x="2894432" y="117698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148DA3F8-F7B1-3EE1-222F-9F54886A0D66}"/>
                </a:ext>
              </a:extLst>
            </p:cNvPr>
            <p:cNvSpPr/>
            <p:nvPr/>
          </p:nvSpPr>
          <p:spPr>
            <a:xfrm>
              <a:off x="2509479" y="1053714"/>
              <a:ext cx="341440" cy="246221"/>
            </a:xfrm>
            <a:prstGeom prst="rect">
              <a:avLst/>
            </a:prstGeom>
            <a:noFill/>
          </p:spPr>
          <p:txBody>
            <a:bodyPr wrap="none" lIns="0" tIns="0" rIns="0" bIns="0" anchor="ctr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solidFill>
                    <a:prstClr val="black"/>
                  </a:solidFill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6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380" name="グループ化 379">
              <a:extLst>
                <a:ext uri="{FF2B5EF4-FFF2-40B4-BE49-F238E27FC236}">
                  <a16:creationId xmlns:a16="http://schemas.microsoft.com/office/drawing/2014/main" id="{3A2C3493-B32F-63FD-7E1C-4898EF0FC51B}"/>
                </a:ext>
              </a:extLst>
            </p:cNvPr>
            <p:cNvGrpSpPr/>
            <p:nvPr/>
          </p:nvGrpSpPr>
          <p:grpSpPr>
            <a:xfrm>
              <a:off x="3230287" y="3740714"/>
              <a:ext cx="108000" cy="721520"/>
              <a:chOff x="3181267" y="2597151"/>
              <a:chExt cx="108000" cy="2157062"/>
            </a:xfrm>
          </p:grpSpPr>
          <p:cxnSp>
            <p:nvCxnSpPr>
              <p:cNvPr id="401" name="直線コネクタ 400">
                <a:extLst>
                  <a:ext uri="{FF2B5EF4-FFF2-40B4-BE49-F238E27FC236}">
                    <a16:creationId xmlns:a16="http://schemas.microsoft.com/office/drawing/2014/main" id="{FC0429CE-02C8-A818-ABAA-7AB71E3DE5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35267" y="2597151"/>
                <a:ext cx="0" cy="215706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2" name="直線コネクタ 401">
                <a:extLst>
                  <a:ext uri="{FF2B5EF4-FFF2-40B4-BE49-F238E27FC236}">
                    <a16:creationId xmlns:a16="http://schemas.microsoft.com/office/drawing/2014/main" id="{EDC28240-56FF-A30F-4A57-7022BAD07C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1267" y="4754213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3" name="直線コネクタ 402">
                <a:extLst>
                  <a:ext uri="{FF2B5EF4-FFF2-40B4-BE49-F238E27FC236}">
                    <a16:creationId xmlns:a16="http://schemas.microsoft.com/office/drawing/2014/main" id="{43D66EC8-0DAB-D846-78D0-F5794ACA40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1267" y="2597151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2" name="グループ化 951">
              <a:extLst>
                <a:ext uri="{FF2B5EF4-FFF2-40B4-BE49-F238E27FC236}">
                  <a16:creationId xmlns:a16="http://schemas.microsoft.com/office/drawing/2014/main" id="{8E95558C-FCF7-8D7F-F66C-1035F4DBA2A6}"/>
                </a:ext>
              </a:extLst>
            </p:cNvPr>
            <p:cNvGrpSpPr/>
            <p:nvPr/>
          </p:nvGrpSpPr>
          <p:grpSpPr>
            <a:xfrm>
              <a:off x="3534255" y="1668695"/>
              <a:ext cx="6562319" cy="1431813"/>
              <a:chOff x="3543920" y="2003268"/>
              <a:chExt cx="6562319" cy="1431813"/>
            </a:xfrm>
          </p:grpSpPr>
          <p:grpSp>
            <p:nvGrpSpPr>
              <p:cNvPr id="950" name="グループ化 949">
                <a:extLst>
                  <a:ext uri="{FF2B5EF4-FFF2-40B4-BE49-F238E27FC236}">
                    <a16:creationId xmlns:a16="http://schemas.microsoft.com/office/drawing/2014/main" id="{816CCCCD-84AD-387B-E415-A0C8F25CC77A}"/>
                  </a:ext>
                </a:extLst>
              </p:cNvPr>
              <p:cNvGrpSpPr/>
              <p:nvPr/>
            </p:nvGrpSpPr>
            <p:grpSpPr>
              <a:xfrm>
                <a:off x="3561920" y="2003268"/>
                <a:ext cx="6544319" cy="1431813"/>
                <a:chOff x="3561920" y="2003268"/>
                <a:chExt cx="6544319" cy="1431813"/>
              </a:xfrm>
            </p:grpSpPr>
            <p:grpSp>
              <p:nvGrpSpPr>
                <p:cNvPr id="444" name="グループ化 443">
                  <a:extLst>
                    <a:ext uri="{FF2B5EF4-FFF2-40B4-BE49-F238E27FC236}">
                      <a16:creationId xmlns:a16="http://schemas.microsoft.com/office/drawing/2014/main" id="{0D84A402-6BE9-9098-29B7-BFCF097ED545}"/>
                    </a:ext>
                  </a:extLst>
                </p:cNvPr>
                <p:cNvGrpSpPr/>
                <p:nvPr/>
              </p:nvGrpSpPr>
              <p:grpSpPr>
                <a:xfrm>
                  <a:off x="3561920" y="2003268"/>
                  <a:ext cx="108000" cy="892332"/>
                  <a:chOff x="3181267" y="2597151"/>
                  <a:chExt cx="108000" cy="2157062"/>
                </a:xfrm>
              </p:grpSpPr>
              <p:cxnSp>
                <p:nvCxnSpPr>
                  <p:cNvPr id="465" name="直線コネクタ 464">
                    <a:extLst>
                      <a:ext uri="{FF2B5EF4-FFF2-40B4-BE49-F238E27FC236}">
                        <a16:creationId xmlns:a16="http://schemas.microsoft.com/office/drawing/2014/main" id="{92D5426B-FA77-AED7-9A0F-B33DB391AD8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6" name="直線コネクタ 465">
                    <a:extLst>
                      <a:ext uri="{FF2B5EF4-FFF2-40B4-BE49-F238E27FC236}">
                        <a16:creationId xmlns:a16="http://schemas.microsoft.com/office/drawing/2014/main" id="{1EF03BA2-0EE3-606B-7B23-136E72E18F8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7" name="直線コネクタ 466">
                    <a:extLst>
                      <a:ext uri="{FF2B5EF4-FFF2-40B4-BE49-F238E27FC236}">
                        <a16:creationId xmlns:a16="http://schemas.microsoft.com/office/drawing/2014/main" id="{A5D3081A-AD55-9093-8A42-833A79AEB9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45" name="グループ化 444">
                  <a:extLst>
                    <a:ext uri="{FF2B5EF4-FFF2-40B4-BE49-F238E27FC236}">
                      <a16:creationId xmlns:a16="http://schemas.microsoft.com/office/drawing/2014/main" id="{5F2F5C2D-A95A-ECE4-FE20-3E393EC20685}"/>
                    </a:ext>
                  </a:extLst>
                </p:cNvPr>
                <p:cNvGrpSpPr/>
                <p:nvPr/>
              </p:nvGrpSpPr>
              <p:grpSpPr>
                <a:xfrm>
                  <a:off x="5160152" y="2388394"/>
                  <a:ext cx="108000" cy="757237"/>
                  <a:chOff x="3181267" y="2597151"/>
                  <a:chExt cx="108000" cy="2157062"/>
                </a:xfrm>
              </p:grpSpPr>
              <p:cxnSp>
                <p:nvCxnSpPr>
                  <p:cNvPr id="462" name="直線コネクタ 461">
                    <a:extLst>
                      <a:ext uri="{FF2B5EF4-FFF2-40B4-BE49-F238E27FC236}">
                        <a16:creationId xmlns:a16="http://schemas.microsoft.com/office/drawing/2014/main" id="{A11E4BE6-8730-0FB0-50EA-E4C35EE17E6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3" name="直線コネクタ 462">
                    <a:extLst>
                      <a:ext uri="{FF2B5EF4-FFF2-40B4-BE49-F238E27FC236}">
                        <a16:creationId xmlns:a16="http://schemas.microsoft.com/office/drawing/2014/main" id="{0CF008C5-4ECA-3E2C-5176-A9388A648AA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4" name="直線コネクタ 463">
                    <a:extLst>
                      <a:ext uri="{FF2B5EF4-FFF2-40B4-BE49-F238E27FC236}">
                        <a16:creationId xmlns:a16="http://schemas.microsoft.com/office/drawing/2014/main" id="{B4B9375A-A2FF-F21F-B346-7CABE8FD65F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46" name="グループ化 445">
                  <a:extLst>
                    <a:ext uri="{FF2B5EF4-FFF2-40B4-BE49-F238E27FC236}">
                      <a16:creationId xmlns:a16="http://schemas.microsoft.com/office/drawing/2014/main" id="{DDFCB9BC-A6C3-4AD8-937A-EAAB7046832D}"/>
                    </a:ext>
                  </a:extLst>
                </p:cNvPr>
                <p:cNvGrpSpPr/>
                <p:nvPr/>
              </p:nvGrpSpPr>
              <p:grpSpPr>
                <a:xfrm>
                  <a:off x="6756697" y="2374105"/>
                  <a:ext cx="108000" cy="812007"/>
                  <a:chOff x="3181267" y="2597151"/>
                  <a:chExt cx="108000" cy="2157062"/>
                </a:xfrm>
              </p:grpSpPr>
              <p:cxnSp>
                <p:nvCxnSpPr>
                  <p:cNvPr id="459" name="直線コネクタ 458">
                    <a:extLst>
                      <a:ext uri="{FF2B5EF4-FFF2-40B4-BE49-F238E27FC236}">
                        <a16:creationId xmlns:a16="http://schemas.microsoft.com/office/drawing/2014/main" id="{8DC6231A-D9FB-9E82-5C6A-7B49EFE8B3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0" name="直線コネクタ 459">
                    <a:extLst>
                      <a:ext uri="{FF2B5EF4-FFF2-40B4-BE49-F238E27FC236}">
                        <a16:creationId xmlns:a16="http://schemas.microsoft.com/office/drawing/2014/main" id="{EC58271F-EEE9-9C98-7319-D73A3BA6D9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1" name="直線コネクタ 460">
                    <a:extLst>
                      <a:ext uri="{FF2B5EF4-FFF2-40B4-BE49-F238E27FC236}">
                        <a16:creationId xmlns:a16="http://schemas.microsoft.com/office/drawing/2014/main" id="{DD2A9BE9-33D5-304B-6892-45B360AE6E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48" name="グループ化 947">
                  <a:extLst>
                    <a:ext uri="{FF2B5EF4-FFF2-40B4-BE49-F238E27FC236}">
                      <a16:creationId xmlns:a16="http://schemas.microsoft.com/office/drawing/2014/main" id="{1414021C-970E-DC53-2E67-7BCA4AD4DAAB}"/>
                    </a:ext>
                  </a:extLst>
                </p:cNvPr>
                <p:cNvGrpSpPr/>
                <p:nvPr/>
              </p:nvGrpSpPr>
              <p:grpSpPr>
                <a:xfrm>
                  <a:off x="8292510" y="2383631"/>
                  <a:ext cx="211596" cy="1051450"/>
                  <a:chOff x="8292510" y="2383631"/>
                  <a:chExt cx="211596" cy="1051450"/>
                </a:xfrm>
              </p:grpSpPr>
              <p:grpSp>
                <p:nvGrpSpPr>
                  <p:cNvPr id="454" name="グループ化 453">
                    <a:extLst>
                      <a:ext uri="{FF2B5EF4-FFF2-40B4-BE49-F238E27FC236}">
                        <a16:creationId xmlns:a16="http://schemas.microsoft.com/office/drawing/2014/main" id="{0ACA5F2E-D7D5-38C5-975A-E86608056EBF}"/>
                      </a:ext>
                    </a:extLst>
                  </p:cNvPr>
                  <p:cNvGrpSpPr/>
                  <p:nvPr/>
                </p:nvGrpSpPr>
                <p:grpSpPr>
                  <a:xfrm>
                    <a:off x="8341637" y="2383631"/>
                    <a:ext cx="108000" cy="831954"/>
                    <a:chOff x="3181267" y="2597151"/>
                    <a:chExt cx="108000" cy="2157062"/>
                  </a:xfrm>
                </p:grpSpPr>
                <p:cxnSp>
                  <p:nvCxnSpPr>
                    <p:cNvPr id="456" name="直線コネクタ 455">
                      <a:extLst>
                        <a:ext uri="{FF2B5EF4-FFF2-40B4-BE49-F238E27FC236}">
                          <a16:creationId xmlns:a16="http://schemas.microsoft.com/office/drawing/2014/main" id="{1993DA55-3F90-BF1A-FAAC-3C483FF4C49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7" name="直線コネクタ 456">
                      <a:extLst>
                        <a:ext uri="{FF2B5EF4-FFF2-40B4-BE49-F238E27FC236}">
                          <a16:creationId xmlns:a16="http://schemas.microsoft.com/office/drawing/2014/main" id="{9A2850D9-FCB9-C869-FAB5-88A42E7BB76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8" name="直線コネクタ 457">
                      <a:extLst>
                        <a:ext uri="{FF2B5EF4-FFF2-40B4-BE49-F238E27FC236}">
                          <a16:creationId xmlns:a16="http://schemas.microsoft.com/office/drawing/2014/main" id="{E30447F0-0A4A-6296-5C32-56947A360E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55" name="テキスト ボックス 454">
                    <a:extLst>
                      <a:ext uri="{FF2B5EF4-FFF2-40B4-BE49-F238E27FC236}">
                        <a16:creationId xmlns:a16="http://schemas.microsoft.com/office/drawing/2014/main" id="{376BCC2A-9083-400E-D4EA-C41E6DC67737}"/>
                      </a:ext>
                    </a:extLst>
                  </p:cNvPr>
                  <p:cNvSpPr txBox="1"/>
                  <p:nvPr/>
                </p:nvSpPr>
                <p:spPr>
                  <a:xfrm>
                    <a:off x="8292510" y="3183286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  <p:grpSp>
              <p:nvGrpSpPr>
                <p:cNvPr id="949" name="グループ化 948">
                  <a:extLst>
                    <a:ext uri="{FF2B5EF4-FFF2-40B4-BE49-F238E27FC236}">
                      <a16:creationId xmlns:a16="http://schemas.microsoft.com/office/drawing/2014/main" id="{00A0275B-8548-5275-FCBC-28C169CCDAFF}"/>
                    </a:ext>
                  </a:extLst>
                </p:cNvPr>
                <p:cNvGrpSpPr/>
                <p:nvPr/>
              </p:nvGrpSpPr>
              <p:grpSpPr>
                <a:xfrm>
                  <a:off x="9894643" y="2290763"/>
                  <a:ext cx="211596" cy="1104959"/>
                  <a:chOff x="9894643" y="2290763"/>
                  <a:chExt cx="211596" cy="1104959"/>
                </a:xfrm>
              </p:grpSpPr>
              <p:grpSp>
                <p:nvGrpSpPr>
                  <p:cNvPr id="449" name="グループ化 448">
                    <a:extLst>
                      <a:ext uri="{FF2B5EF4-FFF2-40B4-BE49-F238E27FC236}">
                        <a16:creationId xmlns:a16="http://schemas.microsoft.com/office/drawing/2014/main" id="{BD311748-29E0-1D4A-9CC0-8C2614876248}"/>
                      </a:ext>
                    </a:extLst>
                  </p:cNvPr>
                  <p:cNvGrpSpPr/>
                  <p:nvPr/>
                </p:nvGrpSpPr>
                <p:grpSpPr>
                  <a:xfrm>
                    <a:off x="9945223" y="2290763"/>
                    <a:ext cx="108000" cy="886092"/>
                    <a:chOff x="3181267" y="2597151"/>
                    <a:chExt cx="108000" cy="2157062"/>
                  </a:xfrm>
                </p:grpSpPr>
                <p:cxnSp>
                  <p:nvCxnSpPr>
                    <p:cNvPr id="451" name="直線コネクタ 450">
                      <a:extLst>
                        <a:ext uri="{FF2B5EF4-FFF2-40B4-BE49-F238E27FC236}">
                          <a16:creationId xmlns:a16="http://schemas.microsoft.com/office/drawing/2014/main" id="{6A838698-86DA-D03E-780A-371266F31DC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2" name="直線コネクタ 451">
                      <a:extLst>
                        <a:ext uri="{FF2B5EF4-FFF2-40B4-BE49-F238E27FC236}">
                          <a16:creationId xmlns:a16="http://schemas.microsoft.com/office/drawing/2014/main" id="{73915694-A9CD-F2A8-B492-6988C2F6439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3" name="直線コネクタ 452">
                      <a:extLst>
                        <a:ext uri="{FF2B5EF4-FFF2-40B4-BE49-F238E27FC236}">
                          <a16:creationId xmlns:a16="http://schemas.microsoft.com/office/drawing/2014/main" id="{62D7A5BF-8060-D702-7158-3F3C92A9EC4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50" name="テキスト ボックス 449">
                    <a:extLst>
                      <a:ext uri="{FF2B5EF4-FFF2-40B4-BE49-F238E27FC236}">
                        <a16:creationId xmlns:a16="http://schemas.microsoft.com/office/drawing/2014/main" id="{6FD8B725-E48D-C759-0ECD-A35E645F5150}"/>
                      </a:ext>
                    </a:extLst>
                  </p:cNvPr>
                  <p:cNvSpPr txBox="1"/>
                  <p:nvPr/>
                </p:nvSpPr>
                <p:spPr>
                  <a:xfrm>
                    <a:off x="9894643" y="3143927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</p:grpSp>
          <p:grpSp>
            <p:nvGrpSpPr>
              <p:cNvPr id="437" name="グループ化 436">
                <a:extLst>
                  <a:ext uri="{FF2B5EF4-FFF2-40B4-BE49-F238E27FC236}">
                    <a16:creationId xmlns:a16="http://schemas.microsoft.com/office/drawing/2014/main" id="{7E74E822-1EF0-F81E-E4A2-27EE905F3416}"/>
                  </a:ext>
                </a:extLst>
              </p:cNvPr>
              <p:cNvGrpSpPr/>
              <p:nvPr/>
            </p:nvGrpSpPr>
            <p:grpSpPr>
              <a:xfrm>
                <a:off x="3543920" y="2387203"/>
                <a:ext cx="6527303" cy="484464"/>
                <a:chOff x="3543920" y="773666"/>
                <a:chExt cx="6527303" cy="484464"/>
              </a:xfrm>
            </p:grpSpPr>
            <p:sp>
              <p:nvSpPr>
                <p:cNvPr id="439" name="正方形/長方形 467">
                  <a:extLst>
                    <a:ext uri="{FF2B5EF4-FFF2-40B4-BE49-F238E27FC236}">
                      <a16:creationId xmlns:a16="http://schemas.microsoft.com/office/drawing/2014/main" id="{0C18305A-9408-BFE7-F9EC-911D163F0401}"/>
                    </a:ext>
                  </a:extLst>
                </p:cNvPr>
                <p:cNvSpPr/>
                <p:nvPr/>
              </p:nvSpPr>
              <p:spPr>
                <a:xfrm>
                  <a:off x="3543920" y="773666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0" name="正方形/長方形 468">
                  <a:extLst>
                    <a:ext uri="{FF2B5EF4-FFF2-40B4-BE49-F238E27FC236}">
                      <a16:creationId xmlns:a16="http://schemas.microsoft.com/office/drawing/2014/main" id="{6273557C-1631-8607-1C7E-2405C0BB0570}"/>
                    </a:ext>
                  </a:extLst>
                </p:cNvPr>
                <p:cNvSpPr/>
                <p:nvPr/>
              </p:nvSpPr>
              <p:spPr>
                <a:xfrm>
                  <a:off x="5142152" y="1090432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1" name="正方形/長方形 469">
                  <a:extLst>
                    <a:ext uri="{FF2B5EF4-FFF2-40B4-BE49-F238E27FC236}">
                      <a16:creationId xmlns:a16="http://schemas.microsoft.com/office/drawing/2014/main" id="{B7584FDB-ED25-AFA1-860E-D7C8BAF308D2}"/>
                    </a:ext>
                  </a:extLst>
                </p:cNvPr>
                <p:cNvSpPr/>
                <p:nvPr/>
              </p:nvSpPr>
              <p:spPr>
                <a:xfrm>
                  <a:off x="6738697" y="1099705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2" name="正方形/長方形 470">
                  <a:extLst>
                    <a:ext uri="{FF2B5EF4-FFF2-40B4-BE49-F238E27FC236}">
                      <a16:creationId xmlns:a16="http://schemas.microsoft.com/office/drawing/2014/main" id="{5D13BD0B-FEFB-94FE-AB2F-686B7E0F4549}"/>
                    </a:ext>
                  </a:extLst>
                </p:cNvPr>
                <p:cNvSpPr/>
                <p:nvPr/>
              </p:nvSpPr>
              <p:spPr>
                <a:xfrm>
                  <a:off x="8323636" y="1114130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3" name="正方形/長方形 471">
                  <a:extLst>
                    <a:ext uri="{FF2B5EF4-FFF2-40B4-BE49-F238E27FC236}">
                      <a16:creationId xmlns:a16="http://schemas.microsoft.com/office/drawing/2014/main" id="{34DCA9C0-248B-CD86-DB99-8F82AC64E66D}"/>
                    </a:ext>
                  </a:extLst>
                </p:cNvPr>
                <p:cNvSpPr/>
                <p:nvPr/>
              </p:nvSpPr>
              <p:spPr>
                <a:xfrm>
                  <a:off x="9927223" y="1060087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51" name="フリーフォーム: 図形 950">
                <a:extLst>
                  <a:ext uri="{FF2B5EF4-FFF2-40B4-BE49-F238E27FC236}">
                    <a16:creationId xmlns:a16="http://schemas.microsoft.com/office/drawing/2014/main" id="{40E38921-E3B3-C809-F7DA-BF00C3DE1A97}"/>
                  </a:ext>
                </a:extLst>
              </p:cNvPr>
              <p:cNvSpPr/>
              <p:nvPr/>
            </p:nvSpPr>
            <p:spPr>
              <a:xfrm>
                <a:off x="3609975" y="2457450"/>
                <a:ext cx="4786313" cy="342900"/>
              </a:xfrm>
              <a:custGeom>
                <a:avLst/>
                <a:gdLst>
                  <a:gd name="connsiteX0" fmla="*/ 0 w 5572125"/>
                  <a:gd name="connsiteY0" fmla="*/ 0 h 828675"/>
                  <a:gd name="connsiteX1" fmla="*/ 1604963 w 5572125"/>
                  <a:gd name="connsiteY1" fmla="*/ 323850 h 828675"/>
                  <a:gd name="connsiteX2" fmla="*/ 3200400 w 5572125"/>
                  <a:gd name="connsiteY2" fmla="*/ 333375 h 828675"/>
                  <a:gd name="connsiteX3" fmla="*/ 4786313 w 5572125"/>
                  <a:gd name="connsiteY3" fmla="*/ 342900 h 828675"/>
                  <a:gd name="connsiteX4" fmla="*/ 5572125 w 5572125"/>
                  <a:gd name="connsiteY4" fmla="*/ 828675 h 828675"/>
                  <a:gd name="connsiteX0" fmla="*/ 0 w 4786313"/>
                  <a:gd name="connsiteY0" fmla="*/ 0 h 342900"/>
                  <a:gd name="connsiteX1" fmla="*/ 1604963 w 4786313"/>
                  <a:gd name="connsiteY1" fmla="*/ 323850 h 342900"/>
                  <a:gd name="connsiteX2" fmla="*/ 3200400 w 4786313"/>
                  <a:gd name="connsiteY2" fmla="*/ 333375 h 342900"/>
                  <a:gd name="connsiteX3" fmla="*/ 4786313 w 4786313"/>
                  <a:gd name="connsiteY3" fmla="*/ 342900 h 342900"/>
                  <a:gd name="connsiteX0" fmla="*/ 0 w 4786313"/>
                  <a:gd name="connsiteY0" fmla="*/ 0 h 342900"/>
                  <a:gd name="connsiteX1" fmla="*/ 1604963 w 4786313"/>
                  <a:gd name="connsiteY1" fmla="*/ 323850 h 342900"/>
                  <a:gd name="connsiteX2" fmla="*/ 3200400 w 4786313"/>
                  <a:gd name="connsiteY2" fmla="*/ 330994 h 342900"/>
                  <a:gd name="connsiteX3" fmla="*/ 4786313 w 4786313"/>
                  <a:gd name="connsiteY3" fmla="*/ 342900 h 34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86313" h="342900">
                    <a:moveTo>
                      <a:pt x="0" y="0"/>
                    </a:moveTo>
                    <a:lnTo>
                      <a:pt x="1604963" y="323850"/>
                    </a:lnTo>
                    <a:lnTo>
                      <a:pt x="3200400" y="330994"/>
                    </a:lnTo>
                    <a:lnTo>
                      <a:pt x="4786313" y="342900"/>
                    </a:lnTo>
                  </a:path>
                </a:pathLst>
              </a:custGeom>
              <a:noFill/>
              <a:ln w="3810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47" name="グループ化 946">
              <a:extLst>
                <a:ext uri="{FF2B5EF4-FFF2-40B4-BE49-F238E27FC236}">
                  <a16:creationId xmlns:a16="http://schemas.microsoft.com/office/drawing/2014/main" id="{EBEDAD4E-DB61-4268-D96A-CD9BA5ABDA94}"/>
                </a:ext>
              </a:extLst>
            </p:cNvPr>
            <p:cNvGrpSpPr/>
            <p:nvPr/>
          </p:nvGrpSpPr>
          <p:grpSpPr>
            <a:xfrm>
              <a:off x="3369375" y="1506133"/>
              <a:ext cx="6563581" cy="1903451"/>
              <a:chOff x="3379040" y="1840706"/>
              <a:chExt cx="6563581" cy="1903451"/>
            </a:xfrm>
          </p:grpSpPr>
          <p:grpSp>
            <p:nvGrpSpPr>
              <p:cNvPr id="945" name="グループ化 944">
                <a:extLst>
                  <a:ext uri="{FF2B5EF4-FFF2-40B4-BE49-F238E27FC236}">
                    <a16:creationId xmlns:a16="http://schemas.microsoft.com/office/drawing/2014/main" id="{7F7FBB8A-F067-3D21-966B-7706FE9EA763}"/>
                  </a:ext>
                </a:extLst>
              </p:cNvPr>
              <p:cNvGrpSpPr/>
              <p:nvPr/>
            </p:nvGrpSpPr>
            <p:grpSpPr>
              <a:xfrm>
                <a:off x="3397040" y="1840706"/>
                <a:ext cx="6545581" cy="1903451"/>
                <a:chOff x="3397040" y="1840706"/>
                <a:chExt cx="6545581" cy="1903451"/>
              </a:xfrm>
            </p:grpSpPr>
            <p:grpSp>
              <p:nvGrpSpPr>
                <p:cNvPr id="412" name="グループ化 411">
                  <a:extLst>
                    <a:ext uri="{FF2B5EF4-FFF2-40B4-BE49-F238E27FC236}">
                      <a16:creationId xmlns:a16="http://schemas.microsoft.com/office/drawing/2014/main" id="{250B3F92-A62D-4A63-5E79-2752BD08C760}"/>
                    </a:ext>
                  </a:extLst>
                </p:cNvPr>
                <p:cNvGrpSpPr/>
                <p:nvPr/>
              </p:nvGrpSpPr>
              <p:grpSpPr>
                <a:xfrm>
                  <a:off x="3397040" y="1840706"/>
                  <a:ext cx="108000" cy="1112044"/>
                  <a:chOff x="3181267" y="2597151"/>
                  <a:chExt cx="108000" cy="2157062"/>
                </a:xfrm>
              </p:grpSpPr>
              <p:cxnSp>
                <p:nvCxnSpPr>
                  <p:cNvPr id="433" name="直線コネクタ 432">
                    <a:extLst>
                      <a:ext uri="{FF2B5EF4-FFF2-40B4-BE49-F238E27FC236}">
                        <a16:creationId xmlns:a16="http://schemas.microsoft.com/office/drawing/2014/main" id="{129EC3BC-202B-E707-1678-8D9DF74016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4" name="直線コネクタ 433">
                    <a:extLst>
                      <a:ext uri="{FF2B5EF4-FFF2-40B4-BE49-F238E27FC236}">
                        <a16:creationId xmlns:a16="http://schemas.microsoft.com/office/drawing/2014/main" id="{01D3FEBF-00EF-B41D-171C-11ABF3A1736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5" name="直線コネクタ 434">
                    <a:extLst>
                      <a:ext uri="{FF2B5EF4-FFF2-40B4-BE49-F238E27FC236}">
                        <a16:creationId xmlns:a16="http://schemas.microsoft.com/office/drawing/2014/main" id="{D0F53DEF-ECEC-4E5A-09A5-D9FD961D85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13" name="グループ化 412">
                  <a:extLst>
                    <a:ext uri="{FF2B5EF4-FFF2-40B4-BE49-F238E27FC236}">
                      <a16:creationId xmlns:a16="http://schemas.microsoft.com/office/drawing/2014/main" id="{FC022C32-1C57-DF11-7A78-A91770565CFD}"/>
                    </a:ext>
                  </a:extLst>
                </p:cNvPr>
                <p:cNvGrpSpPr/>
                <p:nvPr/>
              </p:nvGrpSpPr>
              <p:grpSpPr>
                <a:xfrm>
                  <a:off x="4995272" y="2085606"/>
                  <a:ext cx="108000" cy="1388638"/>
                  <a:chOff x="3181267" y="2597151"/>
                  <a:chExt cx="108000" cy="2157062"/>
                </a:xfrm>
              </p:grpSpPr>
              <p:cxnSp>
                <p:nvCxnSpPr>
                  <p:cNvPr id="430" name="直線コネクタ 429">
                    <a:extLst>
                      <a:ext uri="{FF2B5EF4-FFF2-40B4-BE49-F238E27FC236}">
                        <a16:creationId xmlns:a16="http://schemas.microsoft.com/office/drawing/2014/main" id="{11C6764B-3596-C296-E73B-24ACE385DA3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1" name="直線コネクタ 430">
                    <a:extLst>
                      <a:ext uri="{FF2B5EF4-FFF2-40B4-BE49-F238E27FC236}">
                        <a16:creationId xmlns:a16="http://schemas.microsoft.com/office/drawing/2014/main" id="{310F817D-3CA9-2CB2-77A8-7956D41B7B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2" name="直線コネクタ 431">
                    <a:extLst>
                      <a:ext uri="{FF2B5EF4-FFF2-40B4-BE49-F238E27FC236}">
                        <a16:creationId xmlns:a16="http://schemas.microsoft.com/office/drawing/2014/main" id="{D1DF0E64-41FD-432A-C2B3-04465D09C6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14" name="グループ化 413">
                  <a:extLst>
                    <a:ext uri="{FF2B5EF4-FFF2-40B4-BE49-F238E27FC236}">
                      <a16:creationId xmlns:a16="http://schemas.microsoft.com/office/drawing/2014/main" id="{3CC63AE9-FD8C-95D3-0B7A-721235382E61}"/>
                    </a:ext>
                  </a:extLst>
                </p:cNvPr>
                <p:cNvGrpSpPr/>
                <p:nvPr/>
              </p:nvGrpSpPr>
              <p:grpSpPr>
                <a:xfrm>
                  <a:off x="6591817" y="2321719"/>
                  <a:ext cx="108000" cy="1245393"/>
                  <a:chOff x="3181267" y="2597151"/>
                  <a:chExt cx="108000" cy="2157062"/>
                </a:xfrm>
              </p:grpSpPr>
              <p:cxnSp>
                <p:nvCxnSpPr>
                  <p:cNvPr id="427" name="直線コネクタ 426">
                    <a:extLst>
                      <a:ext uri="{FF2B5EF4-FFF2-40B4-BE49-F238E27FC236}">
                        <a16:creationId xmlns:a16="http://schemas.microsoft.com/office/drawing/2014/main" id="{F12479CF-887F-3F4B-30E8-A91C090920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8" name="直線コネクタ 427">
                    <a:extLst>
                      <a:ext uri="{FF2B5EF4-FFF2-40B4-BE49-F238E27FC236}">
                        <a16:creationId xmlns:a16="http://schemas.microsoft.com/office/drawing/2014/main" id="{888C0875-AAB8-965E-ECD7-709E44639A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9" name="直線コネクタ 428">
                    <a:extLst>
                      <a:ext uri="{FF2B5EF4-FFF2-40B4-BE49-F238E27FC236}">
                        <a16:creationId xmlns:a16="http://schemas.microsoft.com/office/drawing/2014/main" id="{5D104B66-EC0C-75B0-7F7E-6FE62FB777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42" name="グループ化 941">
                  <a:extLst>
                    <a:ext uri="{FF2B5EF4-FFF2-40B4-BE49-F238E27FC236}">
                      <a16:creationId xmlns:a16="http://schemas.microsoft.com/office/drawing/2014/main" id="{DD8EB664-DA02-E2B2-1399-79B7A6358951}"/>
                    </a:ext>
                  </a:extLst>
                </p:cNvPr>
                <p:cNvGrpSpPr/>
                <p:nvPr/>
              </p:nvGrpSpPr>
              <p:grpSpPr>
                <a:xfrm>
                  <a:off x="8127910" y="2150269"/>
                  <a:ext cx="211596" cy="1593888"/>
                  <a:chOff x="8127910" y="2150269"/>
                  <a:chExt cx="211596" cy="1593888"/>
                </a:xfrm>
              </p:grpSpPr>
              <p:grpSp>
                <p:nvGrpSpPr>
                  <p:cNvPr id="422" name="グループ化 421">
                    <a:extLst>
                      <a:ext uri="{FF2B5EF4-FFF2-40B4-BE49-F238E27FC236}">
                        <a16:creationId xmlns:a16="http://schemas.microsoft.com/office/drawing/2014/main" id="{E255C708-2ACA-45B6-5E87-02004C2E86F0}"/>
                      </a:ext>
                    </a:extLst>
                  </p:cNvPr>
                  <p:cNvGrpSpPr/>
                  <p:nvPr/>
                </p:nvGrpSpPr>
                <p:grpSpPr>
                  <a:xfrm>
                    <a:off x="8176757" y="2150269"/>
                    <a:ext cx="108000" cy="1371109"/>
                    <a:chOff x="3181267" y="2597151"/>
                    <a:chExt cx="108000" cy="2157062"/>
                  </a:xfrm>
                </p:grpSpPr>
                <p:cxnSp>
                  <p:nvCxnSpPr>
                    <p:cNvPr id="424" name="直線コネクタ 423">
                      <a:extLst>
                        <a:ext uri="{FF2B5EF4-FFF2-40B4-BE49-F238E27FC236}">
                          <a16:creationId xmlns:a16="http://schemas.microsoft.com/office/drawing/2014/main" id="{A6F621DD-AA2F-4B4C-A05F-3FA6E8DAE8E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5" name="直線コネクタ 424">
                      <a:extLst>
                        <a:ext uri="{FF2B5EF4-FFF2-40B4-BE49-F238E27FC236}">
                          <a16:creationId xmlns:a16="http://schemas.microsoft.com/office/drawing/2014/main" id="{1BDAD068-B0DC-633A-49CA-65A58BDD6E4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6" name="直線コネクタ 425">
                      <a:extLst>
                        <a:ext uri="{FF2B5EF4-FFF2-40B4-BE49-F238E27FC236}">
                          <a16:creationId xmlns:a16="http://schemas.microsoft.com/office/drawing/2014/main" id="{A18DA5CA-F4B1-9E6C-8817-D91AF6C1F6D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23" name="テキスト ボックス 422">
                    <a:extLst>
                      <a:ext uri="{FF2B5EF4-FFF2-40B4-BE49-F238E27FC236}">
                        <a16:creationId xmlns:a16="http://schemas.microsoft.com/office/drawing/2014/main" id="{9A8B7F56-1001-FF5A-45C5-FE239E39BA91}"/>
                      </a:ext>
                    </a:extLst>
                  </p:cNvPr>
                  <p:cNvSpPr txBox="1"/>
                  <p:nvPr/>
                </p:nvSpPr>
                <p:spPr>
                  <a:xfrm>
                    <a:off x="8127910" y="3492362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  <p:grpSp>
              <p:nvGrpSpPr>
                <p:cNvPr id="944" name="グループ化 943">
                  <a:extLst>
                    <a:ext uri="{FF2B5EF4-FFF2-40B4-BE49-F238E27FC236}">
                      <a16:creationId xmlns:a16="http://schemas.microsoft.com/office/drawing/2014/main" id="{4C33358A-4001-38F5-BFF6-5F14B5A6305A}"/>
                    </a:ext>
                  </a:extLst>
                </p:cNvPr>
                <p:cNvGrpSpPr/>
                <p:nvPr/>
              </p:nvGrpSpPr>
              <p:grpSpPr>
                <a:xfrm>
                  <a:off x="9731025" y="2216944"/>
                  <a:ext cx="211596" cy="1522852"/>
                  <a:chOff x="9731025" y="2216944"/>
                  <a:chExt cx="211596" cy="1522852"/>
                </a:xfrm>
              </p:grpSpPr>
              <p:grpSp>
                <p:nvGrpSpPr>
                  <p:cNvPr id="417" name="グループ化 416">
                    <a:extLst>
                      <a:ext uri="{FF2B5EF4-FFF2-40B4-BE49-F238E27FC236}">
                        <a16:creationId xmlns:a16="http://schemas.microsoft.com/office/drawing/2014/main" id="{918511C9-661A-0A16-E790-5A061BBFEEE4}"/>
                      </a:ext>
                    </a:extLst>
                  </p:cNvPr>
                  <p:cNvGrpSpPr/>
                  <p:nvPr/>
                </p:nvGrpSpPr>
                <p:grpSpPr>
                  <a:xfrm>
                    <a:off x="9780343" y="2216944"/>
                    <a:ext cx="108000" cy="1307950"/>
                    <a:chOff x="3181267" y="2597151"/>
                    <a:chExt cx="108000" cy="2157062"/>
                  </a:xfrm>
                </p:grpSpPr>
                <p:cxnSp>
                  <p:nvCxnSpPr>
                    <p:cNvPr id="419" name="直線コネクタ 418">
                      <a:extLst>
                        <a:ext uri="{FF2B5EF4-FFF2-40B4-BE49-F238E27FC236}">
                          <a16:creationId xmlns:a16="http://schemas.microsoft.com/office/drawing/2014/main" id="{05E1E546-81C5-B4AA-D385-4201E99E872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0" name="直線コネクタ 419">
                      <a:extLst>
                        <a:ext uri="{FF2B5EF4-FFF2-40B4-BE49-F238E27FC236}">
                          <a16:creationId xmlns:a16="http://schemas.microsoft.com/office/drawing/2014/main" id="{F216D1EE-8635-B5AC-D7A5-8432B13DC8F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1" name="直線コネクタ 420">
                      <a:extLst>
                        <a:ext uri="{FF2B5EF4-FFF2-40B4-BE49-F238E27FC236}">
                          <a16:creationId xmlns:a16="http://schemas.microsoft.com/office/drawing/2014/main" id="{A4386060-4EF1-8CBE-5B2B-2906F9F7774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18" name="テキスト ボックス 417">
                    <a:extLst>
                      <a:ext uri="{FF2B5EF4-FFF2-40B4-BE49-F238E27FC236}">
                        <a16:creationId xmlns:a16="http://schemas.microsoft.com/office/drawing/2014/main" id="{EE1EC84E-917B-26CE-452F-604A0B5FC37A}"/>
                      </a:ext>
                    </a:extLst>
                  </p:cNvPr>
                  <p:cNvSpPr txBox="1"/>
                  <p:nvPr/>
                </p:nvSpPr>
                <p:spPr>
                  <a:xfrm>
                    <a:off x="9731025" y="3488001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</p:grpSp>
          <p:grpSp>
            <p:nvGrpSpPr>
              <p:cNvPr id="405" name="グループ化 404">
                <a:extLst>
                  <a:ext uri="{FF2B5EF4-FFF2-40B4-BE49-F238E27FC236}">
                    <a16:creationId xmlns:a16="http://schemas.microsoft.com/office/drawing/2014/main" id="{4DEDF085-B261-3970-BABE-3ABFF281D444}"/>
                  </a:ext>
                </a:extLst>
              </p:cNvPr>
              <p:cNvGrpSpPr/>
              <p:nvPr/>
            </p:nvGrpSpPr>
            <p:grpSpPr>
              <a:xfrm>
                <a:off x="3379040" y="2323973"/>
                <a:ext cx="6527303" cy="692316"/>
                <a:chOff x="3370040" y="762399"/>
                <a:chExt cx="6527303" cy="692316"/>
              </a:xfrm>
            </p:grpSpPr>
            <p:sp>
              <p:nvSpPr>
                <p:cNvPr id="407" name="楕円 406">
                  <a:extLst>
                    <a:ext uri="{FF2B5EF4-FFF2-40B4-BE49-F238E27FC236}">
                      <a16:creationId xmlns:a16="http://schemas.microsoft.com/office/drawing/2014/main" id="{8C56D550-2D92-A141-AAEC-46364CC9C2B8}"/>
                    </a:ext>
                  </a:extLst>
                </p:cNvPr>
                <p:cNvSpPr/>
                <p:nvPr/>
              </p:nvSpPr>
              <p:spPr>
                <a:xfrm>
                  <a:off x="3370040" y="762399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8" name="楕円 407">
                  <a:extLst>
                    <a:ext uri="{FF2B5EF4-FFF2-40B4-BE49-F238E27FC236}">
                      <a16:creationId xmlns:a16="http://schemas.microsoft.com/office/drawing/2014/main" id="{80D7DECC-4A27-233A-09BD-6F4F61E1B0AF}"/>
                    </a:ext>
                  </a:extLst>
                </p:cNvPr>
                <p:cNvSpPr/>
                <p:nvPr/>
              </p:nvSpPr>
              <p:spPr>
                <a:xfrm>
                  <a:off x="4968272" y="1147399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9" name="楕円 408">
                  <a:extLst>
                    <a:ext uri="{FF2B5EF4-FFF2-40B4-BE49-F238E27FC236}">
                      <a16:creationId xmlns:a16="http://schemas.microsoft.com/office/drawing/2014/main" id="{7CE411DF-16E8-CF81-32D9-C5FCC64ACD73}"/>
                    </a:ext>
                  </a:extLst>
                </p:cNvPr>
                <p:cNvSpPr/>
                <p:nvPr/>
              </p:nvSpPr>
              <p:spPr>
                <a:xfrm>
                  <a:off x="6564817" y="1310715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0" name="楕円 409">
                  <a:extLst>
                    <a:ext uri="{FF2B5EF4-FFF2-40B4-BE49-F238E27FC236}">
                      <a16:creationId xmlns:a16="http://schemas.microsoft.com/office/drawing/2014/main" id="{F0018712-E84E-66C5-A618-9EC3BE7518B1}"/>
                    </a:ext>
                  </a:extLst>
                </p:cNvPr>
                <p:cNvSpPr/>
                <p:nvPr/>
              </p:nvSpPr>
              <p:spPr>
                <a:xfrm>
                  <a:off x="8149756" y="1200009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1" name="楕円 410">
                  <a:extLst>
                    <a:ext uri="{FF2B5EF4-FFF2-40B4-BE49-F238E27FC236}">
                      <a16:creationId xmlns:a16="http://schemas.microsoft.com/office/drawing/2014/main" id="{B7126FE7-69C8-60A6-E007-11D9C5F7E69B}"/>
                    </a:ext>
                  </a:extLst>
                </p:cNvPr>
                <p:cNvSpPr/>
                <p:nvPr/>
              </p:nvSpPr>
              <p:spPr>
                <a:xfrm>
                  <a:off x="9753343" y="1243611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46" name="フリーフォーム: 図形 945">
                <a:extLst>
                  <a:ext uri="{FF2B5EF4-FFF2-40B4-BE49-F238E27FC236}">
                    <a16:creationId xmlns:a16="http://schemas.microsoft.com/office/drawing/2014/main" id="{B39B7970-8F41-79CD-08B0-2A8B8891DA0F}"/>
                  </a:ext>
                </a:extLst>
              </p:cNvPr>
              <p:cNvSpPr/>
              <p:nvPr/>
            </p:nvSpPr>
            <p:spPr>
              <a:xfrm>
                <a:off x="3448050" y="2393950"/>
                <a:ext cx="4781550" cy="549275"/>
              </a:xfrm>
              <a:custGeom>
                <a:avLst/>
                <a:gdLst>
                  <a:gd name="connsiteX0" fmla="*/ 0 w 4781550"/>
                  <a:gd name="connsiteY0" fmla="*/ 0 h 542925"/>
                  <a:gd name="connsiteX1" fmla="*/ 1600200 w 4781550"/>
                  <a:gd name="connsiteY1" fmla="*/ 385763 h 542925"/>
                  <a:gd name="connsiteX2" fmla="*/ 3195638 w 4781550"/>
                  <a:gd name="connsiteY2" fmla="*/ 542925 h 542925"/>
                  <a:gd name="connsiteX3" fmla="*/ 4781550 w 4781550"/>
                  <a:gd name="connsiteY3" fmla="*/ 438150 h 542925"/>
                  <a:gd name="connsiteX0" fmla="*/ 0 w 4781550"/>
                  <a:gd name="connsiteY0" fmla="*/ 0 h 542925"/>
                  <a:gd name="connsiteX1" fmla="*/ 1600200 w 4781550"/>
                  <a:gd name="connsiteY1" fmla="*/ 385763 h 542925"/>
                  <a:gd name="connsiteX2" fmla="*/ 3195638 w 4781550"/>
                  <a:gd name="connsiteY2" fmla="*/ 542925 h 542925"/>
                  <a:gd name="connsiteX3" fmla="*/ 4781550 w 4781550"/>
                  <a:gd name="connsiteY3" fmla="*/ 435769 h 542925"/>
                  <a:gd name="connsiteX0" fmla="*/ 0 w 4781550"/>
                  <a:gd name="connsiteY0" fmla="*/ 0 h 552450"/>
                  <a:gd name="connsiteX1" fmla="*/ 1600200 w 4781550"/>
                  <a:gd name="connsiteY1" fmla="*/ 395288 h 552450"/>
                  <a:gd name="connsiteX2" fmla="*/ 3195638 w 4781550"/>
                  <a:gd name="connsiteY2" fmla="*/ 552450 h 552450"/>
                  <a:gd name="connsiteX3" fmla="*/ 4781550 w 4781550"/>
                  <a:gd name="connsiteY3" fmla="*/ 445294 h 552450"/>
                  <a:gd name="connsiteX0" fmla="*/ 0 w 4781550"/>
                  <a:gd name="connsiteY0" fmla="*/ 0 h 549275"/>
                  <a:gd name="connsiteX1" fmla="*/ 1600200 w 4781550"/>
                  <a:gd name="connsiteY1" fmla="*/ 392113 h 549275"/>
                  <a:gd name="connsiteX2" fmla="*/ 3195638 w 4781550"/>
                  <a:gd name="connsiteY2" fmla="*/ 549275 h 549275"/>
                  <a:gd name="connsiteX3" fmla="*/ 4781550 w 4781550"/>
                  <a:gd name="connsiteY3" fmla="*/ 442119 h 5492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81550" h="549275">
                    <a:moveTo>
                      <a:pt x="0" y="0"/>
                    </a:moveTo>
                    <a:lnTo>
                      <a:pt x="1600200" y="392113"/>
                    </a:lnTo>
                    <a:lnTo>
                      <a:pt x="3195638" y="549275"/>
                    </a:lnTo>
                    <a:lnTo>
                      <a:pt x="4781550" y="442119"/>
                    </a:lnTo>
                  </a:path>
                </a:pathLst>
              </a:cu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41" name="グループ化 940">
              <a:extLst>
                <a:ext uri="{FF2B5EF4-FFF2-40B4-BE49-F238E27FC236}">
                  <a16:creationId xmlns:a16="http://schemas.microsoft.com/office/drawing/2014/main" id="{BEEC6DFF-B23B-5176-77FE-4EF55CB95973}"/>
                </a:ext>
              </a:extLst>
            </p:cNvPr>
            <p:cNvGrpSpPr/>
            <p:nvPr/>
          </p:nvGrpSpPr>
          <p:grpSpPr>
            <a:xfrm>
              <a:off x="3212287" y="1586301"/>
              <a:ext cx="6562974" cy="1675378"/>
              <a:chOff x="3221952" y="1920874"/>
              <a:chExt cx="6562974" cy="1675378"/>
            </a:xfrm>
          </p:grpSpPr>
          <p:grpSp>
            <p:nvGrpSpPr>
              <p:cNvPr id="939" name="グループ化 938">
                <a:extLst>
                  <a:ext uri="{FF2B5EF4-FFF2-40B4-BE49-F238E27FC236}">
                    <a16:creationId xmlns:a16="http://schemas.microsoft.com/office/drawing/2014/main" id="{C53A15B7-2238-7378-EE75-E0DBA6429F4C}"/>
                  </a:ext>
                </a:extLst>
              </p:cNvPr>
              <p:cNvGrpSpPr/>
              <p:nvPr/>
            </p:nvGrpSpPr>
            <p:grpSpPr>
              <a:xfrm>
                <a:off x="3239952" y="1920874"/>
                <a:ext cx="6544974" cy="1675378"/>
                <a:chOff x="3239952" y="1920874"/>
                <a:chExt cx="6544974" cy="1675378"/>
              </a:xfrm>
            </p:grpSpPr>
            <p:grpSp>
              <p:nvGrpSpPr>
                <p:cNvPr id="476" name="グループ化 475">
                  <a:extLst>
                    <a:ext uri="{FF2B5EF4-FFF2-40B4-BE49-F238E27FC236}">
                      <a16:creationId xmlns:a16="http://schemas.microsoft.com/office/drawing/2014/main" id="{40DD6196-2B8C-7F68-3A54-3C257704524D}"/>
                    </a:ext>
                  </a:extLst>
                </p:cNvPr>
                <p:cNvGrpSpPr/>
                <p:nvPr/>
              </p:nvGrpSpPr>
              <p:grpSpPr>
                <a:xfrm>
                  <a:off x="3239952" y="1920874"/>
                  <a:ext cx="108000" cy="1012825"/>
                  <a:chOff x="3181267" y="2597151"/>
                  <a:chExt cx="108000" cy="2157062"/>
                </a:xfrm>
              </p:grpSpPr>
              <p:cxnSp>
                <p:nvCxnSpPr>
                  <p:cNvPr id="497" name="直線コネクタ 496">
                    <a:extLst>
                      <a:ext uri="{FF2B5EF4-FFF2-40B4-BE49-F238E27FC236}">
                        <a16:creationId xmlns:a16="http://schemas.microsoft.com/office/drawing/2014/main" id="{430AC4AA-5DB8-D7BE-FEC9-CE90C59344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8" name="直線コネクタ 497">
                    <a:extLst>
                      <a:ext uri="{FF2B5EF4-FFF2-40B4-BE49-F238E27FC236}">
                        <a16:creationId xmlns:a16="http://schemas.microsoft.com/office/drawing/2014/main" id="{0371F3DA-1D8D-BF14-DC23-21A52B625C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9" name="直線コネクタ 498">
                    <a:extLst>
                      <a:ext uri="{FF2B5EF4-FFF2-40B4-BE49-F238E27FC236}">
                        <a16:creationId xmlns:a16="http://schemas.microsoft.com/office/drawing/2014/main" id="{284A3CCB-9608-BC18-D7CD-F6E989FBE2F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77" name="グループ化 476">
                  <a:extLst>
                    <a:ext uri="{FF2B5EF4-FFF2-40B4-BE49-F238E27FC236}">
                      <a16:creationId xmlns:a16="http://schemas.microsoft.com/office/drawing/2014/main" id="{4249C1C7-E124-3CB2-AD29-8E2563195F32}"/>
                    </a:ext>
                  </a:extLst>
                </p:cNvPr>
                <p:cNvGrpSpPr/>
                <p:nvPr/>
              </p:nvGrpSpPr>
              <p:grpSpPr>
                <a:xfrm>
                  <a:off x="4838184" y="2218170"/>
                  <a:ext cx="108000" cy="1099706"/>
                  <a:chOff x="3181267" y="2597151"/>
                  <a:chExt cx="108000" cy="2157062"/>
                </a:xfrm>
              </p:grpSpPr>
              <p:cxnSp>
                <p:nvCxnSpPr>
                  <p:cNvPr id="494" name="直線コネクタ 493">
                    <a:extLst>
                      <a:ext uri="{FF2B5EF4-FFF2-40B4-BE49-F238E27FC236}">
                        <a16:creationId xmlns:a16="http://schemas.microsoft.com/office/drawing/2014/main" id="{10BCCEB6-C9C4-D967-2705-C1514A6577A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5" name="直線コネクタ 494">
                    <a:extLst>
                      <a:ext uri="{FF2B5EF4-FFF2-40B4-BE49-F238E27FC236}">
                        <a16:creationId xmlns:a16="http://schemas.microsoft.com/office/drawing/2014/main" id="{38024947-5EDF-F22F-B013-20FCC14B314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6" name="直線コネクタ 495">
                    <a:extLst>
                      <a:ext uri="{FF2B5EF4-FFF2-40B4-BE49-F238E27FC236}">
                        <a16:creationId xmlns:a16="http://schemas.microsoft.com/office/drawing/2014/main" id="{0669DBAB-FAA6-E2EE-3E51-46D29C02C4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78" name="グループ化 477">
                  <a:extLst>
                    <a:ext uri="{FF2B5EF4-FFF2-40B4-BE49-F238E27FC236}">
                      <a16:creationId xmlns:a16="http://schemas.microsoft.com/office/drawing/2014/main" id="{0C7520DD-C338-4EB3-A3F5-BEABB9DED5F3}"/>
                    </a:ext>
                  </a:extLst>
                </p:cNvPr>
                <p:cNvGrpSpPr/>
                <p:nvPr/>
              </p:nvGrpSpPr>
              <p:grpSpPr>
                <a:xfrm>
                  <a:off x="6434729" y="2336800"/>
                  <a:ext cx="108000" cy="1065744"/>
                  <a:chOff x="3181267" y="2597151"/>
                  <a:chExt cx="108000" cy="2157062"/>
                </a:xfrm>
              </p:grpSpPr>
              <p:cxnSp>
                <p:nvCxnSpPr>
                  <p:cNvPr id="491" name="直線コネクタ 490">
                    <a:extLst>
                      <a:ext uri="{FF2B5EF4-FFF2-40B4-BE49-F238E27FC236}">
                        <a16:creationId xmlns:a16="http://schemas.microsoft.com/office/drawing/2014/main" id="{F2DC6A6D-5DC9-C386-5C95-3EB4D67716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2" name="直線コネクタ 491">
                    <a:extLst>
                      <a:ext uri="{FF2B5EF4-FFF2-40B4-BE49-F238E27FC236}">
                        <a16:creationId xmlns:a16="http://schemas.microsoft.com/office/drawing/2014/main" id="{3EC2E22B-982E-4973-1583-6B6D4FBDBD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3" name="直線コネクタ 492">
                    <a:extLst>
                      <a:ext uri="{FF2B5EF4-FFF2-40B4-BE49-F238E27FC236}">
                        <a16:creationId xmlns:a16="http://schemas.microsoft.com/office/drawing/2014/main" id="{49C42C4E-DCDD-367A-7B37-C25719B2F8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37" name="グループ化 936">
                  <a:extLst>
                    <a:ext uri="{FF2B5EF4-FFF2-40B4-BE49-F238E27FC236}">
                      <a16:creationId xmlns:a16="http://schemas.microsoft.com/office/drawing/2014/main" id="{D2DB9A5D-44D4-0C1B-C811-B1818E54EC30}"/>
                    </a:ext>
                  </a:extLst>
                </p:cNvPr>
                <p:cNvGrpSpPr/>
                <p:nvPr/>
              </p:nvGrpSpPr>
              <p:grpSpPr>
                <a:xfrm>
                  <a:off x="7965612" y="2251075"/>
                  <a:ext cx="211596" cy="1345177"/>
                  <a:chOff x="7965612" y="2251075"/>
                  <a:chExt cx="211596" cy="1345177"/>
                </a:xfrm>
              </p:grpSpPr>
              <p:grpSp>
                <p:nvGrpSpPr>
                  <p:cNvPr id="486" name="グループ化 485">
                    <a:extLst>
                      <a:ext uri="{FF2B5EF4-FFF2-40B4-BE49-F238E27FC236}">
                        <a16:creationId xmlns:a16="http://schemas.microsoft.com/office/drawing/2014/main" id="{BD96B061-82FE-AFFE-27AC-5932305231B5}"/>
                      </a:ext>
                    </a:extLst>
                  </p:cNvPr>
                  <p:cNvGrpSpPr/>
                  <p:nvPr/>
                </p:nvGrpSpPr>
                <p:grpSpPr>
                  <a:xfrm>
                    <a:off x="8019669" y="2251075"/>
                    <a:ext cx="108000" cy="1124111"/>
                    <a:chOff x="3181267" y="2597151"/>
                    <a:chExt cx="108000" cy="2157062"/>
                  </a:xfrm>
                </p:grpSpPr>
                <p:cxnSp>
                  <p:nvCxnSpPr>
                    <p:cNvPr id="488" name="直線コネクタ 487">
                      <a:extLst>
                        <a:ext uri="{FF2B5EF4-FFF2-40B4-BE49-F238E27FC236}">
                          <a16:creationId xmlns:a16="http://schemas.microsoft.com/office/drawing/2014/main" id="{0284EDD0-20CC-C5CA-A639-FE75F930EA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9" name="直線コネクタ 488">
                      <a:extLst>
                        <a:ext uri="{FF2B5EF4-FFF2-40B4-BE49-F238E27FC236}">
                          <a16:creationId xmlns:a16="http://schemas.microsoft.com/office/drawing/2014/main" id="{F751A171-56DB-ABB9-F40B-1E5486212F3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0" name="直線コネクタ 489">
                      <a:extLst>
                        <a:ext uri="{FF2B5EF4-FFF2-40B4-BE49-F238E27FC236}">
                          <a16:creationId xmlns:a16="http://schemas.microsoft.com/office/drawing/2014/main" id="{F4AA883B-0406-C514-E311-C0AB4FB2703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87" name="テキスト ボックス 486">
                    <a:extLst>
                      <a:ext uri="{FF2B5EF4-FFF2-40B4-BE49-F238E27FC236}">
                        <a16:creationId xmlns:a16="http://schemas.microsoft.com/office/drawing/2014/main" id="{1EC5AC6B-21E0-B9CF-A8C8-6EB3A1FB04CA}"/>
                      </a:ext>
                    </a:extLst>
                  </p:cNvPr>
                  <p:cNvSpPr txBox="1"/>
                  <p:nvPr/>
                </p:nvSpPr>
                <p:spPr>
                  <a:xfrm>
                    <a:off x="7965612" y="3344457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  <p:grpSp>
              <p:nvGrpSpPr>
                <p:cNvPr id="938" name="グループ化 937">
                  <a:extLst>
                    <a:ext uri="{FF2B5EF4-FFF2-40B4-BE49-F238E27FC236}">
                      <a16:creationId xmlns:a16="http://schemas.microsoft.com/office/drawing/2014/main" id="{B33C49DD-8732-5D62-A4BE-41C67FD8B72A}"/>
                    </a:ext>
                  </a:extLst>
                </p:cNvPr>
                <p:cNvGrpSpPr/>
                <p:nvPr/>
              </p:nvGrpSpPr>
              <p:grpSpPr>
                <a:xfrm>
                  <a:off x="9573330" y="2243138"/>
                  <a:ext cx="211596" cy="1331942"/>
                  <a:chOff x="9573330" y="2243138"/>
                  <a:chExt cx="211596" cy="1331942"/>
                </a:xfrm>
              </p:grpSpPr>
              <p:grpSp>
                <p:nvGrpSpPr>
                  <p:cNvPr id="481" name="グループ化 480">
                    <a:extLst>
                      <a:ext uri="{FF2B5EF4-FFF2-40B4-BE49-F238E27FC236}">
                        <a16:creationId xmlns:a16="http://schemas.microsoft.com/office/drawing/2014/main" id="{A4085BB7-BDE2-BF57-14E9-453F4FCE4AD0}"/>
                      </a:ext>
                    </a:extLst>
                  </p:cNvPr>
                  <p:cNvGrpSpPr/>
                  <p:nvPr/>
                </p:nvGrpSpPr>
                <p:grpSpPr>
                  <a:xfrm>
                    <a:off x="9623255" y="2243138"/>
                    <a:ext cx="108000" cy="1117023"/>
                    <a:chOff x="3181267" y="2597151"/>
                    <a:chExt cx="108000" cy="2157062"/>
                  </a:xfrm>
                </p:grpSpPr>
                <p:cxnSp>
                  <p:nvCxnSpPr>
                    <p:cNvPr id="483" name="直線コネクタ 482">
                      <a:extLst>
                        <a:ext uri="{FF2B5EF4-FFF2-40B4-BE49-F238E27FC236}">
                          <a16:creationId xmlns:a16="http://schemas.microsoft.com/office/drawing/2014/main" id="{504D0564-093B-8A44-68C0-998256B8DB4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4" name="直線コネクタ 483">
                      <a:extLst>
                        <a:ext uri="{FF2B5EF4-FFF2-40B4-BE49-F238E27FC236}">
                          <a16:creationId xmlns:a16="http://schemas.microsoft.com/office/drawing/2014/main" id="{7108E38D-9BD6-212D-1A58-61ED48FD20F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5" name="直線コネクタ 484">
                      <a:extLst>
                        <a:ext uri="{FF2B5EF4-FFF2-40B4-BE49-F238E27FC236}">
                          <a16:creationId xmlns:a16="http://schemas.microsoft.com/office/drawing/2014/main" id="{325D398F-8EC6-22AC-DF32-C40D8163FD0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82" name="テキスト ボックス 481">
                    <a:extLst>
                      <a:ext uri="{FF2B5EF4-FFF2-40B4-BE49-F238E27FC236}">
                        <a16:creationId xmlns:a16="http://schemas.microsoft.com/office/drawing/2014/main" id="{35E91BED-D01B-45E8-C993-30D3D8459E77}"/>
                      </a:ext>
                    </a:extLst>
                  </p:cNvPr>
                  <p:cNvSpPr txBox="1"/>
                  <p:nvPr/>
                </p:nvSpPr>
                <p:spPr>
                  <a:xfrm>
                    <a:off x="9573330" y="3323285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</p:grpSp>
          <p:grpSp>
            <p:nvGrpSpPr>
              <p:cNvPr id="469" name="グループ化 468">
                <a:extLst>
                  <a:ext uri="{FF2B5EF4-FFF2-40B4-BE49-F238E27FC236}">
                    <a16:creationId xmlns:a16="http://schemas.microsoft.com/office/drawing/2014/main" id="{2B29753D-B3ED-DC34-41B6-1B26924F348A}"/>
                  </a:ext>
                </a:extLst>
              </p:cNvPr>
              <p:cNvGrpSpPr/>
              <p:nvPr/>
            </p:nvGrpSpPr>
            <p:grpSpPr>
              <a:xfrm>
                <a:off x="3221952" y="2372257"/>
                <a:ext cx="6527303" cy="566934"/>
                <a:chOff x="3212952" y="2110845"/>
                <a:chExt cx="6527303" cy="566934"/>
              </a:xfrm>
              <a:solidFill>
                <a:schemeClr val="tx1"/>
              </a:solidFill>
            </p:grpSpPr>
            <p:sp>
              <p:nvSpPr>
                <p:cNvPr id="471" name="楕円 470">
                  <a:extLst>
                    <a:ext uri="{FF2B5EF4-FFF2-40B4-BE49-F238E27FC236}">
                      <a16:creationId xmlns:a16="http://schemas.microsoft.com/office/drawing/2014/main" id="{A9D1D4E7-EEE3-A7BF-D403-DA06697513FA}"/>
                    </a:ext>
                  </a:extLst>
                </p:cNvPr>
                <p:cNvSpPr/>
                <p:nvPr/>
              </p:nvSpPr>
              <p:spPr>
                <a:xfrm>
                  <a:off x="3212952" y="2110845"/>
                  <a:ext cx="144000" cy="144000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2" name="楕円 471">
                  <a:extLst>
                    <a:ext uri="{FF2B5EF4-FFF2-40B4-BE49-F238E27FC236}">
                      <a16:creationId xmlns:a16="http://schemas.microsoft.com/office/drawing/2014/main" id="{4B4616D5-9863-7B73-963D-A3C9A74EBDB3}"/>
                    </a:ext>
                  </a:extLst>
                </p:cNvPr>
                <p:cNvSpPr/>
                <p:nvPr/>
              </p:nvSpPr>
              <p:spPr>
                <a:xfrm>
                  <a:off x="4811184" y="2444045"/>
                  <a:ext cx="144000" cy="144000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3" name="楕円 472">
                  <a:extLst>
                    <a:ext uri="{FF2B5EF4-FFF2-40B4-BE49-F238E27FC236}">
                      <a16:creationId xmlns:a16="http://schemas.microsoft.com/office/drawing/2014/main" id="{B29E130B-D8B5-E7E0-147D-A5057E3F60E8}"/>
                    </a:ext>
                  </a:extLst>
                </p:cNvPr>
                <p:cNvSpPr/>
                <p:nvPr/>
              </p:nvSpPr>
              <p:spPr>
                <a:xfrm>
                  <a:off x="6407729" y="2533779"/>
                  <a:ext cx="144000" cy="144000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4" name="楕円 473">
                  <a:extLst>
                    <a:ext uri="{FF2B5EF4-FFF2-40B4-BE49-F238E27FC236}">
                      <a16:creationId xmlns:a16="http://schemas.microsoft.com/office/drawing/2014/main" id="{454FAA8F-EB52-0B37-AF68-14993BDDB3FF}"/>
                    </a:ext>
                  </a:extLst>
                </p:cNvPr>
                <p:cNvSpPr/>
                <p:nvPr/>
              </p:nvSpPr>
              <p:spPr>
                <a:xfrm>
                  <a:off x="7992668" y="2483657"/>
                  <a:ext cx="144000" cy="144000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5" name="楕円 474">
                  <a:extLst>
                    <a:ext uri="{FF2B5EF4-FFF2-40B4-BE49-F238E27FC236}">
                      <a16:creationId xmlns:a16="http://schemas.microsoft.com/office/drawing/2014/main" id="{E4768406-0796-7A6B-26BC-BD9A8CC70D9C}"/>
                    </a:ext>
                  </a:extLst>
                </p:cNvPr>
                <p:cNvSpPr/>
                <p:nvPr/>
              </p:nvSpPr>
              <p:spPr>
                <a:xfrm>
                  <a:off x="9596255" y="2465702"/>
                  <a:ext cx="144000" cy="144000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40" name="フリーフォーム: 図形 939">
                <a:extLst>
                  <a:ext uri="{FF2B5EF4-FFF2-40B4-BE49-F238E27FC236}">
                    <a16:creationId xmlns:a16="http://schemas.microsoft.com/office/drawing/2014/main" id="{04E4DEF8-14BE-EEF0-EDD9-8CB95ED4A44A}"/>
                  </a:ext>
                </a:extLst>
              </p:cNvPr>
              <p:cNvSpPr/>
              <p:nvPr/>
            </p:nvSpPr>
            <p:spPr>
              <a:xfrm>
                <a:off x="3290888" y="2443163"/>
                <a:ext cx="4781550" cy="428625"/>
              </a:xfrm>
              <a:custGeom>
                <a:avLst/>
                <a:gdLst>
                  <a:gd name="connsiteX0" fmla="*/ 0 w 4781550"/>
                  <a:gd name="connsiteY0" fmla="*/ 0 h 428625"/>
                  <a:gd name="connsiteX1" fmla="*/ 1600200 w 4781550"/>
                  <a:gd name="connsiteY1" fmla="*/ 333375 h 428625"/>
                  <a:gd name="connsiteX2" fmla="*/ 3200400 w 4781550"/>
                  <a:gd name="connsiteY2" fmla="*/ 428625 h 428625"/>
                  <a:gd name="connsiteX3" fmla="*/ 4781550 w 4781550"/>
                  <a:gd name="connsiteY3" fmla="*/ 366712 h 428625"/>
                  <a:gd name="connsiteX0" fmla="*/ 0 w 4781550"/>
                  <a:gd name="connsiteY0" fmla="*/ 0 h 428625"/>
                  <a:gd name="connsiteX1" fmla="*/ 1600200 w 4781550"/>
                  <a:gd name="connsiteY1" fmla="*/ 333375 h 428625"/>
                  <a:gd name="connsiteX2" fmla="*/ 3200400 w 4781550"/>
                  <a:gd name="connsiteY2" fmla="*/ 428625 h 428625"/>
                  <a:gd name="connsiteX3" fmla="*/ 4781550 w 4781550"/>
                  <a:gd name="connsiteY3" fmla="*/ 369887 h 428625"/>
                  <a:gd name="connsiteX0" fmla="*/ 0 w 4781550"/>
                  <a:gd name="connsiteY0" fmla="*/ 0 h 428625"/>
                  <a:gd name="connsiteX1" fmla="*/ 1600200 w 4781550"/>
                  <a:gd name="connsiteY1" fmla="*/ 333375 h 428625"/>
                  <a:gd name="connsiteX2" fmla="*/ 3197225 w 4781550"/>
                  <a:gd name="connsiteY2" fmla="*/ 428625 h 428625"/>
                  <a:gd name="connsiteX3" fmla="*/ 4781550 w 4781550"/>
                  <a:gd name="connsiteY3" fmla="*/ 369887 h 4286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81550" h="428625">
                    <a:moveTo>
                      <a:pt x="0" y="0"/>
                    </a:moveTo>
                    <a:lnTo>
                      <a:pt x="1600200" y="333375"/>
                    </a:lnTo>
                    <a:lnTo>
                      <a:pt x="3197225" y="428625"/>
                    </a:lnTo>
                    <a:lnTo>
                      <a:pt x="4781550" y="369887"/>
                    </a:lnTo>
                  </a:path>
                </a:pathLst>
              </a:cu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id="{A5D6A0F5-0575-5238-4EA3-CCFE3DFE2911}"/>
                </a:ext>
              </a:extLst>
            </p:cNvPr>
            <p:cNvGrpSpPr/>
            <p:nvPr/>
          </p:nvGrpSpPr>
          <p:grpSpPr>
            <a:xfrm>
              <a:off x="3534255" y="3826196"/>
              <a:ext cx="6527303" cy="973718"/>
              <a:chOff x="3534255" y="3826196"/>
              <a:chExt cx="6527303" cy="973718"/>
            </a:xfrm>
          </p:grpSpPr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856DFE6B-489C-B24E-8061-B2C401DF04A3}"/>
                  </a:ext>
                </a:extLst>
              </p:cNvPr>
              <p:cNvGrpSpPr/>
              <p:nvPr/>
            </p:nvGrpSpPr>
            <p:grpSpPr>
              <a:xfrm>
                <a:off x="3552255" y="3826196"/>
                <a:ext cx="6506672" cy="973718"/>
                <a:chOff x="3561920" y="3924056"/>
                <a:chExt cx="6506672" cy="973718"/>
              </a:xfrm>
            </p:grpSpPr>
            <p:grpSp>
              <p:nvGrpSpPr>
                <p:cNvPr id="348" name="グループ化 347">
                  <a:extLst>
                    <a:ext uri="{FF2B5EF4-FFF2-40B4-BE49-F238E27FC236}">
                      <a16:creationId xmlns:a16="http://schemas.microsoft.com/office/drawing/2014/main" id="{62C2D5AA-D17D-F89B-0708-F53AFB2D4E2D}"/>
                    </a:ext>
                  </a:extLst>
                </p:cNvPr>
                <p:cNvGrpSpPr/>
                <p:nvPr/>
              </p:nvGrpSpPr>
              <p:grpSpPr>
                <a:xfrm>
                  <a:off x="3561920" y="3924056"/>
                  <a:ext cx="108000" cy="650325"/>
                  <a:chOff x="3181267" y="2435860"/>
                  <a:chExt cx="108000" cy="2318353"/>
                </a:xfrm>
              </p:grpSpPr>
              <p:cxnSp>
                <p:nvCxnSpPr>
                  <p:cNvPr id="369" name="直線コネクタ 368">
                    <a:extLst>
                      <a:ext uri="{FF2B5EF4-FFF2-40B4-BE49-F238E27FC236}">
                        <a16:creationId xmlns:a16="http://schemas.microsoft.com/office/drawing/2014/main" id="{9C308261-C44C-4FAA-4991-BA3A3FE2D7E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435860"/>
                    <a:ext cx="0" cy="231835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0" name="直線コネクタ 369">
                    <a:extLst>
                      <a:ext uri="{FF2B5EF4-FFF2-40B4-BE49-F238E27FC236}">
                        <a16:creationId xmlns:a16="http://schemas.microsoft.com/office/drawing/2014/main" id="{EFCB6996-9E50-99B0-29F6-D71A9A0704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1" name="直線コネクタ 370">
                    <a:extLst>
                      <a:ext uri="{FF2B5EF4-FFF2-40B4-BE49-F238E27FC236}">
                        <a16:creationId xmlns:a16="http://schemas.microsoft.com/office/drawing/2014/main" id="{46672AC9-5CB6-C492-957E-1DE3050FF17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435860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49" name="グループ化 348">
                  <a:extLst>
                    <a:ext uri="{FF2B5EF4-FFF2-40B4-BE49-F238E27FC236}">
                      <a16:creationId xmlns:a16="http://schemas.microsoft.com/office/drawing/2014/main" id="{94FDB6A1-E2B5-5727-CFF9-C13024293AD1}"/>
                    </a:ext>
                  </a:extLst>
                </p:cNvPr>
                <p:cNvGrpSpPr/>
                <p:nvPr/>
              </p:nvGrpSpPr>
              <p:grpSpPr>
                <a:xfrm>
                  <a:off x="5157771" y="4029076"/>
                  <a:ext cx="108000" cy="610393"/>
                  <a:chOff x="3181267" y="2511723"/>
                  <a:chExt cx="108000" cy="1824841"/>
                </a:xfrm>
              </p:grpSpPr>
              <p:cxnSp>
                <p:nvCxnSpPr>
                  <p:cNvPr id="366" name="直線コネクタ 365">
                    <a:extLst>
                      <a:ext uri="{FF2B5EF4-FFF2-40B4-BE49-F238E27FC236}">
                        <a16:creationId xmlns:a16="http://schemas.microsoft.com/office/drawing/2014/main" id="{344D3191-D36F-A2C4-4DF2-AF0AB11A18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11723"/>
                    <a:ext cx="0" cy="182484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7" name="直線コネクタ 366">
                    <a:extLst>
                      <a:ext uri="{FF2B5EF4-FFF2-40B4-BE49-F238E27FC236}">
                        <a16:creationId xmlns:a16="http://schemas.microsoft.com/office/drawing/2014/main" id="{82270349-C578-A02D-03E9-790BC0B1FB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336564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8" name="直線コネクタ 367">
                    <a:extLst>
                      <a:ext uri="{FF2B5EF4-FFF2-40B4-BE49-F238E27FC236}">
                        <a16:creationId xmlns:a16="http://schemas.microsoft.com/office/drawing/2014/main" id="{DE6B7493-4D94-AB9A-F8A8-B737CC16F78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1172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50" name="グループ化 349">
                  <a:extLst>
                    <a:ext uri="{FF2B5EF4-FFF2-40B4-BE49-F238E27FC236}">
                      <a16:creationId xmlns:a16="http://schemas.microsoft.com/office/drawing/2014/main" id="{FB8F405C-64B8-8B4B-1DBE-F9851F280F1C}"/>
                    </a:ext>
                  </a:extLst>
                </p:cNvPr>
                <p:cNvGrpSpPr/>
                <p:nvPr/>
              </p:nvGrpSpPr>
              <p:grpSpPr>
                <a:xfrm>
                  <a:off x="6754316" y="4052888"/>
                  <a:ext cx="108000" cy="643925"/>
                  <a:chOff x="3181267" y="2597151"/>
                  <a:chExt cx="108000" cy="1703494"/>
                </a:xfrm>
              </p:grpSpPr>
              <p:cxnSp>
                <p:nvCxnSpPr>
                  <p:cNvPr id="363" name="直線コネクタ 362">
                    <a:extLst>
                      <a:ext uri="{FF2B5EF4-FFF2-40B4-BE49-F238E27FC236}">
                        <a16:creationId xmlns:a16="http://schemas.microsoft.com/office/drawing/2014/main" id="{84054D05-0824-8221-859C-084F7E32C87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169256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4" name="直線コネクタ 363">
                    <a:extLst>
                      <a:ext uri="{FF2B5EF4-FFF2-40B4-BE49-F238E27FC236}">
                        <a16:creationId xmlns:a16="http://schemas.microsoft.com/office/drawing/2014/main" id="{68E5EF91-1804-85EF-CB9D-6B60D29344A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300645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5" name="直線コネクタ 364">
                    <a:extLst>
                      <a:ext uri="{FF2B5EF4-FFF2-40B4-BE49-F238E27FC236}">
                        <a16:creationId xmlns:a16="http://schemas.microsoft.com/office/drawing/2014/main" id="{FC174A1B-2BC7-EBA9-B792-5EE2ACF47F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" name="グループ化 15">
                  <a:extLst>
                    <a:ext uri="{FF2B5EF4-FFF2-40B4-BE49-F238E27FC236}">
                      <a16:creationId xmlns:a16="http://schemas.microsoft.com/office/drawing/2014/main" id="{F38A33EC-AE06-F406-011C-E0F3FF7D359B}"/>
                    </a:ext>
                  </a:extLst>
                </p:cNvPr>
                <p:cNvGrpSpPr/>
                <p:nvPr/>
              </p:nvGrpSpPr>
              <p:grpSpPr>
                <a:xfrm>
                  <a:off x="8339256" y="4065588"/>
                  <a:ext cx="108000" cy="832186"/>
                  <a:chOff x="8339256" y="4065588"/>
                  <a:chExt cx="108000" cy="832186"/>
                </a:xfrm>
              </p:grpSpPr>
              <p:grpSp>
                <p:nvGrpSpPr>
                  <p:cNvPr id="358" name="グループ化 357">
                    <a:extLst>
                      <a:ext uri="{FF2B5EF4-FFF2-40B4-BE49-F238E27FC236}">
                        <a16:creationId xmlns:a16="http://schemas.microsoft.com/office/drawing/2014/main" id="{62CACF27-2CD4-5CCF-B54E-783F9B6F1C1A}"/>
                      </a:ext>
                    </a:extLst>
                  </p:cNvPr>
                  <p:cNvGrpSpPr/>
                  <p:nvPr/>
                </p:nvGrpSpPr>
                <p:grpSpPr>
                  <a:xfrm>
                    <a:off x="8339256" y="4065588"/>
                    <a:ext cx="108000" cy="620730"/>
                    <a:chOff x="3181267" y="2808003"/>
                    <a:chExt cx="108000" cy="1648910"/>
                  </a:xfrm>
                </p:grpSpPr>
                <p:cxnSp>
                  <p:nvCxnSpPr>
                    <p:cNvPr id="360" name="直線コネクタ 359">
                      <a:extLst>
                        <a:ext uri="{FF2B5EF4-FFF2-40B4-BE49-F238E27FC236}">
                          <a16:creationId xmlns:a16="http://schemas.microsoft.com/office/drawing/2014/main" id="{8C135818-4023-FCAF-2E1A-215B0B04B29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808003"/>
                      <a:ext cx="0" cy="1648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1" name="直線コネクタ 360">
                      <a:extLst>
                        <a:ext uri="{FF2B5EF4-FFF2-40B4-BE49-F238E27FC236}">
                          <a16:creationId xmlns:a16="http://schemas.microsoft.com/office/drawing/2014/main" id="{1F2F0219-A910-9FDE-C4F1-0774BFF1444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4569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2" name="直線コネクタ 361">
                      <a:extLst>
                        <a:ext uri="{FF2B5EF4-FFF2-40B4-BE49-F238E27FC236}">
                          <a16:creationId xmlns:a16="http://schemas.microsoft.com/office/drawing/2014/main" id="{6D9511AF-54A5-2DD8-A6A2-7B792B19A34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80800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0" name="テキスト ボックス 9">
                    <a:extLst>
                      <a:ext uri="{FF2B5EF4-FFF2-40B4-BE49-F238E27FC236}">
                        <a16:creationId xmlns:a16="http://schemas.microsoft.com/office/drawing/2014/main" id="{7F181A1E-4E25-4306-2F2D-BC9805BA875C}"/>
                      </a:ext>
                    </a:extLst>
                  </p:cNvPr>
                  <p:cNvSpPr txBox="1"/>
                  <p:nvPr/>
                </p:nvSpPr>
                <p:spPr>
                  <a:xfrm>
                    <a:off x="8360662" y="4645979"/>
                    <a:ext cx="70532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</a:t>
                    </a:r>
                  </a:p>
                </p:txBody>
              </p:sp>
            </p:grpSp>
            <p:grpSp>
              <p:nvGrpSpPr>
                <p:cNvPr id="19" name="グループ化 18">
                  <a:extLst>
                    <a:ext uri="{FF2B5EF4-FFF2-40B4-BE49-F238E27FC236}">
                      <a16:creationId xmlns:a16="http://schemas.microsoft.com/office/drawing/2014/main" id="{706B2C26-198A-971D-4DA5-C787933709BE}"/>
                    </a:ext>
                  </a:extLst>
                </p:cNvPr>
                <p:cNvGrpSpPr/>
                <p:nvPr/>
              </p:nvGrpSpPr>
              <p:grpSpPr>
                <a:xfrm>
                  <a:off x="9927528" y="4029075"/>
                  <a:ext cx="141064" cy="824098"/>
                  <a:chOff x="9927528" y="4029075"/>
                  <a:chExt cx="141064" cy="824098"/>
                </a:xfrm>
              </p:grpSpPr>
              <p:grpSp>
                <p:nvGrpSpPr>
                  <p:cNvPr id="353" name="グループ化 352">
                    <a:extLst>
                      <a:ext uri="{FF2B5EF4-FFF2-40B4-BE49-F238E27FC236}">
                        <a16:creationId xmlns:a16="http://schemas.microsoft.com/office/drawing/2014/main" id="{D8181DAF-3327-28D0-D260-71F88C010E03}"/>
                      </a:ext>
                    </a:extLst>
                  </p:cNvPr>
                  <p:cNvGrpSpPr/>
                  <p:nvPr/>
                </p:nvGrpSpPr>
                <p:grpSpPr>
                  <a:xfrm>
                    <a:off x="9942842" y="4029075"/>
                    <a:ext cx="108000" cy="608989"/>
                    <a:chOff x="3181267" y="2563734"/>
                    <a:chExt cx="108000" cy="1709266"/>
                  </a:xfrm>
                </p:grpSpPr>
                <p:cxnSp>
                  <p:nvCxnSpPr>
                    <p:cNvPr id="355" name="直線コネクタ 354">
                      <a:extLst>
                        <a:ext uri="{FF2B5EF4-FFF2-40B4-BE49-F238E27FC236}">
                          <a16:creationId xmlns:a16="http://schemas.microsoft.com/office/drawing/2014/main" id="{662E8605-A65A-8A98-56A2-922BCEF94B6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63734"/>
                      <a:ext cx="0" cy="1709266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6" name="直線コネクタ 355">
                      <a:extLst>
                        <a:ext uri="{FF2B5EF4-FFF2-40B4-BE49-F238E27FC236}">
                          <a16:creationId xmlns:a16="http://schemas.microsoft.com/office/drawing/2014/main" id="{90C91B7B-E354-02AF-3DA0-364AEEB70AE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273000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7" name="直線コネクタ 356">
                      <a:extLst>
                        <a:ext uri="{FF2B5EF4-FFF2-40B4-BE49-F238E27FC236}">
                          <a16:creationId xmlns:a16="http://schemas.microsoft.com/office/drawing/2014/main" id="{7162AC4D-778E-6346-3EFF-81F8F373E45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63734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1" name="テキスト ボックス 10">
                    <a:extLst>
                      <a:ext uri="{FF2B5EF4-FFF2-40B4-BE49-F238E27FC236}">
                        <a16:creationId xmlns:a16="http://schemas.microsoft.com/office/drawing/2014/main" id="{88A00044-2911-1BD8-6B23-642766D041F5}"/>
                      </a:ext>
                    </a:extLst>
                  </p:cNvPr>
                  <p:cNvSpPr txBox="1"/>
                  <p:nvPr/>
                </p:nvSpPr>
                <p:spPr>
                  <a:xfrm>
                    <a:off x="9927528" y="4601378"/>
                    <a:ext cx="141064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</a:t>
                    </a:r>
                  </a:p>
                </p:txBody>
              </p:sp>
            </p:grpSp>
          </p:grpSp>
          <p:grpSp>
            <p:nvGrpSpPr>
              <p:cNvPr id="341" name="グループ化 340">
                <a:extLst>
                  <a:ext uri="{FF2B5EF4-FFF2-40B4-BE49-F238E27FC236}">
                    <a16:creationId xmlns:a16="http://schemas.microsoft.com/office/drawing/2014/main" id="{5334F806-2504-442D-96C0-AD115D839924}"/>
                  </a:ext>
                </a:extLst>
              </p:cNvPr>
              <p:cNvGrpSpPr/>
              <p:nvPr/>
            </p:nvGrpSpPr>
            <p:grpSpPr>
              <a:xfrm>
                <a:off x="3534255" y="4080750"/>
                <a:ext cx="6527303" cy="276876"/>
                <a:chOff x="3543920" y="1083228"/>
                <a:chExt cx="6527303" cy="276876"/>
              </a:xfrm>
            </p:grpSpPr>
            <p:sp>
              <p:nvSpPr>
                <p:cNvPr id="343" name="正方形/長方形 467">
                  <a:extLst>
                    <a:ext uri="{FF2B5EF4-FFF2-40B4-BE49-F238E27FC236}">
                      <a16:creationId xmlns:a16="http://schemas.microsoft.com/office/drawing/2014/main" id="{DAC33E22-629F-A397-DCAE-F17C62702EDA}"/>
                    </a:ext>
                  </a:extLst>
                </p:cNvPr>
                <p:cNvSpPr/>
                <p:nvPr/>
              </p:nvSpPr>
              <p:spPr>
                <a:xfrm>
                  <a:off x="3543920" y="1083228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4" name="正方形/長方形 468">
                  <a:extLst>
                    <a:ext uri="{FF2B5EF4-FFF2-40B4-BE49-F238E27FC236}">
                      <a16:creationId xmlns:a16="http://schemas.microsoft.com/office/drawing/2014/main" id="{0DD90159-FA68-09F9-19E0-FA6A73D34C28}"/>
                    </a:ext>
                  </a:extLst>
                </p:cNvPr>
                <p:cNvSpPr/>
                <p:nvPr/>
              </p:nvSpPr>
              <p:spPr>
                <a:xfrm>
                  <a:off x="5142152" y="1171380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5" name="正方形/長方形 469">
                  <a:extLst>
                    <a:ext uri="{FF2B5EF4-FFF2-40B4-BE49-F238E27FC236}">
                      <a16:creationId xmlns:a16="http://schemas.microsoft.com/office/drawing/2014/main" id="{142C2B70-47BB-2352-86C5-25D53037B6EC}"/>
                    </a:ext>
                  </a:extLst>
                </p:cNvPr>
                <p:cNvSpPr/>
                <p:nvPr/>
              </p:nvSpPr>
              <p:spPr>
                <a:xfrm>
                  <a:off x="6738697" y="1216104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6" name="正方形/長方形 470">
                  <a:extLst>
                    <a:ext uri="{FF2B5EF4-FFF2-40B4-BE49-F238E27FC236}">
                      <a16:creationId xmlns:a16="http://schemas.microsoft.com/office/drawing/2014/main" id="{1B3A57D7-2642-E38E-7FE6-5A1DEA90C79D}"/>
                    </a:ext>
                  </a:extLst>
                </p:cNvPr>
                <p:cNvSpPr/>
                <p:nvPr/>
              </p:nvSpPr>
              <p:spPr>
                <a:xfrm>
                  <a:off x="8323636" y="1199954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7" name="正方形/長方形 471">
                  <a:extLst>
                    <a:ext uri="{FF2B5EF4-FFF2-40B4-BE49-F238E27FC236}">
                      <a16:creationId xmlns:a16="http://schemas.microsoft.com/office/drawing/2014/main" id="{4C652768-877D-8273-8C18-EA3B111D1D97}"/>
                    </a:ext>
                  </a:extLst>
                </p:cNvPr>
                <p:cNvSpPr/>
                <p:nvPr/>
              </p:nvSpPr>
              <p:spPr>
                <a:xfrm>
                  <a:off x="9927223" y="1184465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65" name="フリーフォーム: 図形 964">
                <a:extLst>
                  <a:ext uri="{FF2B5EF4-FFF2-40B4-BE49-F238E27FC236}">
                    <a16:creationId xmlns:a16="http://schemas.microsoft.com/office/drawing/2014/main" id="{E7CCCD78-ACA0-057F-25C9-7206F17074C3}"/>
                  </a:ext>
                </a:extLst>
              </p:cNvPr>
              <p:cNvSpPr/>
              <p:nvPr/>
            </p:nvSpPr>
            <p:spPr>
              <a:xfrm>
                <a:off x="3597136" y="4155051"/>
                <a:ext cx="4794251" cy="138114"/>
              </a:xfrm>
              <a:custGeom>
                <a:avLst/>
                <a:gdLst>
                  <a:gd name="connsiteX0" fmla="*/ 0 w 4786313"/>
                  <a:gd name="connsiteY0" fmla="*/ 0 h 195263"/>
                  <a:gd name="connsiteX1" fmla="*/ 1600200 w 4786313"/>
                  <a:gd name="connsiteY1" fmla="*/ 142875 h 195263"/>
                  <a:gd name="connsiteX2" fmla="*/ 3195638 w 4786313"/>
                  <a:gd name="connsiteY2" fmla="*/ 195263 h 195263"/>
                  <a:gd name="connsiteX3" fmla="*/ 4786313 w 4786313"/>
                  <a:gd name="connsiteY3" fmla="*/ 138113 h 195263"/>
                  <a:gd name="connsiteX0" fmla="*/ 0 w 4786313"/>
                  <a:gd name="connsiteY0" fmla="*/ 0 h 195263"/>
                  <a:gd name="connsiteX1" fmla="*/ 1600200 w 4786313"/>
                  <a:gd name="connsiteY1" fmla="*/ 142875 h 195263"/>
                  <a:gd name="connsiteX2" fmla="*/ 3198019 w 4786313"/>
                  <a:gd name="connsiteY2" fmla="*/ 195263 h 195263"/>
                  <a:gd name="connsiteX3" fmla="*/ 4786313 w 4786313"/>
                  <a:gd name="connsiteY3" fmla="*/ 138113 h 195263"/>
                  <a:gd name="connsiteX0" fmla="*/ 0 w 4786313"/>
                  <a:gd name="connsiteY0" fmla="*/ 0 h 195263"/>
                  <a:gd name="connsiteX1" fmla="*/ 1600200 w 4786313"/>
                  <a:gd name="connsiteY1" fmla="*/ 142875 h 195263"/>
                  <a:gd name="connsiteX2" fmla="*/ 3198019 w 4786313"/>
                  <a:gd name="connsiteY2" fmla="*/ 195263 h 195263"/>
                  <a:gd name="connsiteX3" fmla="*/ 4786313 w 4786313"/>
                  <a:gd name="connsiteY3" fmla="*/ 138113 h 195263"/>
                  <a:gd name="connsiteX0" fmla="*/ 0 w 4786313"/>
                  <a:gd name="connsiteY0" fmla="*/ 0 h 195263"/>
                  <a:gd name="connsiteX1" fmla="*/ 1600200 w 4786313"/>
                  <a:gd name="connsiteY1" fmla="*/ 66675 h 195263"/>
                  <a:gd name="connsiteX2" fmla="*/ 3198019 w 4786313"/>
                  <a:gd name="connsiteY2" fmla="*/ 195263 h 195263"/>
                  <a:gd name="connsiteX3" fmla="*/ 4786313 w 4786313"/>
                  <a:gd name="connsiteY3" fmla="*/ 138113 h 195263"/>
                  <a:gd name="connsiteX0" fmla="*/ 0 w 4786313"/>
                  <a:gd name="connsiteY0" fmla="*/ 0 h 138113"/>
                  <a:gd name="connsiteX1" fmla="*/ 1600200 w 4786313"/>
                  <a:gd name="connsiteY1" fmla="*/ 66675 h 138113"/>
                  <a:gd name="connsiteX2" fmla="*/ 3198019 w 4786313"/>
                  <a:gd name="connsiteY2" fmla="*/ 80963 h 138113"/>
                  <a:gd name="connsiteX3" fmla="*/ 4786313 w 4786313"/>
                  <a:gd name="connsiteY3" fmla="*/ 138113 h 138113"/>
                  <a:gd name="connsiteX0" fmla="*/ 0 w 4786313"/>
                  <a:gd name="connsiteY0" fmla="*/ 0 h 80963"/>
                  <a:gd name="connsiteX1" fmla="*/ 1600200 w 4786313"/>
                  <a:gd name="connsiteY1" fmla="*/ 66675 h 80963"/>
                  <a:gd name="connsiteX2" fmla="*/ 3198019 w 4786313"/>
                  <a:gd name="connsiteY2" fmla="*/ 80963 h 80963"/>
                  <a:gd name="connsiteX3" fmla="*/ 4786313 w 4786313"/>
                  <a:gd name="connsiteY3" fmla="*/ 74613 h 80963"/>
                  <a:gd name="connsiteX0" fmla="*/ 0 w 4799013"/>
                  <a:gd name="connsiteY0" fmla="*/ 0 h 100013"/>
                  <a:gd name="connsiteX1" fmla="*/ 1612900 w 4799013"/>
                  <a:gd name="connsiteY1" fmla="*/ 85725 h 100013"/>
                  <a:gd name="connsiteX2" fmla="*/ 3210719 w 4799013"/>
                  <a:gd name="connsiteY2" fmla="*/ 100013 h 100013"/>
                  <a:gd name="connsiteX3" fmla="*/ 4799013 w 4799013"/>
                  <a:gd name="connsiteY3" fmla="*/ 93663 h 100013"/>
                  <a:gd name="connsiteX0" fmla="*/ 0 w 4799013"/>
                  <a:gd name="connsiteY0" fmla="*/ 0 h 133350"/>
                  <a:gd name="connsiteX1" fmla="*/ 1612900 w 4799013"/>
                  <a:gd name="connsiteY1" fmla="*/ 85725 h 133350"/>
                  <a:gd name="connsiteX2" fmla="*/ 3225007 w 4799013"/>
                  <a:gd name="connsiteY2" fmla="*/ 133350 h 133350"/>
                  <a:gd name="connsiteX3" fmla="*/ 4799013 w 4799013"/>
                  <a:gd name="connsiteY3" fmla="*/ 93663 h 133350"/>
                  <a:gd name="connsiteX0" fmla="*/ 0 w 4799013"/>
                  <a:gd name="connsiteY0" fmla="*/ 0 h 133350"/>
                  <a:gd name="connsiteX1" fmla="*/ 1612900 w 4799013"/>
                  <a:gd name="connsiteY1" fmla="*/ 85725 h 133350"/>
                  <a:gd name="connsiteX2" fmla="*/ 3225007 w 4799013"/>
                  <a:gd name="connsiteY2" fmla="*/ 133350 h 133350"/>
                  <a:gd name="connsiteX3" fmla="*/ 4799013 w 4799013"/>
                  <a:gd name="connsiteY3" fmla="*/ 107950 h 133350"/>
                  <a:gd name="connsiteX0" fmla="*/ 0 w 4799013"/>
                  <a:gd name="connsiteY0" fmla="*/ 0 h 133350"/>
                  <a:gd name="connsiteX1" fmla="*/ 1612900 w 4799013"/>
                  <a:gd name="connsiteY1" fmla="*/ 85725 h 133350"/>
                  <a:gd name="connsiteX2" fmla="*/ 3225007 w 4799013"/>
                  <a:gd name="connsiteY2" fmla="*/ 133350 h 133350"/>
                  <a:gd name="connsiteX3" fmla="*/ 4799013 w 4799013"/>
                  <a:gd name="connsiteY3" fmla="*/ 107950 h 133350"/>
                  <a:gd name="connsiteX0" fmla="*/ 0 w 4799013"/>
                  <a:gd name="connsiteY0" fmla="*/ 0 h 133350"/>
                  <a:gd name="connsiteX1" fmla="*/ 1612900 w 4799013"/>
                  <a:gd name="connsiteY1" fmla="*/ 85725 h 133350"/>
                  <a:gd name="connsiteX2" fmla="*/ 3225007 w 4799013"/>
                  <a:gd name="connsiteY2" fmla="*/ 133350 h 133350"/>
                  <a:gd name="connsiteX3" fmla="*/ 4799013 w 4799013"/>
                  <a:gd name="connsiteY3" fmla="*/ 107950 h 133350"/>
                  <a:gd name="connsiteX0" fmla="*/ 0 w 4799013"/>
                  <a:gd name="connsiteY0" fmla="*/ 0 h 133350"/>
                  <a:gd name="connsiteX1" fmla="*/ 1612900 w 4799013"/>
                  <a:gd name="connsiteY1" fmla="*/ 85725 h 133350"/>
                  <a:gd name="connsiteX2" fmla="*/ 3225007 w 4799013"/>
                  <a:gd name="connsiteY2" fmla="*/ 133350 h 133350"/>
                  <a:gd name="connsiteX3" fmla="*/ 4799013 w 4799013"/>
                  <a:gd name="connsiteY3" fmla="*/ 107950 h 133350"/>
                  <a:gd name="connsiteX0" fmla="*/ 0 w 4770438"/>
                  <a:gd name="connsiteY0" fmla="*/ 0 h 138113"/>
                  <a:gd name="connsiteX1" fmla="*/ 1584325 w 4770438"/>
                  <a:gd name="connsiteY1" fmla="*/ 90488 h 138113"/>
                  <a:gd name="connsiteX2" fmla="*/ 3196432 w 4770438"/>
                  <a:gd name="connsiteY2" fmla="*/ 138113 h 138113"/>
                  <a:gd name="connsiteX3" fmla="*/ 4770438 w 4770438"/>
                  <a:gd name="connsiteY3" fmla="*/ 112713 h 138113"/>
                  <a:gd name="connsiteX0" fmla="*/ 0 w 4789488"/>
                  <a:gd name="connsiteY0" fmla="*/ 0 h 133351"/>
                  <a:gd name="connsiteX1" fmla="*/ 1603375 w 4789488"/>
                  <a:gd name="connsiteY1" fmla="*/ 85726 h 133351"/>
                  <a:gd name="connsiteX2" fmla="*/ 3215482 w 4789488"/>
                  <a:gd name="connsiteY2" fmla="*/ 133351 h 133351"/>
                  <a:gd name="connsiteX3" fmla="*/ 4789488 w 4789488"/>
                  <a:gd name="connsiteY3" fmla="*/ 107951 h 133351"/>
                  <a:gd name="connsiteX0" fmla="*/ 0 w 4779963"/>
                  <a:gd name="connsiteY0" fmla="*/ 0 h 133351"/>
                  <a:gd name="connsiteX1" fmla="*/ 1593850 w 4779963"/>
                  <a:gd name="connsiteY1" fmla="*/ 85726 h 133351"/>
                  <a:gd name="connsiteX2" fmla="*/ 3205957 w 4779963"/>
                  <a:gd name="connsiteY2" fmla="*/ 133351 h 133351"/>
                  <a:gd name="connsiteX3" fmla="*/ 4779963 w 4779963"/>
                  <a:gd name="connsiteY3" fmla="*/ 107951 h 133351"/>
                  <a:gd name="connsiteX0" fmla="*/ 0 w 4789488"/>
                  <a:gd name="connsiteY0" fmla="*/ 0 h 138114"/>
                  <a:gd name="connsiteX1" fmla="*/ 1603375 w 4789488"/>
                  <a:gd name="connsiteY1" fmla="*/ 90489 h 138114"/>
                  <a:gd name="connsiteX2" fmla="*/ 3215482 w 4789488"/>
                  <a:gd name="connsiteY2" fmla="*/ 138114 h 138114"/>
                  <a:gd name="connsiteX3" fmla="*/ 4789488 w 4789488"/>
                  <a:gd name="connsiteY3" fmla="*/ 112714 h 138114"/>
                  <a:gd name="connsiteX0" fmla="*/ 0 w 4799013"/>
                  <a:gd name="connsiteY0" fmla="*/ 0 h 138114"/>
                  <a:gd name="connsiteX1" fmla="*/ 1603375 w 4799013"/>
                  <a:gd name="connsiteY1" fmla="*/ 90489 h 138114"/>
                  <a:gd name="connsiteX2" fmla="*/ 3215482 w 4799013"/>
                  <a:gd name="connsiteY2" fmla="*/ 138114 h 138114"/>
                  <a:gd name="connsiteX3" fmla="*/ 4799013 w 4799013"/>
                  <a:gd name="connsiteY3" fmla="*/ 103189 h 138114"/>
                  <a:gd name="connsiteX0" fmla="*/ 0 w 4799013"/>
                  <a:gd name="connsiteY0" fmla="*/ 0 h 138114"/>
                  <a:gd name="connsiteX1" fmla="*/ 1603375 w 4799013"/>
                  <a:gd name="connsiteY1" fmla="*/ 90489 h 138114"/>
                  <a:gd name="connsiteX2" fmla="*/ 3215482 w 4799013"/>
                  <a:gd name="connsiteY2" fmla="*/ 138114 h 138114"/>
                  <a:gd name="connsiteX3" fmla="*/ 4799013 w 4799013"/>
                  <a:gd name="connsiteY3" fmla="*/ 103189 h 138114"/>
                  <a:gd name="connsiteX0" fmla="*/ 0 w 4794251"/>
                  <a:gd name="connsiteY0" fmla="*/ 0 h 138114"/>
                  <a:gd name="connsiteX1" fmla="*/ 1603375 w 4794251"/>
                  <a:gd name="connsiteY1" fmla="*/ 90489 h 138114"/>
                  <a:gd name="connsiteX2" fmla="*/ 3215482 w 4794251"/>
                  <a:gd name="connsiteY2" fmla="*/ 138114 h 138114"/>
                  <a:gd name="connsiteX3" fmla="*/ 4794251 w 4794251"/>
                  <a:gd name="connsiteY3" fmla="*/ 117476 h 1381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94251" h="138114">
                    <a:moveTo>
                      <a:pt x="0" y="0"/>
                    </a:moveTo>
                    <a:lnTo>
                      <a:pt x="1603375" y="90489"/>
                    </a:lnTo>
                    <a:lnTo>
                      <a:pt x="3215482" y="138114"/>
                    </a:lnTo>
                    <a:lnTo>
                      <a:pt x="4794251" y="117476"/>
                    </a:lnTo>
                  </a:path>
                </a:pathLst>
              </a:custGeom>
              <a:noFill/>
              <a:ln w="38100">
                <a:solidFill>
                  <a:srgbClr val="0000FF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2CDA7E4E-A25A-F4BC-9028-4A7CC449D10A}"/>
                </a:ext>
              </a:extLst>
            </p:cNvPr>
            <p:cNvGrpSpPr/>
            <p:nvPr/>
          </p:nvGrpSpPr>
          <p:grpSpPr>
            <a:xfrm>
              <a:off x="3369375" y="3626414"/>
              <a:ext cx="6568575" cy="1309831"/>
              <a:chOff x="3369375" y="3626414"/>
              <a:chExt cx="6568575" cy="1309831"/>
            </a:xfrm>
          </p:grpSpPr>
          <p:grpSp>
            <p:nvGrpSpPr>
              <p:cNvPr id="23" name="グループ化 22">
                <a:extLst>
                  <a:ext uri="{FF2B5EF4-FFF2-40B4-BE49-F238E27FC236}">
                    <a16:creationId xmlns:a16="http://schemas.microsoft.com/office/drawing/2014/main" id="{7EA94A55-35D1-D786-B774-2B7EF14A05DE}"/>
                  </a:ext>
                </a:extLst>
              </p:cNvPr>
              <p:cNvGrpSpPr/>
              <p:nvPr/>
            </p:nvGrpSpPr>
            <p:grpSpPr>
              <a:xfrm>
                <a:off x="3387375" y="3626414"/>
                <a:ext cx="6550575" cy="1309831"/>
                <a:chOff x="3397040" y="3724274"/>
                <a:chExt cx="6550575" cy="1309831"/>
              </a:xfrm>
            </p:grpSpPr>
            <p:grpSp>
              <p:nvGrpSpPr>
                <p:cNvPr id="316" name="グループ化 315">
                  <a:extLst>
                    <a:ext uri="{FF2B5EF4-FFF2-40B4-BE49-F238E27FC236}">
                      <a16:creationId xmlns:a16="http://schemas.microsoft.com/office/drawing/2014/main" id="{0D5A0056-36C6-B384-C6C8-5C8421899897}"/>
                    </a:ext>
                  </a:extLst>
                </p:cNvPr>
                <p:cNvGrpSpPr/>
                <p:nvPr/>
              </p:nvGrpSpPr>
              <p:grpSpPr>
                <a:xfrm>
                  <a:off x="3397040" y="3724274"/>
                  <a:ext cx="108000" cy="788195"/>
                  <a:chOff x="3181267" y="2597151"/>
                  <a:chExt cx="108000" cy="2157062"/>
                </a:xfrm>
              </p:grpSpPr>
              <p:cxnSp>
                <p:nvCxnSpPr>
                  <p:cNvPr id="337" name="直線コネクタ 336">
                    <a:extLst>
                      <a:ext uri="{FF2B5EF4-FFF2-40B4-BE49-F238E27FC236}">
                        <a16:creationId xmlns:a16="http://schemas.microsoft.com/office/drawing/2014/main" id="{3B8DF1D0-EEF0-3336-6E26-78775A1893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8" name="直線コネクタ 337">
                    <a:extLst>
                      <a:ext uri="{FF2B5EF4-FFF2-40B4-BE49-F238E27FC236}">
                        <a16:creationId xmlns:a16="http://schemas.microsoft.com/office/drawing/2014/main" id="{CB939314-1406-BB48-1C2A-07292FCA02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9" name="直線コネクタ 338">
                    <a:extLst>
                      <a:ext uri="{FF2B5EF4-FFF2-40B4-BE49-F238E27FC236}">
                        <a16:creationId xmlns:a16="http://schemas.microsoft.com/office/drawing/2014/main" id="{3569C6D5-F913-C6E0-1259-7E15973B9B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7" name="グループ化 316">
                  <a:extLst>
                    <a:ext uri="{FF2B5EF4-FFF2-40B4-BE49-F238E27FC236}">
                      <a16:creationId xmlns:a16="http://schemas.microsoft.com/office/drawing/2014/main" id="{AB8E537D-D02D-F251-9826-88D942CDD4A1}"/>
                    </a:ext>
                  </a:extLst>
                </p:cNvPr>
                <p:cNvGrpSpPr/>
                <p:nvPr/>
              </p:nvGrpSpPr>
              <p:grpSpPr>
                <a:xfrm>
                  <a:off x="4995272" y="3872708"/>
                  <a:ext cx="108000" cy="819973"/>
                  <a:chOff x="3181267" y="2366600"/>
                  <a:chExt cx="108000" cy="2290072"/>
                </a:xfrm>
              </p:grpSpPr>
              <p:cxnSp>
                <p:nvCxnSpPr>
                  <p:cNvPr id="334" name="直線コネクタ 333">
                    <a:extLst>
                      <a:ext uri="{FF2B5EF4-FFF2-40B4-BE49-F238E27FC236}">
                        <a16:creationId xmlns:a16="http://schemas.microsoft.com/office/drawing/2014/main" id="{43E14036-87C4-08D7-BCF2-898A2ADEA5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366600"/>
                    <a:ext cx="0" cy="229007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5" name="直線コネクタ 334">
                    <a:extLst>
                      <a:ext uri="{FF2B5EF4-FFF2-40B4-BE49-F238E27FC236}">
                        <a16:creationId xmlns:a16="http://schemas.microsoft.com/office/drawing/2014/main" id="{96B1B408-9B2D-B804-5F7B-F788B3809E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656672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6" name="直線コネクタ 335">
                    <a:extLst>
                      <a:ext uri="{FF2B5EF4-FFF2-40B4-BE49-F238E27FC236}">
                        <a16:creationId xmlns:a16="http://schemas.microsoft.com/office/drawing/2014/main" id="{D4E1099E-3279-F4CD-CB9D-B12EDA42DDC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366600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8" name="グループ化 317">
                  <a:extLst>
                    <a:ext uri="{FF2B5EF4-FFF2-40B4-BE49-F238E27FC236}">
                      <a16:creationId xmlns:a16="http://schemas.microsoft.com/office/drawing/2014/main" id="{DC787F01-29C1-887F-DC51-8E673333A5CB}"/>
                    </a:ext>
                  </a:extLst>
                </p:cNvPr>
                <p:cNvGrpSpPr/>
                <p:nvPr/>
              </p:nvGrpSpPr>
              <p:grpSpPr>
                <a:xfrm>
                  <a:off x="6591817" y="3907171"/>
                  <a:ext cx="108000" cy="910098"/>
                  <a:chOff x="3181267" y="2542341"/>
                  <a:chExt cx="108000" cy="2327584"/>
                </a:xfrm>
              </p:grpSpPr>
              <p:cxnSp>
                <p:nvCxnSpPr>
                  <p:cNvPr id="331" name="直線コネクタ 330">
                    <a:extLst>
                      <a:ext uri="{FF2B5EF4-FFF2-40B4-BE49-F238E27FC236}">
                        <a16:creationId xmlns:a16="http://schemas.microsoft.com/office/drawing/2014/main" id="{F5636C61-02D1-BD55-B166-7DC36432D1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42341"/>
                    <a:ext cx="0" cy="2323269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2" name="直線コネクタ 331">
                    <a:extLst>
                      <a:ext uri="{FF2B5EF4-FFF2-40B4-BE49-F238E27FC236}">
                        <a16:creationId xmlns:a16="http://schemas.microsoft.com/office/drawing/2014/main" id="{F2F087B7-626C-029A-CF8B-9B70346597D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869925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3" name="直線コネクタ 332">
                    <a:extLst>
                      <a:ext uri="{FF2B5EF4-FFF2-40B4-BE49-F238E27FC236}">
                        <a16:creationId xmlns:a16="http://schemas.microsoft.com/office/drawing/2014/main" id="{282BD06E-5522-8078-F7FB-D3058844A9A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4234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81C759D9-656B-3E87-CF2D-FBA167757B97}"/>
                    </a:ext>
                  </a:extLst>
                </p:cNvPr>
                <p:cNvGrpSpPr/>
                <p:nvPr/>
              </p:nvGrpSpPr>
              <p:grpSpPr>
                <a:xfrm>
                  <a:off x="8125122" y="3814764"/>
                  <a:ext cx="211596" cy="1219341"/>
                  <a:chOff x="8125122" y="3814764"/>
                  <a:chExt cx="211596" cy="1219341"/>
                </a:xfrm>
              </p:grpSpPr>
              <p:grpSp>
                <p:nvGrpSpPr>
                  <p:cNvPr id="326" name="グループ化 325">
                    <a:extLst>
                      <a:ext uri="{FF2B5EF4-FFF2-40B4-BE49-F238E27FC236}">
                        <a16:creationId xmlns:a16="http://schemas.microsoft.com/office/drawing/2014/main" id="{5ACEB7E4-D862-B8C2-C97D-664E48FED92D}"/>
                      </a:ext>
                    </a:extLst>
                  </p:cNvPr>
                  <p:cNvGrpSpPr/>
                  <p:nvPr/>
                </p:nvGrpSpPr>
                <p:grpSpPr>
                  <a:xfrm>
                    <a:off x="8174558" y="3814764"/>
                    <a:ext cx="108000" cy="935366"/>
                    <a:chOff x="3181267" y="2728678"/>
                    <a:chExt cx="108000" cy="1913495"/>
                  </a:xfrm>
                </p:grpSpPr>
                <p:cxnSp>
                  <p:nvCxnSpPr>
                    <p:cNvPr id="328" name="直線コネクタ 327">
                      <a:extLst>
                        <a:ext uri="{FF2B5EF4-FFF2-40B4-BE49-F238E27FC236}">
                          <a16:creationId xmlns:a16="http://schemas.microsoft.com/office/drawing/2014/main" id="{6866977B-AAD4-19B2-BD49-D271754AA69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728678"/>
                      <a:ext cx="0" cy="1913495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9" name="直線コネクタ 328">
                      <a:extLst>
                        <a:ext uri="{FF2B5EF4-FFF2-40B4-BE49-F238E27FC236}">
                          <a16:creationId xmlns:a16="http://schemas.microsoft.com/office/drawing/2014/main" id="{0A14D658-11B3-D632-9975-C02EAD01581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64217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0" name="直線コネクタ 329">
                      <a:extLst>
                        <a:ext uri="{FF2B5EF4-FFF2-40B4-BE49-F238E27FC236}">
                          <a16:creationId xmlns:a16="http://schemas.microsoft.com/office/drawing/2014/main" id="{25731DF2-E3BD-DCA9-A17B-7EA030C05DF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728678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" name="テキスト ボックス 11">
                    <a:extLst>
                      <a:ext uri="{FF2B5EF4-FFF2-40B4-BE49-F238E27FC236}">
                        <a16:creationId xmlns:a16="http://schemas.microsoft.com/office/drawing/2014/main" id="{342481A7-50DB-5744-3009-E69C25524ACC}"/>
                      </a:ext>
                    </a:extLst>
                  </p:cNvPr>
                  <p:cNvSpPr txBox="1"/>
                  <p:nvPr/>
                </p:nvSpPr>
                <p:spPr>
                  <a:xfrm>
                    <a:off x="8125122" y="4782310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  <p:grpSp>
              <p:nvGrpSpPr>
                <p:cNvPr id="18" name="グループ化 17">
                  <a:extLst>
                    <a:ext uri="{FF2B5EF4-FFF2-40B4-BE49-F238E27FC236}">
                      <a16:creationId xmlns:a16="http://schemas.microsoft.com/office/drawing/2014/main" id="{30EF1738-28B0-8615-5D48-2CE19749F8D9}"/>
                    </a:ext>
                  </a:extLst>
                </p:cNvPr>
                <p:cNvGrpSpPr/>
                <p:nvPr/>
              </p:nvGrpSpPr>
              <p:grpSpPr>
                <a:xfrm>
                  <a:off x="9736019" y="3886200"/>
                  <a:ext cx="211596" cy="1100473"/>
                  <a:chOff x="9736019" y="3886200"/>
                  <a:chExt cx="211596" cy="1100473"/>
                </a:xfrm>
              </p:grpSpPr>
              <p:grpSp>
                <p:nvGrpSpPr>
                  <p:cNvPr id="321" name="グループ化 320">
                    <a:extLst>
                      <a:ext uri="{FF2B5EF4-FFF2-40B4-BE49-F238E27FC236}">
                        <a16:creationId xmlns:a16="http://schemas.microsoft.com/office/drawing/2014/main" id="{15A76B1E-BFA0-5BD0-2AD7-8FD1A1AB3134}"/>
                      </a:ext>
                    </a:extLst>
                  </p:cNvPr>
                  <p:cNvGrpSpPr/>
                  <p:nvPr/>
                </p:nvGrpSpPr>
                <p:grpSpPr>
                  <a:xfrm>
                    <a:off x="9778960" y="3886200"/>
                    <a:ext cx="108000" cy="873919"/>
                    <a:chOff x="3181267" y="2701122"/>
                    <a:chExt cx="108000" cy="1907860"/>
                  </a:xfrm>
                </p:grpSpPr>
                <p:cxnSp>
                  <p:nvCxnSpPr>
                    <p:cNvPr id="323" name="直線コネクタ 322">
                      <a:extLst>
                        <a:ext uri="{FF2B5EF4-FFF2-40B4-BE49-F238E27FC236}">
                          <a16:creationId xmlns:a16="http://schemas.microsoft.com/office/drawing/2014/main" id="{A05C587F-7C0E-BFB6-FA9A-E931429EAE8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701122"/>
                      <a:ext cx="0" cy="190786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4" name="直線コネクタ 323">
                      <a:extLst>
                        <a:ext uri="{FF2B5EF4-FFF2-40B4-BE49-F238E27FC236}">
                          <a16:creationId xmlns:a16="http://schemas.microsoft.com/office/drawing/2014/main" id="{2AAAF2A2-4F16-AB65-151E-16D147D7D8F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598258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5" name="直線コネクタ 324">
                      <a:extLst>
                        <a:ext uri="{FF2B5EF4-FFF2-40B4-BE49-F238E27FC236}">
                          <a16:creationId xmlns:a16="http://schemas.microsoft.com/office/drawing/2014/main" id="{DD9EFE6A-58C1-3D42-A96C-11DE827BAF3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70112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" name="テキスト ボックス 12">
                    <a:extLst>
                      <a:ext uri="{FF2B5EF4-FFF2-40B4-BE49-F238E27FC236}">
                        <a16:creationId xmlns:a16="http://schemas.microsoft.com/office/drawing/2014/main" id="{3BE8F4B5-64DD-880F-3532-AC627B212104}"/>
                      </a:ext>
                    </a:extLst>
                  </p:cNvPr>
                  <p:cNvSpPr txBox="1"/>
                  <p:nvPr/>
                </p:nvSpPr>
                <p:spPr>
                  <a:xfrm>
                    <a:off x="9736019" y="4734878"/>
                    <a:ext cx="211596" cy="2517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lIns="0" tIns="36000" rIns="0" bIns="0" anchor="t">
                    <a:spAutoFit/>
                  </a:bodyPr>
                  <a:lstStyle>
                    <a:defPPr>
                      <a:defRPr lang="ja-JP"/>
                    </a:defPPr>
                    <a:lvl1pPr lvl="0" indent="0" algn="ctr">
                      <a:spcBef>
                        <a:spcPct val="0"/>
                      </a:spcBef>
                      <a:buNone/>
                      <a:defRPr sz="900" b="1" kern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Meiryo UI"/>
                        <a:cs typeface="Arial" panose="020B0604020202020204" pitchFamily="34" charset="0"/>
                      </a:defRPr>
                    </a:lvl1pPr>
                    <a:lvl2pPr indent="0">
                      <a:defRPr sz="1100"/>
                    </a:lvl2pPr>
                    <a:lvl3pPr indent="0">
                      <a:defRPr sz="1100"/>
                    </a:lvl3pPr>
                    <a:lvl4pPr indent="0">
                      <a:defRPr sz="1100"/>
                    </a:lvl4pPr>
                    <a:lvl5pPr indent="0">
                      <a:defRPr sz="1100"/>
                    </a:lvl5pPr>
                    <a:lvl6pPr indent="0">
                      <a:defRPr sz="1100"/>
                    </a:lvl6pPr>
                    <a:lvl7pPr indent="0">
                      <a:defRPr sz="1100"/>
                    </a:lvl7pPr>
                    <a:lvl8pPr indent="0">
                      <a:defRPr sz="1100"/>
                    </a:lvl8pPr>
                    <a:lvl9pPr indent="0">
                      <a:defRPr sz="1100"/>
                    </a:lvl9pPr>
                  </a:lstStyle>
                  <a:p>
                    <a:r>
                      <a:rPr lang="en-US" altLang="ja-JP" sz="1400" dirty="0"/>
                      <a:t>***</a:t>
                    </a:r>
                  </a:p>
                </p:txBody>
              </p:sp>
            </p:grpSp>
          </p:grpSp>
          <p:grpSp>
            <p:nvGrpSpPr>
              <p:cNvPr id="309" name="グループ化 308">
                <a:extLst>
                  <a:ext uri="{FF2B5EF4-FFF2-40B4-BE49-F238E27FC236}">
                    <a16:creationId xmlns:a16="http://schemas.microsoft.com/office/drawing/2014/main" id="{DAC1EF39-8505-8742-778F-03FFC399DDFF}"/>
                  </a:ext>
                </a:extLst>
              </p:cNvPr>
              <p:cNvGrpSpPr/>
              <p:nvPr/>
            </p:nvGrpSpPr>
            <p:grpSpPr>
              <a:xfrm>
                <a:off x="3369375" y="3947455"/>
                <a:ext cx="6527303" cy="375609"/>
                <a:chOff x="3370040" y="752874"/>
                <a:chExt cx="6527303" cy="375609"/>
              </a:xfrm>
            </p:grpSpPr>
            <p:sp>
              <p:nvSpPr>
                <p:cNvPr id="311" name="楕円 310">
                  <a:extLst>
                    <a:ext uri="{FF2B5EF4-FFF2-40B4-BE49-F238E27FC236}">
                      <a16:creationId xmlns:a16="http://schemas.microsoft.com/office/drawing/2014/main" id="{54E993DD-E7C7-A0EE-2293-57D210F03906}"/>
                    </a:ext>
                  </a:extLst>
                </p:cNvPr>
                <p:cNvSpPr/>
                <p:nvPr/>
              </p:nvSpPr>
              <p:spPr>
                <a:xfrm>
                  <a:off x="3370040" y="752874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2" name="楕円 311">
                  <a:extLst>
                    <a:ext uri="{FF2B5EF4-FFF2-40B4-BE49-F238E27FC236}">
                      <a16:creationId xmlns:a16="http://schemas.microsoft.com/office/drawing/2014/main" id="{7E8DF4DF-EA45-D221-EA6D-937B704DFEB5}"/>
                    </a:ext>
                  </a:extLst>
                </p:cNvPr>
                <p:cNvSpPr/>
                <p:nvPr/>
              </p:nvSpPr>
              <p:spPr>
                <a:xfrm>
                  <a:off x="4968272" y="927529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3" name="楕円 312">
                  <a:extLst>
                    <a:ext uri="{FF2B5EF4-FFF2-40B4-BE49-F238E27FC236}">
                      <a16:creationId xmlns:a16="http://schemas.microsoft.com/office/drawing/2014/main" id="{CB780ADE-3864-BF21-EFB6-97681420C54E}"/>
                    </a:ext>
                  </a:extLst>
                </p:cNvPr>
                <p:cNvSpPr/>
                <p:nvPr/>
              </p:nvSpPr>
              <p:spPr>
                <a:xfrm>
                  <a:off x="6564817" y="984483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4" name="楕円 313">
                  <a:extLst>
                    <a:ext uri="{FF2B5EF4-FFF2-40B4-BE49-F238E27FC236}">
                      <a16:creationId xmlns:a16="http://schemas.microsoft.com/office/drawing/2014/main" id="{6F2EE5C1-DBB6-D0FC-15AB-FDF52AB9078F}"/>
                    </a:ext>
                  </a:extLst>
                </p:cNvPr>
                <p:cNvSpPr/>
                <p:nvPr/>
              </p:nvSpPr>
              <p:spPr>
                <a:xfrm>
                  <a:off x="8149756" y="909498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5" name="楕円 314">
                  <a:extLst>
                    <a:ext uri="{FF2B5EF4-FFF2-40B4-BE49-F238E27FC236}">
                      <a16:creationId xmlns:a16="http://schemas.microsoft.com/office/drawing/2014/main" id="{17CE697F-A7B7-6A04-D367-DE61D4B1A18B}"/>
                    </a:ext>
                  </a:extLst>
                </p:cNvPr>
                <p:cNvSpPr/>
                <p:nvPr/>
              </p:nvSpPr>
              <p:spPr>
                <a:xfrm>
                  <a:off x="9753343" y="960243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60" name="フリーフォーム: 図形 959">
                <a:extLst>
                  <a:ext uri="{FF2B5EF4-FFF2-40B4-BE49-F238E27FC236}">
                    <a16:creationId xmlns:a16="http://schemas.microsoft.com/office/drawing/2014/main" id="{6509170C-2D68-41AB-60EB-96C02F21B1EF}"/>
                  </a:ext>
                </a:extLst>
              </p:cNvPr>
              <p:cNvSpPr/>
              <p:nvPr/>
            </p:nvSpPr>
            <p:spPr>
              <a:xfrm>
                <a:off x="3438385" y="4021703"/>
                <a:ext cx="4776788" cy="226218"/>
              </a:xfrm>
              <a:custGeom>
                <a:avLst/>
                <a:gdLst>
                  <a:gd name="connsiteX0" fmla="*/ 0 w 5834063"/>
                  <a:gd name="connsiteY0" fmla="*/ 0 h 442912"/>
                  <a:gd name="connsiteX1" fmla="*/ 1600200 w 5834063"/>
                  <a:gd name="connsiteY1" fmla="*/ 223837 h 442912"/>
                  <a:gd name="connsiteX2" fmla="*/ 3195638 w 5834063"/>
                  <a:gd name="connsiteY2" fmla="*/ 223837 h 442912"/>
                  <a:gd name="connsiteX3" fmla="*/ 4776788 w 5834063"/>
                  <a:gd name="connsiteY3" fmla="*/ 152400 h 442912"/>
                  <a:gd name="connsiteX4" fmla="*/ 5834063 w 5834063"/>
                  <a:gd name="connsiteY4" fmla="*/ 442912 h 442912"/>
                  <a:gd name="connsiteX0" fmla="*/ 0 w 4776788"/>
                  <a:gd name="connsiteY0" fmla="*/ 0 h 223837"/>
                  <a:gd name="connsiteX1" fmla="*/ 1600200 w 4776788"/>
                  <a:gd name="connsiteY1" fmla="*/ 223837 h 223837"/>
                  <a:gd name="connsiteX2" fmla="*/ 3195638 w 4776788"/>
                  <a:gd name="connsiteY2" fmla="*/ 223837 h 223837"/>
                  <a:gd name="connsiteX3" fmla="*/ 4776788 w 4776788"/>
                  <a:gd name="connsiteY3" fmla="*/ 152400 h 223837"/>
                  <a:gd name="connsiteX0" fmla="*/ 0 w 4776788"/>
                  <a:gd name="connsiteY0" fmla="*/ 0 h 226218"/>
                  <a:gd name="connsiteX1" fmla="*/ 1600200 w 4776788"/>
                  <a:gd name="connsiteY1" fmla="*/ 223837 h 226218"/>
                  <a:gd name="connsiteX2" fmla="*/ 3195638 w 4776788"/>
                  <a:gd name="connsiteY2" fmla="*/ 226218 h 226218"/>
                  <a:gd name="connsiteX3" fmla="*/ 4776788 w 4776788"/>
                  <a:gd name="connsiteY3" fmla="*/ 152400 h 226218"/>
                  <a:gd name="connsiteX0" fmla="*/ 0 w 4776788"/>
                  <a:gd name="connsiteY0" fmla="*/ 0 h 226218"/>
                  <a:gd name="connsiteX1" fmla="*/ 1600200 w 4776788"/>
                  <a:gd name="connsiteY1" fmla="*/ 221456 h 226218"/>
                  <a:gd name="connsiteX2" fmla="*/ 3195638 w 4776788"/>
                  <a:gd name="connsiteY2" fmla="*/ 226218 h 226218"/>
                  <a:gd name="connsiteX3" fmla="*/ 4776788 w 4776788"/>
                  <a:gd name="connsiteY3" fmla="*/ 152400 h 226218"/>
                  <a:gd name="connsiteX0" fmla="*/ 0 w 4776788"/>
                  <a:gd name="connsiteY0" fmla="*/ 0 h 226218"/>
                  <a:gd name="connsiteX1" fmla="*/ 1592580 w 4776788"/>
                  <a:gd name="connsiteY1" fmla="*/ 175736 h 226218"/>
                  <a:gd name="connsiteX2" fmla="*/ 3195638 w 4776788"/>
                  <a:gd name="connsiteY2" fmla="*/ 226218 h 226218"/>
                  <a:gd name="connsiteX3" fmla="*/ 4776788 w 4776788"/>
                  <a:gd name="connsiteY3" fmla="*/ 152400 h 226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76788" h="226218">
                    <a:moveTo>
                      <a:pt x="0" y="0"/>
                    </a:moveTo>
                    <a:lnTo>
                      <a:pt x="1592580" y="175736"/>
                    </a:lnTo>
                    <a:lnTo>
                      <a:pt x="3195638" y="226218"/>
                    </a:lnTo>
                    <a:lnTo>
                      <a:pt x="4776788" y="152400"/>
                    </a:lnTo>
                  </a:path>
                </a:pathLst>
              </a:custGeom>
              <a:noFill/>
              <a:ln w="38100"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93613ABF-2A74-12A9-8957-747D502B0AC6}"/>
              </a:ext>
            </a:extLst>
          </p:cNvPr>
          <p:cNvGrpSpPr/>
          <p:nvPr/>
        </p:nvGrpSpPr>
        <p:grpSpPr>
          <a:xfrm>
            <a:off x="3212287" y="3826196"/>
            <a:ext cx="6551693" cy="1027445"/>
            <a:chOff x="3212287" y="3826196"/>
            <a:chExt cx="6551693" cy="1027445"/>
          </a:xfrm>
        </p:grpSpPr>
        <p:grpSp>
          <p:nvGrpSpPr>
            <p:cNvPr id="373" name="グループ化 372">
              <a:extLst>
                <a:ext uri="{FF2B5EF4-FFF2-40B4-BE49-F238E27FC236}">
                  <a16:creationId xmlns:a16="http://schemas.microsoft.com/office/drawing/2014/main" id="{7E59515B-6F96-6C02-6E1B-8EE8FFDFF271}"/>
                </a:ext>
              </a:extLst>
            </p:cNvPr>
            <p:cNvGrpSpPr/>
            <p:nvPr/>
          </p:nvGrpSpPr>
          <p:grpSpPr>
            <a:xfrm>
              <a:off x="3212287" y="4031321"/>
              <a:ext cx="6543381" cy="316617"/>
              <a:chOff x="3212952" y="3344991"/>
              <a:chExt cx="6543381" cy="316617"/>
            </a:xfrm>
            <a:solidFill>
              <a:schemeClr val="tx1"/>
            </a:solidFill>
          </p:grpSpPr>
          <p:sp>
            <p:nvSpPr>
              <p:cNvPr id="375" name="楕円 374">
                <a:extLst>
                  <a:ext uri="{FF2B5EF4-FFF2-40B4-BE49-F238E27FC236}">
                    <a16:creationId xmlns:a16="http://schemas.microsoft.com/office/drawing/2014/main" id="{2F5AE129-B67B-6AEF-C572-5BE6B4D9E3C5}"/>
                  </a:ext>
                </a:extLst>
              </p:cNvPr>
              <p:cNvSpPr/>
              <p:nvPr/>
            </p:nvSpPr>
            <p:spPr>
              <a:xfrm>
                <a:off x="3212952" y="3344991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6" name="楕円 375">
                <a:extLst>
                  <a:ext uri="{FF2B5EF4-FFF2-40B4-BE49-F238E27FC236}">
                    <a16:creationId xmlns:a16="http://schemas.microsoft.com/office/drawing/2014/main" id="{C80D8EF8-1324-39FD-CE72-EE9D452840CC}"/>
                  </a:ext>
                </a:extLst>
              </p:cNvPr>
              <p:cNvSpPr/>
              <p:nvPr/>
            </p:nvSpPr>
            <p:spPr>
              <a:xfrm>
                <a:off x="4811184" y="3462405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7" name="楕円 376">
                <a:extLst>
                  <a:ext uri="{FF2B5EF4-FFF2-40B4-BE49-F238E27FC236}">
                    <a16:creationId xmlns:a16="http://schemas.microsoft.com/office/drawing/2014/main" id="{0B1A29DB-320E-D7C4-11F0-C1378D557C7C}"/>
                  </a:ext>
                </a:extLst>
              </p:cNvPr>
              <p:cNvSpPr/>
              <p:nvPr/>
            </p:nvSpPr>
            <p:spPr>
              <a:xfrm>
                <a:off x="6407729" y="3517608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8" name="楕円 377">
                <a:extLst>
                  <a:ext uri="{FF2B5EF4-FFF2-40B4-BE49-F238E27FC236}">
                    <a16:creationId xmlns:a16="http://schemas.microsoft.com/office/drawing/2014/main" id="{F0A2B239-33FE-1D9F-7307-F090CA635AA2}"/>
                  </a:ext>
                </a:extLst>
              </p:cNvPr>
              <p:cNvSpPr/>
              <p:nvPr/>
            </p:nvSpPr>
            <p:spPr>
              <a:xfrm>
                <a:off x="8019044" y="3476846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9" name="楕円 378">
                <a:extLst>
                  <a:ext uri="{FF2B5EF4-FFF2-40B4-BE49-F238E27FC236}">
                    <a16:creationId xmlns:a16="http://schemas.microsoft.com/office/drawing/2014/main" id="{A89ED4FD-F081-458A-56ED-8139EB0207FD}"/>
                  </a:ext>
                </a:extLst>
              </p:cNvPr>
              <p:cNvSpPr/>
              <p:nvPr/>
            </p:nvSpPr>
            <p:spPr>
              <a:xfrm>
                <a:off x="9612333" y="3479558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55" name="フリーフォーム: 図形 954">
              <a:extLst>
                <a:ext uri="{FF2B5EF4-FFF2-40B4-BE49-F238E27FC236}">
                  <a16:creationId xmlns:a16="http://schemas.microsoft.com/office/drawing/2014/main" id="{DA0663E4-A6B8-CDA6-092F-2640026D83DD}"/>
                </a:ext>
              </a:extLst>
            </p:cNvPr>
            <p:cNvSpPr/>
            <p:nvPr/>
          </p:nvSpPr>
          <p:spPr>
            <a:xfrm>
              <a:off x="3285985" y="4109015"/>
              <a:ext cx="4802188" cy="168275"/>
            </a:xfrm>
            <a:custGeom>
              <a:avLst/>
              <a:gdLst>
                <a:gd name="connsiteX0" fmla="*/ 0 w 4805363"/>
                <a:gd name="connsiteY0" fmla="*/ 0 h 200025"/>
                <a:gd name="connsiteX1" fmla="*/ 1595438 w 4805363"/>
                <a:gd name="connsiteY1" fmla="*/ 185738 h 200025"/>
                <a:gd name="connsiteX2" fmla="*/ 3195638 w 4805363"/>
                <a:gd name="connsiteY2" fmla="*/ 200025 h 200025"/>
                <a:gd name="connsiteX3" fmla="*/ 4805363 w 4805363"/>
                <a:gd name="connsiteY3" fmla="*/ 142875 h 200025"/>
                <a:gd name="connsiteX0" fmla="*/ 0 w 4805363"/>
                <a:gd name="connsiteY0" fmla="*/ 0 h 200025"/>
                <a:gd name="connsiteX1" fmla="*/ 1595438 w 4805363"/>
                <a:gd name="connsiteY1" fmla="*/ 185738 h 200025"/>
                <a:gd name="connsiteX2" fmla="*/ 3195638 w 4805363"/>
                <a:gd name="connsiteY2" fmla="*/ 200025 h 200025"/>
                <a:gd name="connsiteX3" fmla="*/ 4805363 w 4805363"/>
                <a:gd name="connsiteY3" fmla="*/ 123825 h 200025"/>
                <a:gd name="connsiteX0" fmla="*/ 0 w 4802188"/>
                <a:gd name="connsiteY0" fmla="*/ 0 h 200025"/>
                <a:gd name="connsiteX1" fmla="*/ 1595438 w 4802188"/>
                <a:gd name="connsiteY1" fmla="*/ 185738 h 200025"/>
                <a:gd name="connsiteX2" fmla="*/ 3195638 w 4802188"/>
                <a:gd name="connsiteY2" fmla="*/ 200025 h 200025"/>
                <a:gd name="connsiteX3" fmla="*/ 4802188 w 4802188"/>
                <a:gd name="connsiteY3" fmla="*/ 123825 h 200025"/>
                <a:gd name="connsiteX0" fmla="*/ 0 w 4802188"/>
                <a:gd name="connsiteY0" fmla="*/ 0 h 200025"/>
                <a:gd name="connsiteX1" fmla="*/ 1595438 w 4802188"/>
                <a:gd name="connsiteY1" fmla="*/ 185738 h 200025"/>
                <a:gd name="connsiteX2" fmla="*/ 3195638 w 4802188"/>
                <a:gd name="connsiteY2" fmla="*/ 200025 h 200025"/>
                <a:gd name="connsiteX3" fmla="*/ 4802188 w 4802188"/>
                <a:gd name="connsiteY3" fmla="*/ 123825 h 200025"/>
                <a:gd name="connsiteX0" fmla="*/ 0 w 4802188"/>
                <a:gd name="connsiteY0" fmla="*/ 0 h 193675"/>
                <a:gd name="connsiteX1" fmla="*/ 1595438 w 4802188"/>
                <a:gd name="connsiteY1" fmla="*/ 179388 h 193675"/>
                <a:gd name="connsiteX2" fmla="*/ 3195638 w 4802188"/>
                <a:gd name="connsiteY2" fmla="*/ 193675 h 193675"/>
                <a:gd name="connsiteX3" fmla="*/ 4802188 w 4802188"/>
                <a:gd name="connsiteY3" fmla="*/ 117475 h 193675"/>
                <a:gd name="connsiteX0" fmla="*/ 0 w 4802188"/>
                <a:gd name="connsiteY0" fmla="*/ 0 h 193675"/>
                <a:gd name="connsiteX1" fmla="*/ 1601788 w 4802188"/>
                <a:gd name="connsiteY1" fmla="*/ 122238 h 193675"/>
                <a:gd name="connsiteX2" fmla="*/ 3195638 w 4802188"/>
                <a:gd name="connsiteY2" fmla="*/ 193675 h 193675"/>
                <a:gd name="connsiteX3" fmla="*/ 4802188 w 4802188"/>
                <a:gd name="connsiteY3" fmla="*/ 117475 h 193675"/>
                <a:gd name="connsiteX0" fmla="*/ 0 w 4802188"/>
                <a:gd name="connsiteY0" fmla="*/ 0 h 168275"/>
                <a:gd name="connsiteX1" fmla="*/ 1601788 w 4802188"/>
                <a:gd name="connsiteY1" fmla="*/ 122238 h 168275"/>
                <a:gd name="connsiteX2" fmla="*/ 3195638 w 4802188"/>
                <a:gd name="connsiteY2" fmla="*/ 168275 h 168275"/>
                <a:gd name="connsiteX3" fmla="*/ 4802188 w 4802188"/>
                <a:gd name="connsiteY3" fmla="*/ 117475 h 168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802188" h="168275">
                  <a:moveTo>
                    <a:pt x="0" y="0"/>
                  </a:moveTo>
                  <a:lnTo>
                    <a:pt x="1601788" y="122238"/>
                  </a:lnTo>
                  <a:cubicBezTo>
                    <a:pt x="2135188" y="127000"/>
                    <a:pt x="2662238" y="163513"/>
                    <a:pt x="3195638" y="168275"/>
                  </a:cubicBezTo>
                  <a:lnTo>
                    <a:pt x="4802188" y="117475"/>
                  </a:ln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9A567356-B4FA-DA35-EF6C-502024ABBB73}"/>
                </a:ext>
              </a:extLst>
            </p:cNvPr>
            <p:cNvGrpSpPr/>
            <p:nvPr/>
          </p:nvGrpSpPr>
          <p:grpSpPr>
            <a:xfrm>
              <a:off x="4828519" y="3826196"/>
              <a:ext cx="4935461" cy="1027445"/>
              <a:chOff x="4838184" y="3924056"/>
              <a:chExt cx="4935461" cy="1027445"/>
            </a:xfrm>
          </p:grpSpPr>
          <p:grpSp>
            <p:nvGrpSpPr>
              <p:cNvPr id="381" name="グループ化 380">
                <a:extLst>
                  <a:ext uri="{FF2B5EF4-FFF2-40B4-BE49-F238E27FC236}">
                    <a16:creationId xmlns:a16="http://schemas.microsoft.com/office/drawing/2014/main" id="{EB59BE61-498F-FF7E-B731-2B39584E4245}"/>
                  </a:ext>
                </a:extLst>
              </p:cNvPr>
              <p:cNvGrpSpPr/>
              <p:nvPr/>
            </p:nvGrpSpPr>
            <p:grpSpPr>
              <a:xfrm>
                <a:off x="4838184" y="3943350"/>
                <a:ext cx="108000" cy="720725"/>
                <a:chOff x="3181267" y="2418539"/>
                <a:chExt cx="108000" cy="2079208"/>
              </a:xfrm>
            </p:grpSpPr>
            <p:cxnSp>
              <p:nvCxnSpPr>
                <p:cNvPr id="398" name="直線コネクタ 397">
                  <a:extLst>
                    <a:ext uri="{FF2B5EF4-FFF2-40B4-BE49-F238E27FC236}">
                      <a16:creationId xmlns:a16="http://schemas.microsoft.com/office/drawing/2014/main" id="{AED1A438-AE54-7F58-760B-D820F66226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418539"/>
                  <a:ext cx="0" cy="207920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9" name="直線コネクタ 398">
                  <a:extLst>
                    <a:ext uri="{FF2B5EF4-FFF2-40B4-BE49-F238E27FC236}">
                      <a16:creationId xmlns:a16="http://schemas.microsoft.com/office/drawing/2014/main" id="{9BAD9ED1-342D-FBDC-2BF6-B99CAAF861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497747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0" name="直線コネクタ 399">
                  <a:extLst>
                    <a:ext uri="{FF2B5EF4-FFF2-40B4-BE49-F238E27FC236}">
                      <a16:creationId xmlns:a16="http://schemas.microsoft.com/office/drawing/2014/main" id="{29BDAD4A-6BDD-1618-AECF-4B9771BC07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423120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2" name="グループ化 381">
                <a:extLst>
                  <a:ext uri="{FF2B5EF4-FFF2-40B4-BE49-F238E27FC236}">
                    <a16:creationId xmlns:a16="http://schemas.microsoft.com/office/drawing/2014/main" id="{D6B9757A-78DC-637A-0E31-375829A226AA}"/>
                  </a:ext>
                </a:extLst>
              </p:cNvPr>
              <p:cNvGrpSpPr/>
              <p:nvPr/>
            </p:nvGrpSpPr>
            <p:grpSpPr>
              <a:xfrm>
                <a:off x="6434729" y="3976688"/>
                <a:ext cx="108000" cy="783431"/>
                <a:chOff x="3181267" y="2559747"/>
                <a:chExt cx="108000" cy="2051077"/>
              </a:xfrm>
            </p:grpSpPr>
            <p:cxnSp>
              <p:nvCxnSpPr>
                <p:cNvPr id="395" name="直線コネクタ 394">
                  <a:extLst>
                    <a:ext uri="{FF2B5EF4-FFF2-40B4-BE49-F238E27FC236}">
                      <a16:creationId xmlns:a16="http://schemas.microsoft.com/office/drawing/2014/main" id="{CACD215E-34D0-F4AD-964A-3364E8B21F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59747"/>
                  <a:ext cx="0" cy="205107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6" name="直線コネクタ 395">
                  <a:extLst>
                    <a:ext uri="{FF2B5EF4-FFF2-40B4-BE49-F238E27FC236}">
                      <a16:creationId xmlns:a16="http://schemas.microsoft.com/office/drawing/2014/main" id="{6DE9CA96-5BC2-1976-8869-D4488260BAE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610824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7" name="直線コネクタ 396">
                  <a:extLst>
                    <a:ext uri="{FF2B5EF4-FFF2-40B4-BE49-F238E27FC236}">
                      <a16:creationId xmlns:a16="http://schemas.microsoft.com/office/drawing/2014/main" id="{6399A708-EAB5-A97B-DA92-6FA666FB8B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59747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CC0F400D-4C78-0C4A-2DD6-9E370A26863D}"/>
                  </a:ext>
                </a:extLst>
              </p:cNvPr>
              <p:cNvGrpSpPr/>
              <p:nvPr/>
            </p:nvGrpSpPr>
            <p:grpSpPr>
              <a:xfrm>
                <a:off x="7997566" y="3924056"/>
                <a:ext cx="211596" cy="1027445"/>
                <a:chOff x="7997566" y="3924056"/>
                <a:chExt cx="211596" cy="1027445"/>
              </a:xfrm>
            </p:grpSpPr>
            <p:grpSp>
              <p:nvGrpSpPr>
                <p:cNvPr id="390" name="グループ化 389">
                  <a:extLst>
                    <a:ext uri="{FF2B5EF4-FFF2-40B4-BE49-F238E27FC236}">
                      <a16:creationId xmlns:a16="http://schemas.microsoft.com/office/drawing/2014/main" id="{27BB1179-79B5-DCD1-1A18-2D1A53A176E5}"/>
                    </a:ext>
                  </a:extLst>
                </p:cNvPr>
                <p:cNvGrpSpPr/>
                <p:nvPr/>
              </p:nvGrpSpPr>
              <p:grpSpPr>
                <a:xfrm>
                  <a:off x="8046045" y="3924056"/>
                  <a:ext cx="108000" cy="800790"/>
                  <a:chOff x="3181267" y="2287052"/>
                  <a:chExt cx="108000" cy="2240625"/>
                </a:xfrm>
              </p:grpSpPr>
              <p:cxnSp>
                <p:nvCxnSpPr>
                  <p:cNvPr id="392" name="直線コネクタ 391">
                    <a:extLst>
                      <a:ext uri="{FF2B5EF4-FFF2-40B4-BE49-F238E27FC236}">
                        <a16:creationId xmlns:a16="http://schemas.microsoft.com/office/drawing/2014/main" id="{6687A107-9F36-9B1F-3255-33643E20DB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287052"/>
                    <a:ext cx="0" cy="224062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3" name="直線コネクタ 392">
                    <a:extLst>
                      <a:ext uri="{FF2B5EF4-FFF2-40B4-BE49-F238E27FC236}">
                        <a16:creationId xmlns:a16="http://schemas.microsoft.com/office/drawing/2014/main" id="{AA9881B4-DDAA-9707-F344-88B26DDFB6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527677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4" name="直線コネクタ 393">
                    <a:extLst>
                      <a:ext uri="{FF2B5EF4-FFF2-40B4-BE49-F238E27FC236}">
                        <a16:creationId xmlns:a16="http://schemas.microsoft.com/office/drawing/2014/main" id="{A2EAD5F2-4DAA-B13C-9548-096FE954C7B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301059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722D6BD4-D010-E2E6-D455-129A9E2F2E9C}"/>
                    </a:ext>
                  </a:extLst>
                </p:cNvPr>
                <p:cNvSpPr txBox="1"/>
                <p:nvPr/>
              </p:nvSpPr>
              <p:spPr>
                <a:xfrm>
                  <a:off x="7997566" y="4699706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061EB2CB-45CC-F5F9-AAE5-92644B0BD9F6}"/>
                  </a:ext>
                </a:extLst>
              </p:cNvPr>
              <p:cNvGrpSpPr/>
              <p:nvPr/>
            </p:nvGrpSpPr>
            <p:grpSpPr>
              <a:xfrm>
                <a:off x="9562049" y="3960019"/>
                <a:ext cx="211596" cy="950974"/>
                <a:chOff x="9562049" y="3960019"/>
                <a:chExt cx="211596" cy="950974"/>
              </a:xfrm>
            </p:grpSpPr>
            <p:grpSp>
              <p:nvGrpSpPr>
                <p:cNvPr id="385" name="グループ化 384">
                  <a:extLst>
                    <a:ext uri="{FF2B5EF4-FFF2-40B4-BE49-F238E27FC236}">
                      <a16:creationId xmlns:a16="http://schemas.microsoft.com/office/drawing/2014/main" id="{16E2E6F6-AD7B-77A4-BB6C-A3772F7F3C51}"/>
                    </a:ext>
                  </a:extLst>
                </p:cNvPr>
                <p:cNvGrpSpPr/>
                <p:nvPr/>
              </p:nvGrpSpPr>
              <p:grpSpPr>
                <a:xfrm>
                  <a:off x="9639333" y="3960019"/>
                  <a:ext cx="108000" cy="740568"/>
                  <a:chOff x="3181267" y="2638634"/>
                  <a:chExt cx="108000" cy="1842982"/>
                </a:xfrm>
              </p:grpSpPr>
              <p:cxnSp>
                <p:nvCxnSpPr>
                  <p:cNvPr id="387" name="直線コネクタ 386">
                    <a:extLst>
                      <a:ext uri="{FF2B5EF4-FFF2-40B4-BE49-F238E27FC236}">
                        <a16:creationId xmlns:a16="http://schemas.microsoft.com/office/drawing/2014/main" id="{C3088DD2-58BD-F873-9794-16939B38D5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638634"/>
                    <a:ext cx="0" cy="1840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8" name="直線コネクタ 387">
                    <a:extLst>
                      <a:ext uri="{FF2B5EF4-FFF2-40B4-BE49-F238E27FC236}">
                        <a16:creationId xmlns:a16="http://schemas.microsoft.com/office/drawing/2014/main" id="{52E563D2-F4F8-A796-E000-B296AB2526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481616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9" name="直線コネクタ 388">
                    <a:extLst>
                      <a:ext uri="{FF2B5EF4-FFF2-40B4-BE49-F238E27FC236}">
                        <a16:creationId xmlns:a16="http://schemas.microsoft.com/office/drawing/2014/main" id="{597B38FB-66C9-58F1-8E27-DE020DC597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638634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31D30D52-54CB-87D5-1556-CA00DDA8CD06}"/>
                    </a:ext>
                  </a:extLst>
                </p:cNvPr>
                <p:cNvSpPr txBox="1"/>
                <p:nvPr/>
              </p:nvSpPr>
              <p:spPr>
                <a:xfrm>
                  <a:off x="9562049" y="4659198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520171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9AF7C51-98C3-32F7-CE10-4F6E41EA1CF0}"/>
              </a:ext>
            </a:extLst>
          </p:cNvPr>
          <p:cNvSpPr/>
          <p:nvPr/>
        </p:nvSpPr>
        <p:spPr>
          <a:xfrm>
            <a:off x="0" y="0"/>
            <a:ext cx="2993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2B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CFF35454-C118-694F-3041-AD0683CF3EB8}"/>
              </a:ext>
            </a:extLst>
          </p:cNvPr>
          <p:cNvGrpSpPr/>
          <p:nvPr/>
        </p:nvGrpSpPr>
        <p:grpSpPr>
          <a:xfrm>
            <a:off x="1657323" y="541353"/>
            <a:ext cx="8568364" cy="5951693"/>
            <a:chOff x="1657323" y="541353"/>
            <a:chExt cx="8568364" cy="5951693"/>
          </a:xfrm>
        </p:grpSpPr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id="{99B40292-C63F-5B23-E88E-54051DF3F534}"/>
                </a:ext>
              </a:extLst>
            </p:cNvPr>
            <p:cNvGrpSpPr/>
            <p:nvPr/>
          </p:nvGrpSpPr>
          <p:grpSpPr>
            <a:xfrm>
              <a:off x="1657323" y="541353"/>
              <a:ext cx="8568364" cy="2773066"/>
              <a:chOff x="1657323" y="541353"/>
              <a:chExt cx="8568364" cy="2773066"/>
            </a:xfrm>
          </p:grpSpPr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803CD9CE-4F6A-0F33-C726-A8D29B837790}"/>
                  </a:ext>
                </a:extLst>
              </p:cNvPr>
              <p:cNvSpPr txBox="1"/>
              <p:nvPr/>
            </p:nvSpPr>
            <p:spPr>
              <a:xfrm rot="16200000">
                <a:off x="779294" y="1579748"/>
                <a:ext cx="2587055" cy="83099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hange in bedtime home 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BP from baseline to EOT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(mmHg)</a:t>
                </a:r>
              </a:p>
            </p:txBody>
          </p:sp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54F76EBD-CBCB-9372-25E6-4626DDE647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4100" y="869171"/>
                <a:ext cx="7201587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id="{6869C06A-5C11-9A9F-8579-25B1F7937A73}"/>
                  </a:ext>
                </a:extLst>
              </p:cNvPr>
              <p:cNvSpPr/>
              <p:nvPr/>
            </p:nvSpPr>
            <p:spPr>
              <a:xfrm>
                <a:off x="2794774" y="744714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id="{DF95EFD9-DA6C-623B-971D-F6FFF382B8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2937323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正方形/長方形 113">
                <a:extLst>
                  <a:ext uri="{FF2B5EF4-FFF2-40B4-BE49-F238E27FC236}">
                    <a16:creationId xmlns:a16="http://schemas.microsoft.com/office/drawing/2014/main" id="{DA71EEB0-E7D3-98C1-77D7-9E3717B5F168}"/>
                  </a:ext>
                </a:extLst>
              </p:cNvPr>
              <p:cNvSpPr/>
              <p:nvPr/>
            </p:nvSpPr>
            <p:spPr>
              <a:xfrm>
                <a:off x="2560736" y="2813186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3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15" name="直線コネクタ 114">
                <a:extLst>
                  <a:ext uri="{FF2B5EF4-FFF2-40B4-BE49-F238E27FC236}">
                    <a16:creationId xmlns:a16="http://schemas.microsoft.com/office/drawing/2014/main" id="{6192AFF5-F8EC-2F49-8778-16C973C1C2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234642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正方形/長方形 115">
                <a:extLst>
                  <a:ext uri="{FF2B5EF4-FFF2-40B4-BE49-F238E27FC236}">
                    <a16:creationId xmlns:a16="http://schemas.microsoft.com/office/drawing/2014/main" id="{66E6942B-0B0E-67A2-EB80-94DF58DFE2B6}"/>
                  </a:ext>
                </a:extLst>
              </p:cNvPr>
              <p:cNvSpPr/>
              <p:nvPr/>
            </p:nvSpPr>
            <p:spPr>
              <a:xfrm>
                <a:off x="2560736" y="222219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2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17" name="直線コネクタ 116">
                <a:extLst>
                  <a:ext uri="{FF2B5EF4-FFF2-40B4-BE49-F238E27FC236}">
                    <a16:creationId xmlns:a16="http://schemas.microsoft.com/office/drawing/2014/main" id="{774EB12A-1DB2-CFA7-B7EA-9D72BA7FB8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175552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正方形/長方形 117">
                <a:extLst>
                  <a:ext uri="{FF2B5EF4-FFF2-40B4-BE49-F238E27FC236}">
                    <a16:creationId xmlns:a16="http://schemas.microsoft.com/office/drawing/2014/main" id="{F33E9C88-5565-53CF-49D3-08E3F2E931AD}"/>
                  </a:ext>
                </a:extLst>
              </p:cNvPr>
              <p:cNvSpPr/>
              <p:nvPr/>
            </p:nvSpPr>
            <p:spPr>
              <a:xfrm>
                <a:off x="2560736" y="1631202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19" name="直線コネクタ 118">
                <a:extLst>
                  <a:ext uri="{FF2B5EF4-FFF2-40B4-BE49-F238E27FC236}">
                    <a16:creationId xmlns:a16="http://schemas.microsoft.com/office/drawing/2014/main" id="{960C4BBB-360A-4F5B-F002-E8B12AAFAD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1168084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正方形/長方形 119">
                <a:extLst>
                  <a:ext uri="{FF2B5EF4-FFF2-40B4-BE49-F238E27FC236}">
                    <a16:creationId xmlns:a16="http://schemas.microsoft.com/office/drawing/2014/main" id="{CAA8C6BA-1BDA-7E94-A164-853C9D2DD1E1}"/>
                  </a:ext>
                </a:extLst>
              </p:cNvPr>
              <p:cNvSpPr/>
              <p:nvPr/>
            </p:nvSpPr>
            <p:spPr>
              <a:xfrm>
                <a:off x="2794774" y="1044973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21" name="直線コネクタ 120">
                <a:extLst>
                  <a:ext uri="{FF2B5EF4-FFF2-40B4-BE49-F238E27FC236}">
                    <a16:creationId xmlns:a16="http://schemas.microsoft.com/office/drawing/2014/main" id="{6F103DB7-F953-6E19-E5E6-248607A124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4100" y="870575"/>
                <a:ext cx="0" cy="22284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線コネクタ 121">
                <a:extLst>
                  <a:ext uri="{FF2B5EF4-FFF2-40B4-BE49-F238E27FC236}">
                    <a16:creationId xmlns:a16="http://schemas.microsoft.com/office/drawing/2014/main" id="{11D45F0C-8E5A-5DB8-4AC1-15ED03A31B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86917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3" name="グループ化 122">
                <a:extLst>
                  <a:ext uri="{FF2B5EF4-FFF2-40B4-BE49-F238E27FC236}">
                    <a16:creationId xmlns:a16="http://schemas.microsoft.com/office/drawing/2014/main" id="{1896D884-11F2-9E73-2456-617427F5CE98}"/>
                  </a:ext>
                </a:extLst>
              </p:cNvPr>
              <p:cNvGrpSpPr/>
              <p:nvPr/>
            </p:nvGrpSpPr>
            <p:grpSpPr>
              <a:xfrm>
                <a:off x="4360689" y="3098975"/>
                <a:ext cx="4627795" cy="215444"/>
                <a:chOff x="4683258" y="2845511"/>
                <a:chExt cx="4627795" cy="215444"/>
              </a:xfrm>
            </p:grpSpPr>
            <p:grpSp>
              <p:nvGrpSpPr>
                <p:cNvPr id="216" name="グループ化 215">
                  <a:extLst>
                    <a:ext uri="{FF2B5EF4-FFF2-40B4-BE49-F238E27FC236}">
                      <a16:creationId xmlns:a16="http://schemas.microsoft.com/office/drawing/2014/main" id="{878A1091-DDD7-A34F-6545-8C0454565CCF}"/>
                    </a:ext>
                  </a:extLst>
                </p:cNvPr>
                <p:cNvGrpSpPr/>
                <p:nvPr/>
              </p:nvGrpSpPr>
              <p:grpSpPr>
                <a:xfrm>
                  <a:off x="6279513" y="2845511"/>
                  <a:ext cx="1463497" cy="215444"/>
                  <a:chOff x="4782318" y="3119831"/>
                  <a:chExt cx="1463497" cy="215444"/>
                </a:xfrm>
              </p:grpSpPr>
              <p:sp>
                <p:nvSpPr>
                  <p:cNvPr id="227" name="正方形/長方形 226">
                    <a:extLst>
                      <a:ext uri="{FF2B5EF4-FFF2-40B4-BE49-F238E27FC236}">
                        <a16:creationId xmlns:a16="http://schemas.microsoft.com/office/drawing/2014/main" id="{009DC20C-FE06-D53D-E484-A5D86FF0DEDF}"/>
                      </a:ext>
                    </a:extLst>
                  </p:cNvPr>
                  <p:cNvSpPr/>
                  <p:nvPr/>
                </p:nvSpPr>
                <p:spPr>
                  <a:xfrm>
                    <a:off x="5169114" y="3119831"/>
                    <a:ext cx="1076701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AR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2)</a:t>
                    </a:r>
                  </a:p>
                </p:txBody>
              </p:sp>
              <p:grpSp>
                <p:nvGrpSpPr>
                  <p:cNvPr id="228" name="グループ化 227">
                    <a:extLst>
                      <a:ext uri="{FF2B5EF4-FFF2-40B4-BE49-F238E27FC236}">
                        <a16:creationId xmlns:a16="http://schemas.microsoft.com/office/drawing/2014/main" id="{0F15487A-085E-EFD1-C1F9-5EAFA4D98FA2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15555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9" name="直線コネクタ 228">
                      <a:extLst>
                        <a:ext uri="{FF2B5EF4-FFF2-40B4-BE49-F238E27FC236}">
                          <a16:creationId xmlns:a16="http://schemas.microsoft.com/office/drawing/2014/main" id="{EEA826F2-E4B3-7A8A-119C-BAA6F3CD03B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rgbClr val="FF0000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30" name="楕円 229">
                      <a:extLst>
                        <a:ext uri="{FF2B5EF4-FFF2-40B4-BE49-F238E27FC236}">
                          <a16:creationId xmlns:a16="http://schemas.microsoft.com/office/drawing/2014/main" id="{EFA9DC45-D764-5923-FD2C-E09AF4D5CD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17" name="グループ化 216">
                  <a:extLst>
                    <a:ext uri="{FF2B5EF4-FFF2-40B4-BE49-F238E27FC236}">
                      <a16:creationId xmlns:a16="http://schemas.microsoft.com/office/drawing/2014/main" id="{0A740DE7-CA36-541F-F453-CD5C41049307}"/>
                    </a:ext>
                  </a:extLst>
                </p:cNvPr>
                <p:cNvGrpSpPr/>
                <p:nvPr/>
              </p:nvGrpSpPr>
              <p:grpSpPr>
                <a:xfrm>
                  <a:off x="7837938" y="2845511"/>
                  <a:ext cx="1473115" cy="215444"/>
                  <a:chOff x="4782318" y="3352318"/>
                  <a:chExt cx="1473115" cy="215444"/>
                </a:xfrm>
              </p:grpSpPr>
              <p:sp>
                <p:nvSpPr>
                  <p:cNvPr id="223" name="正方形/長方形 222">
                    <a:extLst>
                      <a:ext uri="{FF2B5EF4-FFF2-40B4-BE49-F238E27FC236}">
                        <a16:creationId xmlns:a16="http://schemas.microsoft.com/office/drawing/2014/main" id="{AD93B065-A19C-381F-9B4E-4CA47CE1E436}"/>
                      </a:ext>
                    </a:extLst>
                  </p:cNvPr>
                  <p:cNvSpPr/>
                  <p:nvPr/>
                </p:nvSpPr>
                <p:spPr>
                  <a:xfrm>
                    <a:off x="5169114" y="3352318"/>
                    <a:ext cx="1086319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CC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7)</a:t>
                    </a:r>
                  </a:p>
                </p:txBody>
              </p:sp>
              <p:grpSp>
                <p:nvGrpSpPr>
                  <p:cNvPr id="224" name="グループ化 223">
                    <a:extLst>
                      <a:ext uri="{FF2B5EF4-FFF2-40B4-BE49-F238E27FC236}">
                        <a16:creationId xmlns:a16="http://schemas.microsoft.com/office/drawing/2014/main" id="{BFF004CE-1EA1-0F8A-2CB6-14E9526C1C59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388040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5" name="直線コネクタ 224">
                      <a:extLst>
                        <a:ext uri="{FF2B5EF4-FFF2-40B4-BE49-F238E27FC236}">
                          <a16:creationId xmlns:a16="http://schemas.microsoft.com/office/drawing/2014/main" id="{F7FF01B9-8AB7-4AFF-3AD0-DCAF205E7A0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solidFill>
                      <a:srgbClr val="00B050"/>
                    </a:solidFill>
                    <a:ln w="38100" cap="flat">
                      <a:solidFill>
                        <a:srgbClr val="0000FF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26" name="楕円 225">
                      <a:extLst>
                        <a:ext uri="{FF2B5EF4-FFF2-40B4-BE49-F238E27FC236}">
                          <a16:creationId xmlns:a16="http://schemas.microsoft.com/office/drawing/2014/main" id="{6E40AD3F-58CE-BB4F-CCAB-E3F111A3856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18" name="グループ化 217">
                  <a:extLst>
                    <a:ext uri="{FF2B5EF4-FFF2-40B4-BE49-F238E27FC236}">
                      <a16:creationId xmlns:a16="http://schemas.microsoft.com/office/drawing/2014/main" id="{2A47C4EF-5575-AA8F-1D2D-5EBF809F6FEA}"/>
                    </a:ext>
                  </a:extLst>
                </p:cNvPr>
                <p:cNvGrpSpPr/>
                <p:nvPr/>
              </p:nvGrpSpPr>
              <p:grpSpPr>
                <a:xfrm>
                  <a:off x="4683258" y="2845511"/>
                  <a:ext cx="1501328" cy="215444"/>
                  <a:chOff x="4782318" y="2845511"/>
                  <a:chExt cx="1501328" cy="215444"/>
                </a:xfrm>
              </p:grpSpPr>
              <p:sp>
                <p:nvSpPr>
                  <p:cNvPr id="219" name="正方形/長方形 218">
                    <a:extLst>
                      <a:ext uri="{FF2B5EF4-FFF2-40B4-BE49-F238E27FC236}">
                        <a16:creationId xmlns:a16="http://schemas.microsoft.com/office/drawing/2014/main" id="{A04527B0-A168-BB12-12B5-344F72055CBB}"/>
                      </a:ext>
                    </a:extLst>
                  </p:cNvPr>
                  <p:cNvSpPr/>
                  <p:nvPr/>
                </p:nvSpPr>
                <p:spPr>
                  <a:xfrm>
                    <a:off x="5169114" y="2845511"/>
                    <a:ext cx="1114532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Total</a:t>
                    </a:r>
                    <a:r>
                      <a:rPr lang="ja-JP" altLang="en-US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89)</a:t>
                    </a:r>
                  </a:p>
                </p:txBody>
              </p:sp>
              <p:grpSp>
                <p:nvGrpSpPr>
                  <p:cNvPr id="220" name="グループ化 219">
                    <a:extLst>
                      <a:ext uri="{FF2B5EF4-FFF2-40B4-BE49-F238E27FC236}">
                        <a16:creationId xmlns:a16="http://schemas.microsoft.com/office/drawing/2014/main" id="{8242E0DC-4F37-79BC-D0A2-7845760B4AF3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288123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1" name="直線コネクタ 220">
                      <a:extLst>
                        <a:ext uri="{FF2B5EF4-FFF2-40B4-BE49-F238E27FC236}">
                          <a16:creationId xmlns:a16="http://schemas.microsoft.com/office/drawing/2014/main" id="{F1165D5F-921F-795E-5CD8-47A6DA9D8B8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chemeClr val="tx1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22" name="楕円 221">
                      <a:extLst>
                        <a:ext uri="{FF2B5EF4-FFF2-40B4-BE49-F238E27FC236}">
                          <a16:creationId xmlns:a16="http://schemas.microsoft.com/office/drawing/2014/main" id="{3C64C432-92B1-7684-795B-1C9E227E4CE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cxnSp>
            <p:nvCxnSpPr>
              <p:cNvPr id="124" name="直線コネクタ 123">
                <a:extLst>
                  <a:ext uri="{FF2B5EF4-FFF2-40B4-BE49-F238E27FC236}">
                    <a16:creationId xmlns:a16="http://schemas.microsoft.com/office/drawing/2014/main" id="{591A2DC6-B911-0A90-FD4A-16E7FE3301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264187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ABC7E585-B963-BEFD-BF3A-43BD8599ADAE}"/>
                  </a:ext>
                </a:extLst>
              </p:cNvPr>
              <p:cNvSpPr/>
              <p:nvPr/>
            </p:nvSpPr>
            <p:spPr>
              <a:xfrm>
                <a:off x="2560736" y="2517690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2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直線コネクタ 125">
                <a:extLst>
                  <a:ext uri="{FF2B5EF4-FFF2-40B4-BE49-F238E27FC236}">
                    <a16:creationId xmlns:a16="http://schemas.microsoft.com/office/drawing/2014/main" id="{98A7AB85-8C2D-5ED7-72A4-14E7DC83B8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205097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CF26E89A-9845-2983-7B57-1C65F1AC592D}"/>
                  </a:ext>
                </a:extLst>
              </p:cNvPr>
              <p:cNvSpPr/>
              <p:nvPr/>
            </p:nvSpPr>
            <p:spPr>
              <a:xfrm>
                <a:off x="2560736" y="1926698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28" name="直線コネクタ 127">
                <a:extLst>
                  <a:ext uri="{FF2B5EF4-FFF2-40B4-BE49-F238E27FC236}">
                    <a16:creationId xmlns:a16="http://schemas.microsoft.com/office/drawing/2014/main" id="{7A3FDAE1-3DCD-9C94-39CE-4FD16FDB55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146007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正方形/長方形 128">
                <a:extLst>
                  <a:ext uri="{FF2B5EF4-FFF2-40B4-BE49-F238E27FC236}">
                    <a16:creationId xmlns:a16="http://schemas.microsoft.com/office/drawing/2014/main" id="{FF2D8088-62AC-AED0-1A01-A4DE6ED35D43}"/>
                  </a:ext>
                </a:extLst>
              </p:cNvPr>
              <p:cNvSpPr/>
              <p:nvPr/>
            </p:nvSpPr>
            <p:spPr>
              <a:xfrm>
                <a:off x="2674549" y="1335706"/>
                <a:ext cx="23403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6281A616-7D5A-8567-72C2-4A3A02CEABEA}"/>
                  </a:ext>
                </a:extLst>
              </p:cNvPr>
              <p:cNvSpPr txBox="1"/>
              <p:nvPr/>
            </p:nvSpPr>
            <p:spPr>
              <a:xfrm>
                <a:off x="8362138" y="2213600"/>
                <a:ext cx="211596" cy="25179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0" tIns="36000" rIns="0" bIns="0" anchor="t">
                <a:spAutoFit/>
              </a:bodyPr>
              <a:lstStyle>
                <a:defPPr>
                  <a:defRPr lang="ja-JP"/>
                </a:defPPr>
                <a:lvl1pPr lvl="0" indent="0" algn="ctr">
                  <a:spcBef>
                    <a:spcPct val="0"/>
                  </a:spcBef>
                  <a:buNone/>
                  <a:defRPr sz="900" b="1" kern="0">
                    <a:solidFill>
                      <a:prstClr val="black"/>
                    </a:solidFill>
                    <a:latin typeface="Arial" panose="020B0604020202020204" pitchFamily="34" charset="0"/>
                    <a:ea typeface="Meiryo UI"/>
                    <a:cs typeface="Arial" panose="020B0604020202020204" pitchFamily="34" charset="0"/>
                  </a:defRPr>
                </a:lvl1pPr>
                <a:lvl2pPr indent="0">
                  <a:defRPr sz="1100"/>
                </a:lvl2pPr>
                <a:lvl3pPr indent="0">
                  <a:defRPr sz="1100"/>
                </a:lvl3pPr>
                <a:lvl4pPr indent="0">
                  <a:defRPr sz="1100"/>
                </a:lvl4pPr>
                <a:lvl5pPr indent="0">
                  <a:defRPr sz="1100"/>
                </a:lvl5pPr>
                <a:lvl6pPr indent="0">
                  <a:defRPr sz="1100"/>
                </a:lvl6pPr>
                <a:lvl7pPr indent="0">
                  <a:defRPr sz="1100"/>
                </a:lvl7pPr>
                <a:lvl8pPr indent="0">
                  <a:defRPr sz="1100"/>
                </a:lvl8pPr>
                <a:lvl9pPr indent="0">
                  <a:defRPr sz="1100"/>
                </a:lvl9pPr>
              </a:lstStyle>
              <a:p>
                <a:r>
                  <a:rPr lang="en-US" altLang="ja-JP" sz="1400" dirty="0"/>
                  <a:t>***</a:t>
                </a:r>
              </a:p>
            </p:txBody>
          </p: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0536FD50-1F43-3F51-D468-F82B9E58A326}"/>
                  </a:ext>
                </a:extLst>
              </p:cNvPr>
              <p:cNvSpPr/>
              <p:nvPr/>
            </p:nvSpPr>
            <p:spPr>
              <a:xfrm>
                <a:off x="3101842" y="541353"/>
                <a:ext cx="78386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Baseline</a:t>
                </a: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1D0FC4C6-72BA-D36E-EF8D-58D729424879}"/>
                  </a:ext>
                </a:extLst>
              </p:cNvPr>
              <p:cNvSpPr/>
              <p:nvPr/>
            </p:nvSpPr>
            <p:spPr>
              <a:xfrm>
                <a:off x="4758101" y="541353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4</a:t>
                </a: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E4508756-2FDD-0CF0-B48C-D72A1DAF5082}"/>
                  </a:ext>
                </a:extLst>
              </p:cNvPr>
              <p:cNvSpPr/>
              <p:nvPr/>
            </p:nvSpPr>
            <p:spPr>
              <a:xfrm>
                <a:off x="6355019" y="541353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8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BEC3D4CE-8564-875D-C509-2B5E7F3943DB}"/>
                  </a:ext>
                </a:extLst>
              </p:cNvPr>
              <p:cNvSpPr/>
              <p:nvPr/>
            </p:nvSpPr>
            <p:spPr>
              <a:xfrm>
                <a:off x="7906383" y="541353"/>
                <a:ext cx="805798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12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23735607-24E6-1D1D-112F-12FEFD9607D9}"/>
                  </a:ext>
                </a:extLst>
              </p:cNvPr>
              <p:cNvSpPr/>
              <p:nvPr/>
            </p:nvSpPr>
            <p:spPr>
              <a:xfrm>
                <a:off x="9683572" y="541356"/>
                <a:ext cx="421590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EOT</a:t>
                </a:r>
              </a:p>
            </p:txBody>
          </p:sp>
          <p:cxnSp>
            <p:nvCxnSpPr>
              <p:cNvPr id="11" name="直線コネクタ 10">
                <a:extLst>
                  <a:ext uri="{FF2B5EF4-FFF2-40B4-BE49-F238E27FC236}">
                    <a16:creationId xmlns:a16="http://schemas.microsoft.com/office/drawing/2014/main" id="{DAABC71E-5F53-A1F3-200A-CBD44263FC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93776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線コネクタ 11">
                <a:extLst>
                  <a:ext uri="{FF2B5EF4-FFF2-40B4-BE49-F238E27FC236}">
                    <a16:creationId xmlns:a16="http://schemas.microsoft.com/office/drawing/2014/main" id="{BACA3B9D-0080-D79C-A9A4-B754FD427E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01011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>
                <a:extLst>
                  <a:ext uri="{FF2B5EF4-FFF2-40B4-BE49-F238E27FC236}">
                    <a16:creationId xmlns:a16="http://schemas.microsoft.com/office/drawing/2014/main" id="{84E8B3F4-4DFB-5AD1-82A2-7A1499B8F3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09282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コネクタ 13">
                <a:extLst>
                  <a:ext uri="{FF2B5EF4-FFF2-40B4-BE49-F238E27FC236}">
                    <a16:creationId xmlns:a16="http://schemas.microsoft.com/office/drawing/2014/main" id="{322A4D59-3737-A9D9-5447-A86F16C1E9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94367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コネクタ 14">
                <a:extLst>
                  <a:ext uri="{FF2B5EF4-FFF2-40B4-BE49-F238E27FC236}">
                    <a16:creationId xmlns:a16="http://schemas.microsoft.com/office/drawing/2014/main" id="{E3DE08AE-AAC7-46B3-B52F-1AE94B6A979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04093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8" name="グループ化 387">
                <a:extLst>
                  <a:ext uri="{FF2B5EF4-FFF2-40B4-BE49-F238E27FC236}">
                    <a16:creationId xmlns:a16="http://schemas.microsoft.com/office/drawing/2014/main" id="{E2FBCC57-53A4-7806-0BAD-8045EA918358}"/>
                  </a:ext>
                </a:extLst>
              </p:cNvPr>
              <p:cNvGrpSpPr/>
              <p:nvPr/>
            </p:nvGrpSpPr>
            <p:grpSpPr>
              <a:xfrm>
                <a:off x="3583753" y="1059656"/>
                <a:ext cx="6585760" cy="1356304"/>
                <a:chOff x="3581902" y="1059656"/>
                <a:chExt cx="6585760" cy="1356304"/>
              </a:xfrm>
            </p:grpSpPr>
            <p:grpSp>
              <p:nvGrpSpPr>
                <p:cNvPr id="386" name="グループ化 385">
                  <a:extLst>
                    <a:ext uri="{FF2B5EF4-FFF2-40B4-BE49-F238E27FC236}">
                      <a16:creationId xmlns:a16="http://schemas.microsoft.com/office/drawing/2014/main" id="{385BF83D-F488-0BAE-F52B-D54F28553FAD}"/>
                    </a:ext>
                  </a:extLst>
                </p:cNvPr>
                <p:cNvGrpSpPr/>
                <p:nvPr/>
              </p:nvGrpSpPr>
              <p:grpSpPr>
                <a:xfrm>
                  <a:off x="5207582" y="1059656"/>
                  <a:ext cx="4960080" cy="1356304"/>
                  <a:chOff x="5207582" y="1059656"/>
                  <a:chExt cx="4960080" cy="1356304"/>
                </a:xfrm>
              </p:grpSpPr>
              <p:grpSp>
                <p:nvGrpSpPr>
                  <p:cNvPr id="169" name="グループ化 168">
                    <a:extLst>
                      <a:ext uri="{FF2B5EF4-FFF2-40B4-BE49-F238E27FC236}">
                        <a16:creationId xmlns:a16="http://schemas.microsoft.com/office/drawing/2014/main" id="{3C7B1602-372F-57C0-1BB3-BB1C76A118FE}"/>
                      </a:ext>
                    </a:extLst>
                  </p:cNvPr>
                  <p:cNvGrpSpPr/>
                  <p:nvPr/>
                </p:nvGrpSpPr>
                <p:grpSpPr>
                  <a:xfrm>
                    <a:off x="5207582" y="1066757"/>
                    <a:ext cx="108000" cy="1112087"/>
                    <a:chOff x="3181267" y="2597151"/>
                    <a:chExt cx="108000" cy="2157062"/>
                  </a:xfrm>
                </p:grpSpPr>
                <p:cxnSp>
                  <p:nvCxnSpPr>
                    <p:cNvPr id="185" name="直線コネクタ 184">
                      <a:extLst>
                        <a:ext uri="{FF2B5EF4-FFF2-40B4-BE49-F238E27FC236}">
                          <a16:creationId xmlns:a16="http://schemas.microsoft.com/office/drawing/2014/main" id="{5078F166-9290-8904-0D1D-3CA5E958774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6" name="直線コネクタ 185">
                      <a:extLst>
                        <a:ext uri="{FF2B5EF4-FFF2-40B4-BE49-F238E27FC236}">
                          <a16:creationId xmlns:a16="http://schemas.microsoft.com/office/drawing/2014/main" id="{40BC9866-FE58-4DB6-AD49-FAC36419BFE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7" name="直線コネクタ 186">
                      <a:extLst>
                        <a:ext uri="{FF2B5EF4-FFF2-40B4-BE49-F238E27FC236}">
                          <a16:creationId xmlns:a16="http://schemas.microsoft.com/office/drawing/2014/main" id="{06D369D7-3EC3-C052-2C9A-90DC90771D0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70" name="グループ化 169">
                    <a:extLst>
                      <a:ext uri="{FF2B5EF4-FFF2-40B4-BE49-F238E27FC236}">
                        <a16:creationId xmlns:a16="http://schemas.microsoft.com/office/drawing/2014/main" id="{9F891A3A-2BC6-814D-E92F-C553351A6510}"/>
                      </a:ext>
                    </a:extLst>
                  </p:cNvPr>
                  <p:cNvGrpSpPr/>
                  <p:nvPr/>
                </p:nvGrpSpPr>
                <p:grpSpPr>
                  <a:xfrm>
                    <a:off x="6806881" y="1152096"/>
                    <a:ext cx="108000" cy="1081517"/>
                    <a:chOff x="3181267" y="2597151"/>
                    <a:chExt cx="108000" cy="2157062"/>
                  </a:xfrm>
                </p:grpSpPr>
                <p:cxnSp>
                  <p:nvCxnSpPr>
                    <p:cNvPr id="182" name="直線コネクタ 181">
                      <a:extLst>
                        <a:ext uri="{FF2B5EF4-FFF2-40B4-BE49-F238E27FC236}">
                          <a16:creationId xmlns:a16="http://schemas.microsoft.com/office/drawing/2014/main" id="{5999E296-A27A-B55C-8571-F196CADAE4A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3" name="直線コネクタ 182">
                      <a:extLst>
                        <a:ext uri="{FF2B5EF4-FFF2-40B4-BE49-F238E27FC236}">
                          <a16:creationId xmlns:a16="http://schemas.microsoft.com/office/drawing/2014/main" id="{9A8A51B0-2C0A-FF64-EF0D-4D591AE7D95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4" name="直線コネクタ 183">
                      <a:extLst>
                        <a:ext uri="{FF2B5EF4-FFF2-40B4-BE49-F238E27FC236}">
                          <a16:creationId xmlns:a16="http://schemas.microsoft.com/office/drawing/2014/main" id="{DCAAB6E3-5BE9-88C9-665A-B275B0BCA56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78" name="グループ化 177">
                    <a:extLst>
                      <a:ext uri="{FF2B5EF4-FFF2-40B4-BE49-F238E27FC236}">
                        <a16:creationId xmlns:a16="http://schemas.microsoft.com/office/drawing/2014/main" id="{10A1F96E-54A8-C464-D5E8-FB9881F91025}"/>
                      </a:ext>
                    </a:extLst>
                  </p:cNvPr>
                  <p:cNvGrpSpPr/>
                  <p:nvPr/>
                </p:nvGrpSpPr>
                <p:grpSpPr>
                  <a:xfrm>
                    <a:off x="8412352" y="1059656"/>
                    <a:ext cx="108000" cy="1190008"/>
                    <a:chOff x="9259442" y="1742178"/>
                    <a:chExt cx="108000" cy="310645"/>
                  </a:xfrm>
                </p:grpSpPr>
                <p:cxnSp>
                  <p:nvCxnSpPr>
                    <p:cNvPr id="180" name="直線コネクタ 179">
                      <a:extLst>
                        <a:ext uri="{FF2B5EF4-FFF2-40B4-BE49-F238E27FC236}">
                          <a16:creationId xmlns:a16="http://schemas.microsoft.com/office/drawing/2014/main" id="{1CC2F187-606A-0BB0-3CB1-7C23FC2E8AE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313442" y="1742178"/>
                      <a:ext cx="0" cy="310645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1" name="直線コネクタ 180">
                      <a:extLst>
                        <a:ext uri="{FF2B5EF4-FFF2-40B4-BE49-F238E27FC236}">
                          <a16:creationId xmlns:a16="http://schemas.microsoft.com/office/drawing/2014/main" id="{FED2FE7A-13F2-5660-94FA-AD50D8BC901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259442" y="205282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4" name="直線コネクタ 383">
                      <a:extLst>
                        <a:ext uri="{FF2B5EF4-FFF2-40B4-BE49-F238E27FC236}">
                          <a16:creationId xmlns:a16="http://schemas.microsoft.com/office/drawing/2014/main" id="{C3410F68-2E88-A81B-43DB-079B7B2A584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259442" y="1742178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85" name="グループ化 384">
                    <a:extLst>
                      <a:ext uri="{FF2B5EF4-FFF2-40B4-BE49-F238E27FC236}">
                        <a16:creationId xmlns:a16="http://schemas.microsoft.com/office/drawing/2014/main" id="{13E63566-B28D-2FBB-BEA4-92A53E202904}"/>
                      </a:ext>
                    </a:extLst>
                  </p:cNvPr>
                  <p:cNvGrpSpPr/>
                  <p:nvPr/>
                </p:nvGrpSpPr>
                <p:grpSpPr>
                  <a:xfrm>
                    <a:off x="9956066" y="1073943"/>
                    <a:ext cx="211596" cy="1342017"/>
                    <a:chOff x="9956066" y="1073943"/>
                    <a:chExt cx="211596" cy="1342017"/>
                  </a:xfrm>
                </p:grpSpPr>
                <p:grpSp>
                  <p:nvGrpSpPr>
                    <p:cNvPr id="173" name="グループ化 172">
                      <a:extLst>
                        <a:ext uri="{FF2B5EF4-FFF2-40B4-BE49-F238E27FC236}">
                          <a16:creationId xmlns:a16="http://schemas.microsoft.com/office/drawing/2014/main" id="{3DBC40AB-E953-ED6E-34E2-0EADE92EE96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07866" y="1073943"/>
                      <a:ext cx="108000" cy="1122399"/>
                      <a:chOff x="3181267" y="2597151"/>
                      <a:chExt cx="108000" cy="2157062"/>
                    </a:xfrm>
                  </p:grpSpPr>
                  <p:cxnSp>
                    <p:nvCxnSpPr>
                      <p:cNvPr id="175" name="直線コネクタ 174">
                        <a:extLst>
                          <a:ext uri="{FF2B5EF4-FFF2-40B4-BE49-F238E27FC236}">
                            <a16:creationId xmlns:a16="http://schemas.microsoft.com/office/drawing/2014/main" id="{BA0835BB-12B9-97BD-C751-4FF5D09E142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6" name="直線コネクタ 175">
                        <a:extLst>
                          <a:ext uri="{FF2B5EF4-FFF2-40B4-BE49-F238E27FC236}">
                            <a16:creationId xmlns:a16="http://schemas.microsoft.com/office/drawing/2014/main" id="{1B164C9C-9F00-E4A8-59E8-479607123FD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7" name="直線コネクタ 176">
                        <a:extLst>
                          <a:ext uri="{FF2B5EF4-FFF2-40B4-BE49-F238E27FC236}">
                            <a16:creationId xmlns:a16="http://schemas.microsoft.com/office/drawing/2014/main" id="{4CB9DD9B-DBB7-8BB9-B9CB-7EE560E0272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74" name="テキスト ボックス 173">
                      <a:extLst>
                        <a:ext uri="{FF2B5EF4-FFF2-40B4-BE49-F238E27FC236}">
                          <a16:creationId xmlns:a16="http://schemas.microsoft.com/office/drawing/2014/main" id="{E8D4924F-0EB3-7729-6A5A-F363268CCE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56066" y="2164165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83" name="グループ化 382">
                  <a:extLst>
                    <a:ext uri="{FF2B5EF4-FFF2-40B4-BE49-F238E27FC236}">
                      <a16:creationId xmlns:a16="http://schemas.microsoft.com/office/drawing/2014/main" id="{6230852E-85E6-996D-3259-29FAB1E28983}"/>
                    </a:ext>
                  </a:extLst>
                </p:cNvPr>
                <p:cNvGrpSpPr/>
                <p:nvPr/>
              </p:nvGrpSpPr>
              <p:grpSpPr>
                <a:xfrm>
                  <a:off x="3581902" y="1096084"/>
                  <a:ext cx="6551963" cy="667844"/>
                  <a:chOff x="3581902" y="1096084"/>
                  <a:chExt cx="6551963" cy="667844"/>
                </a:xfrm>
              </p:grpSpPr>
              <p:sp>
                <p:nvSpPr>
                  <p:cNvPr id="164" name="楕円 163">
                    <a:extLst>
                      <a:ext uri="{FF2B5EF4-FFF2-40B4-BE49-F238E27FC236}">
                        <a16:creationId xmlns:a16="http://schemas.microsoft.com/office/drawing/2014/main" id="{0DE65E8C-3EFE-4B59-56AE-08B20C1F8C60}"/>
                      </a:ext>
                    </a:extLst>
                  </p:cNvPr>
                  <p:cNvSpPr/>
                  <p:nvPr/>
                </p:nvSpPr>
                <p:spPr>
                  <a:xfrm>
                    <a:off x="3581902" y="1096084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楕円 164">
                    <a:extLst>
                      <a:ext uri="{FF2B5EF4-FFF2-40B4-BE49-F238E27FC236}">
                        <a16:creationId xmlns:a16="http://schemas.microsoft.com/office/drawing/2014/main" id="{894A2C48-72BF-6F98-690E-629A3216EF97}"/>
                      </a:ext>
                    </a:extLst>
                  </p:cNvPr>
                  <p:cNvSpPr/>
                  <p:nvPr/>
                </p:nvSpPr>
                <p:spPr>
                  <a:xfrm>
                    <a:off x="5189581" y="1547573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楕円 165">
                    <a:extLst>
                      <a:ext uri="{FF2B5EF4-FFF2-40B4-BE49-F238E27FC236}">
                        <a16:creationId xmlns:a16="http://schemas.microsoft.com/office/drawing/2014/main" id="{F730AE4F-36FB-324E-FBC3-DDB484CCAF11}"/>
                      </a:ext>
                    </a:extLst>
                  </p:cNvPr>
                  <p:cNvSpPr/>
                  <p:nvPr/>
                </p:nvSpPr>
                <p:spPr>
                  <a:xfrm>
                    <a:off x="6788880" y="1619928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楕円 166">
                    <a:extLst>
                      <a:ext uri="{FF2B5EF4-FFF2-40B4-BE49-F238E27FC236}">
                        <a16:creationId xmlns:a16="http://schemas.microsoft.com/office/drawing/2014/main" id="{99EEF01A-721B-0B50-BFA9-183A1370E951}"/>
                      </a:ext>
                    </a:extLst>
                  </p:cNvPr>
                  <p:cNvSpPr/>
                  <p:nvPr/>
                </p:nvSpPr>
                <p:spPr>
                  <a:xfrm>
                    <a:off x="8394351" y="1584969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8" name="楕円 167">
                    <a:extLst>
                      <a:ext uri="{FF2B5EF4-FFF2-40B4-BE49-F238E27FC236}">
                        <a16:creationId xmlns:a16="http://schemas.microsoft.com/office/drawing/2014/main" id="{5ECB9806-E830-26A3-8EBD-AC4881C0420A}"/>
                      </a:ext>
                    </a:extLst>
                  </p:cNvPr>
                  <p:cNvSpPr/>
                  <p:nvPr/>
                </p:nvSpPr>
                <p:spPr>
                  <a:xfrm>
                    <a:off x="9989865" y="1560629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7" name="フリーフォーム: 図形 386">
                  <a:extLst>
                    <a:ext uri="{FF2B5EF4-FFF2-40B4-BE49-F238E27FC236}">
                      <a16:creationId xmlns:a16="http://schemas.microsoft.com/office/drawing/2014/main" id="{F2972854-A10F-9D3B-4203-FB4F11DD27D9}"/>
                    </a:ext>
                  </a:extLst>
                </p:cNvPr>
                <p:cNvSpPr/>
                <p:nvPr/>
              </p:nvSpPr>
              <p:spPr>
                <a:xfrm>
                  <a:off x="3650456" y="1166813"/>
                  <a:ext cx="4817269" cy="528638"/>
                </a:xfrm>
                <a:custGeom>
                  <a:avLst/>
                  <a:gdLst>
                    <a:gd name="connsiteX0" fmla="*/ 0 w 4819650"/>
                    <a:gd name="connsiteY0" fmla="*/ 0 h 533400"/>
                    <a:gd name="connsiteX1" fmla="*/ 1609725 w 4819650"/>
                    <a:gd name="connsiteY1" fmla="*/ 452437 h 533400"/>
                    <a:gd name="connsiteX2" fmla="*/ 3209925 w 4819650"/>
                    <a:gd name="connsiteY2" fmla="*/ 533400 h 533400"/>
                    <a:gd name="connsiteX3" fmla="*/ 4819650 w 4819650"/>
                    <a:gd name="connsiteY3" fmla="*/ 490537 h 533400"/>
                    <a:gd name="connsiteX0" fmla="*/ 0 w 4819650"/>
                    <a:gd name="connsiteY0" fmla="*/ 0 h 528638"/>
                    <a:gd name="connsiteX1" fmla="*/ 1609725 w 4819650"/>
                    <a:gd name="connsiteY1" fmla="*/ 452437 h 528638"/>
                    <a:gd name="connsiteX2" fmla="*/ 3212306 w 4819650"/>
                    <a:gd name="connsiteY2" fmla="*/ 528638 h 528638"/>
                    <a:gd name="connsiteX3" fmla="*/ 4819650 w 4819650"/>
                    <a:gd name="connsiteY3" fmla="*/ 490537 h 528638"/>
                    <a:gd name="connsiteX0" fmla="*/ 0 w 4819650"/>
                    <a:gd name="connsiteY0" fmla="*/ 0 h 528638"/>
                    <a:gd name="connsiteX1" fmla="*/ 1612106 w 4819650"/>
                    <a:gd name="connsiteY1" fmla="*/ 452437 h 528638"/>
                    <a:gd name="connsiteX2" fmla="*/ 3212306 w 4819650"/>
                    <a:gd name="connsiteY2" fmla="*/ 528638 h 528638"/>
                    <a:gd name="connsiteX3" fmla="*/ 4819650 w 4819650"/>
                    <a:gd name="connsiteY3" fmla="*/ 490537 h 528638"/>
                    <a:gd name="connsiteX0" fmla="*/ 0 w 4817269"/>
                    <a:gd name="connsiteY0" fmla="*/ 0 h 528638"/>
                    <a:gd name="connsiteX1" fmla="*/ 1609725 w 4817269"/>
                    <a:gd name="connsiteY1" fmla="*/ 452437 h 528638"/>
                    <a:gd name="connsiteX2" fmla="*/ 3209925 w 4817269"/>
                    <a:gd name="connsiteY2" fmla="*/ 528638 h 528638"/>
                    <a:gd name="connsiteX3" fmla="*/ 4817269 w 4817269"/>
                    <a:gd name="connsiteY3" fmla="*/ 490537 h 52863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7269" h="528638">
                      <a:moveTo>
                        <a:pt x="0" y="0"/>
                      </a:moveTo>
                      <a:lnTo>
                        <a:pt x="1609725" y="452437"/>
                      </a:lnTo>
                      <a:lnTo>
                        <a:pt x="3209925" y="528638"/>
                      </a:lnTo>
                      <a:lnTo>
                        <a:pt x="4817269" y="490537"/>
                      </a:lnTo>
                    </a:path>
                  </a:pathLst>
                </a:custGeom>
                <a:noFill/>
                <a:ln w="3810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79" name="グループ化 378">
                <a:extLst>
                  <a:ext uri="{FF2B5EF4-FFF2-40B4-BE49-F238E27FC236}">
                    <a16:creationId xmlns:a16="http://schemas.microsoft.com/office/drawing/2014/main" id="{0AB34610-A74C-646F-7030-13761EA20C0A}"/>
                  </a:ext>
                </a:extLst>
              </p:cNvPr>
              <p:cNvGrpSpPr/>
              <p:nvPr/>
            </p:nvGrpSpPr>
            <p:grpSpPr>
              <a:xfrm>
                <a:off x="3421772" y="1096084"/>
                <a:ext cx="6595289" cy="1889290"/>
                <a:chOff x="3419921" y="1096084"/>
                <a:chExt cx="6595289" cy="1889290"/>
              </a:xfrm>
            </p:grpSpPr>
            <p:grpSp>
              <p:nvGrpSpPr>
                <p:cNvPr id="377" name="グループ化 376">
                  <a:extLst>
                    <a:ext uri="{FF2B5EF4-FFF2-40B4-BE49-F238E27FC236}">
                      <a16:creationId xmlns:a16="http://schemas.microsoft.com/office/drawing/2014/main" id="{938881D7-D6F6-06EB-771E-85A08C8B1770}"/>
                    </a:ext>
                  </a:extLst>
                </p:cNvPr>
                <p:cNvGrpSpPr/>
                <p:nvPr/>
              </p:nvGrpSpPr>
              <p:grpSpPr>
                <a:xfrm>
                  <a:off x="5045601" y="1150144"/>
                  <a:ext cx="4969609" cy="1835230"/>
                  <a:chOff x="5045601" y="1150144"/>
                  <a:chExt cx="4969609" cy="1835230"/>
                </a:xfrm>
              </p:grpSpPr>
              <p:grpSp>
                <p:nvGrpSpPr>
                  <p:cNvPr id="141" name="グループ化 140">
                    <a:extLst>
                      <a:ext uri="{FF2B5EF4-FFF2-40B4-BE49-F238E27FC236}">
                        <a16:creationId xmlns:a16="http://schemas.microsoft.com/office/drawing/2014/main" id="{D479F6E4-A537-2F3F-4E35-7AE9D636D7C7}"/>
                      </a:ext>
                    </a:extLst>
                  </p:cNvPr>
                  <p:cNvGrpSpPr/>
                  <p:nvPr/>
                </p:nvGrpSpPr>
                <p:grpSpPr>
                  <a:xfrm>
                    <a:off x="5045601" y="1150144"/>
                    <a:ext cx="108000" cy="1359694"/>
                    <a:chOff x="3181267" y="2597151"/>
                    <a:chExt cx="108000" cy="2157062"/>
                  </a:xfrm>
                </p:grpSpPr>
                <p:cxnSp>
                  <p:nvCxnSpPr>
                    <p:cNvPr id="158" name="直線コネクタ 157">
                      <a:extLst>
                        <a:ext uri="{FF2B5EF4-FFF2-40B4-BE49-F238E27FC236}">
                          <a16:creationId xmlns:a16="http://schemas.microsoft.com/office/drawing/2014/main" id="{2188B23E-EA3A-54E4-FFCF-B70F9371098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9" name="直線コネクタ 158">
                      <a:extLst>
                        <a:ext uri="{FF2B5EF4-FFF2-40B4-BE49-F238E27FC236}">
                          <a16:creationId xmlns:a16="http://schemas.microsoft.com/office/drawing/2014/main" id="{7941F9AB-1DA7-AD88-E5A9-F5415D62D1F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0" name="直線コネクタ 159">
                      <a:extLst>
                        <a:ext uri="{FF2B5EF4-FFF2-40B4-BE49-F238E27FC236}">
                          <a16:creationId xmlns:a16="http://schemas.microsoft.com/office/drawing/2014/main" id="{15D3EB26-AB81-3C69-410F-A938BF9BF16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42" name="グループ化 141">
                    <a:extLst>
                      <a:ext uri="{FF2B5EF4-FFF2-40B4-BE49-F238E27FC236}">
                        <a16:creationId xmlns:a16="http://schemas.microsoft.com/office/drawing/2014/main" id="{1F178567-584B-85A0-42AE-6EC5AA2C005A}"/>
                      </a:ext>
                    </a:extLst>
                  </p:cNvPr>
                  <p:cNvGrpSpPr/>
                  <p:nvPr/>
                </p:nvGrpSpPr>
                <p:grpSpPr>
                  <a:xfrm>
                    <a:off x="6644900" y="1333500"/>
                    <a:ext cx="108000" cy="1395413"/>
                    <a:chOff x="3181267" y="2597151"/>
                    <a:chExt cx="108000" cy="2157062"/>
                  </a:xfrm>
                </p:grpSpPr>
                <p:cxnSp>
                  <p:nvCxnSpPr>
                    <p:cNvPr id="155" name="直線コネクタ 154">
                      <a:extLst>
                        <a:ext uri="{FF2B5EF4-FFF2-40B4-BE49-F238E27FC236}">
                          <a16:creationId xmlns:a16="http://schemas.microsoft.com/office/drawing/2014/main" id="{D6614A83-2331-DF4B-6CF1-D2C5C5AB029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直線コネクタ 155">
                      <a:extLst>
                        <a:ext uri="{FF2B5EF4-FFF2-40B4-BE49-F238E27FC236}">
                          <a16:creationId xmlns:a16="http://schemas.microsoft.com/office/drawing/2014/main" id="{FD2BE831-380C-D049-449D-A9D3322CAD1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直線コネクタ 156">
                      <a:extLst>
                        <a:ext uri="{FF2B5EF4-FFF2-40B4-BE49-F238E27FC236}">
                          <a16:creationId xmlns:a16="http://schemas.microsoft.com/office/drawing/2014/main" id="{69E67A6F-F6D0-473E-EA28-97CCB5D924D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75" name="グループ化 374">
                    <a:extLst>
                      <a:ext uri="{FF2B5EF4-FFF2-40B4-BE49-F238E27FC236}">
                        <a16:creationId xmlns:a16="http://schemas.microsoft.com/office/drawing/2014/main" id="{547F73B5-102C-301E-CF6B-8BBF1F27CAA3}"/>
                      </a:ext>
                    </a:extLst>
                  </p:cNvPr>
                  <p:cNvGrpSpPr/>
                  <p:nvPr/>
                </p:nvGrpSpPr>
                <p:grpSpPr>
                  <a:xfrm>
                    <a:off x="8198163" y="1276350"/>
                    <a:ext cx="211596" cy="1590216"/>
                    <a:chOff x="8198163" y="1276350"/>
                    <a:chExt cx="211596" cy="1590216"/>
                  </a:xfrm>
                </p:grpSpPr>
                <p:sp>
                  <p:nvSpPr>
                    <p:cNvPr id="150" name="テキスト ボックス 149">
                      <a:extLst>
                        <a:ext uri="{FF2B5EF4-FFF2-40B4-BE49-F238E27FC236}">
                          <a16:creationId xmlns:a16="http://schemas.microsoft.com/office/drawing/2014/main" id="{7325E13A-FB4A-5D3B-088C-F972B741CE0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98163" y="2534293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  <p:grpSp>
                  <p:nvGrpSpPr>
                    <p:cNvPr id="151" name="グループ化 150">
                      <a:extLst>
                        <a:ext uri="{FF2B5EF4-FFF2-40B4-BE49-F238E27FC236}">
                          <a16:creationId xmlns:a16="http://schemas.microsoft.com/office/drawing/2014/main" id="{CBCAF33A-59C2-4838-B5F4-2A2F02C9A42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50371" y="1276350"/>
                      <a:ext cx="108000" cy="1294672"/>
                      <a:chOff x="3181267" y="2597151"/>
                      <a:chExt cx="108000" cy="2157062"/>
                    </a:xfrm>
                  </p:grpSpPr>
                  <p:cxnSp>
                    <p:nvCxnSpPr>
                      <p:cNvPr id="152" name="直線コネクタ 151">
                        <a:extLst>
                          <a:ext uri="{FF2B5EF4-FFF2-40B4-BE49-F238E27FC236}">
                            <a16:creationId xmlns:a16="http://schemas.microsoft.com/office/drawing/2014/main" id="{10346F54-241F-13E0-CDF3-88808E28761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3" name="直線コネクタ 152">
                        <a:extLst>
                          <a:ext uri="{FF2B5EF4-FFF2-40B4-BE49-F238E27FC236}">
                            <a16:creationId xmlns:a16="http://schemas.microsoft.com/office/drawing/2014/main" id="{3B64EA0B-1444-B1A8-EC61-EF90E6985F5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4" name="直線コネクタ 153">
                        <a:extLst>
                          <a:ext uri="{FF2B5EF4-FFF2-40B4-BE49-F238E27FC236}">
                            <a16:creationId xmlns:a16="http://schemas.microsoft.com/office/drawing/2014/main" id="{0F5A0E50-D57A-FBC3-E4FA-3BED3E3D42B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76" name="グループ化 375">
                    <a:extLst>
                      <a:ext uri="{FF2B5EF4-FFF2-40B4-BE49-F238E27FC236}">
                        <a16:creationId xmlns:a16="http://schemas.microsoft.com/office/drawing/2014/main" id="{9D3E0E7E-5417-2ED0-8738-6CC1FB09A583}"/>
                      </a:ext>
                    </a:extLst>
                  </p:cNvPr>
                  <p:cNvGrpSpPr/>
                  <p:nvPr/>
                </p:nvGrpSpPr>
                <p:grpSpPr>
                  <a:xfrm>
                    <a:off x="9803614" y="1309688"/>
                    <a:ext cx="211596" cy="1675686"/>
                    <a:chOff x="9803614" y="1309688"/>
                    <a:chExt cx="211596" cy="1675686"/>
                  </a:xfrm>
                </p:grpSpPr>
                <p:grpSp>
                  <p:nvGrpSpPr>
                    <p:cNvPr id="145" name="グループ化 144">
                      <a:extLst>
                        <a:ext uri="{FF2B5EF4-FFF2-40B4-BE49-F238E27FC236}">
                          <a16:creationId xmlns:a16="http://schemas.microsoft.com/office/drawing/2014/main" id="{B8B64E38-5F94-2F35-F02C-44C8531F3BB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845885" y="1309688"/>
                      <a:ext cx="108000" cy="1377656"/>
                      <a:chOff x="3181267" y="2597151"/>
                      <a:chExt cx="108000" cy="2157062"/>
                    </a:xfrm>
                  </p:grpSpPr>
                  <p:cxnSp>
                    <p:nvCxnSpPr>
                      <p:cNvPr id="147" name="直線コネクタ 146">
                        <a:extLst>
                          <a:ext uri="{FF2B5EF4-FFF2-40B4-BE49-F238E27FC236}">
                            <a16:creationId xmlns:a16="http://schemas.microsoft.com/office/drawing/2014/main" id="{9C0C97F1-5E75-C0A7-4117-C39CDF5ED39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8" name="直線コネクタ 147">
                        <a:extLst>
                          <a:ext uri="{FF2B5EF4-FFF2-40B4-BE49-F238E27FC236}">
                            <a16:creationId xmlns:a16="http://schemas.microsoft.com/office/drawing/2014/main" id="{0020F711-F8D3-2332-C3C8-C13D7C6DBD2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9" name="直線コネクタ 148">
                        <a:extLst>
                          <a:ext uri="{FF2B5EF4-FFF2-40B4-BE49-F238E27FC236}">
                            <a16:creationId xmlns:a16="http://schemas.microsoft.com/office/drawing/2014/main" id="{C36F1EA7-1A0C-68A3-C98E-DDCA86FFA74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46" name="テキスト ボックス 145">
                      <a:extLst>
                        <a:ext uri="{FF2B5EF4-FFF2-40B4-BE49-F238E27FC236}">
                          <a16:creationId xmlns:a16="http://schemas.microsoft.com/office/drawing/2014/main" id="{13233F7E-F034-4823-B51C-6C41D35A9D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03614" y="2653101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74" name="グループ化 373">
                  <a:extLst>
                    <a:ext uri="{FF2B5EF4-FFF2-40B4-BE49-F238E27FC236}">
                      <a16:creationId xmlns:a16="http://schemas.microsoft.com/office/drawing/2014/main" id="{CCA2937B-D0E2-0C6F-7317-161C7E6C1B25}"/>
                    </a:ext>
                  </a:extLst>
                </p:cNvPr>
                <p:cNvGrpSpPr/>
                <p:nvPr/>
              </p:nvGrpSpPr>
              <p:grpSpPr>
                <a:xfrm>
                  <a:off x="3419921" y="1096084"/>
                  <a:ext cx="6551963" cy="1008282"/>
                  <a:chOff x="3419921" y="1096084"/>
                  <a:chExt cx="6551963" cy="1008282"/>
                </a:xfrm>
              </p:grpSpPr>
              <p:sp>
                <p:nvSpPr>
                  <p:cNvPr id="136" name="楕円 135">
                    <a:extLst>
                      <a:ext uri="{FF2B5EF4-FFF2-40B4-BE49-F238E27FC236}">
                        <a16:creationId xmlns:a16="http://schemas.microsoft.com/office/drawing/2014/main" id="{5B26FB43-907D-9DEB-99F3-7DF7E18F5F6A}"/>
                      </a:ext>
                    </a:extLst>
                  </p:cNvPr>
                  <p:cNvSpPr/>
                  <p:nvPr/>
                </p:nvSpPr>
                <p:spPr>
                  <a:xfrm>
                    <a:off x="3419921" y="1096084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7" name="楕円 136">
                    <a:extLst>
                      <a:ext uri="{FF2B5EF4-FFF2-40B4-BE49-F238E27FC236}">
                        <a16:creationId xmlns:a16="http://schemas.microsoft.com/office/drawing/2014/main" id="{B178194C-D0FA-2217-556B-8A87479425B1}"/>
                      </a:ext>
                    </a:extLst>
                  </p:cNvPr>
                  <p:cNvSpPr/>
                  <p:nvPr/>
                </p:nvSpPr>
                <p:spPr>
                  <a:xfrm>
                    <a:off x="5027600" y="1760818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8" name="楕円 137">
                    <a:extLst>
                      <a:ext uri="{FF2B5EF4-FFF2-40B4-BE49-F238E27FC236}">
                        <a16:creationId xmlns:a16="http://schemas.microsoft.com/office/drawing/2014/main" id="{6ACE3E39-2C19-FDEC-5C1E-B0B613C3DF0B}"/>
                      </a:ext>
                    </a:extLst>
                  </p:cNvPr>
                  <p:cNvSpPr/>
                  <p:nvPr/>
                </p:nvSpPr>
                <p:spPr>
                  <a:xfrm>
                    <a:off x="6626899" y="1960366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9" name="楕円 138">
                    <a:extLst>
                      <a:ext uri="{FF2B5EF4-FFF2-40B4-BE49-F238E27FC236}">
                        <a16:creationId xmlns:a16="http://schemas.microsoft.com/office/drawing/2014/main" id="{13217DC9-A68B-AC08-316B-5080ADB73296}"/>
                      </a:ext>
                    </a:extLst>
                  </p:cNvPr>
                  <p:cNvSpPr/>
                  <p:nvPr/>
                </p:nvSpPr>
                <p:spPr>
                  <a:xfrm>
                    <a:off x="8232370" y="1853374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楕円 139">
                    <a:extLst>
                      <a:ext uri="{FF2B5EF4-FFF2-40B4-BE49-F238E27FC236}">
                        <a16:creationId xmlns:a16="http://schemas.microsoft.com/office/drawing/2014/main" id="{299A1EF5-CB4F-F468-0633-2411E45BC5A3}"/>
                      </a:ext>
                    </a:extLst>
                  </p:cNvPr>
                  <p:cNvSpPr/>
                  <p:nvPr/>
                </p:nvSpPr>
                <p:spPr>
                  <a:xfrm>
                    <a:off x="9827884" y="1925785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8" name="フリーフォーム: 図形 377">
                  <a:extLst>
                    <a:ext uri="{FF2B5EF4-FFF2-40B4-BE49-F238E27FC236}">
                      <a16:creationId xmlns:a16="http://schemas.microsoft.com/office/drawing/2014/main" id="{2444092A-65FA-79EE-12F1-5C02FA8A7113}"/>
                    </a:ext>
                  </a:extLst>
                </p:cNvPr>
                <p:cNvSpPr/>
                <p:nvPr/>
              </p:nvSpPr>
              <p:spPr>
                <a:xfrm>
                  <a:off x="3486150" y="1166813"/>
                  <a:ext cx="4819650" cy="866775"/>
                </a:xfrm>
                <a:custGeom>
                  <a:avLst/>
                  <a:gdLst>
                    <a:gd name="connsiteX0" fmla="*/ 0 w 4819650"/>
                    <a:gd name="connsiteY0" fmla="*/ 0 h 862012"/>
                    <a:gd name="connsiteX1" fmla="*/ 1614488 w 4819650"/>
                    <a:gd name="connsiteY1" fmla="*/ 661987 h 862012"/>
                    <a:gd name="connsiteX2" fmla="*/ 3209925 w 4819650"/>
                    <a:gd name="connsiteY2" fmla="*/ 862012 h 862012"/>
                    <a:gd name="connsiteX3" fmla="*/ 4819650 w 4819650"/>
                    <a:gd name="connsiteY3" fmla="*/ 752475 h 862012"/>
                    <a:gd name="connsiteX0" fmla="*/ 0 w 4819650"/>
                    <a:gd name="connsiteY0" fmla="*/ 0 h 866775"/>
                    <a:gd name="connsiteX1" fmla="*/ 1614488 w 4819650"/>
                    <a:gd name="connsiteY1" fmla="*/ 661987 h 866775"/>
                    <a:gd name="connsiteX2" fmla="*/ 3209925 w 4819650"/>
                    <a:gd name="connsiteY2" fmla="*/ 866775 h 866775"/>
                    <a:gd name="connsiteX3" fmla="*/ 4819650 w 4819650"/>
                    <a:gd name="connsiteY3" fmla="*/ 752475 h 866775"/>
                    <a:gd name="connsiteX0" fmla="*/ 0 w 4819650"/>
                    <a:gd name="connsiteY0" fmla="*/ 0 h 866775"/>
                    <a:gd name="connsiteX1" fmla="*/ 1612106 w 4819650"/>
                    <a:gd name="connsiteY1" fmla="*/ 676274 h 866775"/>
                    <a:gd name="connsiteX2" fmla="*/ 3209925 w 4819650"/>
                    <a:gd name="connsiteY2" fmla="*/ 866775 h 866775"/>
                    <a:gd name="connsiteX3" fmla="*/ 4819650 w 4819650"/>
                    <a:gd name="connsiteY3" fmla="*/ 752475 h 866775"/>
                    <a:gd name="connsiteX0" fmla="*/ 0 w 4819650"/>
                    <a:gd name="connsiteY0" fmla="*/ 0 h 866775"/>
                    <a:gd name="connsiteX1" fmla="*/ 1612106 w 4819650"/>
                    <a:gd name="connsiteY1" fmla="*/ 676274 h 866775"/>
                    <a:gd name="connsiteX2" fmla="*/ 3209925 w 4819650"/>
                    <a:gd name="connsiteY2" fmla="*/ 866775 h 866775"/>
                    <a:gd name="connsiteX3" fmla="*/ 4819650 w 4819650"/>
                    <a:gd name="connsiteY3" fmla="*/ 758825 h 866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9650" h="866775">
                      <a:moveTo>
                        <a:pt x="0" y="0"/>
                      </a:moveTo>
                      <a:lnTo>
                        <a:pt x="1612106" y="676274"/>
                      </a:lnTo>
                      <a:lnTo>
                        <a:pt x="3209925" y="866775"/>
                      </a:lnTo>
                      <a:lnTo>
                        <a:pt x="4819650" y="758825"/>
                      </a:lnTo>
                    </a:path>
                  </a:pathLst>
                </a:custGeom>
                <a:noFill/>
                <a:ln w="381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70" name="グループ化 369">
                <a:extLst>
                  <a:ext uri="{FF2B5EF4-FFF2-40B4-BE49-F238E27FC236}">
                    <a16:creationId xmlns:a16="http://schemas.microsoft.com/office/drawing/2014/main" id="{D6BE7103-0CD0-51C8-945B-016E5CA58358}"/>
                  </a:ext>
                </a:extLst>
              </p:cNvPr>
              <p:cNvGrpSpPr/>
              <p:nvPr/>
            </p:nvGrpSpPr>
            <p:grpSpPr>
              <a:xfrm>
                <a:off x="3259790" y="1096084"/>
                <a:ext cx="6584981" cy="1619598"/>
                <a:chOff x="3257939" y="1096084"/>
                <a:chExt cx="6584981" cy="1619598"/>
              </a:xfrm>
            </p:grpSpPr>
            <p:grpSp>
              <p:nvGrpSpPr>
                <p:cNvPr id="368" name="グループ化 367">
                  <a:extLst>
                    <a:ext uri="{FF2B5EF4-FFF2-40B4-BE49-F238E27FC236}">
                      <a16:creationId xmlns:a16="http://schemas.microsoft.com/office/drawing/2014/main" id="{247272AC-4E2E-2967-E7A9-B43D28A5F9BF}"/>
                    </a:ext>
                  </a:extLst>
                </p:cNvPr>
                <p:cNvGrpSpPr/>
                <p:nvPr/>
              </p:nvGrpSpPr>
              <p:grpSpPr>
                <a:xfrm>
                  <a:off x="4883619" y="1099985"/>
                  <a:ext cx="4959301" cy="1615697"/>
                  <a:chOff x="4883619" y="1099985"/>
                  <a:chExt cx="4959301" cy="1615697"/>
                </a:xfrm>
              </p:grpSpPr>
              <p:grpSp>
                <p:nvGrpSpPr>
                  <p:cNvPr id="196" name="グループ化 195">
                    <a:extLst>
                      <a:ext uri="{FF2B5EF4-FFF2-40B4-BE49-F238E27FC236}">
                        <a16:creationId xmlns:a16="http://schemas.microsoft.com/office/drawing/2014/main" id="{049DABCF-0041-E576-9E3B-FD5AD842BB43}"/>
                      </a:ext>
                    </a:extLst>
                  </p:cNvPr>
                  <p:cNvGrpSpPr/>
                  <p:nvPr/>
                </p:nvGrpSpPr>
                <p:grpSpPr>
                  <a:xfrm>
                    <a:off x="4883619" y="1099985"/>
                    <a:ext cx="108000" cy="1252690"/>
                    <a:chOff x="3181267" y="2597151"/>
                    <a:chExt cx="108000" cy="2157062"/>
                  </a:xfrm>
                </p:grpSpPr>
                <p:cxnSp>
                  <p:nvCxnSpPr>
                    <p:cNvPr id="213" name="直線コネクタ 212">
                      <a:extLst>
                        <a:ext uri="{FF2B5EF4-FFF2-40B4-BE49-F238E27FC236}">
                          <a16:creationId xmlns:a16="http://schemas.microsoft.com/office/drawing/2014/main" id="{0A5FD1CB-37A4-66A0-1BE6-70BDCE570DA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4" name="直線コネクタ 213">
                      <a:extLst>
                        <a:ext uri="{FF2B5EF4-FFF2-40B4-BE49-F238E27FC236}">
                          <a16:creationId xmlns:a16="http://schemas.microsoft.com/office/drawing/2014/main" id="{8129E84B-9E28-4621-8CBA-25E651762D0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5" name="直線コネクタ 214">
                      <a:extLst>
                        <a:ext uri="{FF2B5EF4-FFF2-40B4-BE49-F238E27FC236}">
                          <a16:creationId xmlns:a16="http://schemas.microsoft.com/office/drawing/2014/main" id="{C1103C7A-8C89-E272-DCA3-B71AF1FDFBC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97" name="グループ化 196">
                    <a:extLst>
                      <a:ext uri="{FF2B5EF4-FFF2-40B4-BE49-F238E27FC236}">
                        <a16:creationId xmlns:a16="http://schemas.microsoft.com/office/drawing/2014/main" id="{9176BF33-7E9E-4D6C-C9CF-247CE1E93AEB}"/>
                      </a:ext>
                    </a:extLst>
                  </p:cNvPr>
                  <p:cNvGrpSpPr/>
                  <p:nvPr/>
                </p:nvGrpSpPr>
                <p:grpSpPr>
                  <a:xfrm>
                    <a:off x="6482918" y="1221580"/>
                    <a:ext cx="108000" cy="1290639"/>
                    <a:chOff x="3181267" y="2597151"/>
                    <a:chExt cx="108000" cy="2157062"/>
                  </a:xfrm>
                </p:grpSpPr>
                <p:cxnSp>
                  <p:nvCxnSpPr>
                    <p:cNvPr id="210" name="直線コネクタ 209">
                      <a:extLst>
                        <a:ext uri="{FF2B5EF4-FFF2-40B4-BE49-F238E27FC236}">
                          <a16:creationId xmlns:a16="http://schemas.microsoft.com/office/drawing/2014/main" id="{DD13E711-E8E1-00C2-7A49-659510A309D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1" name="直線コネクタ 210">
                      <a:extLst>
                        <a:ext uri="{FF2B5EF4-FFF2-40B4-BE49-F238E27FC236}">
                          <a16:creationId xmlns:a16="http://schemas.microsoft.com/office/drawing/2014/main" id="{CB8F606B-4F39-9427-9CE3-24AF29C04D6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2" name="直線コネクタ 211">
                      <a:extLst>
                        <a:ext uri="{FF2B5EF4-FFF2-40B4-BE49-F238E27FC236}">
                          <a16:creationId xmlns:a16="http://schemas.microsoft.com/office/drawing/2014/main" id="{0FF4741B-CA5E-0C83-E878-671F40566C4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66" name="グループ化 365">
                    <a:extLst>
                      <a:ext uri="{FF2B5EF4-FFF2-40B4-BE49-F238E27FC236}">
                        <a16:creationId xmlns:a16="http://schemas.microsoft.com/office/drawing/2014/main" id="{BB652365-57E1-F3EB-69E4-162AE51F0631}"/>
                      </a:ext>
                    </a:extLst>
                  </p:cNvPr>
                  <p:cNvGrpSpPr/>
                  <p:nvPr/>
                </p:nvGrpSpPr>
                <p:grpSpPr>
                  <a:xfrm>
                    <a:off x="8036031" y="1159669"/>
                    <a:ext cx="211596" cy="1556013"/>
                    <a:chOff x="8036031" y="1159669"/>
                    <a:chExt cx="211596" cy="1556013"/>
                  </a:xfrm>
                </p:grpSpPr>
                <p:grpSp>
                  <p:nvGrpSpPr>
                    <p:cNvPr id="205" name="グループ化 204">
                      <a:extLst>
                        <a:ext uri="{FF2B5EF4-FFF2-40B4-BE49-F238E27FC236}">
                          <a16:creationId xmlns:a16="http://schemas.microsoft.com/office/drawing/2014/main" id="{5DDFC825-048E-7D5A-91FB-06CCCFB0066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88389" y="1159669"/>
                      <a:ext cx="108000" cy="1258712"/>
                      <a:chOff x="3181267" y="2597151"/>
                      <a:chExt cx="108000" cy="2157062"/>
                    </a:xfrm>
                  </p:grpSpPr>
                  <p:cxnSp>
                    <p:nvCxnSpPr>
                      <p:cNvPr id="207" name="直線コネクタ 206">
                        <a:extLst>
                          <a:ext uri="{FF2B5EF4-FFF2-40B4-BE49-F238E27FC236}">
                            <a16:creationId xmlns:a16="http://schemas.microsoft.com/office/drawing/2014/main" id="{8B7FA1A0-02D6-EFCA-F8E0-2454F6299ED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8" name="直線コネクタ 207">
                        <a:extLst>
                          <a:ext uri="{FF2B5EF4-FFF2-40B4-BE49-F238E27FC236}">
                            <a16:creationId xmlns:a16="http://schemas.microsoft.com/office/drawing/2014/main" id="{34552991-282F-363C-FB3A-7627F124577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9" name="直線コネクタ 208">
                        <a:extLst>
                          <a:ext uri="{FF2B5EF4-FFF2-40B4-BE49-F238E27FC236}">
                            <a16:creationId xmlns:a16="http://schemas.microsoft.com/office/drawing/2014/main" id="{057C8784-012C-AD13-6A52-C11A0F58CFC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6" name="テキスト ボックス 205">
                      <a:extLst>
                        <a:ext uri="{FF2B5EF4-FFF2-40B4-BE49-F238E27FC236}">
                          <a16:creationId xmlns:a16="http://schemas.microsoft.com/office/drawing/2014/main" id="{8AE29E8E-AF7F-6097-6A4A-779771E1220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36031" y="2383409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  <p:grpSp>
                <p:nvGrpSpPr>
                  <p:cNvPr id="367" name="グループ化 366">
                    <a:extLst>
                      <a:ext uri="{FF2B5EF4-FFF2-40B4-BE49-F238E27FC236}">
                        <a16:creationId xmlns:a16="http://schemas.microsoft.com/office/drawing/2014/main" id="{59EB48D1-4B49-4C79-590B-5E965035867C}"/>
                      </a:ext>
                    </a:extLst>
                  </p:cNvPr>
                  <p:cNvGrpSpPr/>
                  <p:nvPr/>
                </p:nvGrpSpPr>
                <p:grpSpPr>
                  <a:xfrm>
                    <a:off x="9631324" y="1155700"/>
                    <a:ext cx="211596" cy="1544565"/>
                    <a:chOff x="9631324" y="1155700"/>
                    <a:chExt cx="211596" cy="1544565"/>
                  </a:xfrm>
                </p:grpSpPr>
                <p:grpSp>
                  <p:nvGrpSpPr>
                    <p:cNvPr id="200" name="グループ化 199">
                      <a:extLst>
                        <a:ext uri="{FF2B5EF4-FFF2-40B4-BE49-F238E27FC236}">
                          <a16:creationId xmlns:a16="http://schemas.microsoft.com/office/drawing/2014/main" id="{C93AD4E5-64E2-6748-35AF-2DB31CA38D0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683903" y="1155700"/>
                      <a:ext cx="108000" cy="1293502"/>
                      <a:chOff x="3181267" y="2597151"/>
                      <a:chExt cx="108000" cy="2157062"/>
                    </a:xfrm>
                  </p:grpSpPr>
                  <p:cxnSp>
                    <p:nvCxnSpPr>
                      <p:cNvPr id="202" name="直線コネクタ 201">
                        <a:extLst>
                          <a:ext uri="{FF2B5EF4-FFF2-40B4-BE49-F238E27FC236}">
                            <a16:creationId xmlns:a16="http://schemas.microsoft.com/office/drawing/2014/main" id="{5B37A40B-BB1E-5601-5756-DD13C68F7CD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3" name="直線コネクタ 202">
                        <a:extLst>
                          <a:ext uri="{FF2B5EF4-FFF2-40B4-BE49-F238E27FC236}">
                            <a16:creationId xmlns:a16="http://schemas.microsoft.com/office/drawing/2014/main" id="{903AEB44-1B49-8317-FF6B-5978489A243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4" name="直線コネクタ 203">
                        <a:extLst>
                          <a:ext uri="{FF2B5EF4-FFF2-40B4-BE49-F238E27FC236}">
                            <a16:creationId xmlns:a16="http://schemas.microsoft.com/office/drawing/2014/main" id="{494A36DD-7FB1-E6E2-DF47-A6F609CE914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1" name="テキスト ボックス 200">
                      <a:extLst>
                        <a:ext uri="{FF2B5EF4-FFF2-40B4-BE49-F238E27FC236}">
                          <a16:creationId xmlns:a16="http://schemas.microsoft.com/office/drawing/2014/main" id="{0E63B387-EEFE-6512-5AD5-A10DC2F65A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31324" y="2411981"/>
                      <a:ext cx="211596" cy="28828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190" name="グループ化 189">
                  <a:extLst>
                    <a:ext uri="{FF2B5EF4-FFF2-40B4-BE49-F238E27FC236}">
                      <a16:creationId xmlns:a16="http://schemas.microsoft.com/office/drawing/2014/main" id="{04435D25-EEBF-3C14-6851-C7C484B43765}"/>
                    </a:ext>
                  </a:extLst>
                </p:cNvPr>
                <p:cNvGrpSpPr/>
                <p:nvPr/>
              </p:nvGrpSpPr>
              <p:grpSpPr>
                <a:xfrm>
                  <a:off x="3257939" y="1096084"/>
                  <a:ext cx="6551963" cy="843295"/>
                  <a:chOff x="3257939" y="1096084"/>
                  <a:chExt cx="6551963" cy="843295"/>
                </a:xfrm>
              </p:grpSpPr>
              <p:sp>
                <p:nvSpPr>
                  <p:cNvPr id="191" name="楕円 190">
                    <a:extLst>
                      <a:ext uri="{FF2B5EF4-FFF2-40B4-BE49-F238E27FC236}">
                        <a16:creationId xmlns:a16="http://schemas.microsoft.com/office/drawing/2014/main" id="{5BA355D7-C4B2-533C-46BD-B378A545EA21}"/>
                      </a:ext>
                    </a:extLst>
                  </p:cNvPr>
                  <p:cNvSpPr/>
                  <p:nvPr/>
                </p:nvSpPr>
                <p:spPr>
                  <a:xfrm>
                    <a:off x="3257939" y="109608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2" name="楕円 191">
                    <a:extLst>
                      <a:ext uri="{FF2B5EF4-FFF2-40B4-BE49-F238E27FC236}">
                        <a16:creationId xmlns:a16="http://schemas.microsoft.com/office/drawing/2014/main" id="{E77A5295-CE0E-8D1E-1F1F-32CFE4CAA98E}"/>
                      </a:ext>
                    </a:extLst>
                  </p:cNvPr>
                  <p:cNvSpPr/>
                  <p:nvPr/>
                </p:nvSpPr>
                <p:spPr>
                  <a:xfrm>
                    <a:off x="4865618" y="164733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3" name="楕円 192">
                    <a:extLst>
                      <a:ext uri="{FF2B5EF4-FFF2-40B4-BE49-F238E27FC236}">
                        <a16:creationId xmlns:a16="http://schemas.microsoft.com/office/drawing/2014/main" id="{FAD4F57E-976B-1537-3FF6-48065F39FC9C}"/>
                      </a:ext>
                    </a:extLst>
                  </p:cNvPr>
                  <p:cNvSpPr/>
                  <p:nvPr/>
                </p:nvSpPr>
                <p:spPr>
                  <a:xfrm>
                    <a:off x="6464917" y="1795379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4" name="楕円 193">
                    <a:extLst>
                      <a:ext uri="{FF2B5EF4-FFF2-40B4-BE49-F238E27FC236}">
                        <a16:creationId xmlns:a16="http://schemas.microsoft.com/office/drawing/2014/main" id="{22EDF8DD-C72C-0B4D-3A59-C3A600C63092}"/>
                      </a:ext>
                    </a:extLst>
                  </p:cNvPr>
                  <p:cNvSpPr/>
                  <p:nvPr/>
                </p:nvSpPr>
                <p:spPr>
                  <a:xfrm>
                    <a:off x="8070388" y="1717753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5" name="楕円 194">
                    <a:extLst>
                      <a:ext uri="{FF2B5EF4-FFF2-40B4-BE49-F238E27FC236}">
                        <a16:creationId xmlns:a16="http://schemas.microsoft.com/office/drawing/2014/main" id="{DEA77661-FA9A-6DD0-3074-950EC2F9D73A}"/>
                      </a:ext>
                    </a:extLst>
                  </p:cNvPr>
                  <p:cNvSpPr/>
                  <p:nvPr/>
                </p:nvSpPr>
                <p:spPr>
                  <a:xfrm>
                    <a:off x="9665902" y="1729927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69" name="フリーフォーム: 図形 368">
                  <a:extLst>
                    <a:ext uri="{FF2B5EF4-FFF2-40B4-BE49-F238E27FC236}">
                      <a16:creationId xmlns:a16="http://schemas.microsoft.com/office/drawing/2014/main" id="{20DD35A4-49B7-C31D-5B5B-6F5C23586DE0}"/>
                    </a:ext>
                  </a:extLst>
                </p:cNvPr>
                <p:cNvSpPr/>
                <p:nvPr/>
              </p:nvSpPr>
              <p:spPr>
                <a:xfrm>
                  <a:off x="3321843" y="1166813"/>
                  <a:ext cx="4822031" cy="700087"/>
                </a:xfrm>
                <a:custGeom>
                  <a:avLst/>
                  <a:gdLst>
                    <a:gd name="connsiteX0" fmla="*/ 0 w 6424612"/>
                    <a:gd name="connsiteY0" fmla="*/ 0 h 700087"/>
                    <a:gd name="connsiteX1" fmla="*/ 1614487 w 6424612"/>
                    <a:gd name="connsiteY1" fmla="*/ 547687 h 700087"/>
                    <a:gd name="connsiteX2" fmla="*/ 3219450 w 6424612"/>
                    <a:gd name="connsiteY2" fmla="*/ 700087 h 700087"/>
                    <a:gd name="connsiteX3" fmla="*/ 4824412 w 6424612"/>
                    <a:gd name="connsiteY3" fmla="*/ 628650 h 700087"/>
                    <a:gd name="connsiteX4" fmla="*/ 6424612 w 6424612"/>
                    <a:gd name="connsiteY4" fmla="*/ 628650 h 700087"/>
                    <a:gd name="connsiteX0" fmla="*/ 0 w 6422231"/>
                    <a:gd name="connsiteY0" fmla="*/ 0 h 700087"/>
                    <a:gd name="connsiteX1" fmla="*/ 1614487 w 6422231"/>
                    <a:gd name="connsiteY1" fmla="*/ 547687 h 700087"/>
                    <a:gd name="connsiteX2" fmla="*/ 3219450 w 6422231"/>
                    <a:gd name="connsiteY2" fmla="*/ 700087 h 700087"/>
                    <a:gd name="connsiteX3" fmla="*/ 4824412 w 6422231"/>
                    <a:gd name="connsiteY3" fmla="*/ 628650 h 700087"/>
                    <a:gd name="connsiteX4" fmla="*/ 6422231 w 6422231"/>
                    <a:gd name="connsiteY4" fmla="*/ 638175 h 700087"/>
                    <a:gd name="connsiteX0" fmla="*/ 0 w 6422231"/>
                    <a:gd name="connsiteY0" fmla="*/ 0 h 700087"/>
                    <a:gd name="connsiteX1" fmla="*/ 1614487 w 6422231"/>
                    <a:gd name="connsiteY1" fmla="*/ 547687 h 700087"/>
                    <a:gd name="connsiteX2" fmla="*/ 3219450 w 6422231"/>
                    <a:gd name="connsiteY2" fmla="*/ 700087 h 700087"/>
                    <a:gd name="connsiteX3" fmla="*/ 4824412 w 6422231"/>
                    <a:gd name="connsiteY3" fmla="*/ 628650 h 700087"/>
                    <a:gd name="connsiteX4" fmla="*/ 6422231 w 6422231"/>
                    <a:gd name="connsiteY4" fmla="*/ 638175 h 700087"/>
                    <a:gd name="connsiteX0" fmla="*/ 0 w 6422231"/>
                    <a:gd name="connsiteY0" fmla="*/ 0 h 700087"/>
                    <a:gd name="connsiteX1" fmla="*/ 1614487 w 6422231"/>
                    <a:gd name="connsiteY1" fmla="*/ 547687 h 700087"/>
                    <a:gd name="connsiteX2" fmla="*/ 3219450 w 6422231"/>
                    <a:gd name="connsiteY2" fmla="*/ 700087 h 700087"/>
                    <a:gd name="connsiteX3" fmla="*/ 4824412 w 6422231"/>
                    <a:gd name="connsiteY3" fmla="*/ 626269 h 700087"/>
                    <a:gd name="connsiteX4" fmla="*/ 6422231 w 6422231"/>
                    <a:gd name="connsiteY4" fmla="*/ 638175 h 700087"/>
                    <a:gd name="connsiteX0" fmla="*/ 0 w 6422231"/>
                    <a:gd name="connsiteY0" fmla="*/ 0 h 700087"/>
                    <a:gd name="connsiteX1" fmla="*/ 1616868 w 6422231"/>
                    <a:gd name="connsiteY1" fmla="*/ 554831 h 700087"/>
                    <a:gd name="connsiteX2" fmla="*/ 3219450 w 6422231"/>
                    <a:gd name="connsiteY2" fmla="*/ 700087 h 700087"/>
                    <a:gd name="connsiteX3" fmla="*/ 4824412 w 6422231"/>
                    <a:gd name="connsiteY3" fmla="*/ 626269 h 700087"/>
                    <a:gd name="connsiteX4" fmla="*/ 6422231 w 6422231"/>
                    <a:gd name="connsiteY4" fmla="*/ 638175 h 700087"/>
                    <a:gd name="connsiteX0" fmla="*/ 0 w 6419850"/>
                    <a:gd name="connsiteY0" fmla="*/ 0 h 700087"/>
                    <a:gd name="connsiteX1" fmla="*/ 1614487 w 6419850"/>
                    <a:gd name="connsiteY1" fmla="*/ 554831 h 700087"/>
                    <a:gd name="connsiteX2" fmla="*/ 3217069 w 6419850"/>
                    <a:gd name="connsiteY2" fmla="*/ 700087 h 700087"/>
                    <a:gd name="connsiteX3" fmla="*/ 4822031 w 6419850"/>
                    <a:gd name="connsiteY3" fmla="*/ 626269 h 700087"/>
                    <a:gd name="connsiteX4" fmla="*/ 6419850 w 6419850"/>
                    <a:gd name="connsiteY4" fmla="*/ 638175 h 700087"/>
                    <a:gd name="connsiteX0" fmla="*/ 0 w 4822031"/>
                    <a:gd name="connsiteY0" fmla="*/ 0 h 700087"/>
                    <a:gd name="connsiteX1" fmla="*/ 1614487 w 4822031"/>
                    <a:gd name="connsiteY1" fmla="*/ 554831 h 700087"/>
                    <a:gd name="connsiteX2" fmla="*/ 3217069 w 4822031"/>
                    <a:gd name="connsiteY2" fmla="*/ 700087 h 700087"/>
                    <a:gd name="connsiteX3" fmla="*/ 4822031 w 4822031"/>
                    <a:gd name="connsiteY3" fmla="*/ 626269 h 7000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22031" h="700087">
                      <a:moveTo>
                        <a:pt x="0" y="0"/>
                      </a:moveTo>
                      <a:lnTo>
                        <a:pt x="1614487" y="554831"/>
                      </a:lnTo>
                      <a:lnTo>
                        <a:pt x="3217069" y="700087"/>
                      </a:lnTo>
                      <a:lnTo>
                        <a:pt x="4822031" y="626269"/>
                      </a:ln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A0067788-2E12-48C1-DFE1-2EB387A7613B}"/>
                </a:ext>
              </a:extLst>
            </p:cNvPr>
            <p:cNvGrpSpPr/>
            <p:nvPr/>
          </p:nvGrpSpPr>
          <p:grpSpPr>
            <a:xfrm>
              <a:off x="1657323" y="3718665"/>
              <a:ext cx="8568364" cy="2774381"/>
              <a:chOff x="1657323" y="3718665"/>
              <a:chExt cx="8568364" cy="2774381"/>
            </a:xfrm>
          </p:grpSpPr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20DDCFF6-F15E-20B7-78B1-BD8ED3D5F42D}"/>
                  </a:ext>
                </a:extLst>
              </p:cNvPr>
              <p:cNvSpPr txBox="1"/>
              <p:nvPr/>
            </p:nvSpPr>
            <p:spPr>
              <a:xfrm rot="16200000">
                <a:off x="773684" y="4758375"/>
                <a:ext cx="2598275" cy="83099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hange in bedtime home 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DBP from baseline to EOT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(mmHg)</a:t>
                </a:r>
              </a:p>
            </p:txBody>
          </p:sp>
          <p:cxnSp>
            <p:nvCxnSpPr>
              <p:cNvPr id="233" name="直線コネクタ 232">
                <a:extLst>
                  <a:ext uri="{FF2B5EF4-FFF2-40B4-BE49-F238E27FC236}">
                    <a16:creationId xmlns:a16="http://schemas.microsoft.com/office/drawing/2014/main" id="{242B55D5-B062-DEA4-5D74-0F467BA988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4100" y="4047798"/>
                <a:ext cx="7201587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4" name="正方形/長方形 243">
                <a:extLst>
                  <a:ext uri="{FF2B5EF4-FFF2-40B4-BE49-F238E27FC236}">
                    <a16:creationId xmlns:a16="http://schemas.microsoft.com/office/drawing/2014/main" id="{CBC040E8-2D75-F66D-27E3-8E55FF09802B}"/>
                  </a:ext>
                </a:extLst>
              </p:cNvPr>
              <p:cNvSpPr/>
              <p:nvPr/>
            </p:nvSpPr>
            <p:spPr>
              <a:xfrm>
                <a:off x="2794774" y="3923341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45" name="直線コネクタ 244">
                <a:extLst>
                  <a:ext uri="{FF2B5EF4-FFF2-40B4-BE49-F238E27FC236}">
                    <a16:creationId xmlns:a16="http://schemas.microsoft.com/office/drawing/2014/main" id="{340CDD5E-2A1E-05AF-153A-1DD5E91822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6115950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6" name="正方形/長方形 245">
                <a:extLst>
                  <a:ext uri="{FF2B5EF4-FFF2-40B4-BE49-F238E27FC236}">
                    <a16:creationId xmlns:a16="http://schemas.microsoft.com/office/drawing/2014/main" id="{A5A35CBF-CAC5-C42B-7437-997051A323AF}"/>
                  </a:ext>
                </a:extLst>
              </p:cNvPr>
              <p:cNvSpPr/>
              <p:nvPr/>
            </p:nvSpPr>
            <p:spPr>
              <a:xfrm>
                <a:off x="2560736" y="5991813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49" name="直線コネクタ 248">
                <a:extLst>
                  <a:ext uri="{FF2B5EF4-FFF2-40B4-BE49-F238E27FC236}">
                    <a16:creationId xmlns:a16="http://schemas.microsoft.com/office/drawing/2014/main" id="{4675FC75-95A8-A1CB-8FDD-3C4A4170EC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5598912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0" name="正方形/長方形 249">
                <a:extLst>
                  <a:ext uri="{FF2B5EF4-FFF2-40B4-BE49-F238E27FC236}">
                    <a16:creationId xmlns:a16="http://schemas.microsoft.com/office/drawing/2014/main" id="{2F19D73D-0378-B313-50B4-F7C32DD1717F}"/>
                  </a:ext>
                </a:extLst>
              </p:cNvPr>
              <p:cNvSpPr/>
              <p:nvPr/>
            </p:nvSpPr>
            <p:spPr>
              <a:xfrm>
                <a:off x="2560736" y="5474695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51" name="直線コネクタ 250">
                <a:extLst>
                  <a:ext uri="{FF2B5EF4-FFF2-40B4-BE49-F238E27FC236}">
                    <a16:creationId xmlns:a16="http://schemas.microsoft.com/office/drawing/2014/main" id="{E115A471-D55A-0C2F-1DD8-7F81518300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4566744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2" name="正方形/長方形 251">
                <a:extLst>
                  <a:ext uri="{FF2B5EF4-FFF2-40B4-BE49-F238E27FC236}">
                    <a16:creationId xmlns:a16="http://schemas.microsoft.com/office/drawing/2014/main" id="{331C11B4-8100-A719-01A4-FF739F34F469}"/>
                  </a:ext>
                </a:extLst>
              </p:cNvPr>
              <p:cNvSpPr/>
              <p:nvPr/>
            </p:nvSpPr>
            <p:spPr>
              <a:xfrm>
                <a:off x="2794774" y="4443634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53" name="直線コネクタ 252">
                <a:extLst>
                  <a:ext uri="{FF2B5EF4-FFF2-40B4-BE49-F238E27FC236}">
                    <a16:creationId xmlns:a16="http://schemas.microsoft.com/office/drawing/2014/main" id="{A71601A0-A2EE-341E-043C-E6D6E2327A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4100" y="4049202"/>
                <a:ext cx="0" cy="22284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直線コネクタ 253">
                <a:extLst>
                  <a:ext uri="{FF2B5EF4-FFF2-40B4-BE49-F238E27FC236}">
                    <a16:creationId xmlns:a16="http://schemas.microsoft.com/office/drawing/2014/main" id="{F4F841EC-F74F-C212-897F-426F8101429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4047798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5" name="グループ化 254">
                <a:extLst>
                  <a:ext uri="{FF2B5EF4-FFF2-40B4-BE49-F238E27FC236}">
                    <a16:creationId xmlns:a16="http://schemas.microsoft.com/office/drawing/2014/main" id="{36ADD716-A2E9-30F0-0B44-5EFF4348390B}"/>
                  </a:ext>
                </a:extLst>
              </p:cNvPr>
              <p:cNvGrpSpPr/>
              <p:nvPr/>
            </p:nvGrpSpPr>
            <p:grpSpPr>
              <a:xfrm>
                <a:off x="4360689" y="6277602"/>
                <a:ext cx="4627795" cy="215444"/>
                <a:chOff x="4683258" y="2845511"/>
                <a:chExt cx="4627795" cy="215444"/>
              </a:xfrm>
            </p:grpSpPr>
            <p:grpSp>
              <p:nvGrpSpPr>
                <p:cNvPr id="348" name="グループ化 347">
                  <a:extLst>
                    <a:ext uri="{FF2B5EF4-FFF2-40B4-BE49-F238E27FC236}">
                      <a16:creationId xmlns:a16="http://schemas.microsoft.com/office/drawing/2014/main" id="{EF3F70E1-84AC-8925-FE60-80EBA5009C51}"/>
                    </a:ext>
                  </a:extLst>
                </p:cNvPr>
                <p:cNvGrpSpPr/>
                <p:nvPr/>
              </p:nvGrpSpPr>
              <p:grpSpPr>
                <a:xfrm>
                  <a:off x="6279513" y="2845511"/>
                  <a:ext cx="1463497" cy="215444"/>
                  <a:chOff x="4782318" y="3119831"/>
                  <a:chExt cx="1463497" cy="215444"/>
                </a:xfrm>
              </p:grpSpPr>
              <p:sp>
                <p:nvSpPr>
                  <p:cNvPr id="359" name="正方形/長方形 358">
                    <a:extLst>
                      <a:ext uri="{FF2B5EF4-FFF2-40B4-BE49-F238E27FC236}">
                        <a16:creationId xmlns:a16="http://schemas.microsoft.com/office/drawing/2014/main" id="{76E31B12-8001-4164-8870-A3C858A9DA0C}"/>
                      </a:ext>
                    </a:extLst>
                  </p:cNvPr>
                  <p:cNvSpPr/>
                  <p:nvPr/>
                </p:nvSpPr>
                <p:spPr>
                  <a:xfrm>
                    <a:off x="5169114" y="3119831"/>
                    <a:ext cx="1076701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AR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2)</a:t>
                    </a:r>
                  </a:p>
                </p:txBody>
              </p:sp>
              <p:grpSp>
                <p:nvGrpSpPr>
                  <p:cNvPr id="360" name="グループ化 359">
                    <a:extLst>
                      <a:ext uri="{FF2B5EF4-FFF2-40B4-BE49-F238E27FC236}">
                        <a16:creationId xmlns:a16="http://schemas.microsoft.com/office/drawing/2014/main" id="{3584E482-2716-8A45-853B-225D10EC8AF2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15555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61" name="直線コネクタ 360">
                      <a:extLst>
                        <a:ext uri="{FF2B5EF4-FFF2-40B4-BE49-F238E27FC236}">
                          <a16:creationId xmlns:a16="http://schemas.microsoft.com/office/drawing/2014/main" id="{9330489D-463A-3AA5-F6B1-ABABF786D37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rgbClr val="FF0000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62" name="楕円 361">
                      <a:extLst>
                        <a:ext uri="{FF2B5EF4-FFF2-40B4-BE49-F238E27FC236}">
                          <a16:creationId xmlns:a16="http://schemas.microsoft.com/office/drawing/2014/main" id="{E9FC66D6-F456-1D9B-108B-F656C902324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49" name="グループ化 348">
                  <a:extLst>
                    <a:ext uri="{FF2B5EF4-FFF2-40B4-BE49-F238E27FC236}">
                      <a16:creationId xmlns:a16="http://schemas.microsoft.com/office/drawing/2014/main" id="{746F53FA-6824-7B03-796F-15DBC161C169}"/>
                    </a:ext>
                  </a:extLst>
                </p:cNvPr>
                <p:cNvGrpSpPr/>
                <p:nvPr/>
              </p:nvGrpSpPr>
              <p:grpSpPr>
                <a:xfrm>
                  <a:off x="7837938" y="2845511"/>
                  <a:ext cx="1473115" cy="215444"/>
                  <a:chOff x="4782318" y="3352318"/>
                  <a:chExt cx="1473115" cy="215444"/>
                </a:xfrm>
              </p:grpSpPr>
              <p:sp>
                <p:nvSpPr>
                  <p:cNvPr id="355" name="正方形/長方形 354">
                    <a:extLst>
                      <a:ext uri="{FF2B5EF4-FFF2-40B4-BE49-F238E27FC236}">
                        <a16:creationId xmlns:a16="http://schemas.microsoft.com/office/drawing/2014/main" id="{4D494C53-F0C5-09F4-BA34-6069CEBCDA85}"/>
                      </a:ext>
                    </a:extLst>
                  </p:cNvPr>
                  <p:cNvSpPr/>
                  <p:nvPr/>
                </p:nvSpPr>
                <p:spPr>
                  <a:xfrm>
                    <a:off x="5169114" y="3352318"/>
                    <a:ext cx="1086319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CC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7)</a:t>
                    </a:r>
                  </a:p>
                </p:txBody>
              </p:sp>
              <p:grpSp>
                <p:nvGrpSpPr>
                  <p:cNvPr id="356" name="グループ化 355">
                    <a:extLst>
                      <a:ext uri="{FF2B5EF4-FFF2-40B4-BE49-F238E27FC236}">
                        <a16:creationId xmlns:a16="http://schemas.microsoft.com/office/drawing/2014/main" id="{01FD8B00-605A-E28C-E3FF-2C4536EC06E7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388040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57" name="直線コネクタ 356">
                      <a:extLst>
                        <a:ext uri="{FF2B5EF4-FFF2-40B4-BE49-F238E27FC236}">
                          <a16:creationId xmlns:a16="http://schemas.microsoft.com/office/drawing/2014/main" id="{482D91D6-8C4B-A3CF-DEB8-2297BEEB2A7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solidFill>
                      <a:srgbClr val="00B050"/>
                    </a:solidFill>
                    <a:ln w="38100" cap="flat">
                      <a:solidFill>
                        <a:srgbClr val="0000FF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58" name="楕円 357">
                      <a:extLst>
                        <a:ext uri="{FF2B5EF4-FFF2-40B4-BE49-F238E27FC236}">
                          <a16:creationId xmlns:a16="http://schemas.microsoft.com/office/drawing/2014/main" id="{0BE3744F-2400-5349-92BA-5FE2F7BA69C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50" name="グループ化 349">
                  <a:extLst>
                    <a:ext uri="{FF2B5EF4-FFF2-40B4-BE49-F238E27FC236}">
                      <a16:creationId xmlns:a16="http://schemas.microsoft.com/office/drawing/2014/main" id="{718DB0F6-18F2-20F4-7526-BB1915487DDF}"/>
                    </a:ext>
                  </a:extLst>
                </p:cNvPr>
                <p:cNvGrpSpPr/>
                <p:nvPr/>
              </p:nvGrpSpPr>
              <p:grpSpPr>
                <a:xfrm>
                  <a:off x="4683258" y="2845511"/>
                  <a:ext cx="1501328" cy="215444"/>
                  <a:chOff x="4782318" y="2845511"/>
                  <a:chExt cx="1501328" cy="215444"/>
                </a:xfrm>
              </p:grpSpPr>
              <p:sp>
                <p:nvSpPr>
                  <p:cNvPr id="351" name="正方形/長方形 350">
                    <a:extLst>
                      <a:ext uri="{FF2B5EF4-FFF2-40B4-BE49-F238E27FC236}">
                        <a16:creationId xmlns:a16="http://schemas.microsoft.com/office/drawing/2014/main" id="{C277F7AA-E906-A7B2-E3BF-1E393836B531}"/>
                      </a:ext>
                    </a:extLst>
                  </p:cNvPr>
                  <p:cNvSpPr/>
                  <p:nvPr/>
                </p:nvSpPr>
                <p:spPr>
                  <a:xfrm>
                    <a:off x="5169114" y="2845511"/>
                    <a:ext cx="1114532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Total</a:t>
                    </a:r>
                    <a:r>
                      <a:rPr lang="ja-JP" altLang="en-US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89)</a:t>
                    </a:r>
                  </a:p>
                </p:txBody>
              </p:sp>
              <p:grpSp>
                <p:nvGrpSpPr>
                  <p:cNvPr id="352" name="グループ化 351">
                    <a:extLst>
                      <a:ext uri="{FF2B5EF4-FFF2-40B4-BE49-F238E27FC236}">
                        <a16:creationId xmlns:a16="http://schemas.microsoft.com/office/drawing/2014/main" id="{B3239B7C-F23A-B57F-38B5-2318313EA7B3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288123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53" name="直線コネクタ 352">
                      <a:extLst>
                        <a:ext uri="{FF2B5EF4-FFF2-40B4-BE49-F238E27FC236}">
                          <a16:creationId xmlns:a16="http://schemas.microsoft.com/office/drawing/2014/main" id="{43E0BD2A-2FCE-D775-B80C-EAF53A63921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chemeClr val="tx1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54" name="楕円 353">
                      <a:extLst>
                        <a:ext uri="{FF2B5EF4-FFF2-40B4-BE49-F238E27FC236}">
                          <a16:creationId xmlns:a16="http://schemas.microsoft.com/office/drawing/2014/main" id="{3C92E872-ED59-BDE5-1CAC-0EDE6D0770B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cxnSp>
            <p:nvCxnSpPr>
              <p:cNvPr id="260" name="直線コネクタ 259">
                <a:extLst>
                  <a:ext uri="{FF2B5EF4-FFF2-40B4-BE49-F238E27FC236}">
                    <a16:creationId xmlns:a16="http://schemas.microsoft.com/office/drawing/2014/main" id="{033172D0-E217-41C1-5FE7-91AB5F4F0E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2101" y="5081874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正方形/長方形 260">
                <a:extLst>
                  <a:ext uri="{FF2B5EF4-FFF2-40B4-BE49-F238E27FC236}">
                    <a16:creationId xmlns:a16="http://schemas.microsoft.com/office/drawing/2014/main" id="{6076B92B-09D8-AE6E-938A-4D2957A190BA}"/>
                  </a:ext>
                </a:extLst>
              </p:cNvPr>
              <p:cNvSpPr/>
              <p:nvPr/>
            </p:nvSpPr>
            <p:spPr>
              <a:xfrm>
                <a:off x="2674549" y="4957577"/>
                <a:ext cx="23403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8" name="テキスト ボックス 337">
                <a:extLst>
                  <a:ext uri="{FF2B5EF4-FFF2-40B4-BE49-F238E27FC236}">
                    <a16:creationId xmlns:a16="http://schemas.microsoft.com/office/drawing/2014/main" id="{D7E0D95A-FD9C-E153-83EF-69C2EA4A9578}"/>
                  </a:ext>
                </a:extLst>
              </p:cNvPr>
              <p:cNvSpPr txBox="1"/>
              <p:nvPr/>
            </p:nvSpPr>
            <p:spPr>
              <a:xfrm>
                <a:off x="7997487" y="5574932"/>
                <a:ext cx="211596" cy="33227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0" tIns="36000" rIns="0" bIns="0" anchor="t">
                <a:spAutoFit/>
              </a:bodyPr>
              <a:lstStyle>
                <a:defPPr>
                  <a:defRPr lang="ja-JP"/>
                </a:defPPr>
                <a:lvl1pPr lvl="0" indent="0" algn="ctr">
                  <a:spcBef>
                    <a:spcPct val="0"/>
                  </a:spcBef>
                  <a:buNone/>
                  <a:defRPr sz="900" b="1" kern="0">
                    <a:solidFill>
                      <a:prstClr val="black"/>
                    </a:solidFill>
                    <a:latin typeface="Arial" panose="020B0604020202020204" pitchFamily="34" charset="0"/>
                    <a:ea typeface="Meiryo UI"/>
                    <a:cs typeface="Arial" panose="020B0604020202020204" pitchFamily="34" charset="0"/>
                  </a:defRPr>
                </a:lvl1pPr>
                <a:lvl2pPr indent="0">
                  <a:defRPr sz="1100"/>
                </a:lvl2pPr>
                <a:lvl3pPr indent="0">
                  <a:defRPr sz="1100"/>
                </a:lvl3pPr>
                <a:lvl4pPr indent="0">
                  <a:defRPr sz="1100"/>
                </a:lvl4pPr>
                <a:lvl5pPr indent="0">
                  <a:defRPr sz="1100"/>
                </a:lvl5pPr>
                <a:lvl6pPr indent="0">
                  <a:defRPr sz="1100"/>
                </a:lvl6pPr>
                <a:lvl7pPr indent="0">
                  <a:defRPr sz="1100"/>
                </a:lvl7pPr>
                <a:lvl8pPr indent="0">
                  <a:defRPr sz="1100"/>
                </a:lvl8pPr>
                <a:lvl9pPr indent="0">
                  <a:defRPr sz="1100"/>
                </a:lvl9pPr>
              </a:lstStyle>
              <a:p>
                <a:r>
                  <a:rPr lang="en-US" altLang="ja-JP" sz="1400" dirty="0"/>
                  <a:t>***</a:t>
                </a:r>
              </a:p>
            </p:txBody>
          </p:sp>
          <p:cxnSp>
            <p:nvCxnSpPr>
              <p:cNvPr id="16" name="直線コネクタ 15">
                <a:extLst>
                  <a:ext uri="{FF2B5EF4-FFF2-40B4-BE49-F238E27FC236}">
                    <a16:creationId xmlns:a16="http://schemas.microsoft.com/office/drawing/2014/main" id="{E512FD22-DD07-E7EE-5D02-43ABBC2547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93776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コネクタ 16">
                <a:extLst>
                  <a:ext uri="{FF2B5EF4-FFF2-40B4-BE49-F238E27FC236}">
                    <a16:creationId xmlns:a16="http://schemas.microsoft.com/office/drawing/2014/main" id="{3ABE6AAC-96FD-4513-01E8-CF896554DD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01011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線コネクタ 17">
                <a:extLst>
                  <a:ext uri="{FF2B5EF4-FFF2-40B4-BE49-F238E27FC236}">
                    <a16:creationId xmlns:a16="http://schemas.microsoft.com/office/drawing/2014/main" id="{86A01227-5DA7-81A8-E787-3C9F8F6D0F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09282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473834E5-F17E-53A4-53FE-BBC2DE7213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94367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752E2CBE-4840-A7BA-F7F4-70046BF930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04093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正方形/長方形 20">
                <a:extLst>
                  <a:ext uri="{FF2B5EF4-FFF2-40B4-BE49-F238E27FC236}">
                    <a16:creationId xmlns:a16="http://schemas.microsoft.com/office/drawing/2014/main" id="{2888083F-07EF-F55C-9FDB-08039E69DF1B}"/>
                  </a:ext>
                </a:extLst>
              </p:cNvPr>
              <p:cNvSpPr/>
              <p:nvPr/>
            </p:nvSpPr>
            <p:spPr>
              <a:xfrm>
                <a:off x="3101842" y="3718665"/>
                <a:ext cx="78386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Baseline</a:t>
                </a:r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FE451ED1-D120-6801-5347-A443D6454D64}"/>
                  </a:ext>
                </a:extLst>
              </p:cNvPr>
              <p:cNvSpPr/>
              <p:nvPr/>
            </p:nvSpPr>
            <p:spPr>
              <a:xfrm>
                <a:off x="4758101" y="3718665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4</a:t>
                </a:r>
              </a:p>
            </p:txBody>
          </p:sp>
          <p:sp>
            <p:nvSpPr>
              <p:cNvPr id="23" name="正方形/長方形 22">
                <a:extLst>
                  <a:ext uri="{FF2B5EF4-FFF2-40B4-BE49-F238E27FC236}">
                    <a16:creationId xmlns:a16="http://schemas.microsoft.com/office/drawing/2014/main" id="{5311954B-1979-D985-45FA-6FEF04C02C2C}"/>
                  </a:ext>
                </a:extLst>
              </p:cNvPr>
              <p:cNvSpPr/>
              <p:nvPr/>
            </p:nvSpPr>
            <p:spPr>
              <a:xfrm>
                <a:off x="6355019" y="3718665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8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" name="正方形/長方形 23">
                <a:extLst>
                  <a:ext uri="{FF2B5EF4-FFF2-40B4-BE49-F238E27FC236}">
                    <a16:creationId xmlns:a16="http://schemas.microsoft.com/office/drawing/2014/main" id="{8D01FEE5-08EC-CFDD-1BE1-1CCB859C1CDC}"/>
                  </a:ext>
                </a:extLst>
              </p:cNvPr>
              <p:cNvSpPr/>
              <p:nvPr/>
            </p:nvSpPr>
            <p:spPr>
              <a:xfrm>
                <a:off x="7906383" y="3718665"/>
                <a:ext cx="805798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12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" name="正方形/長方形 24">
                <a:extLst>
                  <a:ext uri="{FF2B5EF4-FFF2-40B4-BE49-F238E27FC236}">
                    <a16:creationId xmlns:a16="http://schemas.microsoft.com/office/drawing/2014/main" id="{A720C658-8130-EDC0-3BC6-3DC6B57A3375}"/>
                  </a:ext>
                </a:extLst>
              </p:cNvPr>
              <p:cNvSpPr/>
              <p:nvPr/>
            </p:nvSpPr>
            <p:spPr>
              <a:xfrm>
                <a:off x="9683572" y="3718668"/>
                <a:ext cx="421590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EOT</a:t>
                </a:r>
              </a:p>
            </p:txBody>
          </p:sp>
          <p:grpSp>
            <p:nvGrpSpPr>
              <p:cNvPr id="415" name="グループ化 414">
                <a:extLst>
                  <a:ext uri="{FF2B5EF4-FFF2-40B4-BE49-F238E27FC236}">
                    <a16:creationId xmlns:a16="http://schemas.microsoft.com/office/drawing/2014/main" id="{A9A79C62-8340-029F-652B-5F76CF1D3E58}"/>
                  </a:ext>
                </a:extLst>
              </p:cNvPr>
              <p:cNvGrpSpPr/>
              <p:nvPr/>
            </p:nvGrpSpPr>
            <p:grpSpPr>
              <a:xfrm>
                <a:off x="3583753" y="4168774"/>
                <a:ext cx="6551963" cy="1647203"/>
                <a:chOff x="3581902" y="4168774"/>
                <a:chExt cx="6551963" cy="1647203"/>
              </a:xfrm>
            </p:grpSpPr>
            <p:grpSp>
              <p:nvGrpSpPr>
                <p:cNvPr id="413" name="グループ化 412">
                  <a:extLst>
                    <a:ext uri="{FF2B5EF4-FFF2-40B4-BE49-F238E27FC236}">
                      <a16:creationId xmlns:a16="http://schemas.microsoft.com/office/drawing/2014/main" id="{C7D9E5B7-E071-D365-0354-7CF14196BC72}"/>
                    </a:ext>
                  </a:extLst>
                </p:cNvPr>
                <p:cNvGrpSpPr/>
                <p:nvPr/>
              </p:nvGrpSpPr>
              <p:grpSpPr>
                <a:xfrm>
                  <a:off x="5207582" y="4168774"/>
                  <a:ext cx="4924814" cy="1647203"/>
                  <a:chOff x="5207582" y="4168774"/>
                  <a:chExt cx="4924814" cy="1647203"/>
                </a:xfrm>
              </p:grpSpPr>
              <p:grpSp>
                <p:nvGrpSpPr>
                  <p:cNvPr id="300" name="グループ化 299">
                    <a:extLst>
                      <a:ext uri="{FF2B5EF4-FFF2-40B4-BE49-F238E27FC236}">
                        <a16:creationId xmlns:a16="http://schemas.microsoft.com/office/drawing/2014/main" id="{7257A964-966A-AC62-29D5-4598E47CB608}"/>
                      </a:ext>
                    </a:extLst>
                  </p:cNvPr>
                  <p:cNvGrpSpPr/>
                  <p:nvPr/>
                </p:nvGrpSpPr>
                <p:grpSpPr>
                  <a:xfrm>
                    <a:off x="5207582" y="4168774"/>
                    <a:ext cx="108000" cy="1184276"/>
                    <a:chOff x="3181267" y="2597151"/>
                    <a:chExt cx="108000" cy="2157062"/>
                  </a:xfrm>
                </p:grpSpPr>
                <p:cxnSp>
                  <p:nvCxnSpPr>
                    <p:cNvPr id="317" name="直線コネクタ 316">
                      <a:extLst>
                        <a:ext uri="{FF2B5EF4-FFF2-40B4-BE49-F238E27FC236}">
                          <a16:creationId xmlns:a16="http://schemas.microsoft.com/office/drawing/2014/main" id="{B6E24CC2-F53F-A8AD-5860-FBD20DCAC5C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8" name="直線コネクタ 317">
                      <a:extLst>
                        <a:ext uri="{FF2B5EF4-FFF2-40B4-BE49-F238E27FC236}">
                          <a16:creationId xmlns:a16="http://schemas.microsoft.com/office/drawing/2014/main" id="{AA34D6B2-D38F-E319-F632-FFFF0CA6FF6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9" name="直線コネクタ 318">
                      <a:extLst>
                        <a:ext uri="{FF2B5EF4-FFF2-40B4-BE49-F238E27FC236}">
                          <a16:creationId xmlns:a16="http://schemas.microsoft.com/office/drawing/2014/main" id="{1EDB7B08-F2F6-3AB0-26D5-96958B9E43E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01" name="グループ化 300">
                    <a:extLst>
                      <a:ext uri="{FF2B5EF4-FFF2-40B4-BE49-F238E27FC236}">
                        <a16:creationId xmlns:a16="http://schemas.microsoft.com/office/drawing/2014/main" id="{4C1317F7-FFD6-F4DB-FC5C-4F5BE70C0883}"/>
                      </a:ext>
                    </a:extLst>
                  </p:cNvPr>
                  <p:cNvGrpSpPr/>
                  <p:nvPr/>
                </p:nvGrpSpPr>
                <p:grpSpPr>
                  <a:xfrm>
                    <a:off x="6806881" y="4297362"/>
                    <a:ext cx="108000" cy="1153319"/>
                    <a:chOff x="3181267" y="2597151"/>
                    <a:chExt cx="108000" cy="2157062"/>
                  </a:xfrm>
                </p:grpSpPr>
                <p:cxnSp>
                  <p:nvCxnSpPr>
                    <p:cNvPr id="314" name="直線コネクタ 313">
                      <a:extLst>
                        <a:ext uri="{FF2B5EF4-FFF2-40B4-BE49-F238E27FC236}">
                          <a16:creationId xmlns:a16="http://schemas.microsoft.com/office/drawing/2014/main" id="{373034F8-6C52-4F60-411C-E52A00878A4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5" name="直線コネクタ 314">
                      <a:extLst>
                        <a:ext uri="{FF2B5EF4-FFF2-40B4-BE49-F238E27FC236}">
                          <a16:creationId xmlns:a16="http://schemas.microsoft.com/office/drawing/2014/main" id="{87CEF931-8D29-92C7-BBD1-A87AD3BC28A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6" name="直線コネクタ 315">
                      <a:extLst>
                        <a:ext uri="{FF2B5EF4-FFF2-40B4-BE49-F238E27FC236}">
                          <a16:creationId xmlns:a16="http://schemas.microsoft.com/office/drawing/2014/main" id="{586E60B3-6A02-0F2E-E032-EC41A6E6C5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11" name="グループ化 410">
                    <a:extLst>
                      <a:ext uri="{FF2B5EF4-FFF2-40B4-BE49-F238E27FC236}">
                        <a16:creationId xmlns:a16="http://schemas.microsoft.com/office/drawing/2014/main" id="{13267C32-81F3-03F5-1AC1-52B64EF5C20C}"/>
                      </a:ext>
                    </a:extLst>
                  </p:cNvPr>
                  <p:cNvGrpSpPr/>
                  <p:nvPr/>
                </p:nvGrpSpPr>
                <p:grpSpPr>
                  <a:xfrm>
                    <a:off x="8412352" y="4207670"/>
                    <a:ext cx="108000" cy="1608307"/>
                    <a:chOff x="8412352" y="4207670"/>
                    <a:chExt cx="108000" cy="1608307"/>
                  </a:xfrm>
                </p:grpSpPr>
                <p:grpSp>
                  <p:nvGrpSpPr>
                    <p:cNvPr id="309" name="グループ化 308">
                      <a:extLst>
                        <a:ext uri="{FF2B5EF4-FFF2-40B4-BE49-F238E27FC236}">
                          <a16:creationId xmlns:a16="http://schemas.microsoft.com/office/drawing/2014/main" id="{5BBF4F3D-8981-DE21-3106-80E843EAC70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12352" y="4207670"/>
                      <a:ext cx="108000" cy="1308728"/>
                      <a:chOff x="9259442" y="1742178"/>
                      <a:chExt cx="108000" cy="310645"/>
                    </a:xfrm>
                  </p:grpSpPr>
                  <p:cxnSp>
                    <p:nvCxnSpPr>
                      <p:cNvPr id="311" name="直線コネクタ 310">
                        <a:extLst>
                          <a:ext uri="{FF2B5EF4-FFF2-40B4-BE49-F238E27FC236}">
                            <a16:creationId xmlns:a16="http://schemas.microsoft.com/office/drawing/2014/main" id="{6CA85ED7-0D6F-98C7-546E-C546C47912F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313442" y="1742178"/>
                        <a:ext cx="0" cy="310645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2" name="直線コネクタ 311">
                        <a:extLst>
                          <a:ext uri="{FF2B5EF4-FFF2-40B4-BE49-F238E27FC236}">
                            <a16:creationId xmlns:a16="http://schemas.microsoft.com/office/drawing/2014/main" id="{A6766501-64C4-0569-716F-CD910FD8E53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205282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3" name="直線コネクタ 312">
                        <a:extLst>
                          <a:ext uri="{FF2B5EF4-FFF2-40B4-BE49-F238E27FC236}">
                            <a16:creationId xmlns:a16="http://schemas.microsoft.com/office/drawing/2014/main" id="{45127B50-C3C9-C726-7B67-A758C9A6286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1742178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10" name="テキスト ボックス 309">
                      <a:extLst>
                        <a:ext uri="{FF2B5EF4-FFF2-40B4-BE49-F238E27FC236}">
                          <a16:creationId xmlns:a16="http://schemas.microsoft.com/office/drawing/2014/main" id="{E8082B70-2C32-114F-F6E2-452AD3F7B8F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30819" y="5483704"/>
                      <a:ext cx="70532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</a:t>
                      </a:r>
                    </a:p>
                  </p:txBody>
                </p:sp>
              </p:grpSp>
              <p:grpSp>
                <p:nvGrpSpPr>
                  <p:cNvPr id="412" name="グループ化 411">
                    <a:extLst>
                      <a:ext uri="{FF2B5EF4-FFF2-40B4-BE49-F238E27FC236}">
                        <a16:creationId xmlns:a16="http://schemas.microsoft.com/office/drawing/2014/main" id="{CC59B143-4F99-D749-5802-E71E1C2A34C5}"/>
                      </a:ext>
                    </a:extLst>
                  </p:cNvPr>
                  <p:cNvGrpSpPr/>
                  <p:nvPr/>
                </p:nvGrpSpPr>
                <p:grpSpPr>
                  <a:xfrm>
                    <a:off x="9991332" y="4224338"/>
                    <a:ext cx="141064" cy="1476618"/>
                    <a:chOff x="9991332" y="4224338"/>
                    <a:chExt cx="141064" cy="1476618"/>
                  </a:xfrm>
                </p:grpSpPr>
                <p:grpSp>
                  <p:nvGrpSpPr>
                    <p:cNvPr id="304" name="グループ化 303">
                      <a:extLst>
                        <a:ext uri="{FF2B5EF4-FFF2-40B4-BE49-F238E27FC236}">
                          <a16:creationId xmlns:a16="http://schemas.microsoft.com/office/drawing/2014/main" id="{8A55D583-B4D6-976D-DAE4-58B5A92F9A4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07866" y="4224338"/>
                      <a:ext cx="108000" cy="1176826"/>
                      <a:chOff x="3181267" y="2597151"/>
                      <a:chExt cx="108000" cy="2157062"/>
                    </a:xfrm>
                  </p:grpSpPr>
                  <p:cxnSp>
                    <p:nvCxnSpPr>
                      <p:cNvPr id="306" name="直線コネクタ 305">
                        <a:extLst>
                          <a:ext uri="{FF2B5EF4-FFF2-40B4-BE49-F238E27FC236}">
                            <a16:creationId xmlns:a16="http://schemas.microsoft.com/office/drawing/2014/main" id="{E410B8C6-4045-C100-8862-B0D08D57DAD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7" name="直線コネクタ 306">
                        <a:extLst>
                          <a:ext uri="{FF2B5EF4-FFF2-40B4-BE49-F238E27FC236}">
                            <a16:creationId xmlns:a16="http://schemas.microsoft.com/office/drawing/2014/main" id="{3051EFBF-75A6-88F0-0270-091E9570B87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8" name="直線コネクタ 307">
                        <a:extLst>
                          <a:ext uri="{FF2B5EF4-FFF2-40B4-BE49-F238E27FC236}">
                            <a16:creationId xmlns:a16="http://schemas.microsoft.com/office/drawing/2014/main" id="{74342D1B-A0E6-B7D8-58E3-46B9D54DE35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05" name="テキスト ボックス 304">
                      <a:extLst>
                        <a:ext uri="{FF2B5EF4-FFF2-40B4-BE49-F238E27FC236}">
                          <a16:creationId xmlns:a16="http://schemas.microsoft.com/office/drawing/2014/main" id="{DB3ED4C3-B80A-1CF2-35C4-7681A72478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91332" y="5368683"/>
                      <a:ext cx="141064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</a:t>
                      </a:r>
                    </a:p>
                  </p:txBody>
                </p:sp>
              </p:grpSp>
            </p:grpSp>
            <p:grpSp>
              <p:nvGrpSpPr>
                <p:cNvPr id="410" name="グループ化 409">
                  <a:extLst>
                    <a:ext uri="{FF2B5EF4-FFF2-40B4-BE49-F238E27FC236}">
                      <a16:creationId xmlns:a16="http://schemas.microsoft.com/office/drawing/2014/main" id="{CAA9F457-A16B-5DB7-8B53-6EDAD91A415C}"/>
                    </a:ext>
                  </a:extLst>
                </p:cNvPr>
                <p:cNvGrpSpPr/>
                <p:nvPr/>
              </p:nvGrpSpPr>
              <p:grpSpPr>
                <a:xfrm>
                  <a:off x="3581902" y="4494744"/>
                  <a:ext cx="6551963" cy="452575"/>
                  <a:chOff x="3581902" y="4494744"/>
                  <a:chExt cx="6551963" cy="452575"/>
                </a:xfrm>
              </p:grpSpPr>
              <p:sp>
                <p:nvSpPr>
                  <p:cNvPr id="295" name="楕円 294">
                    <a:extLst>
                      <a:ext uri="{FF2B5EF4-FFF2-40B4-BE49-F238E27FC236}">
                        <a16:creationId xmlns:a16="http://schemas.microsoft.com/office/drawing/2014/main" id="{B7C30921-7072-1E36-D36A-8BA33850C43E}"/>
                      </a:ext>
                    </a:extLst>
                  </p:cNvPr>
                  <p:cNvSpPr/>
                  <p:nvPr/>
                </p:nvSpPr>
                <p:spPr>
                  <a:xfrm>
                    <a:off x="3581902" y="4494744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6" name="楕円 295">
                    <a:extLst>
                      <a:ext uri="{FF2B5EF4-FFF2-40B4-BE49-F238E27FC236}">
                        <a16:creationId xmlns:a16="http://schemas.microsoft.com/office/drawing/2014/main" id="{37BE9C95-9271-8E0C-F02A-5BF95DE97AB5}"/>
                      </a:ext>
                    </a:extLst>
                  </p:cNvPr>
                  <p:cNvSpPr/>
                  <p:nvPr/>
                </p:nvSpPr>
                <p:spPr>
                  <a:xfrm>
                    <a:off x="5189581" y="4688896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7" name="楕円 296">
                    <a:extLst>
                      <a:ext uri="{FF2B5EF4-FFF2-40B4-BE49-F238E27FC236}">
                        <a16:creationId xmlns:a16="http://schemas.microsoft.com/office/drawing/2014/main" id="{240598F0-A8F8-4166-3143-5F1ABBFE4C3C}"/>
                      </a:ext>
                    </a:extLst>
                  </p:cNvPr>
                  <p:cNvSpPr/>
                  <p:nvPr/>
                </p:nvSpPr>
                <p:spPr>
                  <a:xfrm>
                    <a:off x="6788880" y="4803319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8" name="楕円 297">
                    <a:extLst>
                      <a:ext uri="{FF2B5EF4-FFF2-40B4-BE49-F238E27FC236}">
                        <a16:creationId xmlns:a16="http://schemas.microsoft.com/office/drawing/2014/main" id="{A205E784-23A3-DD46-62E0-53D522022E93}"/>
                      </a:ext>
                    </a:extLst>
                  </p:cNvPr>
                  <p:cNvSpPr/>
                  <p:nvPr/>
                </p:nvSpPr>
                <p:spPr>
                  <a:xfrm>
                    <a:off x="8394351" y="4794554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9" name="楕円 298">
                    <a:extLst>
                      <a:ext uri="{FF2B5EF4-FFF2-40B4-BE49-F238E27FC236}">
                        <a16:creationId xmlns:a16="http://schemas.microsoft.com/office/drawing/2014/main" id="{C38F033B-FE9B-9CEF-733E-AB65554D9C23}"/>
                      </a:ext>
                    </a:extLst>
                  </p:cNvPr>
                  <p:cNvSpPr/>
                  <p:nvPr/>
                </p:nvSpPr>
                <p:spPr>
                  <a:xfrm>
                    <a:off x="9989865" y="4739255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14" name="フリーフォーム: 図形 413">
                  <a:extLst>
                    <a:ext uri="{FF2B5EF4-FFF2-40B4-BE49-F238E27FC236}">
                      <a16:creationId xmlns:a16="http://schemas.microsoft.com/office/drawing/2014/main" id="{2C2F9AF4-D436-81E2-3EEB-1FD5ABF88823}"/>
                    </a:ext>
                  </a:extLst>
                </p:cNvPr>
                <p:cNvSpPr/>
                <p:nvPr/>
              </p:nvSpPr>
              <p:spPr>
                <a:xfrm>
                  <a:off x="3650456" y="4569619"/>
                  <a:ext cx="4812507" cy="307182"/>
                </a:xfrm>
                <a:custGeom>
                  <a:avLst/>
                  <a:gdLst>
                    <a:gd name="connsiteX0" fmla="*/ 0 w 4814888"/>
                    <a:gd name="connsiteY0" fmla="*/ 0 h 314325"/>
                    <a:gd name="connsiteX1" fmla="*/ 1614488 w 4814888"/>
                    <a:gd name="connsiteY1" fmla="*/ 204788 h 314325"/>
                    <a:gd name="connsiteX2" fmla="*/ 3209925 w 4814888"/>
                    <a:gd name="connsiteY2" fmla="*/ 314325 h 314325"/>
                    <a:gd name="connsiteX3" fmla="*/ 4814888 w 4814888"/>
                    <a:gd name="connsiteY3" fmla="*/ 300038 h 314325"/>
                    <a:gd name="connsiteX0" fmla="*/ 0 w 4814888"/>
                    <a:gd name="connsiteY0" fmla="*/ 0 h 314325"/>
                    <a:gd name="connsiteX1" fmla="*/ 1614488 w 4814888"/>
                    <a:gd name="connsiteY1" fmla="*/ 204788 h 314325"/>
                    <a:gd name="connsiteX2" fmla="*/ 3209925 w 4814888"/>
                    <a:gd name="connsiteY2" fmla="*/ 314325 h 314325"/>
                    <a:gd name="connsiteX3" fmla="*/ 4814888 w 4814888"/>
                    <a:gd name="connsiteY3" fmla="*/ 304801 h 314325"/>
                    <a:gd name="connsiteX0" fmla="*/ 0 w 4814888"/>
                    <a:gd name="connsiteY0" fmla="*/ 0 h 314325"/>
                    <a:gd name="connsiteX1" fmla="*/ 1616870 w 4814888"/>
                    <a:gd name="connsiteY1" fmla="*/ 197644 h 314325"/>
                    <a:gd name="connsiteX2" fmla="*/ 3209925 w 4814888"/>
                    <a:gd name="connsiteY2" fmla="*/ 314325 h 314325"/>
                    <a:gd name="connsiteX3" fmla="*/ 4814888 w 4814888"/>
                    <a:gd name="connsiteY3" fmla="*/ 304801 h 314325"/>
                    <a:gd name="connsiteX0" fmla="*/ 0 w 4814888"/>
                    <a:gd name="connsiteY0" fmla="*/ 0 h 314325"/>
                    <a:gd name="connsiteX1" fmla="*/ 1616870 w 4814888"/>
                    <a:gd name="connsiteY1" fmla="*/ 197644 h 314325"/>
                    <a:gd name="connsiteX2" fmla="*/ 3209925 w 4814888"/>
                    <a:gd name="connsiteY2" fmla="*/ 314325 h 314325"/>
                    <a:gd name="connsiteX3" fmla="*/ 4814888 w 4814888"/>
                    <a:gd name="connsiteY3" fmla="*/ 304801 h 314325"/>
                    <a:gd name="connsiteX0" fmla="*/ 0 w 4812507"/>
                    <a:gd name="connsiteY0" fmla="*/ 0 h 307182"/>
                    <a:gd name="connsiteX1" fmla="*/ 1614489 w 4812507"/>
                    <a:gd name="connsiteY1" fmla="*/ 190501 h 307182"/>
                    <a:gd name="connsiteX2" fmla="*/ 3207544 w 4812507"/>
                    <a:gd name="connsiteY2" fmla="*/ 307182 h 307182"/>
                    <a:gd name="connsiteX3" fmla="*/ 4812507 w 4812507"/>
                    <a:gd name="connsiteY3" fmla="*/ 297658 h 30718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2507" h="307182">
                      <a:moveTo>
                        <a:pt x="0" y="0"/>
                      </a:moveTo>
                      <a:lnTo>
                        <a:pt x="1614489" y="190501"/>
                      </a:lnTo>
                      <a:lnTo>
                        <a:pt x="3207544" y="307182"/>
                      </a:lnTo>
                      <a:lnTo>
                        <a:pt x="4812507" y="297658"/>
                      </a:lnTo>
                    </a:path>
                  </a:pathLst>
                </a:custGeom>
                <a:noFill/>
                <a:ln w="38100">
                  <a:solidFill>
                    <a:srgbClr val="0000FF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406" name="グループ化 405">
                <a:extLst>
                  <a:ext uri="{FF2B5EF4-FFF2-40B4-BE49-F238E27FC236}">
                    <a16:creationId xmlns:a16="http://schemas.microsoft.com/office/drawing/2014/main" id="{1F93FA73-8E0B-85E0-AF66-733CECDC37EC}"/>
                  </a:ext>
                </a:extLst>
              </p:cNvPr>
              <p:cNvGrpSpPr/>
              <p:nvPr/>
            </p:nvGrpSpPr>
            <p:grpSpPr>
              <a:xfrm>
                <a:off x="3421772" y="4461669"/>
                <a:ext cx="6585765" cy="1576097"/>
                <a:chOff x="3419921" y="4461669"/>
                <a:chExt cx="6585765" cy="1576097"/>
              </a:xfrm>
            </p:grpSpPr>
            <p:grpSp>
              <p:nvGrpSpPr>
                <p:cNvPr id="404" name="グループ化 403">
                  <a:extLst>
                    <a:ext uri="{FF2B5EF4-FFF2-40B4-BE49-F238E27FC236}">
                      <a16:creationId xmlns:a16="http://schemas.microsoft.com/office/drawing/2014/main" id="{AB8ED285-1482-C601-4E0D-94DF5284163D}"/>
                    </a:ext>
                  </a:extLst>
                </p:cNvPr>
                <p:cNvGrpSpPr/>
                <p:nvPr/>
              </p:nvGrpSpPr>
              <p:grpSpPr>
                <a:xfrm>
                  <a:off x="5045601" y="4461669"/>
                  <a:ext cx="4960085" cy="1576097"/>
                  <a:chOff x="5045601" y="4461669"/>
                  <a:chExt cx="4960085" cy="1576097"/>
                </a:xfrm>
              </p:grpSpPr>
              <p:grpSp>
                <p:nvGrpSpPr>
                  <p:cNvPr id="273" name="グループ化 272">
                    <a:extLst>
                      <a:ext uri="{FF2B5EF4-FFF2-40B4-BE49-F238E27FC236}">
                        <a16:creationId xmlns:a16="http://schemas.microsoft.com/office/drawing/2014/main" id="{CFBA1C95-2CBC-177A-798F-24CBDA9B0F02}"/>
                      </a:ext>
                    </a:extLst>
                  </p:cNvPr>
                  <p:cNvGrpSpPr/>
                  <p:nvPr/>
                </p:nvGrpSpPr>
                <p:grpSpPr>
                  <a:xfrm>
                    <a:off x="5045601" y="4461669"/>
                    <a:ext cx="108000" cy="1231900"/>
                    <a:chOff x="3181267" y="2597151"/>
                    <a:chExt cx="108000" cy="2157062"/>
                  </a:xfrm>
                </p:grpSpPr>
                <p:cxnSp>
                  <p:nvCxnSpPr>
                    <p:cNvPr id="289" name="直線コネクタ 288">
                      <a:extLst>
                        <a:ext uri="{FF2B5EF4-FFF2-40B4-BE49-F238E27FC236}">
                          <a16:creationId xmlns:a16="http://schemas.microsoft.com/office/drawing/2014/main" id="{8C0FA1FD-1827-5C1D-7AA0-463AE37E019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0" name="直線コネクタ 289">
                      <a:extLst>
                        <a:ext uri="{FF2B5EF4-FFF2-40B4-BE49-F238E27FC236}">
                          <a16:creationId xmlns:a16="http://schemas.microsoft.com/office/drawing/2014/main" id="{337FF805-05D9-89C9-D04D-B26B21C7716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1" name="直線コネクタ 290">
                      <a:extLst>
                        <a:ext uri="{FF2B5EF4-FFF2-40B4-BE49-F238E27FC236}">
                          <a16:creationId xmlns:a16="http://schemas.microsoft.com/office/drawing/2014/main" id="{8749D02B-E891-61F9-A98D-05E2BC81A68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74" name="グループ化 273">
                    <a:extLst>
                      <a:ext uri="{FF2B5EF4-FFF2-40B4-BE49-F238E27FC236}">
                        <a16:creationId xmlns:a16="http://schemas.microsoft.com/office/drawing/2014/main" id="{6D7D81E7-852B-FC1E-A7A7-BF198200F851}"/>
                      </a:ext>
                    </a:extLst>
                  </p:cNvPr>
                  <p:cNvGrpSpPr/>
                  <p:nvPr/>
                </p:nvGrpSpPr>
                <p:grpSpPr>
                  <a:xfrm>
                    <a:off x="6644900" y="4590256"/>
                    <a:ext cx="108000" cy="1277143"/>
                    <a:chOff x="3181267" y="2597151"/>
                    <a:chExt cx="108000" cy="2157062"/>
                  </a:xfrm>
                </p:grpSpPr>
                <p:cxnSp>
                  <p:nvCxnSpPr>
                    <p:cNvPr id="286" name="直線コネクタ 285">
                      <a:extLst>
                        <a:ext uri="{FF2B5EF4-FFF2-40B4-BE49-F238E27FC236}">
                          <a16:creationId xmlns:a16="http://schemas.microsoft.com/office/drawing/2014/main" id="{E609E01A-4F55-F378-353F-73F83501FB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7" name="直線コネクタ 286">
                      <a:extLst>
                        <a:ext uri="{FF2B5EF4-FFF2-40B4-BE49-F238E27FC236}">
                          <a16:creationId xmlns:a16="http://schemas.microsoft.com/office/drawing/2014/main" id="{8272E26A-451A-BFBA-B718-28687B01FD8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8" name="直線コネクタ 287">
                      <a:extLst>
                        <a:ext uri="{FF2B5EF4-FFF2-40B4-BE49-F238E27FC236}">
                          <a16:creationId xmlns:a16="http://schemas.microsoft.com/office/drawing/2014/main" id="{296576BB-5789-4A9C-C8B4-A36F75D9ACB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02" name="グループ化 401">
                    <a:extLst>
                      <a:ext uri="{FF2B5EF4-FFF2-40B4-BE49-F238E27FC236}">
                        <a16:creationId xmlns:a16="http://schemas.microsoft.com/office/drawing/2014/main" id="{3D5181E1-AD38-9EB9-300F-00F1B79E914A}"/>
                      </a:ext>
                    </a:extLst>
                  </p:cNvPr>
                  <p:cNvGrpSpPr/>
                  <p:nvPr/>
                </p:nvGrpSpPr>
                <p:grpSpPr>
                  <a:xfrm>
                    <a:off x="8198345" y="4610100"/>
                    <a:ext cx="211596" cy="1290902"/>
                    <a:chOff x="8198345" y="4610100"/>
                    <a:chExt cx="211596" cy="1290902"/>
                  </a:xfrm>
                </p:grpSpPr>
                <p:sp>
                  <p:nvSpPr>
                    <p:cNvPr id="282" name="テキスト ボックス 281">
                      <a:extLst>
                        <a:ext uri="{FF2B5EF4-FFF2-40B4-BE49-F238E27FC236}">
                          <a16:creationId xmlns:a16="http://schemas.microsoft.com/office/drawing/2014/main" id="{D872B7D4-232A-A797-93A9-42C31D3AFD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98345" y="5649207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  <p:grpSp>
                  <p:nvGrpSpPr>
                    <p:cNvPr id="283" name="グループ化 282">
                      <a:extLst>
                        <a:ext uri="{FF2B5EF4-FFF2-40B4-BE49-F238E27FC236}">
                          <a16:creationId xmlns:a16="http://schemas.microsoft.com/office/drawing/2014/main" id="{0895203D-50A3-3461-F0DB-D62B1CE6107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50371" y="4610100"/>
                      <a:ext cx="108000" cy="1067318"/>
                      <a:chOff x="3181267" y="2597151"/>
                      <a:chExt cx="108000" cy="2157062"/>
                    </a:xfrm>
                  </p:grpSpPr>
                  <p:cxnSp>
                    <p:nvCxnSpPr>
                      <p:cNvPr id="284" name="直線コネクタ 283">
                        <a:extLst>
                          <a:ext uri="{FF2B5EF4-FFF2-40B4-BE49-F238E27FC236}">
                            <a16:creationId xmlns:a16="http://schemas.microsoft.com/office/drawing/2014/main" id="{B845A53F-1F8D-041E-B60B-42954905743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5" name="直線コネクタ 284">
                        <a:extLst>
                          <a:ext uri="{FF2B5EF4-FFF2-40B4-BE49-F238E27FC236}">
                            <a16:creationId xmlns:a16="http://schemas.microsoft.com/office/drawing/2014/main" id="{E1DFD7F3-8094-92A1-FBB2-1CC9254D4DE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1" name="直線コネクタ 400">
                        <a:extLst>
                          <a:ext uri="{FF2B5EF4-FFF2-40B4-BE49-F238E27FC236}">
                            <a16:creationId xmlns:a16="http://schemas.microsoft.com/office/drawing/2014/main" id="{69D345D8-874F-5006-9551-4A265905843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403" name="グループ化 402">
                    <a:extLst>
                      <a:ext uri="{FF2B5EF4-FFF2-40B4-BE49-F238E27FC236}">
                        <a16:creationId xmlns:a16="http://schemas.microsoft.com/office/drawing/2014/main" id="{AF76A8DA-1768-294B-6EEB-80E447482C96}"/>
                      </a:ext>
                    </a:extLst>
                  </p:cNvPr>
                  <p:cNvGrpSpPr/>
                  <p:nvPr/>
                </p:nvGrpSpPr>
                <p:grpSpPr>
                  <a:xfrm>
                    <a:off x="9794090" y="4650581"/>
                    <a:ext cx="211596" cy="1387185"/>
                    <a:chOff x="9794090" y="4650581"/>
                    <a:chExt cx="211596" cy="1387185"/>
                  </a:xfrm>
                </p:grpSpPr>
                <p:grpSp>
                  <p:nvGrpSpPr>
                    <p:cNvPr id="277" name="グループ化 276">
                      <a:extLst>
                        <a:ext uri="{FF2B5EF4-FFF2-40B4-BE49-F238E27FC236}">
                          <a16:creationId xmlns:a16="http://schemas.microsoft.com/office/drawing/2014/main" id="{A983EA43-104D-3BFE-E567-1A558E3D78C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845885" y="4650581"/>
                      <a:ext cx="108000" cy="1088390"/>
                      <a:chOff x="3181267" y="2597151"/>
                      <a:chExt cx="108000" cy="2157062"/>
                    </a:xfrm>
                  </p:grpSpPr>
                  <p:cxnSp>
                    <p:nvCxnSpPr>
                      <p:cNvPr id="279" name="直線コネクタ 278">
                        <a:extLst>
                          <a:ext uri="{FF2B5EF4-FFF2-40B4-BE49-F238E27FC236}">
                            <a16:creationId xmlns:a16="http://schemas.microsoft.com/office/drawing/2014/main" id="{20B8D0FF-EF58-9904-F992-CD7B0D7FF74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0" name="直線コネクタ 279">
                        <a:extLst>
                          <a:ext uri="{FF2B5EF4-FFF2-40B4-BE49-F238E27FC236}">
                            <a16:creationId xmlns:a16="http://schemas.microsoft.com/office/drawing/2014/main" id="{602B78DB-6A57-ED53-9095-27E328DF53D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1" name="直線コネクタ 280">
                        <a:extLst>
                          <a:ext uri="{FF2B5EF4-FFF2-40B4-BE49-F238E27FC236}">
                            <a16:creationId xmlns:a16="http://schemas.microsoft.com/office/drawing/2014/main" id="{88323CB7-FFFC-B215-B6DA-323FB1A365F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78" name="テキスト ボックス 277">
                      <a:extLst>
                        <a:ext uri="{FF2B5EF4-FFF2-40B4-BE49-F238E27FC236}">
                          <a16:creationId xmlns:a16="http://schemas.microsoft.com/office/drawing/2014/main" id="{83C8EBCC-CE3F-CEFC-D3EB-5E6AAEE456E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94090" y="5705493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400" name="グループ化 399">
                  <a:extLst>
                    <a:ext uri="{FF2B5EF4-FFF2-40B4-BE49-F238E27FC236}">
                      <a16:creationId xmlns:a16="http://schemas.microsoft.com/office/drawing/2014/main" id="{9F0CCD64-104A-D057-B62A-54E60C87666F}"/>
                    </a:ext>
                  </a:extLst>
                </p:cNvPr>
                <p:cNvGrpSpPr/>
                <p:nvPr/>
              </p:nvGrpSpPr>
              <p:grpSpPr>
                <a:xfrm>
                  <a:off x="3419921" y="4494744"/>
                  <a:ext cx="6551963" cy="800947"/>
                  <a:chOff x="3419921" y="4494744"/>
                  <a:chExt cx="6551963" cy="800947"/>
                </a:xfrm>
              </p:grpSpPr>
              <p:sp>
                <p:nvSpPr>
                  <p:cNvPr id="268" name="楕円 267">
                    <a:extLst>
                      <a:ext uri="{FF2B5EF4-FFF2-40B4-BE49-F238E27FC236}">
                        <a16:creationId xmlns:a16="http://schemas.microsoft.com/office/drawing/2014/main" id="{C26D5585-1B1A-0627-6501-F0C5FC777207}"/>
                      </a:ext>
                    </a:extLst>
                  </p:cNvPr>
                  <p:cNvSpPr/>
                  <p:nvPr/>
                </p:nvSpPr>
                <p:spPr>
                  <a:xfrm>
                    <a:off x="3419921" y="4494744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9" name="楕円 268">
                    <a:extLst>
                      <a:ext uri="{FF2B5EF4-FFF2-40B4-BE49-F238E27FC236}">
                        <a16:creationId xmlns:a16="http://schemas.microsoft.com/office/drawing/2014/main" id="{F2CD07EA-B02F-A150-224A-69E597C0BBE2}"/>
                      </a:ext>
                    </a:extLst>
                  </p:cNvPr>
                  <p:cNvSpPr/>
                  <p:nvPr/>
                </p:nvSpPr>
                <p:spPr>
                  <a:xfrm>
                    <a:off x="5027600" y="5006913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0" name="楕円 269">
                    <a:extLst>
                      <a:ext uri="{FF2B5EF4-FFF2-40B4-BE49-F238E27FC236}">
                        <a16:creationId xmlns:a16="http://schemas.microsoft.com/office/drawing/2014/main" id="{B5ABA1F8-1CD5-0029-C840-AA4DC7414F86}"/>
                      </a:ext>
                    </a:extLst>
                  </p:cNvPr>
                  <p:cNvSpPr/>
                  <p:nvPr/>
                </p:nvSpPr>
                <p:spPr>
                  <a:xfrm>
                    <a:off x="6626899" y="5151691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1" name="楕円 270">
                    <a:extLst>
                      <a:ext uri="{FF2B5EF4-FFF2-40B4-BE49-F238E27FC236}">
                        <a16:creationId xmlns:a16="http://schemas.microsoft.com/office/drawing/2014/main" id="{80BAE4B6-C571-54F5-984F-CC84DA2F0B23}"/>
                      </a:ext>
                    </a:extLst>
                  </p:cNvPr>
                  <p:cNvSpPr/>
                  <p:nvPr/>
                </p:nvSpPr>
                <p:spPr>
                  <a:xfrm>
                    <a:off x="8232370" y="5075658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2" name="楕円 271">
                    <a:extLst>
                      <a:ext uri="{FF2B5EF4-FFF2-40B4-BE49-F238E27FC236}">
                        <a16:creationId xmlns:a16="http://schemas.microsoft.com/office/drawing/2014/main" id="{361010A5-7FC9-DF14-317F-F1A1A81E8C4F}"/>
                      </a:ext>
                    </a:extLst>
                  </p:cNvPr>
                  <p:cNvSpPr/>
                  <p:nvPr/>
                </p:nvSpPr>
                <p:spPr>
                  <a:xfrm>
                    <a:off x="9827884" y="5121875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05" name="フリーフォーム: 図形 404">
                  <a:extLst>
                    <a:ext uri="{FF2B5EF4-FFF2-40B4-BE49-F238E27FC236}">
                      <a16:creationId xmlns:a16="http://schemas.microsoft.com/office/drawing/2014/main" id="{343C4B7D-2691-5FCB-7778-62C73434B86C}"/>
                    </a:ext>
                  </a:extLst>
                </p:cNvPr>
                <p:cNvSpPr/>
                <p:nvPr/>
              </p:nvSpPr>
              <p:spPr>
                <a:xfrm>
                  <a:off x="3486150" y="4567238"/>
                  <a:ext cx="4819650" cy="657225"/>
                </a:xfrm>
                <a:custGeom>
                  <a:avLst/>
                  <a:gdLst>
                    <a:gd name="connsiteX0" fmla="*/ 0 w 4819650"/>
                    <a:gd name="connsiteY0" fmla="*/ 0 h 657225"/>
                    <a:gd name="connsiteX1" fmla="*/ 1609725 w 4819650"/>
                    <a:gd name="connsiteY1" fmla="*/ 514350 h 657225"/>
                    <a:gd name="connsiteX2" fmla="*/ 3209925 w 4819650"/>
                    <a:gd name="connsiteY2" fmla="*/ 657225 h 657225"/>
                    <a:gd name="connsiteX3" fmla="*/ 4819650 w 4819650"/>
                    <a:gd name="connsiteY3" fmla="*/ 581025 h 657225"/>
                    <a:gd name="connsiteX0" fmla="*/ 0 w 4819650"/>
                    <a:gd name="connsiteY0" fmla="*/ 0 h 657225"/>
                    <a:gd name="connsiteX1" fmla="*/ 1609725 w 4819650"/>
                    <a:gd name="connsiteY1" fmla="*/ 514350 h 657225"/>
                    <a:gd name="connsiteX2" fmla="*/ 3214688 w 4819650"/>
                    <a:gd name="connsiteY2" fmla="*/ 657225 h 657225"/>
                    <a:gd name="connsiteX3" fmla="*/ 4819650 w 4819650"/>
                    <a:gd name="connsiteY3" fmla="*/ 581025 h 657225"/>
                    <a:gd name="connsiteX0" fmla="*/ 0 w 4819650"/>
                    <a:gd name="connsiteY0" fmla="*/ 0 h 657225"/>
                    <a:gd name="connsiteX1" fmla="*/ 1614487 w 4819650"/>
                    <a:gd name="connsiteY1" fmla="*/ 514350 h 657225"/>
                    <a:gd name="connsiteX2" fmla="*/ 3214688 w 4819650"/>
                    <a:gd name="connsiteY2" fmla="*/ 657225 h 657225"/>
                    <a:gd name="connsiteX3" fmla="*/ 4819650 w 4819650"/>
                    <a:gd name="connsiteY3" fmla="*/ 581025 h 6572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9650" h="657225">
                      <a:moveTo>
                        <a:pt x="0" y="0"/>
                      </a:moveTo>
                      <a:lnTo>
                        <a:pt x="1614487" y="514350"/>
                      </a:lnTo>
                      <a:lnTo>
                        <a:pt x="3214688" y="657225"/>
                      </a:lnTo>
                      <a:lnTo>
                        <a:pt x="4819650" y="581025"/>
                      </a:lnTo>
                    </a:path>
                  </a:pathLst>
                </a:custGeom>
                <a:noFill/>
                <a:ln w="38100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96" name="グループ化 395">
                <a:extLst>
                  <a:ext uri="{FF2B5EF4-FFF2-40B4-BE49-F238E27FC236}">
                    <a16:creationId xmlns:a16="http://schemas.microsoft.com/office/drawing/2014/main" id="{7AC13CBC-6902-4134-83FC-7593258AC8E6}"/>
                  </a:ext>
                </a:extLst>
              </p:cNvPr>
              <p:cNvGrpSpPr/>
              <p:nvPr/>
            </p:nvGrpSpPr>
            <p:grpSpPr>
              <a:xfrm>
                <a:off x="3259790" y="4298156"/>
                <a:ext cx="6584981" cy="1597602"/>
                <a:chOff x="3257939" y="4298156"/>
                <a:chExt cx="6584981" cy="1597602"/>
              </a:xfrm>
            </p:grpSpPr>
            <p:grpSp>
              <p:nvGrpSpPr>
                <p:cNvPr id="394" name="グループ化 393">
                  <a:extLst>
                    <a:ext uri="{FF2B5EF4-FFF2-40B4-BE49-F238E27FC236}">
                      <a16:creationId xmlns:a16="http://schemas.microsoft.com/office/drawing/2014/main" id="{FEB7E3B2-76CB-795D-C27D-D87CC686B6AE}"/>
                    </a:ext>
                  </a:extLst>
                </p:cNvPr>
                <p:cNvGrpSpPr/>
                <p:nvPr/>
              </p:nvGrpSpPr>
              <p:grpSpPr>
                <a:xfrm>
                  <a:off x="4883619" y="4298156"/>
                  <a:ext cx="4959301" cy="1597602"/>
                  <a:chOff x="4883619" y="4298156"/>
                  <a:chExt cx="4959301" cy="1597602"/>
                </a:xfrm>
              </p:grpSpPr>
              <p:grpSp>
                <p:nvGrpSpPr>
                  <p:cNvPr id="328" name="グループ化 327">
                    <a:extLst>
                      <a:ext uri="{FF2B5EF4-FFF2-40B4-BE49-F238E27FC236}">
                        <a16:creationId xmlns:a16="http://schemas.microsoft.com/office/drawing/2014/main" id="{F4CEEFF6-7615-57FF-9170-47CF0B9C0C7B}"/>
                      </a:ext>
                    </a:extLst>
                  </p:cNvPr>
                  <p:cNvGrpSpPr/>
                  <p:nvPr/>
                </p:nvGrpSpPr>
                <p:grpSpPr>
                  <a:xfrm>
                    <a:off x="4883619" y="4298156"/>
                    <a:ext cx="108000" cy="1238250"/>
                    <a:chOff x="3181267" y="2597151"/>
                    <a:chExt cx="108000" cy="2157062"/>
                  </a:xfrm>
                </p:grpSpPr>
                <p:cxnSp>
                  <p:nvCxnSpPr>
                    <p:cNvPr id="345" name="直線コネクタ 344">
                      <a:extLst>
                        <a:ext uri="{FF2B5EF4-FFF2-40B4-BE49-F238E27FC236}">
                          <a16:creationId xmlns:a16="http://schemas.microsoft.com/office/drawing/2014/main" id="{79BDD44C-76BF-3EF3-0A4C-8C7D92238B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6" name="直線コネクタ 345">
                      <a:extLst>
                        <a:ext uri="{FF2B5EF4-FFF2-40B4-BE49-F238E27FC236}">
                          <a16:creationId xmlns:a16="http://schemas.microsoft.com/office/drawing/2014/main" id="{105EE83C-D655-65BB-C5B4-796D598A0EE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7" name="直線コネクタ 346">
                      <a:extLst>
                        <a:ext uri="{FF2B5EF4-FFF2-40B4-BE49-F238E27FC236}">
                          <a16:creationId xmlns:a16="http://schemas.microsoft.com/office/drawing/2014/main" id="{2D491400-5F2F-45E1-99B2-BE6233D24AD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29" name="グループ化 328">
                    <a:extLst>
                      <a:ext uri="{FF2B5EF4-FFF2-40B4-BE49-F238E27FC236}">
                        <a16:creationId xmlns:a16="http://schemas.microsoft.com/office/drawing/2014/main" id="{25052802-A246-E406-22E0-2F8BA948D1EF}"/>
                      </a:ext>
                    </a:extLst>
                  </p:cNvPr>
                  <p:cNvGrpSpPr/>
                  <p:nvPr/>
                </p:nvGrpSpPr>
                <p:grpSpPr>
                  <a:xfrm>
                    <a:off x="6482918" y="4421981"/>
                    <a:ext cx="108000" cy="1252538"/>
                    <a:chOff x="3181267" y="2597151"/>
                    <a:chExt cx="108000" cy="2157062"/>
                  </a:xfrm>
                </p:grpSpPr>
                <p:cxnSp>
                  <p:nvCxnSpPr>
                    <p:cNvPr id="342" name="直線コネクタ 341">
                      <a:extLst>
                        <a:ext uri="{FF2B5EF4-FFF2-40B4-BE49-F238E27FC236}">
                          <a16:creationId xmlns:a16="http://schemas.microsoft.com/office/drawing/2014/main" id="{66CAA3D4-2795-C39C-198F-00960DE03C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3" name="直線コネクタ 342">
                      <a:extLst>
                        <a:ext uri="{FF2B5EF4-FFF2-40B4-BE49-F238E27FC236}">
                          <a16:creationId xmlns:a16="http://schemas.microsoft.com/office/drawing/2014/main" id="{725B5358-50BB-89EE-F156-B1938B5298A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4" name="直線コネクタ 343">
                      <a:extLst>
                        <a:ext uri="{FF2B5EF4-FFF2-40B4-BE49-F238E27FC236}">
                          <a16:creationId xmlns:a16="http://schemas.microsoft.com/office/drawing/2014/main" id="{3192D5C7-0F39-5624-DF80-3B75D199C45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37" name="グループ化 336">
                    <a:extLst>
                      <a:ext uri="{FF2B5EF4-FFF2-40B4-BE49-F238E27FC236}">
                        <a16:creationId xmlns:a16="http://schemas.microsoft.com/office/drawing/2014/main" id="{A9DB55E1-3BA0-40A0-C007-C1CFA8973CC2}"/>
                      </a:ext>
                    </a:extLst>
                  </p:cNvPr>
                  <p:cNvGrpSpPr/>
                  <p:nvPr/>
                </p:nvGrpSpPr>
                <p:grpSpPr>
                  <a:xfrm>
                    <a:off x="8088389" y="4391025"/>
                    <a:ext cx="108000" cy="1217889"/>
                    <a:chOff x="3181267" y="2597151"/>
                    <a:chExt cx="108000" cy="2157062"/>
                  </a:xfrm>
                </p:grpSpPr>
                <p:cxnSp>
                  <p:nvCxnSpPr>
                    <p:cNvPr id="339" name="直線コネクタ 338">
                      <a:extLst>
                        <a:ext uri="{FF2B5EF4-FFF2-40B4-BE49-F238E27FC236}">
                          <a16:creationId xmlns:a16="http://schemas.microsoft.com/office/drawing/2014/main" id="{564426B6-37EA-FB8F-8226-921853A18C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0" name="直線コネクタ 339">
                      <a:extLst>
                        <a:ext uri="{FF2B5EF4-FFF2-40B4-BE49-F238E27FC236}">
                          <a16:creationId xmlns:a16="http://schemas.microsoft.com/office/drawing/2014/main" id="{E957FEA7-9E7B-9DDC-DCE2-5613AADE651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1" name="直線コネクタ 340">
                      <a:extLst>
                        <a:ext uri="{FF2B5EF4-FFF2-40B4-BE49-F238E27FC236}">
                          <a16:creationId xmlns:a16="http://schemas.microsoft.com/office/drawing/2014/main" id="{F44D0F43-B624-5835-9FFF-1B3A7B27B36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93" name="グループ化 392">
                    <a:extLst>
                      <a:ext uri="{FF2B5EF4-FFF2-40B4-BE49-F238E27FC236}">
                        <a16:creationId xmlns:a16="http://schemas.microsoft.com/office/drawing/2014/main" id="{B33F634A-ECEB-98C5-F32F-C03F2F5475BD}"/>
                      </a:ext>
                    </a:extLst>
                  </p:cNvPr>
                  <p:cNvGrpSpPr/>
                  <p:nvPr/>
                </p:nvGrpSpPr>
                <p:grpSpPr>
                  <a:xfrm>
                    <a:off x="9631324" y="4402931"/>
                    <a:ext cx="211596" cy="1492827"/>
                    <a:chOff x="9631324" y="4402931"/>
                    <a:chExt cx="211596" cy="1492827"/>
                  </a:xfrm>
                </p:grpSpPr>
                <p:grpSp>
                  <p:nvGrpSpPr>
                    <p:cNvPr id="332" name="グループ化 331">
                      <a:extLst>
                        <a:ext uri="{FF2B5EF4-FFF2-40B4-BE49-F238E27FC236}">
                          <a16:creationId xmlns:a16="http://schemas.microsoft.com/office/drawing/2014/main" id="{09C3A2FA-8E93-4150-5013-0C8BD41C5F2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683903" y="4402931"/>
                      <a:ext cx="108000" cy="1194108"/>
                      <a:chOff x="3181267" y="2597151"/>
                      <a:chExt cx="108000" cy="2157062"/>
                    </a:xfrm>
                  </p:grpSpPr>
                  <p:cxnSp>
                    <p:nvCxnSpPr>
                      <p:cNvPr id="334" name="直線コネクタ 333">
                        <a:extLst>
                          <a:ext uri="{FF2B5EF4-FFF2-40B4-BE49-F238E27FC236}">
                            <a16:creationId xmlns:a16="http://schemas.microsoft.com/office/drawing/2014/main" id="{33D48126-945A-FE2B-7967-646ABB49AE4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5" name="直線コネクタ 334">
                        <a:extLst>
                          <a:ext uri="{FF2B5EF4-FFF2-40B4-BE49-F238E27FC236}">
                            <a16:creationId xmlns:a16="http://schemas.microsoft.com/office/drawing/2014/main" id="{CC65F37E-7C26-C975-D957-697189E9625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6" name="直線コネクタ 335">
                        <a:extLst>
                          <a:ext uri="{FF2B5EF4-FFF2-40B4-BE49-F238E27FC236}">
                            <a16:creationId xmlns:a16="http://schemas.microsoft.com/office/drawing/2014/main" id="{BE6B4574-1489-D968-EA4C-22F597A7167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33" name="テキスト ボックス 332">
                      <a:extLst>
                        <a:ext uri="{FF2B5EF4-FFF2-40B4-BE49-F238E27FC236}">
                          <a16:creationId xmlns:a16="http://schemas.microsoft.com/office/drawing/2014/main" id="{260384C2-84D2-D916-1220-10DA3931A1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31324" y="5563485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92" name="グループ化 391">
                  <a:extLst>
                    <a:ext uri="{FF2B5EF4-FFF2-40B4-BE49-F238E27FC236}">
                      <a16:creationId xmlns:a16="http://schemas.microsoft.com/office/drawing/2014/main" id="{974D68DF-6442-BECA-EB81-D225A9421A39}"/>
                    </a:ext>
                  </a:extLst>
                </p:cNvPr>
                <p:cNvGrpSpPr/>
                <p:nvPr/>
              </p:nvGrpSpPr>
              <p:grpSpPr>
                <a:xfrm>
                  <a:off x="3257939" y="4494744"/>
                  <a:ext cx="6551963" cy="620880"/>
                  <a:chOff x="3257939" y="4494744"/>
                  <a:chExt cx="6551963" cy="620880"/>
                </a:xfrm>
              </p:grpSpPr>
              <p:sp>
                <p:nvSpPr>
                  <p:cNvPr id="323" name="楕円 322">
                    <a:extLst>
                      <a:ext uri="{FF2B5EF4-FFF2-40B4-BE49-F238E27FC236}">
                        <a16:creationId xmlns:a16="http://schemas.microsoft.com/office/drawing/2014/main" id="{4C023D92-2AC2-4291-B3A1-9B95BB4CE74A}"/>
                      </a:ext>
                    </a:extLst>
                  </p:cNvPr>
                  <p:cNvSpPr/>
                  <p:nvPr/>
                </p:nvSpPr>
                <p:spPr>
                  <a:xfrm>
                    <a:off x="3257939" y="449474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4" name="楕円 323">
                    <a:extLst>
                      <a:ext uri="{FF2B5EF4-FFF2-40B4-BE49-F238E27FC236}">
                        <a16:creationId xmlns:a16="http://schemas.microsoft.com/office/drawing/2014/main" id="{3E31BBC1-E78B-59BF-FB5D-12C7ECD2E586}"/>
                      </a:ext>
                    </a:extLst>
                  </p:cNvPr>
                  <p:cNvSpPr/>
                  <p:nvPr/>
                </p:nvSpPr>
                <p:spPr>
                  <a:xfrm>
                    <a:off x="4865618" y="483707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5" name="楕円 324">
                    <a:extLst>
                      <a:ext uri="{FF2B5EF4-FFF2-40B4-BE49-F238E27FC236}">
                        <a16:creationId xmlns:a16="http://schemas.microsoft.com/office/drawing/2014/main" id="{0858409D-5BC6-8673-E485-60A3AF105520}"/>
                      </a:ext>
                    </a:extLst>
                  </p:cNvPr>
                  <p:cNvSpPr/>
                  <p:nvPr/>
                </p:nvSpPr>
                <p:spPr>
                  <a:xfrm>
                    <a:off x="6464917" y="497162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6" name="楕円 325">
                    <a:extLst>
                      <a:ext uri="{FF2B5EF4-FFF2-40B4-BE49-F238E27FC236}">
                        <a16:creationId xmlns:a16="http://schemas.microsoft.com/office/drawing/2014/main" id="{6588D86E-2908-F4B9-7D8D-747B5285B7E5}"/>
                      </a:ext>
                    </a:extLst>
                  </p:cNvPr>
                  <p:cNvSpPr/>
                  <p:nvPr/>
                </p:nvSpPr>
                <p:spPr>
                  <a:xfrm>
                    <a:off x="8070388" y="4927336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7" name="楕円 326">
                    <a:extLst>
                      <a:ext uri="{FF2B5EF4-FFF2-40B4-BE49-F238E27FC236}">
                        <a16:creationId xmlns:a16="http://schemas.microsoft.com/office/drawing/2014/main" id="{7DBC38BA-CB99-80A4-95E2-24BE5E414D6B}"/>
                      </a:ext>
                    </a:extLst>
                  </p:cNvPr>
                  <p:cNvSpPr/>
                  <p:nvPr/>
                </p:nvSpPr>
                <p:spPr>
                  <a:xfrm>
                    <a:off x="9665902" y="4927603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95" name="フリーフォーム: 図形 394">
                  <a:extLst>
                    <a:ext uri="{FF2B5EF4-FFF2-40B4-BE49-F238E27FC236}">
                      <a16:creationId xmlns:a16="http://schemas.microsoft.com/office/drawing/2014/main" id="{2D47CD30-84F2-BEBB-B3FB-BC8953755FC0}"/>
                    </a:ext>
                  </a:extLst>
                </p:cNvPr>
                <p:cNvSpPr/>
                <p:nvPr/>
              </p:nvSpPr>
              <p:spPr>
                <a:xfrm>
                  <a:off x="3326607" y="4562475"/>
                  <a:ext cx="4819649" cy="483395"/>
                </a:xfrm>
                <a:custGeom>
                  <a:avLst/>
                  <a:gdLst>
                    <a:gd name="connsiteX0" fmla="*/ 0 w 4824412"/>
                    <a:gd name="connsiteY0" fmla="*/ 0 h 485775"/>
                    <a:gd name="connsiteX1" fmla="*/ 1619250 w 4824412"/>
                    <a:gd name="connsiteY1" fmla="*/ 352425 h 485775"/>
                    <a:gd name="connsiteX2" fmla="*/ 3214687 w 4824412"/>
                    <a:gd name="connsiteY2" fmla="*/ 485775 h 485775"/>
                    <a:gd name="connsiteX3" fmla="*/ 4824412 w 4824412"/>
                    <a:gd name="connsiteY3" fmla="*/ 452437 h 485775"/>
                    <a:gd name="connsiteX0" fmla="*/ 0 w 4826793"/>
                    <a:gd name="connsiteY0" fmla="*/ 0 h 485775"/>
                    <a:gd name="connsiteX1" fmla="*/ 1619250 w 4826793"/>
                    <a:gd name="connsiteY1" fmla="*/ 352425 h 485775"/>
                    <a:gd name="connsiteX2" fmla="*/ 3214687 w 4826793"/>
                    <a:gd name="connsiteY2" fmla="*/ 485775 h 485775"/>
                    <a:gd name="connsiteX3" fmla="*/ 4826793 w 4826793"/>
                    <a:gd name="connsiteY3" fmla="*/ 433387 h 485775"/>
                    <a:gd name="connsiteX0" fmla="*/ 0 w 4826793"/>
                    <a:gd name="connsiteY0" fmla="*/ 0 h 485775"/>
                    <a:gd name="connsiteX1" fmla="*/ 1619250 w 4826793"/>
                    <a:gd name="connsiteY1" fmla="*/ 352425 h 485775"/>
                    <a:gd name="connsiteX2" fmla="*/ 3214687 w 4826793"/>
                    <a:gd name="connsiteY2" fmla="*/ 485775 h 485775"/>
                    <a:gd name="connsiteX3" fmla="*/ 4826793 w 4826793"/>
                    <a:gd name="connsiteY3" fmla="*/ 438149 h 485775"/>
                    <a:gd name="connsiteX0" fmla="*/ 0 w 4826793"/>
                    <a:gd name="connsiteY0" fmla="*/ 0 h 488157"/>
                    <a:gd name="connsiteX1" fmla="*/ 1619250 w 4826793"/>
                    <a:gd name="connsiteY1" fmla="*/ 352425 h 488157"/>
                    <a:gd name="connsiteX2" fmla="*/ 3214687 w 4826793"/>
                    <a:gd name="connsiteY2" fmla="*/ 488157 h 488157"/>
                    <a:gd name="connsiteX3" fmla="*/ 4826793 w 4826793"/>
                    <a:gd name="connsiteY3" fmla="*/ 438149 h 488157"/>
                    <a:gd name="connsiteX0" fmla="*/ 0 w 4826793"/>
                    <a:gd name="connsiteY0" fmla="*/ 0 h 483395"/>
                    <a:gd name="connsiteX1" fmla="*/ 1619250 w 4826793"/>
                    <a:gd name="connsiteY1" fmla="*/ 347663 h 483395"/>
                    <a:gd name="connsiteX2" fmla="*/ 3214687 w 4826793"/>
                    <a:gd name="connsiteY2" fmla="*/ 483395 h 483395"/>
                    <a:gd name="connsiteX3" fmla="*/ 4826793 w 4826793"/>
                    <a:gd name="connsiteY3" fmla="*/ 433387 h 483395"/>
                    <a:gd name="connsiteX0" fmla="*/ 0 w 4819649"/>
                    <a:gd name="connsiteY0" fmla="*/ 0 h 483395"/>
                    <a:gd name="connsiteX1" fmla="*/ 1612106 w 4819649"/>
                    <a:gd name="connsiteY1" fmla="*/ 347663 h 483395"/>
                    <a:gd name="connsiteX2" fmla="*/ 3207543 w 4819649"/>
                    <a:gd name="connsiteY2" fmla="*/ 483395 h 483395"/>
                    <a:gd name="connsiteX3" fmla="*/ 4819649 w 4819649"/>
                    <a:gd name="connsiteY3" fmla="*/ 433387 h 4833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9649" h="483395">
                      <a:moveTo>
                        <a:pt x="0" y="0"/>
                      </a:moveTo>
                      <a:lnTo>
                        <a:pt x="1612106" y="347663"/>
                      </a:lnTo>
                      <a:lnTo>
                        <a:pt x="3207543" y="483395"/>
                      </a:lnTo>
                      <a:lnTo>
                        <a:pt x="4819649" y="433387"/>
                      </a:ln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1968339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id="{E5AF4EA0-5554-427D-9EEE-813F565420B2}"/>
              </a:ext>
            </a:extLst>
          </p:cNvPr>
          <p:cNvGrpSpPr/>
          <p:nvPr/>
        </p:nvGrpSpPr>
        <p:grpSpPr>
          <a:xfrm>
            <a:off x="4146738" y="5594224"/>
            <a:ext cx="5093346" cy="452458"/>
            <a:chOff x="14358031" y="770856"/>
            <a:chExt cx="5093346" cy="452458"/>
          </a:xfrm>
        </p:grpSpPr>
        <p:grpSp>
          <p:nvGrpSpPr>
            <p:cNvPr id="256" name="グループ化 255">
              <a:extLst>
                <a:ext uri="{FF2B5EF4-FFF2-40B4-BE49-F238E27FC236}">
                  <a16:creationId xmlns:a16="http://schemas.microsoft.com/office/drawing/2014/main" id="{27F793F5-21D0-4C9D-B89E-44B0AE38DE4D}"/>
                </a:ext>
              </a:extLst>
            </p:cNvPr>
            <p:cNvGrpSpPr/>
            <p:nvPr/>
          </p:nvGrpSpPr>
          <p:grpSpPr>
            <a:xfrm>
              <a:off x="16427188" y="806578"/>
              <a:ext cx="1463497" cy="381014"/>
              <a:chOff x="16427188" y="806578"/>
              <a:chExt cx="1463497" cy="381014"/>
            </a:xfrm>
          </p:grpSpPr>
          <p:sp>
            <p:nvSpPr>
              <p:cNvPr id="276" name="正方形/長方形 275">
                <a:extLst>
                  <a:ext uri="{FF2B5EF4-FFF2-40B4-BE49-F238E27FC236}">
                    <a16:creationId xmlns:a16="http://schemas.microsoft.com/office/drawing/2014/main" id="{E7B7521B-08A2-43E5-BCFE-5A748FA49E22}"/>
                  </a:ext>
                </a:extLst>
              </p:cNvPr>
              <p:cNvSpPr/>
              <p:nvPr/>
            </p:nvSpPr>
            <p:spPr>
              <a:xfrm>
                <a:off x="16813984" y="893799"/>
                <a:ext cx="1076701" cy="215444"/>
              </a:xfrm>
              <a:prstGeom prst="rect">
                <a:avLst/>
              </a:prstGeom>
              <a:noFill/>
            </p:spPr>
            <p:txBody>
              <a:bodyPr wrap="none" lIns="36000" tIns="0" rIns="0" bIns="0" anchor="ctr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RB (</a:t>
                </a:r>
                <a:r>
                  <a:rPr lang="en-US" altLang="ja-JP" sz="1400" i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n </a:t>
                </a: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= 45)</a:t>
                </a:r>
              </a:p>
            </p:txBody>
          </p:sp>
          <p:grpSp>
            <p:nvGrpSpPr>
              <p:cNvPr id="277" name="グループ化 276">
                <a:extLst>
                  <a:ext uri="{FF2B5EF4-FFF2-40B4-BE49-F238E27FC236}">
                    <a16:creationId xmlns:a16="http://schemas.microsoft.com/office/drawing/2014/main" id="{0D86186C-95B7-4876-9B98-0DF2F808A9CF}"/>
                  </a:ext>
                </a:extLst>
              </p:cNvPr>
              <p:cNvGrpSpPr/>
              <p:nvPr/>
            </p:nvGrpSpPr>
            <p:grpSpPr>
              <a:xfrm>
                <a:off x="16427188" y="806578"/>
                <a:ext cx="360000" cy="144000"/>
                <a:chOff x="4090696" y="4907843"/>
                <a:chExt cx="360000" cy="144000"/>
              </a:xfrm>
            </p:grpSpPr>
            <p:cxnSp>
              <p:nvCxnSpPr>
                <p:cNvPr id="281" name="直線コネクタ 280">
                  <a:extLst>
                    <a:ext uri="{FF2B5EF4-FFF2-40B4-BE49-F238E27FC236}">
                      <a16:creationId xmlns:a16="http://schemas.microsoft.com/office/drawing/2014/main" id="{CE8A359E-9C28-43F3-95F0-987A3C3701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90696" y="4979843"/>
                  <a:ext cx="360000" cy="0"/>
                </a:xfrm>
                <a:prstGeom prst="line">
                  <a:avLst/>
                </a:prstGeom>
                <a:noFill/>
                <a:ln w="38100" cap="flat">
                  <a:solidFill>
                    <a:srgbClr val="FF0000"/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82" name="楕円 281">
                  <a:extLst>
                    <a:ext uri="{FF2B5EF4-FFF2-40B4-BE49-F238E27FC236}">
                      <a16:creationId xmlns:a16="http://schemas.microsoft.com/office/drawing/2014/main" id="{B104A2F6-1AF2-4198-9953-D20F8F0A5405}"/>
                    </a:ext>
                  </a:extLst>
                </p:cNvPr>
                <p:cNvSpPr/>
                <p:nvPr/>
              </p:nvSpPr>
              <p:spPr>
                <a:xfrm>
                  <a:off x="4198696" y="4907843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8" name="グループ化 277">
                <a:extLst>
                  <a:ext uri="{FF2B5EF4-FFF2-40B4-BE49-F238E27FC236}">
                    <a16:creationId xmlns:a16="http://schemas.microsoft.com/office/drawing/2014/main" id="{A5D114F8-2271-45CD-B3C5-9337D98F541C}"/>
                  </a:ext>
                </a:extLst>
              </p:cNvPr>
              <p:cNvGrpSpPr/>
              <p:nvPr/>
            </p:nvGrpSpPr>
            <p:grpSpPr>
              <a:xfrm>
                <a:off x="16427188" y="1043592"/>
                <a:ext cx="360000" cy="144000"/>
                <a:chOff x="4090696" y="4907843"/>
                <a:chExt cx="360000" cy="144000"/>
              </a:xfrm>
            </p:grpSpPr>
            <p:cxnSp>
              <p:nvCxnSpPr>
                <p:cNvPr id="279" name="直線コネクタ 278">
                  <a:extLst>
                    <a:ext uri="{FF2B5EF4-FFF2-40B4-BE49-F238E27FC236}">
                      <a16:creationId xmlns:a16="http://schemas.microsoft.com/office/drawing/2014/main" id="{D7EE74CC-6343-4071-A4D0-BD44BF2164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90696" y="4979843"/>
                  <a:ext cx="360000" cy="0"/>
                </a:xfrm>
                <a:prstGeom prst="line">
                  <a:avLst/>
                </a:prstGeom>
                <a:noFill/>
                <a:ln w="38100" cap="flat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80" name="楕円 279">
                  <a:extLst>
                    <a:ext uri="{FF2B5EF4-FFF2-40B4-BE49-F238E27FC236}">
                      <a16:creationId xmlns:a16="http://schemas.microsoft.com/office/drawing/2014/main" id="{1C754D73-6835-49EC-8E5A-C26210EBC45B}"/>
                    </a:ext>
                  </a:extLst>
                </p:cNvPr>
                <p:cNvSpPr/>
                <p:nvPr/>
              </p:nvSpPr>
              <p:spPr>
                <a:xfrm>
                  <a:off x="4198696" y="4907843"/>
                  <a:ext cx="144000" cy="14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57" name="グループ化 256">
              <a:extLst>
                <a:ext uri="{FF2B5EF4-FFF2-40B4-BE49-F238E27FC236}">
                  <a16:creationId xmlns:a16="http://schemas.microsoft.com/office/drawing/2014/main" id="{17A4EFD6-E14F-4D5D-9AE0-B0A83F75691C}"/>
                </a:ext>
              </a:extLst>
            </p:cNvPr>
            <p:cNvGrpSpPr/>
            <p:nvPr/>
          </p:nvGrpSpPr>
          <p:grpSpPr>
            <a:xfrm>
              <a:off x="17978262" y="806578"/>
              <a:ext cx="1473115" cy="381014"/>
              <a:chOff x="17978262" y="806578"/>
              <a:chExt cx="1473115" cy="381014"/>
            </a:xfrm>
          </p:grpSpPr>
          <p:sp>
            <p:nvSpPr>
              <p:cNvPr id="269" name="正方形/長方形 268">
                <a:extLst>
                  <a:ext uri="{FF2B5EF4-FFF2-40B4-BE49-F238E27FC236}">
                    <a16:creationId xmlns:a16="http://schemas.microsoft.com/office/drawing/2014/main" id="{BFFEDCB1-DAB7-409B-BC0F-31C8E19CB9FD}"/>
                  </a:ext>
                </a:extLst>
              </p:cNvPr>
              <p:cNvSpPr/>
              <p:nvPr/>
            </p:nvSpPr>
            <p:spPr>
              <a:xfrm>
                <a:off x="18365058" y="889676"/>
                <a:ext cx="1086319" cy="215444"/>
              </a:xfrm>
              <a:prstGeom prst="rect">
                <a:avLst/>
              </a:prstGeom>
              <a:noFill/>
            </p:spPr>
            <p:txBody>
              <a:bodyPr wrap="none" lIns="36000" tIns="0" rIns="0" bIns="0" anchor="ctr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CB (</a:t>
                </a:r>
                <a:r>
                  <a:rPr lang="en-US" altLang="ja-JP" sz="1400" i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n </a:t>
                </a: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= 48)</a:t>
                </a:r>
              </a:p>
            </p:txBody>
          </p:sp>
          <p:grpSp>
            <p:nvGrpSpPr>
              <p:cNvPr id="270" name="グループ化 269">
                <a:extLst>
                  <a:ext uri="{FF2B5EF4-FFF2-40B4-BE49-F238E27FC236}">
                    <a16:creationId xmlns:a16="http://schemas.microsoft.com/office/drawing/2014/main" id="{619075A8-EDEC-4203-81FC-4C92611C27E8}"/>
                  </a:ext>
                </a:extLst>
              </p:cNvPr>
              <p:cNvGrpSpPr/>
              <p:nvPr/>
            </p:nvGrpSpPr>
            <p:grpSpPr>
              <a:xfrm>
                <a:off x="17978262" y="1043592"/>
                <a:ext cx="360000" cy="144000"/>
                <a:chOff x="4188937" y="4907843"/>
                <a:chExt cx="360000" cy="144000"/>
              </a:xfrm>
            </p:grpSpPr>
            <p:cxnSp>
              <p:nvCxnSpPr>
                <p:cNvPr id="274" name="直線コネクタ 273">
                  <a:extLst>
                    <a:ext uri="{FF2B5EF4-FFF2-40B4-BE49-F238E27FC236}">
                      <a16:creationId xmlns:a16="http://schemas.microsoft.com/office/drawing/2014/main" id="{49716730-1EC3-4CA4-94A0-23A909883D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88937" y="4979843"/>
                  <a:ext cx="360000" cy="0"/>
                </a:xfrm>
                <a:prstGeom prst="line">
                  <a:avLst/>
                </a:prstGeom>
                <a:noFill/>
                <a:ln w="38100" cap="flat">
                  <a:solidFill>
                    <a:srgbClr val="0000FF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75" name="楕円 274">
                  <a:extLst>
                    <a:ext uri="{FF2B5EF4-FFF2-40B4-BE49-F238E27FC236}">
                      <a16:creationId xmlns:a16="http://schemas.microsoft.com/office/drawing/2014/main" id="{196DC08D-B3C4-43BD-B9CD-D66D2EEAB5B9}"/>
                    </a:ext>
                  </a:extLst>
                </p:cNvPr>
                <p:cNvSpPr/>
                <p:nvPr/>
              </p:nvSpPr>
              <p:spPr>
                <a:xfrm>
                  <a:off x="4296937" y="4907843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1" name="グループ化 270">
                <a:extLst>
                  <a:ext uri="{FF2B5EF4-FFF2-40B4-BE49-F238E27FC236}">
                    <a16:creationId xmlns:a16="http://schemas.microsoft.com/office/drawing/2014/main" id="{CB25E04D-2CD2-4FC5-BD24-222561FC51C3}"/>
                  </a:ext>
                </a:extLst>
              </p:cNvPr>
              <p:cNvGrpSpPr/>
              <p:nvPr/>
            </p:nvGrpSpPr>
            <p:grpSpPr>
              <a:xfrm>
                <a:off x="17978262" y="806578"/>
                <a:ext cx="360000" cy="144000"/>
                <a:chOff x="4188937" y="4907843"/>
                <a:chExt cx="360000" cy="144000"/>
              </a:xfrm>
            </p:grpSpPr>
            <p:cxnSp>
              <p:nvCxnSpPr>
                <p:cNvPr id="272" name="直線コネクタ 271">
                  <a:extLst>
                    <a:ext uri="{FF2B5EF4-FFF2-40B4-BE49-F238E27FC236}">
                      <a16:creationId xmlns:a16="http://schemas.microsoft.com/office/drawing/2014/main" id="{6846334B-B439-4540-A05E-6808FEA3D72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88937" y="4979843"/>
                  <a:ext cx="360000" cy="0"/>
                </a:xfrm>
                <a:prstGeom prst="line">
                  <a:avLst/>
                </a:prstGeom>
                <a:solidFill>
                  <a:srgbClr val="00B050"/>
                </a:solidFill>
                <a:ln w="38100" cap="flat">
                  <a:solidFill>
                    <a:srgbClr val="0000FF"/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73" name="楕円 272">
                  <a:extLst>
                    <a:ext uri="{FF2B5EF4-FFF2-40B4-BE49-F238E27FC236}">
                      <a16:creationId xmlns:a16="http://schemas.microsoft.com/office/drawing/2014/main" id="{DF49A6CB-6067-48A2-94D4-E845B2DD1E65}"/>
                    </a:ext>
                  </a:extLst>
                </p:cNvPr>
                <p:cNvSpPr/>
                <p:nvPr/>
              </p:nvSpPr>
              <p:spPr>
                <a:xfrm>
                  <a:off x="4296937" y="4907843"/>
                  <a:ext cx="144000" cy="14400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58" name="グループ化 257">
              <a:extLst>
                <a:ext uri="{FF2B5EF4-FFF2-40B4-BE49-F238E27FC236}">
                  <a16:creationId xmlns:a16="http://schemas.microsoft.com/office/drawing/2014/main" id="{5355EB58-3D9A-4C63-A96C-763D11E13818}"/>
                </a:ext>
              </a:extLst>
            </p:cNvPr>
            <p:cNvGrpSpPr/>
            <p:nvPr/>
          </p:nvGrpSpPr>
          <p:grpSpPr>
            <a:xfrm>
              <a:off x="14853398" y="806578"/>
              <a:ext cx="1501328" cy="381014"/>
              <a:chOff x="14853398" y="806578"/>
              <a:chExt cx="1501328" cy="381014"/>
            </a:xfrm>
          </p:grpSpPr>
          <p:sp>
            <p:nvSpPr>
              <p:cNvPr id="262" name="正方形/長方形 261">
                <a:extLst>
                  <a:ext uri="{FF2B5EF4-FFF2-40B4-BE49-F238E27FC236}">
                    <a16:creationId xmlns:a16="http://schemas.microsoft.com/office/drawing/2014/main" id="{1B9E958B-B65D-479A-8E13-D1335EB6C893}"/>
                  </a:ext>
                </a:extLst>
              </p:cNvPr>
              <p:cNvSpPr/>
              <p:nvPr/>
            </p:nvSpPr>
            <p:spPr>
              <a:xfrm>
                <a:off x="15240194" y="893799"/>
                <a:ext cx="1114532" cy="215444"/>
              </a:xfrm>
              <a:prstGeom prst="rect">
                <a:avLst/>
              </a:prstGeom>
              <a:noFill/>
            </p:spPr>
            <p:txBody>
              <a:bodyPr wrap="none" lIns="36000" tIns="0" rIns="0" bIns="0" anchor="ctr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Total</a:t>
                </a:r>
                <a:r>
                  <a:rPr lang="ja-JP" altLang="en-US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</a:t>
                </a: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(</a:t>
                </a:r>
                <a:r>
                  <a:rPr lang="en-US" altLang="ja-JP" sz="1400" i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N </a:t>
                </a: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= 93)</a:t>
                </a:r>
              </a:p>
            </p:txBody>
          </p:sp>
          <p:grpSp>
            <p:nvGrpSpPr>
              <p:cNvPr id="263" name="グループ化 262">
                <a:extLst>
                  <a:ext uri="{FF2B5EF4-FFF2-40B4-BE49-F238E27FC236}">
                    <a16:creationId xmlns:a16="http://schemas.microsoft.com/office/drawing/2014/main" id="{F1A61A61-2552-48AE-972C-400B682BB847}"/>
                  </a:ext>
                </a:extLst>
              </p:cNvPr>
              <p:cNvGrpSpPr/>
              <p:nvPr/>
            </p:nvGrpSpPr>
            <p:grpSpPr>
              <a:xfrm>
                <a:off x="14853398" y="806578"/>
                <a:ext cx="360000" cy="144000"/>
                <a:chOff x="4007569" y="4907843"/>
                <a:chExt cx="360000" cy="144000"/>
              </a:xfrm>
            </p:grpSpPr>
            <p:cxnSp>
              <p:nvCxnSpPr>
                <p:cNvPr id="267" name="直線コネクタ 266">
                  <a:extLst>
                    <a:ext uri="{FF2B5EF4-FFF2-40B4-BE49-F238E27FC236}">
                      <a16:creationId xmlns:a16="http://schemas.microsoft.com/office/drawing/2014/main" id="{BC8401C9-D219-4232-9903-5ABDCEA267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07569" y="4979843"/>
                  <a:ext cx="360000" cy="0"/>
                </a:xfrm>
                <a:prstGeom prst="line">
                  <a:avLst/>
                </a:prstGeom>
                <a:noFill/>
                <a:ln w="38100" cap="flat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68" name="楕円 267">
                  <a:extLst>
                    <a:ext uri="{FF2B5EF4-FFF2-40B4-BE49-F238E27FC236}">
                      <a16:creationId xmlns:a16="http://schemas.microsoft.com/office/drawing/2014/main" id="{A10B9EB1-90C3-47C8-B389-A2B0A83637A8}"/>
                    </a:ext>
                  </a:extLst>
                </p:cNvPr>
                <p:cNvSpPr/>
                <p:nvPr/>
              </p:nvSpPr>
              <p:spPr>
                <a:xfrm>
                  <a:off x="4115569" y="4907843"/>
                  <a:ext cx="144000" cy="144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4" name="グループ化 263">
                <a:extLst>
                  <a:ext uri="{FF2B5EF4-FFF2-40B4-BE49-F238E27FC236}">
                    <a16:creationId xmlns:a16="http://schemas.microsoft.com/office/drawing/2014/main" id="{525836C5-E147-4D32-A5BB-3251FF9A5690}"/>
                  </a:ext>
                </a:extLst>
              </p:cNvPr>
              <p:cNvGrpSpPr/>
              <p:nvPr/>
            </p:nvGrpSpPr>
            <p:grpSpPr>
              <a:xfrm>
                <a:off x="14853398" y="1043592"/>
                <a:ext cx="360000" cy="144000"/>
                <a:chOff x="4007569" y="4907843"/>
                <a:chExt cx="360000" cy="144000"/>
              </a:xfrm>
            </p:grpSpPr>
            <p:cxnSp>
              <p:nvCxnSpPr>
                <p:cNvPr id="265" name="直線コネクタ 264">
                  <a:extLst>
                    <a:ext uri="{FF2B5EF4-FFF2-40B4-BE49-F238E27FC236}">
                      <a16:creationId xmlns:a16="http://schemas.microsoft.com/office/drawing/2014/main" id="{0695A2E6-5043-4E66-A87C-A98D81753E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07569" y="4979843"/>
                  <a:ext cx="360000" cy="0"/>
                </a:xfrm>
                <a:prstGeom prst="line">
                  <a:avLst/>
                </a:prstGeom>
                <a:noFill/>
                <a:ln w="38100" cap="flat"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66" name="楕円 265">
                  <a:extLst>
                    <a:ext uri="{FF2B5EF4-FFF2-40B4-BE49-F238E27FC236}">
                      <a16:creationId xmlns:a16="http://schemas.microsoft.com/office/drawing/2014/main" id="{4728FC62-2DC4-40FF-9E00-1BE0F46861C8}"/>
                    </a:ext>
                  </a:extLst>
                </p:cNvPr>
                <p:cNvSpPr/>
                <p:nvPr/>
              </p:nvSpPr>
              <p:spPr>
                <a:xfrm>
                  <a:off x="4115569" y="4907843"/>
                  <a:ext cx="144000" cy="144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1" lang="ja-JP" alt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59" name="グループ化 258">
              <a:extLst>
                <a:ext uri="{FF2B5EF4-FFF2-40B4-BE49-F238E27FC236}">
                  <a16:creationId xmlns:a16="http://schemas.microsoft.com/office/drawing/2014/main" id="{3A9BB19C-AFC4-4A67-8FD7-6A9854320EA9}"/>
                </a:ext>
              </a:extLst>
            </p:cNvPr>
            <p:cNvGrpSpPr/>
            <p:nvPr/>
          </p:nvGrpSpPr>
          <p:grpSpPr>
            <a:xfrm>
              <a:off x="14358031" y="770856"/>
              <a:ext cx="406646" cy="452458"/>
              <a:chOff x="14358031" y="770856"/>
              <a:chExt cx="406646" cy="452458"/>
            </a:xfrm>
          </p:grpSpPr>
          <p:sp>
            <p:nvSpPr>
              <p:cNvPr id="260" name="正方形/長方形 259">
                <a:extLst>
                  <a:ext uri="{FF2B5EF4-FFF2-40B4-BE49-F238E27FC236}">
                    <a16:creationId xmlns:a16="http://schemas.microsoft.com/office/drawing/2014/main" id="{50BA0EF0-E71A-428D-BF91-1E6EF0D919ED}"/>
                  </a:ext>
                </a:extLst>
              </p:cNvPr>
              <p:cNvSpPr/>
              <p:nvPr/>
            </p:nvSpPr>
            <p:spPr>
              <a:xfrm>
                <a:off x="14363398" y="770856"/>
                <a:ext cx="397028" cy="215444"/>
              </a:xfrm>
              <a:prstGeom prst="rect">
                <a:avLst/>
              </a:prstGeom>
              <a:noFill/>
            </p:spPr>
            <p:txBody>
              <a:bodyPr wrap="none" lIns="36000" tIns="0" rIns="0" bIns="0" anchor="ctr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SBP</a:t>
                </a:r>
              </a:p>
            </p:txBody>
          </p:sp>
          <p:sp>
            <p:nvSpPr>
              <p:cNvPr id="261" name="正方形/長方形 260">
                <a:extLst>
                  <a:ext uri="{FF2B5EF4-FFF2-40B4-BE49-F238E27FC236}">
                    <a16:creationId xmlns:a16="http://schemas.microsoft.com/office/drawing/2014/main" id="{C3B3CD73-ED25-42A1-9589-391D64BE0876}"/>
                  </a:ext>
                </a:extLst>
              </p:cNvPr>
              <p:cNvSpPr/>
              <p:nvPr/>
            </p:nvSpPr>
            <p:spPr>
              <a:xfrm>
                <a:off x="14358031" y="1007870"/>
                <a:ext cx="406646" cy="215444"/>
              </a:xfrm>
              <a:prstGeom prst="rect">
                <a:avLst/>
              </a:prstGeom>
              <a:noFill/>
            </p:spPr>
            <p:txBody>
              <a:bodyPr wrap="none" lIns="36000" tIns="0" rIns="0" bIns="0" anchor="ctr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DBP</a:t>
                </a:r>
              </a:p>
            </p:txBody>
          </p:sp>
        </p:grp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CEAAB36-74AB-A331-77F5-293A8277F912}"/>
              </a:ext>
            </a:extLst>
          </p:cNvPr>
          <p:cNvSpPr/>
          <p:nvPr/>
        </p:nvSpPr>
        <p:spPr>
          <a:xfrm>
            <a:off x="0" y="0"/>
            <a:ext cx="2993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2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00F0E16-74EC-EA0C-4855-01C16C47285F}"/>
              </a:ext>
            </a:extLst>
          </p:cNvPr>
          <p:cNvSpPr txBox="1"/>
          <p:nvPr/>
        </p:nvSpPr>
        <p:spPr>
          <a:xfrm rot="16200000">
            <a:off x="1207273" y="2839552"/>
            <a:ext cx="184435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ffice BP (mmHg)</a:t>
            </a: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DDFDCEC6-3E39-7CD4-2FD4-8293EC0385E3}"/>
              </a:ext>
            </a:extLst>
          </p:cNvPr>
          <p:cNvCxnSpPr>
            <a:cxnSpLocks/>
          </p:cNvCxnSpPr>
          <p:nvPr/>
        </p:nvCxnSpPr>
        <p:spPr>
          <a:xfrm>
            <a:off x="2966432" y="811319"/>
            <a:ext cx="0" cy="4168757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8338CFA5-9E13-F16A-562D-B8F1F3B42F0E}"/>
              </a:ext>
            </a:extLst>
          </p:cNvPr>
          <p:cNvSpPr/>
          <p:nvPr/>
        </p:nvSpPr>
        <p:spPr>
          <a:xfrm>
            <a:off x="3048837" y="5050256"/>
            <a:ext cx="783869" cy="24622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aseline</a:t>
            </a: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7F55DBD7-8801-6102-445B-5849409311DC}"/>
              </a:ext>
            </a:extLst>
          </p:cNvPr>
          <p:cNvSpPr/>
          <p:nvPr/>
        </p:nvSpPr>
        <p:spPr>
          <a:xfrm>
            <a:off x="4693011" y="5050256"/>
            <a:ext cx="691984" cy="24622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Week 4</a:t>
            </a: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0F5301A8-38D6-EED7-4755-F07836D45DEF}"/>
              </a:ext>
            </a:extLst>
          </p:cNvPr>
          <p:cNvSpPr/>
          <p:nvPr/>
        </p:nvSpPr>
        <p:spPr>
          <a:xfrm>
            <a:off x="6289556" y="5050256"/>
            <a:ext cx="691984" cy="24622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Week 8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7D070D06-288F-37E3-4289-7E9E59FDC58A}"/>
              </a:ext>
            </a:extLst>
          </p:cNvPr>
          <p:cNvSpPr/>
          <p:nvPr/>
        </p:nvSpPr>
        <p:spPr>
          <a:xfrm>
            <a:off x="7830844" y="5050256"/>
            <a:ext cx="805798" cy="24622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Week 12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48" name="直線コネクタ 447">
            <a:extLst>
              <a:ext uri="{FF2B5EF4-FFF2-40B4-BE49-F238E27FC236}">
                <a16:creationId xmlns:a16="http://schemas.microsoft.com/office/drawing/2014/main" id="{8EAAA186-A39C-7377-FAD6-4A3DDD87F89D}"/>
              </a:ext>
            </a:extLst>
          </p:cNvPr>
          <p:cNvCxnSpPr>
            <a:cxnSpLocks/>
          </p:cNvCxnSpPr>
          <p:nvPr/>
        </p:nvCxnSpPr>
        <p:spPr>
          <a:xfrm>
            <a:off x="3440771" y="498007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9" name="直線コネクタ 448">
            <a:extLst>
              <a:ext uri="{FF2B5EF4-FFF2-40B4-BE49-F238E27FC236}">
                <a16:creationId xmlns:a16="http://schemas.microsoft.com/office/drawing/2014/main" id="{A2229B92-3183-5E59-8EA9-AD72421A6515}"/>
              </a:ext>
            </a:extLst>
          </p:cNvPr>
          <p:cNvCxnSpPr>
            <a:cxnSpLocks/>
          </p:cNvCxnSpPr>
          <p:nvPr/>
        </p:nvCxnSpPr>
        <p:spPr>
          <a:xfrm>
            <a:off x="6635548" y="498007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直線コネクタ 449">
            <a:extLst>
              <a:ext uri="{FF2B5EF4-FFF2-40B4-BE49-F238E27FC236}">
                <a16:creationId xmlns:a16="http://schemas.microsoft.com/office/drawing/2014/main" id="{80A6C1E8-65B7-DE9A-E85F-AA096AEADF0B}"/>
              </a:ext>
            </a:extLst>
          </p:cNvPr>
          <p:cNvCxnSpPr>
            <a:cxnSpLocks/>
          </p:cNvCxnSpPr>
          <p:nvPr/>
        </p:nvCxnSpPr>
        <p:spPr>
          <a:xfrm>
            <a:off x="8233743" y="498007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直線コネクタ 450">
            <a:extLst>
              <a:ext uri="{FF2B5EF4-FFF2-40B4-BE49-F238E27FC236}">
                <a16:creationId xmlns:a16="http://schemas.microsoft.com/office/drawing/2014/main" id="{C61D08B1-3DFB-308A-6163-11181B389A52}"/>
              </a:ext>
            </a:extLst>
          </p:cNvPr>
          <p:cNvCxnSpPr>
            <a:cxnSpLocks/>
          </p:cNvCxnSpPr>
          <p:nvPr/>
        </p:nvCxnSpPr>
        <p:spPr>
          <a:xfrm>
            <a:off x="9828929" y="498007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2" name="正方形/長方形 451">
            <a:extLst>
              <a:ext uri="{FF2B5EF4-FFF2-40B4-BE49-F238E27FC236}">
                <a16:creationId xmlns:a16="http://schemas.microsoft.com/office/drawing/2014/main" id="{A6CFC02C-C203-A95C-1F4B-A4CFE14C70FC}"/>
              </a:ext>
            </a:extLst>
          </p:cNvPr>
          <p:cNvSpPr/>
          <p:nvPr/>
        </p:nvSpPr>
        <p:spPr>
          <a:xfrm>
            <a:off x="9618134" y="5050256"/>
            <a:ext cx="421590" cy="24622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OT</a:t>
            </a:r>
          </a:p>
        </p:txBody>
      </p:sp>
      <p:cxnSp>
        <p:nvCxnSpPr>
          <p:cNvPr id="453" name="直線コネクタ 452">
            <a:extLst>
              <a:ext uri="{FF2B5EF4-FFF2-40B4-BE49-F238E27FC236}">
                <a16:creationId xmlns:a16="http://schemas.microsoft.com/office/drawing/2014/main" id="{C72C02A7-F90C-ACEE-873C-36576B2C0326}"/>
              </a:ext>
            </a:extLst>
          </p:cNvPr>
          <p:cNvCxnSpPr>
            <a:cxnSpLocks/>
          </p:cNvCxnSpPr>
          <p:nvPr/>
        </p:nvCxnSpPr>
        <p:spPr>
          <a:xfrm>
            <a:off x="5039003" y="498007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4" name="直線コネクタ 453">
            <a:extLst>
              <a:ext uri="{FF2B5EF4-FFF2-40B4-BE49-F238E27FC236}">
                <a16:creationId xmlns:a16="http://schemas.microsoft.com/office/drawing/2014/main" id="{EF759BD3-43D9-7B37-3914-B139189B28EE}"/>
              </a:ext>
            </a:extLst>
          </p:cNvPr>
          <p:cNvCxnSpPr>
            <a:cxnSpLocks/>
          </p:cNvCxnSpPr>
          <p:nvPr/>
        </p:nvCxnSpPr>
        <p:spPr>
          <a:xfrm>
            <a:off x="2894432" y="484261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5" name="正方形/長方形 454">
            <a:extLst>
              <a:ext uri="{FF2B5EF4-FFF2-40B4-BE49-F238E27FC236}">
                <a16:creationId xmlns:a16="http://schemas.microsoft.com/office/drawing/2014/main" id="{93A817B1-BC11-FB9C-8CBF-AF1F6D48E569}"/>
              </a:ext>
            </a:extLst>
          </p:cNvPr>
          <p:cNvSpPr/>
          <p:nvPr/>
        </p:nvSpPr>
        <p:spPr>
          <a:xfrm>
            <a:off x="2623292" y="4717722"/>
            <a:ext cx="227627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56" name="直線コネクタ 455">
            <a:extLst>
              <a:ext uri="{FF2B5EF4-FFF2-40B4-BE49-F238E27FC236}">
                <a16:creationId xmlns:a16="http://schemas.microsoft.com/office/drawing/2014/main" id="{A0F2CD60-90A2-6BFC-D977-555885C899A6}"/>
              </a:ext>
            </a:extLst>
          </p:cNvPr>
          <p:cNvCxnSpPr>
            <a:cxnSpLocks/>
          </p:cNvCxnSpPr>
          <p:nvPr/>
        </p:nvCxnSpPr>
        <p:spPr>
          <a:xfrm>
            <a:off x="2894432" y="337636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7" name="正方形/長方形 456">
            <a:extLst>
              <a:ext uri="{FF2B5EF4-FFF2-40B4-BE49-F238E27FC236}">
                <a16:creationId xmlns:a16="http://schemas.microsoft.com/office/drawing/2014/main" id="{EB076DF9-B820-477E-961E-9E50E08D2311}"/>
              </a:ext>
            </a:extLst>
          </p:cNvPr>
          <p:cNvSpPr/>
          <p:nvPr/>
        </p:nvSpPr>
        <p:spPr>
          <a:xfrm>
            <a:off x="2509479" y="3252120"/>
            <a:ext cx="341440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58" name="直線コネクタ 457">
            <a:extLst>
              <a:ext uri="{FF2B5EF4-FFF2-40B4-BE49-F238E27FC236}">
                <a16:creationId xmlns:a16="http://schemas.microsoft.com/office/drawing/2014/main" id="{6D688CEB-321A-AABB-8A9D-618ABB1D3D0D}"/>
              </a:ext>
            </a:extLst>
          </p:cNvPr>
          <p:cNvCxnSpPr>
            <a:cxnSpLocks/>
          </p:cNvCxnSpPr>
          <p:nvPr/>
        </p:nvCxnSpPr>
        <p:spPr>
          <a:xfrm>
            <a:off x="2894432" y="191011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9" name="正方形/長方形 458">
            <a:extLst>
              <a:ext uri="{FF2B5EF4-FFF2-40B4-BE49-F238E27FC236}">
                <a16:creationId xmlns:a16="http://schemas.microsoft.com/office/drawing/2014/main" id="{8BAA0F34-2211-DED3-8B13-C30937577102}"/>
              </a:ext>
            </a:extLst>
          </p:cNvPr>
          <p:cNvSpPr/>
          <p:nvPr/>
        </p:nvSpPr>
        <p:spPr>
          <a:xfrm>
            <a:off x="2509479" y="1786516"/>
            <a:ext cx="341440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4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60" name="直線コネクタ 459">
            <a:extLst>
              <a:ext uri="{FF2B5EF4-FFF2-40B4-BE49-F238E27FC236}">
                <a16:creationId xmlns:a16="http://schemas.microsoft.com/office/drawing/2014/main" id="{EB563062-A789-3E42-641F-3F9E9100935B}"/>
              </a:ext>
            </a:extLst>
          </p:cNvPr>
          <p:cNvCxnSpPr>
            <a:cxnSpLocks/>
          </p:cNvCxnSpPr>
          <p:nvPr/>
        </p:nvCxnSpPr>
        <p:spPr>
          <a:xfrm>
            <a:off x="2966432" y="4980076"/>
            <a:ext cx="7200101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1" name="直線コネクタ 460">
            <a:extLst>
              <a:ext uri="{FF2B5EF4-FFF2-40B4-BE49-F238E27FC236}">
                <a16:creationId xmlns:a16="http://schemas.microsoft.com/office/drawing/2014/main" id="{C8CDD938-4551-90F4-7562-390685B7E41D}"/>
              </a:ext>
            </a:extLst>
          </p:cNvPr>
          <p:cNvCxnSpPr>
            <a:cxnSpLocks/>
          </p:cNvCxnSpPr>
          <p:nvPr/>
        </p:nvCxnSpPr>
        <p:spPr>
          <a:xfrm>
            <a:off x="2894432" y="410949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2" name="正方形/長方形 461">
            <a:extLst>
              <a:ext uri="{FF2B5EF4-FFF2-40B4-BE49-F238E27FC236}">
                <a16:creationId xmlns:a16="http://schemas.microsoft.com/office/drawing/2014/main" id="{9EB07716-FD63-E5D7-9397-BC50D9D61F7E}"/>
              </a:ext>
            </a:extLst>
          </p:cNvPr>
          <p:cNvSpPr/>
          <p:nvPr/>
        </p:nvSpPr>
        <p:spPr>
          <a:xfrm>
            <a:off x="2623292" y="3984922"/>
            <a:ext cx="227627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63" name="直線コネクタ 462">
            <a:extLst>
              <a:ext uri="{FF2B5EF4-FFF2-40B4-BE49-F238E27FC236}">
                <a16:creationId xmlns:a16="http://schemas.microsoft.com/office/drawing/2014/main" id="{3E6C1E50-2203-BAF1-688E-E0A1881E1114}"/>
              </a:ext>
            </a:extLst>
          </p:cNvPr>
          <p:cNvCxnSpPr>
            <a:cxnSpLocks/>
          </p:cNvCxnSpPr>
          <p:nvPr/>
        </p:nvCxnSpPr>
        <p:spPr>
          <a:xfrm>
            <a:off x="2894432" y="26432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4" name="正方形/長方形 463">
            <a:extLst>
              <a:ext uri="{FF2B5EF4-FFF2-40B4-BE49-F238E27FC236}">
                <a16:creationId xmlns:a16="http://schemas.microsoft.com/office/drawing/2014/main" id="{ADD31490-307A-A2F6-5C80-76C0CD9E0BB2}"/>
              </a:ext>
            </a:extLst>
          </p:cNvPr>
          <p:cNvSpPr/>
          <p:nvPr/>
        </p:nvSpPr>
        <p:spPr>
          <a:xfrm>
            <a:off x="2509479" y="2519318"/>
            <a:ext cx="341440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2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465" name="直線コネクタ 464">
            <a:extLst>
              <a:ext uri="{FF2B5EF4-FFF2-40B4-BE49-F238E27FC236}">
                <a16:creationId xmlns:a16="http://schemas.microsoft.com/office/drawing/2014/main" id="{F907BD5D-0ABF-2F12-29F5-111BE19274C7}"/>
              </a:ext>
            </a:extLst>
          </p:cNvPr>
          <p:cNvCxnSpPr>
            <a:cxnSpLocks/>
          </p:cNvCxnSpPr>
          <p:nvPr/>
        </p:nvCxnSpPr>
        <p:spPr>
          <a:xfrm>
            <a:off x="2894432" y="117698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6" name="正方形/長方形 465">
            <a:extLst>
              <a:ext uri="{FF2B5EF4-FFF2-40B4-BE49-F238E27FC236}">
                <a16:creationId xmlns:a16="http://schemas.microsoft.com/office/drawing/2014/main" id="{CDB35BBA-F7E6-0E31-18BA-C0CC1E13844B}"/>
              </a:ext>
            </a:extLst>
          </p:cNvPr>
          <p:cNvSpPr/>
          <p:nvPr/>
        </p:nvSpPr>
        <p:spPr>
          <a:xfrm>
            <a:off x="2509479" y="1053714"/>
            <a:ext cx="341440" cy="246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6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902" name="グループ化 901">
            <a:extLst>
              <a:ext uri="{FF2B5EF4-FFF2-40B4-BE49-F238E27FC236}">
                <a16:creationId xmlns:a16="http://schemas.microsoft.com/office/drawing/2014/main" id="{0C8AB671-F09E-DBBF-9A02-C92121987C24}"/>
              </a:ext>
            </a:extLst>
          </p:cNvPr>
          <p:cNvGrpSpPr/>
          <p:nvPr/>
        </p:nvGrpSpPr>
        <p:grpSpPr>
          <a:xfrm>
            <a:off x="3534255" y="1031470"/>
            <a:ext cx="6562319" cy="1708477"/>
            <a:chOff x="3543920" y="1366043"/>
            <a:chExt cx="6562319" cy="1708477"/>
          </a:xfrm>
        </p:grpSpPr>
        <p:grpSp>
          <p:nvGrpSpPr>
            <p:cNvPr id="900" name="グループ化 899">
              <a:extLst>
                <a:ext uri="{FF2B5EF4-FFF2-40B4-BE49-F238E27FC236}">
                  <a16:creationId xmlns:a16="http://schemas.microsoft.com/office/drawing/2014/main" id="{C4DA97AF-9FB2-CE84-6A7E-B3DA000F13B2}"/>
                </a:ext>
              </a:extLst>
            </p:cNvPr>
            <p:cNvGrpSpPr/>
            <p:nvPr/>
          </p:nvGrpSpPr>
          <p:grpSpPr>
            <a:xfrm>
              <a:off x="3561920" y="1366043"/>
              <a:ext cx="6544319" cy="1708477"/>
              <a:chOff x="3561920" y="1366043"/>
              <a:chExt cx="6544319" cy="1708477"/>
            </a:xfrm>
          </p:grpSpPr>
          <p:grpSp>
            <p:nvGrpSpPr>
              <p:cNvPr id="318" name="グループ化 317">
                <a:extLst>
                  <a:ext uri="{FF2B5EF4-FFF2-40B4-BE49-F238E27FC236}">
                    <a16:creationId xmlns:a16="http://schemas.microsoft.com/office/drawing/2014/main" id="{3FAF034A-5E57-ECA0-13BE-967D5075BD86}"/>
                  </a:ext>
                </a:extLst>
              </p:cNvPr>
              <p:cNvGrpSpPr/>
              <p:nvPr/>
            </p:nvGrpSpPr>
            <p:grpSpPr>
              <a:xfrm>
                <a:off x="3561920" y="1366043"/>
                <a:ext cx="108000" cy="1134269"/>
                <a:chOff x="3181267" y="2597151"/>
                <a:chExt cx="108000" cy="2157062"/>
              </a:xfrm>
            </p:grpSpPr>
            <p:cxnSp>
              <p:nvCxnSpPr>
                <p:cNvPr id="595" name="直線コネクタ 594">
                  <a:extLst>
                    <a:ext uri="{FF2B5EF4-FFF2-40B4-BE49-F238E27FC236}">
                      <a16:creationId xmlns:a16="http://schemas.microsoft.com/office/drawing/2014/main" id="{114C8AAF-6808-A77B-E233-3EDFD97E25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6" name="直線コネクタ 595">
                  <a:extLst>
                    <a:ext uri="{FF2B5EF4-FFF2-40B4-BE49-F238E27FC236}">
                      <a16:creationId xmlns:a16="http://schemas.microsoft.com/office/drawing/2014/main" id="{E63C8036-BDA0-910F-E264-76C3374D6C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7" name="直線コネクタ 596">
                  <a:extLst>
                    <a:ext uri="{FF2B5EF4-FFF2-40B4-BE49-F238E27FC236}">
                      <a16:creationId xmlns:a16="http://schemas.microsoft.com/office/drawing/2014/main" id="{E029774D-A250-001F-2D26-56D14F9B69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9" name="グループ化 318">
                <a:extLst>
                  <a:ext uri="{FF2B5EF4-FFF2-40B4-BE49-F238E27FC236}">
                    <a16:creationId xmlns:a16="http://schemas.microsoft.com/office/drawing/2014/main" id="{EDA67CF0-0B68-9907-5006-0F4C3290DB67}"/>
                  </a:ext>
                </a:extLst>
              </p:cNvPr>
              <p:cNvGrpSpPr/>
              <p:nvPr/>
            </p:nvGrpSpPr>
            <p:grpSpPr>
              <a:xfrm>
                <a:off x="5160152" y="1782127"/>
                <a:ext cx="108000" cy="1132523"/>
                <a:chOff x="3181267" y="2597151"/>
                <a:chExt cx="108000" cy="2157062"/>
              </a:xfrm>
            </p:grpSpPr>
            <p:cxnSp>
              <p:nvCxnSpPr>
                <p:cNvPr id="592" name="直線コネクタ 591">
                  <a:extLst>
                    <a:ext uri="{FF2B5EF4-FFF2-40B4-BE49-F238E27FC236}">
                      <a16:creationId xmlns:a16="http://schemas.microsoft.com/office/drawing/2014/main" id="{B107A357-7222-4FA5-B7B9-E959CFB762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3" name="直線コネクタ 592">
                  <a:extLst>
                    <a:ext uri="{FF2B5EF4-FFF2-40B4-BE49-F238E27FC236}">
                      <a16:creationId xmlns:a16="http://schemas.microsoft.com/office/drawing/2014/main" id="{629EDC6D-2BE4-E9B1-8FD1-E1E7669E0F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4" name="直線コネクタ 593">
                  <a:extLst>
                    <a:ext uri="{FF2B5EF4-FFF2-40B4-BE49-F238E27FC236}">
                      <a16:creationId xmlns:a16="http://schemas.microsoft.com/office/drawing/2014/main" id="{AC154BA3-BF3F-E1C9-6F8E-E601BF9786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76" name="グループ化 575">
                <a:extLst>
                  <a:ext uri="{FF2B5EF4-FFF2-40B4-BE49-F238E27FC236}">
                    <a16:creationId xmlns:a16="http://schemas.microsoft.com/office/drawing/2014/main" id="{AAAC6A06-3377-425E-5204-8219DE6F3C5F}"/>
                  </a:ext>
                </a:extLst>
              </p:cNvPr>
              <p:cNvGrpSpPr/>
              <p:nvPr/>
            </p:nvGrpSpPr>
            <p:grpSpPr>
              <a:xfrm>
                <a:off x="6756697" y="1574006"/>
                <a:ext cx="108000" cy="1193007"/>
                <a:chOff x="3181267" y="2597151"/>
                <a:chExt cx="108000" cy="2157062"/>
              </a:xfrm>
            </p:grpSpPr>
            <p:cxnSp>
              <p:nvCxnSpPr>
                <p:cNvPr id="589" name="直線コネクタ 588">
                  <a:extLst>
                    <a:ext uri="{FF2B5EF4-FFF2-40B4-BE49-F238E27FC236}">
                      <a16:creationId xmlns:a16="http://schemas.microsoft.com/office/drawing/2014/main" id="{BFD74FC2-4E24-66CB-86A2-A0094F8765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0" name="直線コネクタ 589">
                  <a:extLst>
                    <a:ext uri="{FF2B5EF4-FFF2-40B4-BE49-F238E27FC236}">
                      <a16:creationId xmlns:a16="http://schemas.microsoft.com/office/drawing/2014/main" id="{2009DA66-5A19-373A-3129-240BE83C76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1" name="直線コネクタ 590">
                  <a:extLst>
                    <a:ext uri="{FF2B5EF4-FFF2-40B4-BE49-F238E27FC236}">
                      <a16:creationId xmlns:a16="http://schemas.microsoft.com/office/drawing/2014/main" id="{2E28D4A0-A23B-99D6-A874-D3A47D2154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98" name="グループ化 897">
                <a:extLst>
                  <a:ext uri="{FF2B5EF4-FFF2-40B4-BE49-F238E27FC236}">
                    <a16:creationId xmlns:a16="http://schemas.microsoft.com/office/drawing/2014/main" id="{B146A6BC-C506-9A47-3F80-00325DBF9F6C}"/>
                  </a:ext>
                </a:extLst>
              </p:cNvPr>
              <p:cNvGrpSpPr/>
              <p:nvPr/>
            </p:nvGrpSpPr>
            <p:grpSpPr>
              <a:xfrm>
                <a:off x="8292510" y="1671638"/>
                <a:ext cx="211596" cy="1400469"/>
                <a:chOff x="8292510" y="1671638"/>
                <a:chExt cx="211596" cy="1400469"/>
              </a:xfrm>
            </p:grpSpPr>
            <p:grpSp>
              <p:nvGrpSpPr>
                <p:cNvPr id="584" name="グループ化 583">
                  <a:extLst>
                    <a:ext uri="{FF2B5EF4-FFF2-40B4-BE49-F238E27FC236}">
                      <a16:creationId xmlns:a16="http://schemas.microsoft.com/office/drawing/2014/main" id="{73893A45-D26F-E95B-78F5-1E6D148D8B05}"/>
                    </a:ext>
                  </a:extLst>
                </p:cNvPr>
                <p:cNvGrpSpPr/>
                <p:nvPr/>
              </p:nvGrpSpPr>
              <p:grpSpPr>
                <a:xfrm>
                  <a:off x="8341637" y="1671638"/>
                  <a:ext cx="108000" cy="1180567"/>
                  <a:chOff x="3181267" y="2597151"/>
                  <a:chExt cx="108000" cy="2157062"/>
                </a:xfrm>
              </p:grpSpPr>
              <p:cxnSp>
                <p:nvCxnSpPr>
                  <p:cNvPr id="586" name="直線コネクタ 585">
                    <a:extLst>
                      <a:ext uri="{FF2B5EF4-FFF2-40B4-BE49-F238E27FC236}">
                        <a16:creationId xmlns:a16="http://schemas.microsoft.com/office/drawing/2014/main" id="{39C089A4-B3E9-33BA-7815-FB83432A4A6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7" name="直線コネクタ 586">
                    <a:extLst>
                      <a:ext uri="{FF2B5EF4-FFF2-40B4-BE49-F238E27FC236}">
                        <a16:creationId xmlns:a16="http://schemas.microsoft.com/office/drawing/2014/main" id="{4D227542-5A81-FED2-ED15-4C65383D46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8" name="直線コネクタ 587">
                    <a:extLst>
                      <a:ext uri="{FF2B5EF4-FFF2-40B4-BE49-F238E27FC236}">
                        <a16:creationId xmlns:a16="http://schemas.microsoft.com/office/drawing/2014/main" id="{1CB39A27-83D0-EB9A-7643-3C2D343A35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85" name="テキスト ボックス 584">
                  <a:extLst>
                    <a:ext uri="{FF2B5EF4-FFF2-40B4-BE49-F238E27FC236}">
                      <a16:creationId xmlns:a16="http://schemas.microsoft.com/office/drawing/2014/main" id="{7DF36D90-0BAA-3FFD-3C98-017124B7D4F9}"/>
                    </a:ext>
                  </a:extLst>
                </p:cNvPr>
                <p:cNvSpPr txBox="1"/>
                <p:nvPr/>
              </p:nvSpPr>
              <p:spPr>
                <a:xfrm>
                  <a:off x="8292510" y="2820312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899" name="グループ化 898">
                <a:extLst>
                  <a:ext uri="{FF2B5EF4-FFF2-40B4-BE49-F238E27FC236}">
                    <a16:creationId xmlns:a16="http://schemas.microsoft.com/office/drawing/2014/main" id="{AE9C1ADB-76A6-4795-1F42-02C0BD4606B9}"/>
                  </a:ext>
                </a:extLst>
              </p:cNvPr>
              <p:cNvGrpSpPr/>
              <p:nvPr/>
            </p:nvGrpSpPr>
            <p:grpSpPr>
              <a:xfrm>
                <a:off x="9894643" y="1676400"/>
                <a:ext cx="211596" cy="1398120"/>
                <a:chOff x="9894643" y="1676400"/>
                <a:chExt cx="211596" cy="1398120"/>
              </a:xfrm>
            </p:grpSpPr>
            <p:grpSp>
              <p:nvGrpSpPr>
                <p:cNvPr id="579" name="グループ化 578">
                  <a:extLst>
                    <a:ext uri="{FF2B5EF4-FFF2-40B4-BE49-F238E27FC236}">
                      <a16:creationId xmlns:a16="http://schemas.microsoft.com/office/drawing/2014/main" id="{AA7D2DD5-E010-EB8C-5B6A-DB17E87AA982}"/>
                    </a:ext>
                  </a:extLst>
                </p:cNvPr>
                <p:cNvGrpSpPr/>
                <p:nvPr/>
              </p:nvGrpSpPr>
              <p:grpSpPr>
                <a:xfrm>
                  <a:off x="9945223" y="1676400"/>
                  <a:ext cx="108000" cy="1175175"/>
                  <a:chOff x="3181267" y="2597151"/>
                  <a:chExt cx="108000" cy="2157062"/>
                </a:xfrm>
              </p:grpSpPr>
              <p:cxnSp>
                <p:nvCxnSpPr>
                  <p:cNvPr id="581" name="直線コネクタ 580">
                    <a:extLst>
                      <a:ext uri="{FF2B5EF4-FFF2-40B4-BE49-F238E27FC236}">
                        <a16:creationId xmlns:a16="http://schemas.microsoft.com/office/drawing/2014/main" id="{8C9F7BF6-3A30-8AD4-F60C-5D3E8B71896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2" name="直線コネクタ 581">
                    <a:extLst>
                      <a:ext uri="{FF2B5EF4-FFF2-40B4-BE49-F238E27FC236}">
                        <a16:creationId xmlns:a16="http://schemas.microsoft.com/office/drawing/2014/main" id="{A53B0B8F-7AB9-48A3-FDC0-5BA11F9D319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3" name="直線コネクタ 582">
                    <a:extLst>
                      <a:ext uri="{FF2B5EF4-FFF2-40B4-BE49-F238E27FC236}">
                        <a16:creationId xmlns:a16="http://schemas.microsoft.com/office/drawing/2014/main" id="{51479EC0-6BF8-48B4-03D1-88B858F6E0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80" name="テキスト ボックス 579">
                  <a:extLst>
                    <a:ext uri="{FF2B5EF4-FFF2-40B4-BE49-F238E27FC236}">
                      <a16:creationId xmlns:a16="http://schemas.microsoft.com/office/drawing/2014/main" id="{5AD6DD67-0EE7-6596-A194-0483EAA53A46}"/>
                    </a:ext>
                  </a:extLst>
                </p:cNvPr>
                <p:cNvSpPr txBox="1"/>
                <p:nvPr/>
              </p:nvSpPr>
              <p:spPr>
                <a:xfrm>
                  <a:off x="9894643" y="2822725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311" name="グループ化 310">
              <a:extLst>
                <a:ext uri="{FF2B5EF4-FFF2-40B4-BE49-F238E27FC236}">
                  <a16:creationId xmlns:a16="http://schemas.microsoft.com/office/drawing/2014/main" id="{4DAA189A-D5A1-D37A-E772-4E35CBC272B4}"/>
                </a:ext>
              </a:extLst>
            </p:cNvPr>
            <p:cNvGrpSpPr/>
            <p:nvPr/>
          </p:nvGrpSpPr>
          <p:grpSpPr>
            <a:xfrm>
              <a:off x="3543920" y="1876184"/>
              <a:ext cx="6527303" cy="575068"/>
              <a:chOff x="3543920" y="785571"/>
              <a:chExt cx="6527303" cy="575068"/>
            </a:xfrm>
          </p:grpSpPr>
          <p:sp>
            <p:nvSpPr>
              <p:cNvPr id="313" name="正方形/長方形 467">
                <a:extLst>
                  <a:ext uri="{FF2B5EF4-FFF2-40B4-BE49-F238E27FC236}">
                    <a16:creationId xmlns:a16="http://schemas.microsoft.com/office/drawing/2014/main" id="{D5BD2D99-A44D-0558-0E15-02A16EEDA553}"/>
                  </a:ext>
                </a:extLst>
              </p:cNvPr>
              <p:cNvSpPr/>
              <p:nvPr/>
            </p:nvSpPr>
            <p:spPr>
              <a:xfrm>
                <a:off x="3543920" y="785571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4" name="正方形/長方形 468">
                <a:extLst>
                  <a:ext uri="{FF2B5EF4-FFF2-40B4-BE49-F238E27FC236}">
                    <a16:creationId xmlns:a16="http://schemas.microsoft.com/office/drawing/2014/main" id="{CEB769CF-F351-E679-FA01-B564DD9911B0}"/>
                  </a:ext>
                </a:extLst>
              </p:cNvPr>
              <p:cNvSpPr/>
              <p:nvPr/>
            </p:nvSpPr>
            <p:spPr>
              <a:xfrm>
                <a:off x="5142152" y="1216639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5" name="正方形/長方形 469">
                <a:extLst>
                  <a:ext uri="{FF2B5EF4-FFF2-40B4-BE49-F238E27FC236}">
                    <a16:creationId xmlns:a16="http://schemas.microsoft.com/office/drawing/2014/main" id="{C35D757F-0AE5-25DB-EEAE-774C8443F9F7}"/>
                  </a:ext>
                </a:extLst>
              </p:cNvPr>
              <p:cNvSpPr/>
              <p:nvPr/>
            </p:nvSpPr>
            <p:spPr>
              <a:xfrm>
                <a:off x="6738697" y="1037792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6" name="正方形/長方形 470">
                <a:extLst>
                  <a:ext uri="{FF2B5EF4-FFF2-40B4-BE49-F238E27FC236}">
                    <a16:creationId xmlns:a16="http://schemas.microsoft.com/office/drawing/2014/main" id="{38B17569-46CC-83BD-6CEB-7F507CD3256A}"/>
                  </a:ext>
                </a:extLst>
              </p:cNvPr>
              <p:cNvSpPr/>
              <p:nvPr/>
            </p:nvSpPr>
            <p:spPr>
              <a:xfrm>
                <a:off x="8323636" y="1123654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7" name="正方形/長方形 471">
                <a:extLst>
                  <a:ext uri="{FF2B5EF4-FFF2-40B4-BE49-F238E27FC236}">
                    <a16:creationId xmlns:a16="http://schemas.microsoft.com/office/drawing/2014/main" id="{55614495-7B6E-1547-3533-4606E95B2916}"/>
                  </a:ext>
                </a:extLst>
              </p:cNvPr>
              <p:cNvSpPr/>
              <p:nvPr/>
            </p:nvSpPr>
            <p:spPr>
              <a:xfrm>
                <a:off x="9927223" y="1138668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1" name="フリーフォーム: 図形 900">
              <a:extLst>
                <a:ext uri="{FF2B5EF4-FFF2-40B4-BE49-F238E27FC236}">
                  <a16:creationId xmlns:a16="http://schemas.microsoft.com/office/drawing/2014/main" id="{9CBBC8B1-9C07-1512-77DD-85457D31478C}"/>
                </a:ext>
              </a:extLst>
            </p:cNvPr>
            <p:cNvSpPr/>
            <p:nvPr/>
          </p:nvSpPr>
          <p:spPr>
            <a:xfrm>
              <a:off x="3614738" y="1947862"/>
              <a:ext cx="4781550" cy="435770"/>
            </a:xfrm>
            <a:custGeom>
              <a:avLst/>
              <a:gdLst>
                <a:gd name="connsiteX0" fmla="*/ 0 w 4781550"/>
                <a:gd name="connsiteY0" fmla="*/ 0 h 433388"/>
                <a:gd name="connsiteX1" fmla="*/ 1604962 w 4781550"/>
                <a:gd name="connsiteY1" fmla="*/ 433388 h 433388"/>
                <a:gd name="connsiteX2" fmla="*/ 3195637 w 4781550"/>
                <a:gd name="connsiteY2" fmla="*/ 257175 h 433388"/>
                <a:gd name="connsiteX3" fmla="*/ 4781550 w 4781550"/>
                <a:gd name="connsiteY3" fmla="*/ 338138 h 433388"/>
                <a:gd name="connsiteX0" fmla="*/ 0 w 4781550"/>
                <a:gd name="connsiteY0" fmla="*/ 0 h 440532"/>
                <a:gd name="connsiteX1" fmla="*/ 1604962 w 4781550"/>
                <a:gd name="connsiteY1" fmla="*/ 440532 h 440532"/>
                <a:gd name="connsiteX2" fmla="*/ 3195637 w 4781550"/>
                <a:gd name="connsiteY2" fmla="*/ 257175 h 440532"/>
                <a:gd name="connsiteX3" fmla="*/ 4781550 w 4781550"/>
                <a:gd name="connsiteY3" fmla="*/ 338138 h 440532"/>
                <a:gd name="connsiteX0" fmla="*/ 0 w 4781550"/>
                <a:gd name="connsiteY0" fmla="*/ 0 h 435770"/>
                <a:gd name="connsiteX1" fmla="*/ 1604962 w 4781550"/>
                <a:gd name="connsiteY1" fmla="*/ 435770 h 435770"/>
                <a:gd name="connsiteX2" fmla="*/ 3195637 w 4781550"/>
                <a:gd name="connsiteY2" fmla="*/ 252413 h 435770"/>
                <a:gd name="connsiteX3" fmla="*/ 4781550 w 4781550"/>
                <a:gd name="connsiteY3" fmla="*/ 333376 h 435770"/>
                <a:gd name="connsiteX0" fmla="*/ 0 w 4781550"/>
                <a:gd name="connsiteY0" fmla="*/ 0 h 435770"/>
                <a:gd name="connsiteX1" fmla="*/ 1604962 w 4781550"/>
                <a:gd name="connsiteY1" fmla="*/ 435770 h 435770"/>
                <a:gd name="connsiteX2" fmla="*/ 3195637 w 4781550"/>
                <a:gd name="connsiteY2" fmla="*/ 252413 h 435770"/>
                <a:gd name="connsiteX3" fmla="*/ 4781550 w 4781550"/>
                <a:gd name="connsiteY3" fmla="*/ 339726 h 435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81550" h="435770">
                  <a:moveTo>
                    <a:pt x="0" y="0"/>
                  </a:moveTo>
                  <a:lnTo>
                    <a:pt x="1604962" y="435770"/>
                  </a:lnTo>
                  <a:lnTo>
                    <a:pt x="3195637" y="252413"/>
                  </a:lnTo>
                  <a:lnTo>
                    <a:pt x="4781550" y="339726"/>
                  </a:lnTo>
                </a:path>
              </a:pathLst>
            </a:custGeom>
            <a:noFill/>
            <a:ln w="381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04" name="グループ化 903">
            <a:extLst>
              <a:ext uri="{FF2B5EF4-FFF2-40B4-BE49-F238E27FC236}">
                <a16:creationId xmlns:a16="http://schemas.microsoft.com/office/drawing/2014/main" id="{9F057901-7CA4-0AC3-446B-1F69F31387B5}"/>
              </a:ext>
            </a:extLst>
          </p:cNvPr>
          <p:cNvGrpSpPr/>
          <p:nvPr/>
        </p:nvGrpSpPr>
        <p:grpSpPr>
          <a:xfrm>
            <a:off x="3369375" y="956898"/>
            <a:ext cx="6563581" cy="2096843"/>
            <a:chOff x="3379040" y="1291471"/>
            <a:chExt cx="6563581" cy="2096843"/>
          </a:xfrm>
        </p:grpSpPr>
        <p:grpSp>
          <p:nvGrpSpPr>
            <p:cNvPr id="897" name="グループ化 896">
              <a:extLst>
                <a:ext uri="{FF2B5EF4-FFF2-40B4-BE49-F238E27FC236}">
                  <a16:creationId xmlns:a16="http://schemas.microsoft.com/office/drawing/2014/main" id="{6BA4CDBA-B9DF-2DE8-CBD1-ADDA2B0D125F}"/>
                </a:ext>
              </a:extLst>
            </p:cNvPr>
            <p:cNvGrpSpPr/>
            <p:nvPr/>
          </p:nvGrpSpPr>
          <p:grpSpPr>
            <a:xfrm>
              <a:off x="3397040" y="1291471"/>
              <a:ext cx="6545581" cy="2096843"/>
              <a:chOff x="3397040" y="1291471"/>
              <a:chExt cx="6545581" cy="2096843"/>
            </a:xfrm>
          </p:grpSpPr>
          <p:grpSp>
            <p:nvGrpSpPr>
              <p:cNvPr id="214" name="グループ化 213">
                <a:extLst>
                  <a:ext uri="{FF2B5EF4-FFF2-40B4-BE49-F238E27FC236}">
                    <a16:creationId xmlns:a16="http://schemas.microsoft.com/office/drawing/2014/main" id="{3C43EC2C-39E0-E2C9-DD4E-7534C0BCBA6F}"/>
                  </a:ext>
                </a:extLst>
              </p:cNvPr>
              <p:cNvGrpSpPr/>
              <p:nvPr/>
            </p:nvGrpSpPr>
            <p:grpSpPr>
              <a:xfrm>
                <a:off x="3397040" y="1291471"/>
                <a:ext cx="108000" cy="1480304"/>
                <a:chOff x="3181267" y="2597151"/>
                <a:chExt cx="108000" cy="2157062"/>
              </a:xfrm>
            </p:grpSpPr>
            <p:cxnSp>
              <p:nvCxnSpPr>
                <p:cNvPr id="307" name="直線コネクタ 306">
                  <a:extLst>
                    <a:ext uri="{FF2B5EF4-FFF2-40B4-BE49-F238E27FC236}">
                      <a16:creationId xmlns:a16="http://schemas.microsoft.com/office/drawing/2014/main" id="{100EC74E-E2C9-8A66-99A3-B9990D1420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8" name="直線コネクタ 307">
                  <a:extLst>
                    <a:ext uri="{FF2B5EF4-FFF2-40B4-BE49-F238E27FC236}">
                      <a16:creationId xmlns:a16="http://schemas.microsoft.com/office/drawing/2014/main" id="{788BDE6C-C044-65A8-7291-DE7FCC8ACA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直線コネクタ 308">
                  <a:extLst>
                    <a:ext uri="{FF2B5EF4-FFF2-40B4-BE49-F238E27FC236}">
                      <a16:creationId xmlns:a16="http://schemas.microsoft.com/office/drawing/2014/main" id="{AE1EF0DD-2700-F838-1377-538EBAE0E8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556DCCA7-A7F6-4E33-7B18-6A50163493DA}"/>
                  </a:ext>
                </a:extLst>
              </p:cNvPr>
              <p:cNvGrpSpPr/>
              <p:nvPr/>
            </p:nvGrpSpPr>
            <p:grpSpPr>
              <a:xfrm>
                <a:off x="4995272" y="1939924"/>
                <a:ext cx="108000" cy="1254959"/>
                <a:chOff x="3181267" y="2597151"/>
                <a:chExt cx="108000" cy="2157062"/>
              </a:xfrm>
            </p:grpSpPr>
            <p:cxnSp>
              <p:nvCxnSpPr>
                <p:cNvPr id="304" name="直線コネクタ 303">
                  <a:extLst>
                    <a:ext uri="{FF2B5EF4-FFF2-40B4-BE49-F238E27FC236}">
                      <a16:creationId xmlns:a16="http://schemas.microsoft.com/office/drawing/2014/main" id="{99DAE2A0-30B8-CFB1-BC71-5509048548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5" name="直線コネクタ 304">
                  <a:extLst>
                    <a:ext uri="{FF2B5EF4-FFF2-40B4-BE49-F238E27FC236}">
                      <a16:creationId xmlns:a16="http://schemas.microsoft.com/office/drawing/2014/main" id="{E8A180E6-DBE0-28D9-E512-D29270F271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6" name="直線コネクタ 305">
                  <a:extLst>
                    <a:ext uri="{FF2B5EF4-FFF2-40B4-BE49-F238E27FC236}">
                      <a16:creationId xmlns:a16="http://schemas.microsoft.com/office/drawing/2014/main" id="{267DA638-866E-C1E6-277E-AF82D7BE99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6" name="グループ化 215">
                <a:extLst>
                  <a:ext uri="{FF2B5EF4-FFF2-40B4-BE49-F238E27FC236}">
                    <a16:creationId xmlns:a16="http://schemas.microsoft.com/office/drawing/2014/main" id="{6CBD1382-BAF7-6896-01AC-001610F45100}"/>
                  </a:ext>
                </a:extLst>
              </p:cNvPr>
              <p:cNvGrpSpPr/>
              <p:nvPr/>
            </p:nvGrpSpPr>
            <p:grpSpPr>
              <a:xfrm>
                <a:off x="6591817" y="1997075"/>
                <a:ext cx="108000" cy="1031875"/>
                <a:chOff x="3181267" y="2597151"/>
                <a:chExt cx="108000" cy="2157062"/>
              </a:xfrm>
            </p:grpSpPr>
            <p:cxnSp>
              <p:nvCxnSpPr>
                <p:cNvPr id="301" name="直線コネクタ 300">
                  <a:extLst>
                    <a:ext uri="{FF2B5EF4-FFF2-40B4-BE49-F238E27FC236}">
                      <a16:creationId xmlns:a16="http://schemas.microsoft.com/office/drawing/2014/main" id="{A2AE2206-1B41-F3F1-ED96-EE3481100E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直線コネクタ 301">
                  <a:extLst>
                    <a:ext uri="{FF2B5EF4-FFF2-40B4-BE49-F238E27FC236}">
                      <a16:creationId xmlns:a16="http://schemas.microsoft.com/office/drawing/2014/main" id="{8F606DF5-9CB5-B874-16F3-BAEF32530D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3" name="直線コネクタ 302">
                  <a:extLst>
                    <a:ext uri="{FF2B5EF4-FFF2-40B4-BE49-F238E27FC236}">
                      <a16:creationId xmlns:a16="http://schemas.microsoft.com/office/drawing/2014/main" id="{C79AC037-EF59-6667-3559-6C1784FFCA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94" name="グループ化 893">
                <a:extLst>
                  <a:ext uri="{FF2B5EF4-FFF2-40B4-BE49-F238E27FC236}">
                    <a16:creationId xmlns:a16="http://schemas.microsoft.com/office/drawing/2014/main" id="{B86A4F22-5B27-0463-97AB-335D4B08C2B6}"/>
                  </a:ext>
                </a:extLst>
              </p:cNvPr>
              <p:cNvGrpSpPr/>
              <p:nvPr/>
            </p:nvGrpSpPr>
            <p:grpSpPr>
              <a:xfrm>
                <a:off x="8124239" y="1866900"/>
                <a:ext cx="211596" cy="1504292"/>
                <a:chOff x="8124239" y="1866900"/>
                <a:chExt cx="211596" cy="1504292"/>
              </a:xfrm>
            </p:grpSpPr>
            <p:grpSp>
              <p:nvGrpSpPr>
                <p:cNvPr id="296" name="グループ化 295">
                  <a:extLst>
                    <a:ext uri="{FF2B5EF4-FFF2-40B4-BE49-F238E27FC236}">
                      <a16:creationId xmlns:a16="http://schemas.microsoft.com/office/drawing/2014/main" id="{C910BA42-4ADD-842E-2202-B74F6B86AED2}"/>
                    </a:ext>
                  </a:extLst>
                </p:cNvPr>
                <p:cNvGrpSpPr/>
                <p:nvPr/>
              </p:nvGrpSpPr>
              <p:grpSpPr>
                <a:xfrm>
                  <a:off x="8176757" y="1866900"/>
                  <a:ext cx="108000" cy="1283043"/>
                  <a:chOff x="3181267" y="2597151"/>
                  <a:chExt cx="108000" cy="2157062"/>
                </a:xfrm>
              </p:grpSpPr>
              <p:cxnSp>
                <p:nvCxnSpPr>
                  <p:cNvPr id="298" name="直線コネクタ 297">
                    <a:extLst>
                      <a:ext uri="{FF2B5EF4-FFF2-40B4-BE49-F238E27FC236}">
                        <a16:creationId xmlns:a16="http://schemas.microsoft.com/office/drawing/2014/main" id="{27B0C3A5-7050-F498-7841-6C2141F320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9" name="直線コネクタ 298">
                    <a:extLst>
                      <a:ext uri="{FF2B5EF4-FFF2-40B4-BE49-F238E27FC236}">
                        <a16:creationId xmlns:a16="http://schemas.microsoft.com/office/drawing/2014/main" id="{7B1036BC-D92C-4B89-52BF-B70D8ECF16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0" name="直線コネクタ 299">
                    <a:extLst>
                      <a:ext uri="{FF2B5EF4-FFF2-40B4-BE49-F238E27FC236}">
                        <a16:creationId xmlns:a16="http://schemas.microsoft.com/office/drawing/2014/main" id="{9EBEA479-F801-53D1-7168-D59A3E216C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7" name="テキスト ボックス 296">
                  <a:extLst>
                    <a:ext uri="{FF2B5EF4-FFF2-40B4-BE49-F238E27FC236}">
                      <a16:creationId xmlns:a16="http://schemas.microsoft.com/office/drawing/2014/main" id="{9D53D411-05EA-7670-D58B-AA96A50161CC}"/>
                    </a:ext>
                  </a:extLst>
                </p:cNvPr>
                <p:cNvSpPr txBox="1"/>
                <p:nvPr/>
              </p:nvSpPr>
              <p:spPr>
                <a:xfrm>
                  <a:off x="8124239" y="3119397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895" name="グループ化 894">
                <a:extLst>
                  <a:ext uri="{FF2B5EF4-FFF2-40B4-BE49-F238E27FC236}">
                    <a16:creationId xmlns:a16="http://schemas.microsoft.com/office/drawing/2014/main" id="{C775E574-8AD6-57A8-0175-8CF0E7451B5A}"/>
                  </a:ext>
                </a:extLst>
              </p:cNvPr>
              <p:cNvGrpSpPr/>
              <p:nvPr/>
            </p:nvGrpSpPr>
            <p:grpSpPr>
              <a:xfrm>
                <a:off x="9731025" y="1854200"/>
                <a:ext cx="211596" cy="1534114"/>
                <a:chOff x="9731025" y="1854200"/>
                <a:chExt cx="211596" cy="1534114"/>
              </a:xfrm>
            </p:grpSpPr>
            <p:grpSp>
              <p:nvGrpSpPr>
                <p:cNvPr id="249" name="グループ化 248">
                  <a:extLst>
                    <a:ext uri="{FF2B5EF4-FFF2-40B4-BE49-F238E27FC236}">
                      <a16:creationId xmlns:a16="http://schemas.microsoft.com/office/drawing/2014/main" id="{AA2344AB-BE9D-19E1-1557-73D6E6813DD7}"/>
                    </a:ext>
                  </a:extLst>
                </p:cNvPr>
                <p:cNvGrpSpPr/>
                <p:nvPr/>
              </p:nvGrpSpPr>
              <p:grpSpPr>
                <a:xfrm>
                  <a:off x="9780343" y="1854200"/>
                  <a:ext cx="108000" cy="1315134"/>
                  <a:chOff x="3181267" y="2597151"/>
                  <a:chExt cx="108000" cy="2157062"/>
                </a:xfrm>
              </p:grpSpPr>
              <p:cxnSp>
                <p:nvCxnSpPr>
                  <p:cNvPr id="252" name="直線コネクタ 251">
                    <a:extLst>
                      <a:ext uri="{FF2B5EF4-FFF2-40B4-BE49-F238E27FC236}">
                        <a16:creationId xmlns:a16="http://schemas.microsoft.com/office/drawing/2014/main" id="{5EF55410-C2FD-CBBF-05AB-85FB780F45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4" name="直線コネクタ 283">
                    <a:extLst>
                      <a:ext uri="{FF2B5EF4-FFF2-40B4-BE49-F238E27FC236}">
                        <a16:creationId xmlns:a16="http://schemas.microsoft.com/office/drawing/2014/main" id="{0592461B-7409-6ED2-D013-552FFB0557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5" name="直線コネクタ 294">
                    <a:extLst>
                      <a:ext uri="{FF2B5EF4-FFF2-40B4-BE49-F238E27FC236}">
                        <a16:creationId xmlns:a16="http://schemas.microsoft.com/office/drawing/2014/main" id="{C98B1728-4D0A-89AB-9F80-FCAABE3C5D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0" name="テキスト ボックス 249">
                  <a:extLst>
                    <a:ext uri="{FF2B5EF4-FFF2-40B4-BE49-F238E27FC236}">
                      <a16:creationId xmlns:a16="http://schemas.microsoft.com/office/drawing/2014/main" id="{10074DDC-5256-EB76-5D27-2EAC998FFD16}"/>
                    </a:ext>
                  </a:extLst>
                </p:cNvPr>
                <p:cNvSpPr txBox="1"/>
                <p:nvPr/>
              </p:nvSpPr>
              <p:spPr>
                <a:xfrm>
                  <a:off x="9731025" y="3136519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207" name="グループ化 206">
              <a:extLst>
                <a:ext uri="{FF2B5EF4-FFF2-40B4-BE49-F238E27FC236}">
                  <a16:creationId xmlns:a16="http://schemas.microsoft.com/office/drawing/2014/main" id="{745233FB-9A0B-D12C-32C1-0BC1642F4496}"/>
                </a:ext>
              </a:extLst>
            </p:cNvPr>
            <p:cNvGrpSpPr/>
            <p:nvPr/>
          </p:nvGrpSpPr>
          <p:grpSpPr>
            <a:xfrm>
              <a:off x="3379040" y="1968413"/>
              <a:ext cx="6527303" cy="663937"/>
              <a:chOff x="3370040" y="757637"/>
              <a:chExt cx="6527303" cy="663937"/>
            </a:xfrm>
          </p:grpSpPr>
          <p:sp>
            <p:nvSpPr>
              <p:cNvPr id="209" name="楕円 208">
                <a:extLst>
                  <a:ext uri="{FF2B5EF4-FFF2-40B4-BE49-F238E27FC236}">
                    <a16:creationId xmlns:a16="http://schemas.microsoft.com/office/drawing/2014/main" id="{279836E3-02B9-0EFC-F721-01F74DFB962A}"/>
                  </a:ext>
                </a:extLst>
              </p:cNvPr>
              <p:cNvSpPr/>
              <p:nvPr/>
            </p:nvSpPr>
            <p:spPr>
              <a:xfrm>
                <a:off x="3370040" y="757637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10" name="楕円 209">
                <a:extLst>
                  <a:ext uri="{FF2B5EF4-FFF2-40B4-BE49-F238E27FC236}">
                    <a16:creationId xmlns:a16="http://schemas.microsoft.com/office/drawing/2014/main" id="{3E939D8A-A641-DB04-1916-D1611434F748}"/>
                  </a:ext>
                </a:extLst>
              </p:cNvPr>
              <p:cNvSpPr/>
              <p:nvPr/>
            </p:nvSpPr>
            <p:spPr>
              <a:xfrm>
                <a:off x="4968272" y="1277574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11" name="楕円 210">
                <a:extLst>
                  <a:ext uri="{FF2B5EF4-FFF2-40B4-BE49-F238E27FC236}">
                    <a16:creationId xmlns:a16="http://schemas.microsoft.com/office/drawing/2014/main" id="{39F0374D-0CA8-A3FF-C7AC-52BDA976398B}"/>
                  </a:ext>
                </a:extLst>
              </p:cNvPr>
              <p:cNvSpPr/>
              <p:nvPr/>
            </p:nvSpPr>
            <p:spPr>
              <a:xfrm>
                <a:off x="6564817" y="1234515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12" name="楕円 211">
                <a:extLst>
                  <a:ext uri="{FF2B5EF4-FFF2-40B4-BE49-F238E27FC236}">
                    <a16:creationId xmlns:a16="http://schemas.microsoft.com/office/drawing/2014/main" id="{B3F5EA3B-917F-82E7-8381-421FBF6111FD}"/>
                  </a:ext>
                </a:extLst>
              </p:cNvPr>
              <p:cNvSpPr/>
              <p:nvPr/>
            </p:nvSpPr>
            <p:spPr>
              <a:xfrm>
                <a:off x="8149756" y="1219059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13" name="楕円 212">
                <a:extLst>
                  <a:ext uri="{FF2B5EF4-FFF2-40B4-BE49-F238E27FC236}">
                    <a16:creationId xmlns:a16="http://schemas.microsoft.com/office/drawing/2014/main" id="{36AA3E2F-D218-FFBE-E80B-63096E8A2BCB}"/>
                  </a:ext>
                </a:extLst>
              </p:cNvPr>
              <p:cNvSpPr/>
              <p:nvPr/>
            </p:nvSpPr>
            <p:spPr>
              <a:xfrm>
                <a:off x="9753343" y="1218211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3" name="フリーフォーム: 図形 902">
              <a:extLst>
                <a:ext uri="{FF2B5EF4-FFF2-40B4-BE49-F238E27FC236}">
                  <a16:creationId xmlns:a16="http://schemas.microsoft.com/office/drawing/2014/main" id="{F0111D56-445F-B8DB-055D-5A4AA11C3B43}"/>
                </a:ext>
              </a:extLst>
            </p:cNvPr>
            <p:cNvSpPr/>
            <p:nvPr/>
          </p:nvSpPr>
          <p:spPr>
            <a:xfrm>
              <a:off x="3448050" y="2038350"/>
              <a:ext cx="4781550" cy="528638"/>
            </a:xfrm>
            <a:custGeom>
              <a:avLst/>
              <a:gdLst>
                <a:gd name="connsiteX0" fmla="*/ 0 w 4781550"/>
                <a:gd name="connsiteY0" fmla="*/ 0 h 528638"/>
                <a:gd name="connsiteX1" fmla="*/ 1600200 w 4781550"/>
                <a:gd name="connsiteY1" fmla="*/ 528638 h 528638"/>
                <a:gd name="connsiteX2" fmla="*/ 3195638 w 4781550"/>
                <a:gd name="connsiteY2" fmla="*/ 485775 h 528638"/>
                <a:gd name="connsiteX3" fmla="*/ 4781550 w 4781550"/>
                <a:gd name="connsiteY3" fmla="*/ 461963 h 528638"/>
                <a:gd name="connsiteX0" fmla="*/ 0 w 4781550"/>
                <a:gd name="connsiteY0" fmla="*/ 0 h 528638"/>
                <a:gd name="connsiteX1" fmla="*/ 1600200 w 4781550"/>
                <a:gd name="connsiteY1" fmla="*/ 528638 h 528638"/>
                <a:gd name="connsiteX2" fmla="*/ 3198813 w 4781550"/>
                <a:gd name="connsiteY2" fmla="*/ 485775 h 528638"/>
                <a:gd name="connsiteX3" fmla="*/ 4781550 w 4781550"/>
                <a:gd name="connsiteY3" fmla="*/ 461963 h 5286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81550" h="528638">
                  <a:moveTo>
                    <a:pt x="0" y="0"/>
                  </a:moveTo>
                  <a:lnTo>
                    <a:pt x="1600200" y="528638"/>
                  </a:lnTo>
                  <a:lnTo>
                    <a:pt x="3198813" y="485775"/>
                  </a:lnTo>
                  <a:lnTo>
                    <a:pt x="4781550" y="461963"/>
                  </a:lnTo>
                </a:path>
              </a:pathLst>
            </a:cu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893" name="グループ化 892">
            <a:extLst>
              <a:ext uri="{FF2B5EF4-FFF2-40B4-BE49-F238E27FC236}">
                <a16:creationId xmlns:a16="http://schemas.microsoft.com/office/drawing/2014/main" id="{86BBC732-E33E-558D-DF51-70D55F769CA4}"/>
              </a:ext>
            </a:extLst>
          </p:cNvPr>
          <p:cNvGrpSpPr/>
          <p:nvPr/>
        </p:nvGrpSpPr>
        <p:grpSpPr>
          <a:xfrm>
            <a:off x="3212287" y="987022"/>
            <a:ext cx="6562974" cy="1915711"/>
            <a:chOff x="3221952" y="1321595"/>
            <a:chExt cx="6562974" cy="1915711"/>
          </a:xfrm>
        </p:grpSpPr>
        <p:grpSp>
          <p:nvGrpSpPr>
            <p:cNvPr id="891" name="グループ化 890">
              <a:extLst>
                <a:ext uri="{FF2B5EF4-FFF2-40B4-BE49-F238E27FC236}">
                  <a16:creationId xmlns:a16="http://schemas.microsoft.com/office/drawing/2014/main" id="{C7B39B07-6122-D6DC-FA54-4A610DC341D1}"/>
                </a:ext>
              </a:extLst>
            </p:cNvPr>
            <p:cNvGrpSpPr/>
            <p:nvPr/>
          </p:nvGrpSpPr>
          <p:grpSpPr>
            <a:xfrm>
              <a:off x="3239952" y="1321595"/>
              <a:ext cx="6544974" cy="1915711"/>
              <a:chOff x="3239952" y="1321595"/>
              <a:chExt cx="6544974" cy="1915711"/>
            </a:xfrm>
          </p:grpSpPr>
          <p:grpSp>
            <p:nvGrpSpPr>
              <p:cNvPr id="606" name="グループ化 605">
                <a:extLst>
                  <a:ext uri="{FF2B5EF4-FFF2-40B4-BE49-F238E27FC236}">
                    <a16:creationId xmlns:a16="http://schemas.microsoft.com/office/drawing/2014/main" id="{4E37C00A-3D84-32F5-A82A-A804031C8D91}"/>
                  </a:ext>
                </a:extLst>
              </p:cNvPr>
              <p:cNvGrpSpPr/>
              <p:nvPr/>
            </p:nvGrpSpPr>
            <p:grpSpPr>
              <a:xfrm>
                <a:off x="3239952" y="1321595"/>
                <a:ext cx="108000" cy="1319212"/>
                <a:chOff x="3181267" y="2597151"/>
                <a:chExt cx="108000" cy="2157062"/>
              </a:xfrm>
            </p:grpSpPr>
            <p:cxnSp>
              <p:nvCxnSpPr>
                <p:cNvPr id="627" name="直線コネクタ 626">
                  <a:extLst>
                    <a:ext uri="{FF2B5EF4-FFF2-40B4-BE49-F238E27FC236}">
                      <a16:creationId xmlns:a16="http://schemas.microsoft.com/office/drawing/2014/main" id="{41B5E45B-A427-CE9D-F5E4-39E3698448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8" name="直線コネクタ 627">
                  <a:extLst>
                    <a:ext uri="{FF2B5EF4-FFF2-40B4-BE49-F238E27FC236}">
                      <a16:creationId xmlns:a16="http://schemas.microsoft.com/office/drawing/2014/main" id="{E37E0B4A-F8DA-93A4-1304-5478FD0A4D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9" name="直線コネクタ 628">
                  <a:extLst>
                    <a:ext uri="{FF2B5EF4-FFF2-40B4-BE49-F238E27FC236}">
                      <a16:creationId xmlns:a16="http://schemas.microsoft.com/office/drawing/2014/main" id="{6F386567-B32D-9304-6D71-E2CBFDE175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7" name="グループ化 606">
                <a:extLst>
                  <a:ext uri="{FF2B5EF4-FFF2-40B4-BE49-F238E27FC236}">
                    <a16:creationId xmlns:a16="http://schemas.microsoft.com/office/drawing/2014/main" id="{8E8C2466-82BE-D3C6-90CC-4FEEA7EC90FB}"/>
                  </a:ext>
                </a:extLst>
              </p:cNvPr>
              <p:cNvGrpSpPr/>
              <p:nvPr/>
            </p:nvGrpSpPr>
            <p:grpSpPr>
              <a:xfrm>
                <a:off x="4838184" y="1847850"/>
                <a:ext cx="108000" cy="1200945"/>
                <a:chOff x="3181267" y="2597151"/>
                <a:chExt cx="108000" cy="2157062"/>
              </a:xfrm>
            </p:grpSpPr>
            <p:cxnSp>
              <p:nvCxnSpPr>
                <p:cNvPr id="624" name="直線コネクタ 623">
                  <a:extLst>
                    <a:ext uri="{FF2B5EF4-FFF2-40B4-BE49-F238E27FC236}">
                      <a16:creationId xmlns:a16="http://schemas.microsoft.com/office/drawing/2014/main" id="{59760E55-08D1-AC22-4A61-6B7912AFD7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5" name="直線コネクタ 624">
                  <a:extLst>
                    <a:ext uri="{FF2B5EF4-FFF2-40B4-BE49-F238E27FC236}">
                      <a16:creationId xmlns:a16="http://schemas.microsoft.com/office/drawing/2014/main" id="{9D0E3DC4-C2B1-9EB7-1214-C83D990576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6" name="直線コネクタ 625">
                  <a:extLst>
                    <a:ext uri="{FF2B5EF4-FFF2-40B4-BE49-F238E27FC236}">
                      <a16:creationId xmlns:a16="http://schemas.microsoft.com/office/drawing/2014/main" id="{0ADA844A-1FBB-0FC6-72B5-3A749BBD8C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8" name="グループ化 607">
                <a:extLst>
                  <a:ext uri="{FF2B5EF4-FFF2-40B4-BE49-F238E27FC236}">
                    <a16:creationId xmlns:a16="http://schemas.microsoft.com/office/drawing/2014/main" id="{D0BC52D1-8DA5-05A1-B10E-C38C6E19FC39}"/>
                  </a:ext>
                </a:extLst>
              </p:cNvPr>
              <p:cNvGrpSpPr/>
              <p:nvPr/>
            </p:nvGrpSpPr>
            <p:grpSpPr>
              <a:xfrm>
                <a:off x="6434729" y="1762125"/>
                <a:ext cx="108000" cy="1152263"/>
                <a:chOff x="3181267" y="2597151"/>
                <a:chExt cx="108000" cy="2157062"/>
              </a:xfrm>
            </p:grpSpPr>
            <p:cxnSp>
              <p:nvCxnSpPr>
                <p:cNvPr id="621" name="直線コネクタ 620">
                  <a:extLst>
                    <a:ext uri="{FF2B5EF4-FFF2-40B4-BE49-F238E27FC236}">
                      <a16:creationId xmlns:a16="http://schemas.microsoft.com/office/drawing/2014/main" id="{F860EC5B-C612-98F5-7E41-5FFC9598EA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2" name="直線コネクタ 621">
                  <a:extLst>
                    <a:ext uri="{FF2B5EF4-FFF2-40B4-BE49-F238E27FC236}">
                      <a16:creationId xmlns:a16="http://schemas.microsoft.com/office/drawing/2014/main" id="{6B9C7BE5-2331-1F78-5BC8-AF3DFF8257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3" name="直線コネクタ 622">
                  <a:extLst>
                    <a:ext uri="{FF2B5EF4-FFF2-40B4-BE49-F238E27FC236}">
                      <a16:creationId xmlns:a16="http://schemas.microsoft.com/office/drawing/2014/main" id="{392DF816-F16F-9AA9-F698-C1E06E7B63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89" name="グループ化 888">
                <a:extLst>
                  <a:ext uri="{FF2B5EF4-FFF2-40B4-BE49-F238E27FC236}">
                    <a16:creationId xmlns:a16="http://schemas.microsoft.com/office/drawing/2014/main" id="{5D6C9D32-0EDC-89EB-AD3D-05D357F0E591}"/>
                  </a:ext>
                </a:extLst>
              </p:cNvPr>
              <p:cNvGrpSpPr/>
              <p:nvPr/>
            </p:nvGrpSpPr>
            <p:grpSpPr>
              <a:xfrm>
                <a:off x="7970801" y="1745456"/>
                <a:ext cx="211596" cy="1479768"/>
                <a:chOff x="7970801" y="1745456"/>
                <a:chExt cx="211596" cy="1479768"/>
              </a:xfrm>
            </p:grpSpPr>
            <p:grpSp>
              <p:nvGrpSpPr>
                <p:cNvPr id="616" name="グループ化 615">
                  <a:extLst>
                    <a:ext uri="{FF2B5EF4-FFF2-40B4-BE49-F238E27FC236}">
                      <a16:creationId xmlns:a16="http://schemas.microsoft.com/office/drawing/2014/main" id="{D7EFBDB4-0B11-865D-C405-203C2C44CAAB}"/>
                    </a:ext>
                  </a:extLst>
                </p:cNvPr>
                <p:cNvGrpSpPr/>
                <p:nvPr/>
              </p:nvGrpSpPr>
              <p:grpSpPr>
                <a:xfrm>
                  <a:off x="8019669" y="1745456"/>
                  <a:ext cx="108000" cy="1255873"/>
                  <a:chOff x="3181267" y="2597151"/>
                  <a:chExt cx="108000" cy="2157062"/>
                </a:xfrm>
              </p:grpSpPr>
              <p:cxnSp>
                <p:nvCxnSpPr>
                  <p:cNvPr id="618" name="直線コネクタ 617">
                    <a:extLst>
                      <a:ext uri="{FF2B5EF4-FFF2-40B4-BE49-F238E27FC236}">
                        <a16:creationId xmlns:a16="http://schemas.microsoft.com/office/drawing/2014/main" id="{7279019A-E1FE-7A60-D899-5A094B1B1E7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9" name="直線コネクタ 618">
                    <a:extLst>
                      <a:ext uri="{FF2B5EF4-FFF2-40B4-BE49-F238E27FC236}">
                        <a16:creationId xmlns:a16="http://schemas.microsoft.com/office/drawing/2014/main" id="{D4871940-C852-E53D-2C50-3297A08178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0" name="直線コネクタ 619">
                    <a:extLst>
                      <a:ext uri="{FF2B5EF4-FFF2-40B4-BE49-F238E27FC236}">
                        <a16:creationId xmlns:a16="http://schemas.microsoft.com/office/drawing/2014/main" id="{61CD88F6-CBA3-6FBB-346E-8955007FB7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17" name="テキスト ボックス 616">
                  <a:extLst>
                    <a:ext uri="{FF2B5EF4-FFF2-40B4-BE49-F238E27FC236}">
                      <a16:creationId xmlns:a16="http://schemas.microsoft.com/office/drawing/2014/main" id="{C1BFE32C-4B54-6440-D3BB-27B169DC8030}"/>
                    </a:ext>
                  </a:extLst>
                </p:cNvPr>
                <p:cNvSpPr txBox="1"/>
                <p:nvPr/>
              </p:nvSpPr>
              <p:spPr>
                <a:xfrm>
                  <a:off x="7970801" y="2973429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890" name="グループ化 889">
                <a:extLst>
                  <a:ext uri="{FF2B5EF4-FFF2-40B4-BE49-F238E27FC236}">
                    <a16:creationId xmlns:a16="http://schemas.microsoft.com/office/drawing/2014/main" id="{6EF4F578-3955-19C0-2506-DFCD8B74E085}"/>
                  </a:ext>
                </a:extLst>
              </p:cNvPr>
              <p:cNvGrpSpPr/>
              <p:nvPr/>
            </p:nvGrpSpPr>
            <p:grpSpPr>
              <a:xfrm>
                <a:off x="9573330" y="1745456"/>
                <a:ext cx="211596" cy="1491850"/>
                <a:chOff x="9573330" y="1745456"/>
                <a:chExt cx="211596" cy="1491850"/>
              </a:xfrm>
            </p:grpSpPr>
            <p:grpSp>
              <p:nvGrpSpPr>
                <p:cNvPr id="611" name="グループ化 610">
                  <a:extLst>
                    <a:ext uri="{FF2B5EF4-FFF2-40B4-BE49-F238E27FC236}">
                      <a16:creationId xmlns:a16="http://schemas.microsoft.com/office/drawing/2014/main" id="{A58874DF-0E0E-7CC8-AFFA-28EB8636F2C9}"/>
                    </a:ext>
                  </a:extLst>
                </p:cNvPr>
                <p:cNvGrpSpPr/>
                <p:nvPr/>
              </p:nvGrpSpPr>
              <p:grpSpPr>
                <a:xfrm>
                  <a:off x="9623255" y="1745456"/>
                  <a:ext cx="108000" cy="1271805"/>
                  <a:chOff x="3181267" y="2597151"/>
                  <a:chExt cx="108000" cy="2157062"/>
                </a:xfrm>
              </p:grpSpPr>
              <p:cxnSp>
                <p:nvCxnSpPr>
                  <p:cNvPr id="613" name="直線コネクタ 612">
                    <a:extLst>
                      <a:ext uri="{FF2B5EF4-FFF2-40B4-BE49-F238E27FC236}">
                        <a16:creationId xmlns:a16="http://schemas.microsoft.com/office/drawing/2014/main" id="{F763ED98-46B6-37C0-4D77-ABC211D242D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4" name="直線コネクタ 613">
                    <a:extLst>
                      <a:ext uri="{FF2B5EF4-FFF2-40B4-BE49-F238E27FC236}">
                        <a16:creationId xmlns:a16="http://schemas.microsoft.com/office/drawing/2014/main" id="{C6A9D530-A384-5FC0-61B3-6EE451EA20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5" name="直線コネクタ 614">
                    <a:extLst>
                      <a:ext uri="{FF2B5EF4-FFF2-40B4-BE49-F238E27FC236}">
                        <a16:creationId xmlns:a16="http://schemas.microsoft.com/office/drawing/2014/main" id="{C3635327-9560-BC8E-144F-A420F94115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12" name="テキスト ボックス 611">
                  <a:extLst>
                    <a:ext uri="{FF2B5EF4-FFF2-40B4-BE49-F238E27FC236}">
                      <a16:creationId xmlns:a16="http://schemas.microsoft.com/office/drawing/2014/main" id="{D8E2E210-D4CB-EF98-057C-A2423C302377}"/>
                    </a:ext>
                  </a:extLst>
                </p:cNvPr>
                <p:cNvSpPr txBox="1"/>
                <p:nvPr/>
              </p:nvSpPr>
              <p:spPr>
                <a:xfrm>
                  <a:off x="9573330" y="2985511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599" name="グループ化 598">
              <a:extLst>
                <a:ext uri="{FF2B5EF4-FFF2-40B4-BE49-F238E27FC236}">
                  <a16:creationId xmlns:a16="http://schemas.microsoft.com/office/drawing/2014/main" id="{C6AC5D5A-A404-AF8A-9748-D50F3BBFDD29}"/>
                </a:ext>
              </a:extLst>
            </p:cNvPr>
            <p:cNvGrpSpPr/>
            <p:nvPr/>
          </p:nvGrpSpPr>
          <p:grpSpPr>
            <a:xfrm>
              <a:off x="3221952" y="1915057"/>
              <a:ext cx="6527303" cy="608168"/>
              <a:chOff x="3212952" y="2106083"/>
              <a:chExt cx="6527303" cy="608168"/>
            </a:xfrm>
            <a:solidFill>
              <a:schemeClr val="tx1"/>
            </a:solidFill>
          </p:grpSpPr>
          <p:sp>
            <p:nvSpPr>
              <p:cNvPr id="601" name="楕円 600">
                <a:extLst>
                  <a:ext uri="{FF2B5EF4-FFF2-40B4-BE49-F238E27FC236}">
                    <a16:creationId xmlns:a16="http://schemas.microsoft.com/office/drawing/2014/main" id="{C62107DB-2DA2-6870-1D02-86608F6FD0D4}"/>
                  </a:ext>
                </a:extLst>
              </p:cNvPr>
              <p:cNvSpPr/>
              <p:nvPr/>
            </p:nvSpPr>
            <p:spPr>
              <a:xfrm>
                <a:off x="3212952" y="2106083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02" name="楕円 601">
                <a:extLst>
                  <a:ext uri="{FF2B5EF4-FFF2-40B4-BE49-F238E27FC236}">
                    <a16:creationId xmlns:a16="http://schemas.microsoft.com/office/drawing/2014/main" id="{31B66F51-2575-C9C8-ED86-7EFAB3715D96}"/>
                  </a:ext>
                </a:extLst>
              </p:cNvPr>
              <p:cNvSpPr/>
              <p:nvPr/>
            </p:nvSpPr>
            <p:spPr>
              <a:xfrm>
                <a:off x="4811184" y="2570251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03" name="楕円 602">
                <a:extLst>
                  <a:ext uri="{FF2B5EF4-FFF2-40B4-BE49-F238E27FC236}">
                    <a16:creationId xmlns:a16="http://schemas.microsoft.com/office/drawing/2014/main" id="{A1D945C5-D911-48AA-02D8-DB1AAE8505E3}"/>
                  </a:ext>
                </a:extLst>
              </p:cNvPr>
              <p:cNvSpPr/>
              <p:nvPr/>
            </p:nvSpPr>
            <p:spPr>
              <a:xfrm>
                <a:off x="6407729" y="2471867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04" name="楕円 603">
                <a:extLst>
                  <a:ext uri="{FF2B5EF4-FFF2-40B4-BE49-F238E27FC236}">
                    <a16:creationId xmlns:a16="http://schemas.microsoft.com/office/drawing/2014/main" id="{C695D10A-C17C-7842-BAF3-B481735B103F}"/>
                  </a:ext>
                </a:extLst>
              </p:cNvPr>
              <p:cNvSpPr/>
              <p:nvPr/>
            </p:nvSpPr>
            <p:spPr>
              <a:xfrm>
                <a:off x="7992668" y="2507470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05" name="楕円 604">
                <a:extLst>
                  <a:ext uri="{FF2B5EF4-FFF2-40B4-BE49-F238E27FC236}">
                    <a16:creationId xmlns:a16="http://schemas.microsoft.com/office/drawing/2014/main" id="{EA5021DB-FEB3-E2F3-4D19-D09D961CA694}"/>
                  </a:ext>
                </a:extLst>
              </p:cNvPr>
              <p:cNvSpPr/>
              <p:nvPr/>
            </p:nvSpPr>
            <p:spPr>
              <a:xfrm>
                <a:off x="9596255" y="2506183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92" name="フリーフォーム: 図形 891">
              <a:extLst>
                <a:ext uri="{FF2B5EF4-FFF2-40B4-BE49-F238E27FC236}">
                  <a16:creationId xmlns:a16="http://schemas.microsoft.com/office/drawing/2014/main" id="{69E20772-D752-0ABF-D489-E0C9C7F279EE}"/>
                </a:ext>
              </a:extLst>
            </p:cNvPr>
            <p:cNvSpPr/>
            <p:nvPr/>
          </p:nvSpPr>
          <p:spPr>
            <a:xfrm>
              <a:off x="3288507" y="1985964"/>
              <a:ext cx="4783931" cy="461962"/>
            </a:xfrm>
            <a:custGeom>
              <a:avLst/>
              <a:gdLst>
                <a:gd name="connsiteX0" fmla="*/ 0 w 4786313"/>
                <a:gd name="connsiteY0" fmla="*/ 0 h 466725"/>
                <a:gd name="connsiteX1" fmla="*/ 1604963 w 4786313"/>
                <a:gd name="connsiteY1" fmla="*/ 466725 h 466725"/>
                <a:gd name="connsiteX2" fmla="*/ 3200400 w 4786313"/>
                <a:gd name="connsiteY2" fmla="*/ 371475 h 466725"/>
                <a:gd name="connsiteX3" fmla="*/ 4786313 w 4786313"/>
                <a:gd name="connsiteY3" fmla="*/ 409575 h 466725"/>
                <a:gd name="connsiteX0" fmla="*/ 0 w 4783931"/>
                <a:gd name="connsiteY0" fmla="*/ 0 h 461962"/>
                <a:gd name="connsiteX1" fmla="*/ 1602581 w 4783931"/>
                <a:gd name="connsiteY1" fmla="*/ 461962 h 461962"/>
                <a:gd name="connsiteX2" fmla="*/ 3198018 w 4783931"/>
                <a:gd name="connsiteY2" fmla="*/ 366712 h 461962"/>
                <a:gd name="connsiteX3" fmla="*/ 4783931 w 4783931"/>
                <a:gd name="connsiteY3" fmla="*/ 404812 h 4619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83931" h="461962">
                  <a:moveTo>
                    <a:pt x="0" y="0"/>
                  </a:moveTo>
                  <a:lnTo>
                    <a:pt x="1602581" y="461962"/>
                  </a:lnTo>
                  <a:lnTo>
                    <a:pt x="3198018" y="366712"/>
                  </a:lnTo>
                  <a:lnTo>
                    <a:pt x="4783931" y="404812"/>
                  </a:ln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19" name="グループ化 918">
            <a:extLst>
              <a:ext uri="{FF2B5EF4-FFF2-40B4-BE49-F238E27FC236}">
                <a16:creationId xmlns:a16="http://schemas.microsoft.com/office/drawing/2014/main" id="{93976824-88C4-0947-D6EF-C7DF4D847BB7}"/>
              </a:ext>
            </a:extLst>
          </p:cNvPr>
          <p:cNvGrpSpPr/>
          <p:nvPr/>
        </p:nvGrpSpPr>
        <p:grpSpPr>
          <a:xfrm>
            <a:off x="3534255" y="3540905"/>
            <a:ext cx="6559938" cy="1248664"/>
            <a:chOff x="3543920" y="3875478"/>
            <a:chExt cx="6559938" cy="1248664"/>
          </a:xfrm>
        </p:grpSpPr>
        <p:grpSp>
          <p:nvGrpSpPr>
            <p:cNvPr id="917" name="グループ化 916">
              <a:extLst>
                <a:ext uri="{FF2B5EF4-FFF2-40B4-BE49-F238E27FC236}">
                  <a16:creationId xmlns:a16="http://schemas.microsoft.com/office/drawing/2014/main" id="{4AE63C87-963E-7B7C-9DDF-1ADA77598F41}"/>
                </a:ext>
              </a:extLst>
            </p:cNvPr>
            <p:cNvGrpSpPr/>
            <p:nvPr/>
          </p:nvGrpSpPr>
          <p:grpSpPr>
            <a:xfrm>
              <a:off x="3561920" y="3875478"/>
              <a:ext cx="6541938" cy="1248664"/>
              <a:chOff x="3561920" y="3875478"/>
              <a:chExt cx="6541938" cy="1248664"/>
            </a:xfrm>
          </p:grpSpPr>
          <p:grpSp>
            <p:nvGrpSpPr>
              <p:cNvPr id="531" name="グループ化 530">
                <a:extLst>
                  <a:ext uri="{FF2B5EF4-FFF2-40B4-BE49-F238E27FC236}">
                    <a16:creationId xmlns:a16="http://schemas.microsoft.com/office/drawing/2014/main" id="{F00EECFF-2EDE-9FC6-FDD6-964B09717FB9}"/>
                  </a:ext>
                </a:extLst>
              </p:cNvPr>
              <p:cNvGrpSpPr/>
              <p:nvPr/>
            </p:nvGrpSpPr>
            <p:grpSpPr>
              <a:xfrm>
                <a:off x="3561920" y="3875478"/>
                <a:ext cx="108000" cy="865591"/>
                <a:chOff x="3181267" y="2597151"/>
                <a:chExt cx="108000" cy="2157062"/>
              </a:xfrm>
            </p:grpSpPr>
            <p:cxnSp>
              <p:nvCxnSpPr>
                <p:cNvPr id="552" name="直線コネクタ 551">
                  <a:extLst>
                    <a:ext uri="{FF2B5EF4-FFF2-40B4-BE49-F238E27FC236}">
                      <a16:creationId xmlns:a16="http://schemas.microsoft.com/office/drawing/2014/main" id="{8D25BB3F-13D6-E38D-B31C-1A2A368697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3" name="直線コネクタ 552">
                  <a:extLst>
                    <a:ext uri="{FF2B5EF4-FFF2-40B4-BE49-F238E27FC236}">
                      <a16:creationId xmlns:a16="http://schemas.microsoft.com/office/drawing/2014/main" id="{F6F05360-382B-58E8-5E6E-661C808E10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4" name="直線コネクタ 553">
                  <a:extLst>
                    <a:ext uri="{FF2B5EF4-FFF2-40B4-BE49-F238E27FC236}">
                      <a16:creationId xmlns:a16="http://schemas.microsoft.com/office/drawing/2014/main" id="{52A0B27F-6E5E-3571-326A-BE50BFE490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2" name="グループ化 531">
                <a:extLst>
                  <a:ext uri="{FF2B5EF4-FFF2-40B4-BE49-F238E27FC236}">
                    <a16:creationId xmlns:a16="http://schemas.microsoft.com/office/drawing/2014/main" id="{15BF3DCD-E700-6F0B-DC74-51DD392120B6}"/>
                  </a:ext>
                </a:extLst>
              </p:cNvPr>
              <p:cNvGrpSpPr/>
              <p:nvPr/>
            </p:nvGrpSpPr>
            <p:grpSpPr>
              <a:xfrm>
                <a:off x="5157771" y="4044792"/>
                <a:ext cx="108000" cy="901064"/>
                <a:chOff x="3181267" y="2597151"/>
                <a:chExt cx="108000" cy="2157062"/>
              </a:xfrm>
            </p:grpSpPr>
            <p:cxnSp>
              <p:nvCxnSpPr>
                <p:cNvPr id="549" name="直線コネクタ 548">
                  <a:extLst>
                    <a:ext uri="{FF2B5EF4-FFF2-40B4-BE49-F238E27FC236}">
                      <a16:creationId xmlns:a16="http://schemas.microsoft.com/office/drawing/2014/main" id="{8EA2C392-F281-8726-A718-F3BBE2D473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0" name="直線コネクタ 549">
                  <a:extLst>
                    <a:ext uri="{FF2B5EF4-FFF2-40B4-BE49-F238E27FC236}">
                      <a16:creationId xmlns:a16="http://schemas.microsoft.com/office/drawing/2014/main" id="{F113ED58-9566-0E16-99D1-0879FB8F26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1" name="直線コネクタ 550">
                  <a:extLst>
                    <a:ext uri="{FF2B5EF4-FFF2-40B4-BE49-F238E27FC236}">
                      <a16:creationId xmlns:a16="http://schemas.microsoft.com/office/drawing/2014/main" id="{69769B90-411C-60FA-1398-DE2DB1D013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3" name="グループ化 532">
                <a:extLst>
                  <a:ext uri="{FF2B5EF4-FFF2-40B4-BE49-F238E27FC236}">
                    <a16:creationId xmlns:a16="http://schemas.microsoft.com/office/drawing/2014/main" id="{277F4EB9-1CA0-E975-2BDD-EF99436F129D}"/>
                  </a:ext>
                </a:extLst>
              </p:cNvPr>
              <p:cNvGrpSpPr/>
              <p:nvPr/>
            </p:nvGrpSpPr>
            <p:grpSpPr>
              <a:xfrm>
                <a:off x="6754316" y="3902869"/>
                <a:ext cx="108000" cy="1078742"/>
                <a:chOff x="3181267" y="2597151"/>
                <a:chExt cx="108000" cy="2157062"/>
              </a:xfrm>
            </p:grpSpPr>
            <p:cxnSp>
              <p:nvCxnSpPr>
                <p:cNvPr id="546" name="直線コネクタ 545">
                  <a:extLst>
                    <a:ext uri="{FF2B5EF4-FFF2-40B4-BE49-F238E27FC236}">
                      <a16:creationId xmlns:a16="http://schemas.microsoft.com/office/drawing/2014/main" id="{D8A25771-9523-2145-BB2D-CFA63DB971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7" name="直線コネクタ 546">
                  <a:extLst>
                    <a:ext uri="{FF2B5EF4-FFF2-40B4-BE49-F238E27FC236}">
                      <a16:creationId xmlns:a16="http://schemas.microsoft.com/office/drawing/2014/main" id="{E1B5AA4D-5BF7-A32E-0A75-8410D54892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8" name="直線コネクタ 547">
                  <a:extLst>
                    <a:ext uri="{FF2B5EF4-FFF2-40B4-BE49-F238E27FC236}">
                      <a16:creationId xmlns:a16="http://schemas.microsoft.com/office/drawing/2014/main" id="{4275A6FE-17E7-5AF7-C829-8A0758CB78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15" name="グループ化 914">
                <a:extLst>
                  <a:ext uri="{FF2B5EF4-FFF2-40B4-BE49-F238E27FC236}">
                    <a16:creationId xmlns:a16="http://schemas.microsoft.com/office/drawing/2014/main" id="{897A7B91-B705-919A-E5D4-59ABD45E2EED}"/>
                  </a:ext>
                </a:extLst>
              </p:cNvPr>
              <p:cNvGrpSpPr/>
              <p:nvPr/>
            </p:nvGrpSpPr>
            <p:grpSpPr>
              <a:xfrm>
                <a:off x="8290130" y="4076701"/>
                <a:ext cx="211596" cy="1047441"/>
                <a:chOff x="8290130" y="4076701"/>
                <a:chExt cx="211596" cy="1047441"/>
              </a:xfrm>
            </p:grpSpPr>
            <p:grpSp>
              <p:nvGrpSpPr>
                <p:cNvPr id="541" name="グループ化 540">
                  <a:extLst>
                    <a:ext uri="{FF2B5EF4-FFF2-40B4-BE49-F238E27FC236}">
                      <a16:creationId xmlns:a16="http://schemas.microsoft.com/office/drawing/2014/main" id="{273F3666-11E5-6E3A-10ED-F8B9BA47154A}"/>
                    </a:ext>
                  </a:extLst>
                </p:cNvPr>
                <p:cNvGrpSpPr/>
                <p:nvPr/>
              </p:nvGrpSpPr>
              <p:grpSpPr>
                <a:xfrm>
                  <a:off x="8339256" y="4076701"/>
                  <a:ext cx="108000" cy="834884"/>
                  <a:chOff x="3181267" y="2597151"/>
                  <a:chExt cx="108000" cy="2157062"/>
                </a:xfrm>
              </p:grpSpPr>
              <p:cxnSp>
                <p:nvCxnSpPr>
                  <p:cNvPr id="543" name="直線コネクタ 542">
                    <a:extLst>
                      <a:ext uri="{FF2B5EF4-FFF2-40B4-BE49-F238E27FC236}">
                        <a16:creationId xmlns:a16="http://schemas.microsoft.com/office/drawing/2014/main" id="{F8DB540A-6B28-7017-D8D0-BDE742C54F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4" name="直線コネクタ 543">
                    <a:extLst>
                      <a:ext uri="{FF2B5EF4-FFF2-40B4-BE49-F238E27FC236}">
                        <a16:creationId xmlns:a16="http://schemas.microsoft.com/office/drawing/2014/main" id="{D32CD598-60A8-8703-EBFA-C402F0F899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5" name="直線コネクタ 544">
                    <a:extLst>
                      <a:ext uri="{FF2B5EF4-FFF2-40B4-BE49-F238E27FC236}">
                        <a16:creationId xmlns:a16="http://schemas.microsoft.com/office/drawing/2014/main" id="{648835BF-CE76-A1BE-0B43-501ACBA3D2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42" name="テキスト ボックス 541">
                  <a:extLst>
                    <a:ext uri="{FF2B5EF4-FFF2-40B4-BE49-F238E27FC236}">
                      <a16:creationId xmlns:a16="http://schemas.microsoft.com/office/drawing/2014/main" id="{ED825124-7DBF-0230-F3F8-277814C735FC}"/>
                    </a:ext>
                  </a:extLst>
                </p:cNvPr>
                <p:cNvSpPr txBox="1"/>
                <p:nvPr/>
              </p:nvSpPr>
              <p:spPr>
                <a:xfrm>
                  <a:off x="8290130" y="4872347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916" name="グループ化 915">
                <a:extLst>
                  <a:ext uri="{FF2B5EF4-FFF2-40B4-BE49-F238E27FC236}">
                    <a16:creationId xmlns:a16="http://schemas.microsoft.com/office/drawing/2014/main" id="{A5F3A0C6-58EF-ED58-BEBC-E9AE228BBD63}"/>
                  </a:ext>
                </a:extLst>
              </p:cNvPr>
              <p:cNvGrpSpPr/>
              <p:nvPr/>
            </p:nvGrpSpPr>
            <p:grpSpPr>
              <a:xfrm>
                <a:off x="9892262" y="4093369"/>
                <a:ext cx="211596" cy="1005319"/>
                <a:chOff x="9892262" y="4093369"/>
                <a:chExt cx="211596" cy="1005319"/>
              </a:xfrm>
            </p:grpSpPr>
            <p:grpSp>
              <p:nvGrpSpPr>
                <p:cNvPr id="536" name="グループ化 535">
                  <a:extLst>
                    <a:ext uri="{FF2B5EF4-FFF2-40B4-BE49-F238E27FC236}">
                      <a16:creationId xmlns:a16="http://schemas.microsoft.com/office/drawing/2014/main" id="{7364F460-82BE-D386-0413-6FFDA5987CAE}"/>
                    </a:ext>
                  </a:extLst>
                </p:cNvPr>
                <p:cNvGrpSpPr/>
                <p:nvPr/>
              </p:nvGrpSpPr>
              <p:grpSpPr>
                <a:xfrm>
                  <a:off x="9942842" y="4093369"/>
                  <a:ext cx="108000" cy="796155"/>
                  <a:chOff x="3181267" y="2597151"/>
                  <a:chExt cx="108000" cy="2157062"/>
                </a:xfrm>
              </p:grpSpPr>
              <p:cxnSp>
                <p:nvCxnSpPr>
                  <p:cNvPr id="538" name="直線コネクタ 537">
                    <a:extLst>
                      <a:ext uri="{FF2B5EF4-FFF2-40B4-BE49-F238E27FC236}">
                        <a16:creationId xmlns:a16="http://schemas.microsoft.com/office/drawing/2014/main" id="{6BDE7472-B493-A0BB-77D4-6DD8202B06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9" name="直線コネクタ 538">
                    <a:extLst>
                      <a:ext uri="{FF2B5EF4-FFF2-40B4-BE49-F238E27FC236}">
                        <a16:creationId xmlns:a16="http://schemas.microsoft.com/office/drawing/2014/main" id="{073F637C-1AB0-A07E-2DC1-9A7C25B8D7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0" name="直線コネクタ 539">
                    <a:extLst>
                      <a:ext uri="{FF2B5EF4-FFF2-40B4-BE49-F238E27FC236}">
                        <a16:creationId xmlns:a16="http://schemas.microsoft.com/office/drawing/2014/main" id="{157006CF-4330-4272-CE70-1E453A3C780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37" name="テキスト ボックス 536">
                  <a:extLst>
                    <a:ext uri="{FF2B5EF4-FFF2-40B4-BE49-F238E27FC236}">
                      <a16:creationId xmlns:a16="http://schemas.microsoft.com/office/drawing/2014/main" id="{4FA931BA-DB14-93AD-F929-652AD1A2621D}"/>
                    </a:ext>
                  </a:extLst>
                </p:cNvPr>
                <p:cNvSpPr txBox="1"/>
                <p:nvPr/>
              </p:nvSpPr>
              <p:spPr>
                <a:xfrm>
                  <a:off x="9892262" y="4846893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524" name="グループ化 523">
              <a:extLst>
                <a:ext uri="{FF2B5EF4-FFF2-40B4-BE49-F238E27FC236}">
                  <a16:creationId xmlns:a16="http://schemas.microsoft.com/office/drawing/2014/main" id="{CACB1F70-DB27-FAEE-EC23-E15514D2A598}"/>
                </a:ext>
              </a:extLst>
            </p:cNvPr>
            <p:cNvGrpSpPr/>
            <p:nvPr/>
          </p:nvGrpSpPr>
          <p:grpSpPr>
            <a:xfrm>
              <a:off x="3543920" y="4225283"/>
              <a:ext cx="6527303" cy="349457"/>
              <a:chOff x="3543920" y="1107041"/>
              <a:chExt cx="6527303" cy="349457"/>
            </a:xfrm>
          </p:grpSpPr>
          <p:sp>
            <p:nvSpPr>
              <p:cNvPr id="526" name="正方形/長方形 467">
                <a:extLst>
                  <a:ext uri="{FF2B5EF4-FFF2-40B4-BE49-F238E27FC236}">
                    <a16:creationId xmlns:a16="http://schemas.microsoft.com/office/drawing/2014/main" id="{4BD093EC-C15D-5875-CE16-77B35639D072}"/>
                  </a:ext>
                </a:extLst>
              </p:cNvPr>
              <p:cNvSpPr/>
              <p:nvPr/>
            </p:nvSpPr>
            <p:spPr>
              <a:xfrm>
                <a:off x="3543920" y="1107041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27" name="正方形/長方形 468">
                <a:extLst>
                  <a:ext uri="{FF2B5EF4-FFF2-40B4-BE49-F238E27FC236}">
                    <a16:creationId xmlns:a16="http://schemas.microsoft.com/office/drawing/2014/main" id="{ABB67A16-48CC-EB6A-F4D1-2C7F6411B9DD}"/>
                  </a:ext>
                </a:extLst>
              </p:cNvPr>
              <p:cNvSpPr/>
              <p:nvPr/>
            </p:nvSpPr>
            <p:spPr>
              <a:xfrm>
                <a:off x="5142152" y="1299983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28" name="正方形/長方形 469">
                <a:extLst>
                  <a:ext uri="{FF2B5EF4-FFF2-40B4-BE49-F238E27FC236}">
                    <a16:creationId xmlns:a16="http://schemas.microsoft.com/office/drawing/2014/main" id="{8AF4CB53-E0A9-C652-2E44-D6F8101EF66F}"/>
                  </a:ext>
                </a:extLst>
              </p:cNvPr>
              <p:cNvSpPr/>
              <p:nvPr/>
            </p:nvSpPr>
            <p:spPr>
              <a:xfrm>
                <a:off x="6738697" y="1244962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29" name="正方形/長方形 470">
                <a:extLst>
                  <a:ext uri="{FF2B5EF4-FFF2-40B4-BE49-F238E27FC236}">
                    <a16:creationId xmlns:a16="http://schemas.microsoft.com/office/drawing/2014/main" id="{03CA87F0-C5A7-623C-7D6B-B1735DFD08CB}"/>
                  </a:ext>
                </a:extLst>
              </p:cNvPr>
              <p:cNvSpPr/>
              <p:nvPr/>
            </p:nvSpPr>
            <p:spPr>
              <a:xfrm>
                <a:off x="8323636" y="1307011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30" name="正方形/長方形 471">
                <a:extLst>
                  <a:ext uri="{FF2B5EF4-FFF2-40B4-BE49-F238E27FC236}">
                    <a16:creationId xmlns:a16="http://schemas.microsoft.com/office/drawing/2014/main" id="{4A6FE521-B7A1-C66F-75C9-8857D3BA3F2A}"/>
                  </a:ext>
                </a:extLst>
              </p:cNvPr>
              <p:cNvSpPr/>
              <p:nvPr/>
            </p:nvSpPr>
            <p:spPr>
              <a:xfrm>
                <a:off x="9927223" y="1312498"/>
                <a:ext cx="144000" cy="14400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8" name="フリーフォーム: 図形 917">
              <a:extLst>
                <a:ext uri="{FF2B5EF4-FFF2-40B4-BE49-F238E27FC236}">
                  <a16:creationId xmlns:a16="http://schemas.microsoft.com/office/drawing/2014/main" id="{69ED40FF-F047-26AA-B813-DD94D117B817}"/>
                </a:ext>
              </a:extLst>
            </p:cNvPr>
            <p:cNvSpPr/>
            <p:nvPr/>
          </p:nvSpPr>
          <p:spPr>
            <a:xfrm>
              <a:off x="3611563" y="4292600"/>
              <a:ext cx="4783137" cy="209550"/>
            </a:xfrm>
            <a:custGeom>
              <a:avLst/>
              <a:gdLst>
                <a:gd name="connsiteX0" fmla="*/ 0 w 4786312"/>
                <a:gd name="connsiteY0" fmla="*/ 0 h 209550"/>
                <a:gd name="connsiteX1" fmla="*/ 1609725 w 4786312"/>
                <a:gd name="connsiteY1" fmla="*/ 204788 h 209550"/>
                <a:gd name="connsiteX2" fmla="*/ 3205162 w 4786312"/>
                <a:gd name="connsiteY2" fmla="*/ 142875 h 209550"/>
                <a:gd name="connsiteX3" fmla="*/ 4786312 w 4786312"/>
                <a:gd name="connsiteY3" fmla="*/ 209550 h 209550"/>
                <a:gd name="connsiteX0" fmla="*/ 0 w 4789487"/>
                <a:gd name="connsiteY0" fmla="*/ 0 h 215900"/>
                <a:gd name="connsiteX1" fmla="*/ 1609725 w 4789487"/>
                <a:gd name="connsiteY1" fmla="*/ 204788 h 215900"/>
                <a:gd name="connsiteX2" fmla="*/ 3205162 w 4789487"/>
                <a:gd name="connsiteY2" fmla="*/ 142875 h 215900"/>
                <a:gd name="connsiteX3" fmla="*/ 4789487 w 4789487"/>
                <a:gd name="connsiteY3" fmla="*/ 215900 h 215900"/>
                <a:gd name="connsiteX0" fmla="*/ 0 w 4789487"/>
                <a:gd name="connsiteY0" fmla="*/ 0 h 215900"/>
                <a:gd name="connsiteX1" fmla="*/ 1609725 w 4789487"/>
                <a:gd name="connsiteY1" fmla="*/ 204788 h 215900"/>
                <a:gd name="connsiteX2" fmla="*/ 3205162 w 4789487"/>
                <a:gd name="connsiteY2" fmla="*/ 146050 h 215900"/>
                <a:gd name="connsiteX3" fmla="*/ 4789487 w 4789487"/>
                <a:gd name="connsiteY3" fmla="*/ 215900 h 215900"/>
                <a:gd name="connsiteX0" fmla="*/ 0 w 4783137"/>
                <a:gd name="connsiteY0" fmla="*/ 0 h 209550"/>
                <a:gd name="connsiteX1" fmla="*/ 1603375 w 4783137"/>
                <a:gd name="connsiteY1" fmla="*/ 198438 h 209550"/>
                <a:gd name="connsiteX2" fmla="*/ 3198812 w 4783137"/>
                <a:gd name="connsiteY2" fmla="*/ 139700 h 209550"/>
                <a:gd name="connsiteX3" fmla="*/ 4783137 w 4783137"/>
                <a:gd name="connsiteY3" fmla="*/ 209550 h 2095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83137" h="209550">
                  <a:moveTo>
                    <a:pt x="0" y="0"/>
                  </a:moveTo>
                  <a:lnTo>
                    <a:pt x="1603375" y="198438"/>
                  </a:lnTo>
                  <a:lnTo>
                    <a:pt x="3198812" y="139700"/>
                  </a:lnTo>
                  <a:lnTo>
                    <a:pt x="4783137" y="209550"/>
                  </a:lnTo>
                </a:path>
              </a:pathLst>
            </a:custGeom>
            <a:noFill/>
            <a:ln w="38100">
              <a:solidFill>
                <a:srgbClr val="0000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14" name="グループ化 913">
            <a:extLst>
              <a:ext uri="{FF2B5EF4-FFF2-40B4-BE49-F238E27FC236}">
                <a16:creationId xmlns:a16="http://schemas.microsoft.com/office/drawing/2014/main" id="{DC44972D-3152-AF33-CE61-B796D1DED522}"/>
              </a:ext>
            </a:extLst>
          </p:cNvPr>
          <p:cNvGrpSpPr/>
          <p:nvPr/>
        </p:nvGrpSpPr>
        <p:grpSpPr>
          <a:xfrm>
            <a:off x="3369375" y="3454315"/>
            <a:ext cx="6568575" cy="1441949"/>
            <a:chOff x="3379040" y="3788888"/>
            <a:chExt cx="6568575" cy="1441949"/>
          </a:xfrm>
        </p:grpSpPr>
        <p:grpSp>
          <p:nvGrpSpPr>
            <p:cNvPr id="912" name="グループ化 911">
              <a:extLst>
                <a:ext uri="{FF2B5EF4-FFF2-40B4-BE49-F238E27FC236}">
                  <a16:creationId xmlns:a16="http://schemas.microsoft.com/office/drawing/2014/main" id="{EF0050ED-B299-F79E-00F2-0C20E724B845}"/>
                </a:ext>
              </a:extLst>
            </p:cNvPr>
            <p:cNvGrpSpPr/>
            <p:nvPr/>
          </p:nvGrpSpPr>
          <p:grpSpPr>
            <a:xfrm>
              <a:off x="3397040" y="3788888"/>
              <a:ext cx="6550575" cy="1441949"/>
              <a:chOff x="3397040" y="3788888"/>
              <a:chExt cx="6550575" cy="1441949"/>
            </a:xfrm>
          </p:grpSpPr>
          <p:grpSp>
            <p:nvGrpSpPr>
              <p:cNvPr id="481" name="グループ化 480">
                <a:extLst>
                  <a:ext uri="{FF2B5EF4-FFF2-40B4-BE49-F238E27FC236}">
                    <a16:creationId xmlns:a16="http://schemas.microsoft.com/office/drawing/2014/main" id="{BF2C1430-36B4-88CD-BCC1-24C31473A89D}"/>
                  </a:ext>
                </a:extLst>
              </p:cNvPr>
              <p:cNvGrpSpPr/>
              <p:nvPr/>
            </p:nvGrpSpPr>
            <p:grpSpPr>
              <a:xfrm>
                <a:off x="3397040" y="3788888"/>
                <a:ext cx="108000" cy="940276"/>
                <a:chOff x="3181267" y="2597151"/>
                <a:chExt cx="108000" cy="2157062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41BD5040-A16B-5056-E8D3-01073C5EB40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612D2BB9-42C9-7CE6-82B6-CA38907040D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2" name="直線コネクタ 521">
                  <a:extLst>
                    <a:ext uri="{FF2B5EF4-FFF2-40B4-BE49-F238E27FC236}">
                      <a16:creationId xmlns:a16="http://schemas.microsoft.com/office/drawing/2014/main" id="{6C5E4D45-6833-8B06-F8DE-DB44A567BC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2" name="グループ化 481">
                <a:extLst>
                  <a:ext uri="{FF2B5EF4-FFF2-40B4-BE49-F238E27FC236}">
                    <a16:creationId xmlns:a16="http://schemas.microsoft.com/office/drawing/2014/main" id="{481B64FD-869C-3942-D3BC-2A586B2FDB23}"/>
                  </a:ext>
                </a:extLst>
              </p:cNvPr>
              <p:cNvGrpSpPr/>
              <p:nvPr/>
            </p:nvGrpSpPr>
            <p:grpSpPr>
              <a:xfrm>
                <a:off x="4995272" y="4012727"/>
                <a:ext cx="108000" cy="961704"/>
                <a:chOff x="3181267" y="2597151"/>
                <a:chExt cx="108000" cy="2157062"/>
              </a:xfrm>
            </p:grpSpPr>
            <p:cxnSp>
              <p:nvCxnSpPr>
                <p:cNvPr id="67" name="直線コネクタ 66">
                  <a:extLst>
                    <a:ext uri="{FF2B5EF4-FFF2-40B4-BE49-F238E27FC236}">
                      <a16:creationId xmlns:a16="http://schemas.microsoft.com/office/drawing/2014/main" id="{C4243643-8C09-7517-9BC5-3718F8B959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線コネクタ 68">
                  <a:extLst>
                    <a:ext uri="{FF2B5EF4-FFF2-40B4-BE49-F238E27FC236}">
                      <a16:creationId xmlns:a16="http://schemas.microsoft.com/office/drawing/2014/main" id="{3C4674C1-61DE-5ECE-91BB-0E66C94B10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コネクタ 70">
                  <a:extLst>
                    <a:ext uri="{FF2B5EF4-FFF2-40B4-BE49-F238E27FC236}">
                      <a16:creationId xmlns:a16="http://schemas.microsoft.com/office/drawing/2014/main" id="{1F46F21C-91CC-EB8E-D94D-E41133C092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3" name="グループ化 482">
                <a:extLst>
                  <a:ext uri="{FF2B5EF4-FFF2-40B4-BE49-F238E27FC236}">
                    <a16:creationId xmlns:a16="http://schemas.microsoft.com/office/drawing/2014/main" id="{8F917652-EB5C-4429-FB0C-7A79AFCAED41}"/>
                  </a:ext>
                </a:extLst>
              </p:cNvPr>
              <p:cNvGrpSpPr/>
              <p:nvPr/>
            </p:nvGrpSpPr>
            <p:grpSpPr>
              <a:xfrm>
                <a:off x="6591817" y="4076700"/>
                <a:ext cx="108000" cy="819469"/>
                <a:chOff x="3181267" y="2597151"/>
                <a:chExt cx="108000" cy="2157062"/>
              </a:xfrm>
            </p:grpSpPr>
            <p:cxnSp>
              <p:nvCxnSpPr>
                <p:cNvPr id="496" name="直線コネクタ 495">
                  <a:extLst>
                    <a:ext uri="{FF2B5EF4-FFF2-40B4-BE49-F238E27FC236}">
                      <a16:creationId xmlns:a16="http://schemas.microsoft.com/office/drawing/2014/main" id="{F370D1CA-4FDB-39CF-BCCA-E3A746DD62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線コネクタ 63">
                  <a:extLst>
                    <a:ext uri="{FF2B5EF4-FFF2-40B4-BE49-F238E27FC236}">
                      <a16:creationId xmlns:a16="http://schemas.microsoft.com/office/drawing/2014/main" id="{6E121A08-2E59-8A33-ECF2-3DCC425339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コネクタ 65">
                  <a:extLst>
                    <a:ext uri="{FF2B5EF4-FFF2-40B4-BE49-F238E27FC236}">
                      <a16:creationId xmlns:a16="http://schemas.microsoft.com/office/drawing/2014/main" id="{362B1018-365E-C8C0-6062-D5B77CD005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10" name="グループ化 909">
                <a:extLst>
                  <a:ext uri="{FF2B5EF4-FFF2-40B4-BE49-F238E27FC236}">
                    <a16:creationId xmlns:a16="http://schemas.microsoft.com/office/drawing/2014/main" id="{DC55BDB4-D1A6-76D1-D709-9EEDF54B538D}"/>
                  </a:ext>
                </a:extLst>
              </p:cNvPr>
              <p:cNvGrpSpPr/>
              <p:nvPr/>
            </p:nvGrpSpPr>
            <p:grpSpPr>
              <a:xfrm>
                <a:off x="8160388" y="3983831"/>
                <a:ext cx="141064" cy="1235608"/>
                <a:chOff x="8160388" y="3983831"/>
                <a:chExt cx="141064" cy="1235608"/>
              </a:xfrm>
            </p:grpSpPr>
            <p:grpSp>
              <p:nvGrpSpPr>
                <p:cNvPr id="491" name="グループ化 490">
                  <a:extLst>
                    <a:ext uri="{FF2B5EF4-FFF2-40B4-BE49-F238E27FC236}">
                      <a16:creationId xmlns:a16="http://schemas.microsoft.com/office/drawing/2014/main" id="{4E227865-346D-5BEB-0269-0A5E12C65CAD}"/>
                    </a:ext>
                  </a:extLst>
                </p:cNvPr>
                <p:cNvGrpSpPr/>
                <p:nvPr/>
              </p:nvGrpSpPr>
              <p:grpSpPr>
                <a:xfrm>
                  <a:off x="8174558" y="3983831"/>
                  <a:ext cx="108000" cy="957118"/>
                  <a:chOff x="3181267" y="2597151"/>
                  <a:chExt cx="108000" cy="2157062"/>
                </a:xfrm>
              </p:grpSpPr>
              <p:cxnSp>
                <p:nvCxnSpPr>
                  <p:cNvPr id="493" name="直線コネクタ 492">
                    <a:extLst>
                      <a:ext uri="{FF2B5EF4-FFF2-40B4-BE49-F238E27FC236}">
                        <a16:creationId xmlns:a16="http://schemas.microsoft.com/office/drawing/2014/main" id="{FA598CC3-2B14-77E6-CAEE-789E7F3A1F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4" name="直線コネクタ 493">
                    <a:extLst>
                      <a:ext uri="{FF2B5EF4-FFF2-40B4-BE49-F238E27FC236}">
                        <a16:creationId xmlns:a16="http://schemas.microsoft.com/office/drawing/2014/main" id="{535D9D4B-7411-8102-1304-5A31479E77D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5" name="直線コネクタ 494">
                    <a:extLst>
                      <a:ext uri="{FF2B5EF4-FFF2-40B4-BE49-F238E27FC236}">
                        <a16:creationId xmlns:a16="http://schemas.microsoft.com/office/drawing/2014/main" id="{71B73395-D8AA-7178-0BAD-B8A0B5EEF3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92" name="テキスト ボックス 491">
                  <a:extLst>
                    <a:ext uri="{FF2B5EF4-FFF2-40B4-BE49-F238E27FC236}">
                      <a16:creationId xmlns:a16="http://schemas.microsoft.com/office/drawing/2014/main" id="{A314D5A2-EAD5-C928-D451-FE4A6691264E}"/>
                    </a:ext>
                  </a:extLst>
                </p:cNvPr>
                <p:cNvSpPr txBox="1"/>
                <p:nvPr/>
              </p:nvSpPr>
              <p:spPr>
                <a:xfrm>
                  <a:off x="8160388" y="4967644"/>
                  <a:ext cx="141064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</a:t>
                  </a:r>
                </a:p>
              </p:txBody>
            </p:sp>
          </p:grpSp>
          <p:grpSp>
            <p:nvGrpSpPr>
              <p:cNvPr id="911" name="グループ化 910">
                <a:extLst>
                  <a:ext uri="{FF2B5EF4-FFF2-40B4-BE49-F238E27FC236}">
                    <a16:creationId xmlns:a16="http://schemas.microsoft.com/office/drawing/2014/main" id="{E5487114-74AF-2687-C787-6FEF527B0BD4}"/>
                  </a:ext>
                </a:extLst>
              </p:cNvPr>
              <p:cNvGrpSpPr/>
              <p:nvPr/>
            </p:nvGrpSpPr>
            <p:grpSpPr>
              <a:xfrm>
                <a:off x="9736019" y="3979069"/>
                <a:ext cx="211596" cy="1251768"/>
                <a:chOff x="9736019" y="3979069"/>
                <a:chExt cx="211596" cy="1251768"/>
              </a:xfrm>
            </p:grpSpPr>
            <p:grpSp>
              <p:nvGrpSpPr>
                <p:cNvPr id="486" name="グループ化 485">
                  <a:extLst>
                    <a:ext uri="{FF2B5EF4-FFF2-40B4-BE49-F238E27FC236}">
                      <a16:creationId xmlns:a16="http://schemas.microsoft.com/office/drawing/2014/main" id="{78386B79-5F2C-0899-66D6-9F76A09D8BB0}"/>
                    </a:ext>
                  </a:extLst>
                </p:cNvPr>
                <p:cNvGrpSpPr/>
                <p:nvPr/>
              </p:nvGrpSpPr>
              <p:grpSpPr>
                <a:xfrm>
                  <a:off x="9778960" y="3979069"/>
                  <a:ext cx="108000" cy="1019345"/>
                  <a:chOff x="3181267" y="2597151"/>
                  <a:chExt cx="108000" cy="2157062"/>
                </a:xfrm>
              </p:grpSpPr>
              <p:cxnSp>
                <p:nvCxnSpPr>
                  <p:cNvPr id="488" name="直線コネクタ 487">
                    <a:extLst>
                      <a:ext uri="{FF2B5EF4-FFF2-40B4-BE49-F238E27FC236}">
                        <a16:creationId xmlns:a16="http://schemas.microsoft.com/office/drawing/2014/main" id="{2DC835C0-9F02-6B0B-BFE8-E6AD8F1166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9" name="直線コネクタ 488">
                    <a:extLst>
                      <a:ext uri="{FF2B5EF4-FFF2-40B4-BE49-F238E27FC236}">
                        <a16:creationId xmlns:a16="http://schemas.microsoft.com/office/drawing/2014/main" id="{E39E8067-1D35-3D8C-EBE4-C4B38F4AAC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0" name="直線コネクタ 489">
                    <a:extLst>
                      <a:ext uri="{FF2B5EF4-FFF2-40B4-BE49-F238E27FC236}">
                        <a16:creationId xmlns:a16="http://schemas.microsoft.com/office/drawing/2014/main" id="{DEB17507-6166-3201-D89B-70321EB634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87" name="テキスト ボックス 486">
                  <a:extLst>
                    <a:ext uri="{FF2B5EF4-FFF2-40B4-BE49-F238E27FC236}">
                      <a16:creationId xmlns:a16="http://schemas.microsoft.com/office/drawing/2014/main" id="{CE9FDB4F-5D97-74E8-DC8E-D799C49D14A8}"/>
                    </a:ext>
                  </a:extLst>
                </p:cNvPr>
                <p:cNvSpPr txBox="1"/>
                <p:nvPr/>
              </p:nvSpPr>
              <p:spPr>
                <a:xfrm>
                  <a:off x="9736019" y="4979042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474" name="グループ化 473">
              <a:extLst>
                <a:ext uri="{FF2B5EF4-FFF2-40B4-BE49-F238E27FC236}">
                  <a16:creationId xmlns:a16="http://schemas.microsoft.com/office/drawing/2014/main" id="{489E6516-5770-9093-4248-66A5D41B7C9C}"/>
                </a:ext>
              </a:extLst>
            </p:cNvPr>
            <p:cNvGrpSpPr/>
            <p:nvPr/>
          </p:nvGrpSpPr>
          <p:grpSpPr>
            <a:xfrm>
              <a:off x="3379040" y="4195651"/>
              <a:ext cx="6527303" cy="375181"/>
              <a:chOff x="3370040" y="750493"/>
              <a:chExt cx="6527303" cy="375181"/>
            </a:xfrm>
          </p:grpSpPr>
          <p:sp>
            <p:nvSpPr>
              <p:cNvPr id="476" name="楕円 475">
                <a:extLst>
                  <a:ext uri="{FF2B5EF4-FFF2-40B4-BE49-F238E27FC236}">
                    <a16:creationId xmlns:a16="http://schemas.microsoft.com/office/drawing/2014/main" id="{4C09CFDA-EE28-6443-7BF9-8AEE49E264BF}"/>
                  </a:ext>
                </a:extLst>
              </p:cNvPr>
              <p:cNvSpPr/>
              <p:nvPr/>
            </p:nvSpPr>
            <p:spPr>
              <a:xfrm>
                <a:off x="3370040" y="750493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77" name="楕円 476">
                <a:extLst>
                  <a:ext uri="{FF2B5EF4-FFF2-40B4-BE49-F238E27FC236}">
                    <a16:creationId xmlns:a16="http://schemas.microsoft.com/office/drawing/2014/main" id="{C20FD491-A753-360C-A4D6-4196C9F6DFDF}"/>
                  </a:ext>
                </a:extLst>
              </p:cNvPr>
              <p:cNvSpPr/>
              <p:nvPr/>
            </p:nvSpPr>
            <p:spPr>
              <a:xfrm>
                <a:off x="4968272" y="975948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78" name="楕円 477">
                <a:extLst>
                  <a:ext uri="{FF2B5EF4-FFF2-40B4-BE49-F238E27FC236}">
                    <a16:creationId xmlns:a16="http://schemas.microsoft.com/office/drawing/2014/main" id="{F459E0FB-D6AD-7CEB-81AA-857996DDC448}"/>
                  </a:ext>
                </a:extLst>
              </p:cNvPr>
              <p:cNvSpPr/>
              <p:nvPr/>
            </p:nvSpPr>
            <p:spPr>
              <a:xfrm>
                <a:off x="6564817" y="958290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79" name="楕円 478">
                <a:extLst>
                  <a:ext uri="{FF2B5EF4-FFF2-40B4-BE49-F238E27FC236}">
                    <a16:creationId xmlns:a16="http://schemas.microsoft.com/office/drawing/2014/main" id="{F9B1E581-4857-85C0-6CC9-4BA5DE885E23}"/>
                  </a:ext>
                </a:extLst>
              </p:cNvPr>
              <p:cNvSpPr/>
              <p:nvPr/>
            </p:nvSpPr>
            <p:spPr>
              <a:xfrm>
                <a:off x="8149756" y="961885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80" name="楕円 479">
                <a:extLst>
                  <a:ext uri="{FF2B5EF4-FFF2-40B4-BE49-F238E27FC236}">
                    <a16:creationId xmlns:a16="http://schemas.microsoft.com/office/drawing/2014/main" id="{574ABC3B-A7C6-1B4D-1E25-37A91C874DE4}"/>
                  </a:ext>
                </a:extLst>
              </p:cNvPr>
              <p:cNvSpPr/>
              <p:nvPr/>
            </p:nvSpPr>
            <p:spPr>
              <a:xfrm>
                <a:off x="9753343" y="981674"/>
                <a:ext cx="144000" cy="14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3" name="フリーフォーム: 図形 912">
              <a:extLst>
                <a:ext uri="{FF2B5EF4-FFF2-40B4-BE49-F238E27FC236}">
                  <a16:creationId xmlns:a16="http://schemas.microsoft.com/office/drawing/2014/main" id="{EEBF379B-3379-2FE2-BD06-944395E29F99}"/>
                </a:ext>
              </a:extLst>
            </p:cNvPr>
            <p:cNvSpPr/>
            <p:nvPr/>
          </p:nvSpPr>
          <p:spPr>
            <a:xfrm>
              <a:off x="3448050" y="4262438"/>
              <a:ext cx="4781550" cy="233362"/>
            </a:xfrm>
            <a:custGeom>
              <a:avLst/>
              <a:gdLst>
                <a:gd name="connsiteX0" fmla="*/ 0 w 4781550"/>
                <a:gd name="connsiteY0" fmla="*/ 0 h 233362"/>
                <a:gd name="connsiteX1" fmla="*/ 1590675 w 4781550"/>
                <a:gd name="connsiteY1" fmla="*/ 233362 h 233362"/>
                <a:gd name="connsiteX2" fmla="*/ 3195638 w 4781550"/>
                <a:gd name="connsiteY2" fmla="*/ 214312 h 233362"/>
                <a:gd name="connsiteX3" fmla="*/ 4781550 w 4781550"/>
                <a:gd name="connsiteY3" fmla="*/ 214312 h 233362"/>
                <a:gd name="connsiteX0" fmla="*/ 0 w 4781550"/>
                <a:gd name="connsiteY0" fmla="*/ 0 h 233362"/>
                <a:gd name="connsiteX1" fmla="*/ 1597025 w 4781550"/>
                <a:gd name="connsiteY1" fmla="*/ 233362 h 233362"/>
                <a:gd name="connsiteX2" fmla="*/ 3195638 w 4781550"/>
                <a:gd name="connsiteY2" fmla="*/ 214312 h 233362"/>
                <a:gd name="connsiteX3" fmla="*/ 4781550 w 4781550"/>
                <a:gd name="connsiteY3" fmla="*/ 214312 h 2333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81550" h="233362">
                  <a:moveTo>
                    <a:pt x="0" y="0"/>
                  </a:moveTo>
                  <a:lnTo>
                    <a:pt x="1597025" y="233362"/>
                  </a:lnTo>
                  <a:lnTo>
                    <a:pt x="3195638" y="214312"/>
                  </a:lnTo>
                  <a:lnTo>
                    <a:pt x="4781550" y="214312"/>
                  </a:lnTo>
                </a:path>
              </a:pathLst>
            </a:custGeom>
            <a:noFill/>
            <a:ln w="38100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09" name="グループ化 908">
            <a:extLst>
              <a:ext uri="{FF2B5EF4-FFF2-40B4-BE49-F238E27FC236}">
                <a16:creationId xmlns:a16="http://schemas.microsoft.com/office/drawing/2014/main" id="{0633FCAB-AE6A-0366-1090-D672B8F701AF}"/>
              </a:ext>
            </a:extLst>
          </p:cNvPr>
          <p:cNvGrpSpPr/>
          <p:nvPr/>
        </p:nvGrpSpPr>
        <p:grpSpPr>
          <a:xfrm>
            <a:off x="3212287" y="3499238"/>
            <a:ext cx="6543381" cy="1320474"/>
            <a:chOff x="3221952" y="3833811"/>
            <a:chExt cx="6543381" cy="1320474"/>
          </a:xfrm>
        </p:grpSpPr>
        <p:grpSp>
          <p:nvGrpSpPr>
            <p:cNvPr id="907" name="グループ化 906">
              <a:extLst>
                <a:ext uri="{FF2B5EF4-FFF2-40B4-BE49-F238E27FC236}">
                  <a16:creationId xmlns:a16="http://schemas.microsoft.com/office/drawing/2014/main" id="{7E1CDD52-2890-D0A4-0E9E-3A48254B54AB}"/>
                </a:ext>
              </a:extLst>
            </p:cNvPr>
            <p:cNvGrpSpPr/>
            <p:nvPr/>
          </p:nvGrpSpPr>
          <p:grpSpPr>
            <a:xfrm>
              <a:off x="3239952" y="3833811"/>
              <a:ext cx="6509698" cy="1320474"/>
              <a:chOff x="3239952" y="3833811"/>
              <a:chExt cx="6509698" cy="1320474"/>
            </a:xfrm>
          </p:grpSpPr>
          <p:grpSp>
            <p:nvGrpSpPr>
              <p:cNvPr id="563" name="グループ化 562">
                <a:extLst>
                  <a:ext uri="{FF2B5EF4-FFF2-40B4-BE49-F238E27FC236}">
                    <a16:creationId xmlns:a16="http://schemas.microsoft.com/office/drawing/2014/main" id="{3CA59167-9D85-B6C6-C1CF-165EAB124164}"/>
                  </a:ext>
                </a:extLst>
              </p:cNvPr>
              <p:cNvGrpSpPr/>
              <p:nvPr/>
            </p:nvGrpSpPr>
            <p:grpSpPr>
              <a:xfrm>
                <a:off x="3239952" y="3833811"/>
                <a:ext cx="108000" cy="900113"/>
                <a:chOff x="3181267" y="2597151"/>
                <a:chExt cx="108000" cy="2157062"/>
              </a:xfrm>
            </p:grpSpPr>
            <p:cxnSp>
              <p:nvCxnSpPr>
                <p:cNvPr id="203" name="直線コネクタ 202">
                  <a:extLst>
                    <a:ext uri="{FF2B5EF4-FFF2-40B4-BE49-F238E27FC236}">
                      <a16:creationId xmlns:a16="http://schemas.microsoft.com/office/drawing/2014/main" id="{DDFF387D-AFDB-D5D8-73E5-2E05AD2A130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直線コネクタ 203">
                  <a:extLst>
                    <a:ext uri="{FF2B5EF4-FFF2-40B4-BE49-F238E27FC236}">
                      <a16:creationId xmlns:a16="http://schemas.microsoft.com/office/drawing/2014/main" id="{9601B66D-AAF8-EFDB-136A-7C5B34B666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直線コネクタ 204">
                  <a:extLst>
                    <a:ext uri="{FF2B5EF4-FFF2-40B4-BE49-F238E27FC236}">
                      <a16:creationId xmlns:a16="http://schemas.microsoft.com/office/drawing/2014/main" id="{56DEC89C-B5DD-E15A-26D5-9A4924879B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4" name="グループ化 563">
                <a:extLst>
                  <a:ext uri="{FF2B5EF4-FFF2-40B4-BE49-F238E27FC236}">
                    <a16:creationId xmlns:a16="http://schemas.microsoft.com/office/drawing/2014/main" id="{9CC94E01-3507-CF51-72BC-ADFE66B9BABE}"/>
                  </a:ext>
                </a:extLst>
              </p:cNvPr>
              <p:cNvGrpSpPr/>
              <p:nvPr/>
            </p:nvGrpSpPr>
            <p:grpSpPr>
              <a:xfrm>
                <a:off x="4838184" y="4040981"/>
                <a:ext cx="108000" cy="909638"/>
                <a:chOff x="3181267" y="2597151"/>
                <a:chExt cx="108000" cy="2157062"/>
              </a:xfrm>
            </p:grpSpPr>
            <p:cxnSp>
              <p:nvCxnSpPr>
                <p:cNvPr id="200" name="直線コネクタ 199">
                  <a:extLst>
                    <a:ext uri="{FF2B5EF4-FFF2-40B4-BE49-F238E27FC236}">
                      <a16:creationId xmlns:a16="http://schemas.microsoft.com/office/drawing/2014/main" id="{3FCE234E-1A88-1CD0-1F49-31F9C5D393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直線コネクタ 200">
                  <a:extLst>
                    <a:ext uri="{FF2B5EF4-FFF2-40B4-BE49-F238E27FC236}">
                      <a16:creationId xmlns:a16="http://schemas.microsoft.com/office/drawing/2014/main" id="{97B5249C-F641-E62B-53F4-14336647A4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直線コネクタ 201">
                  <a:extLst>
                    <a:ext uri="{FF2B5EF4-FFF2-40B4-BE49-F238E27FC236}">
                      <a16:creationId xmlns:a16="http://schemas.microsoft.com/office/drawing/2014/main" id="{74E25CA2-7FFC-880F-DDE0-2718CE995F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5" name="グループ化 564">
                <a:extLst>
                  <a:ext uri="{FF2B5EF4-FFF2-40B4-BE49-F238E27FC236}">
                    <a16:creationId xmlns:a16="http://schemas.microsoft.com/office/drawing/2014/main" id="{3227FA96-D8A0-8BE6-38F9-3C413FF20F39}"/>
                  </a:ext>
                </a:extLst>
              </p:cNvPr>
              <p:cNvGrpSpPr/>
              <p:nvPr/>
            </p:nvGrpSpPr>
            <p:grpSpPr>
              <a:xfrm>
                <a:off x="6434729" y="3988594"/>
                <a:ext cx="108000" cy="950119"/>
                <a:chOff x="3181267" y="2597151"/>
                <a:chExt cx="108000" cy="2157062"/>
              </a:xfrm>
            </p:grpSpPr>
            <p:cxnSp>
              <p:nvCxnSpPr>
                <p:cNvPr id="197" name="直線コネクタ 196">
                  <a:extLst>
                    <a:ext uri="{FF2B5EF4-FFF2-40B4-BE49-F238E27FC236}">
                      <a16:creationId xmlns:a16="http://schemas.microsoft.com/office/drawing/2014/main" id="{938EE088-91E5-AF9E-FA87-D0B0EBF5F8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267" y="2597151"/>
                  <a:ext cx="0" cy="21570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直線コネクタ 197">
                  <a:extLst>
                    <a:ext uri="{FF2B5EF4-FFF2-40B4-BE49-F238E27FC236}">
                      <a16:creationId xmlns:a16="http://schemas.microsoft.com/office/drawing/2014/main" id="{E747F941-D0EC-C08C-75A7-FD13E4A6A4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4754213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直線コネクタ 198">
                  <a:extLst>
                    <a:ext uri="{FF2B5EF4-FFF2-40B4-BE49-F238E27FC236}">
                      <a16:creationId xmlns:a16="http://schemas.microsoft.com/office/drawing/2014/main" id="{44C2519A-0171-25AA-F589-930119FB96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81267" y="2597151"/>
                  <a:ext cx="10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05" name="グループ化 904">
                <a:extLst>
                  <a:ext uri="{FF2B5EF4-FFF2-40B4-BE49-F238E27FC236}">
                    <a16:creationId xmlns:a16="http://schemas.microsoft.com/office/drawing/2014/main" id="{5E1AB802-6FCD-0845-6DE7-CCF9D44CFD22}"/>
                  </a:ext>
                </a:extLst>
              </p:cNvPr>
              <p:cNvGrpSpPr/>
              <p:nvPr/>
            </p:nvGrpSpPr>
            <p:grpSpPr>
              <a:xfrm>
                <a:off x="7997566" y="4036218"/>
                <a:ext cx="211596" cy="1098682"/>
                <a:chOff x="7997566" y="4036218"/>
                <a:chExt cx="211596" cy="1098682"/>
              </a:xfrm>
            </p:grpSpPr>
            <p:grpSp>
              <p:nvGrpSpPr>
                <p:cNvPr id="573" name="グループ化 572">
                  <a:extLst>
                    <a:ext uri="{FF2B5EF4-FFF2-40B4-BE49-F238E27FC236}">
                      <a16:creationId xmlns:a16="http://schemas.microsoft.com/office/drawing/2014/main" id="{2414C318-CF83-B4D5-70BD-6B1A9E2A7494}"/>
                    </a:ext>
                  </a:extLst>
                </p:cNvPr>
                <p:cNvGrpSpPr/>
                <p:nvPr/>
              </p:nvGrpSpPr>
              <p:grpSpPr>
                <a:xfrm>
                  <a:off x="8046045" y="4036218"/>
                  <a:ext cx="108000" cy="881509"/>
                  <a:chOff x="3181267" y="2154479"/>
                  <a:chExt cx="108000" cy="2599734"/>
                </a:xfrm>
              </p:grpSpPr>
              <p:cxnSp>
                <p:nvCxnSpPr>
                  <p:cNvPr id="575" name="直線コネクタ 574">
                    <a:extLst>
                      <a:ext uri="{FF2B5EF4-FFF2-40B4-BE49-F238E27FC236}">
                        <a16:creationId xmlns:a16="http://schemas.microsoft.com/office/drawing/2014/main" id="{91F0FB1F-2429-1119-74BA-B0468EC47A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154479"/>
                    <a:ext cx="0" cy="259973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直線コネクタ 194">
                    <a:extLst>
                      <a:ext uri="{FF2B5EF4-FFF2-40B4-BE49-F238E27FC236}">
                        <a16:creationId xmlns:a16="http://schemas.microsoft.com/office/drawing/2014/main" id="{7212274A-8F62-1FC7-73CB-3CBD1DF728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6" name="直線コネクタ 195">
                    <a:extLst>
                      <a:ext uri="{FF2B5EF4-FFF2-40B4-BE49-F238E27FC236}">
                        <a16:creationId xmlns:a16="http://schemas.microsoft.com/office/drawing/2014/main" id="{819D12DC-BEB4-1A3F-9559-B85CEDBF39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154479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74" name="テキスト ボックス 573">
                  <a:extLst>
                    <a:ext uri="{FF2B5EF4-FFF2-40B4-BE49-F238E27FC236}">
                      <a16:creationId xmlns:a16="http://schemas.microsoft.com/office/drawing/2014/main" id="{D65482E1-AFFA-603F-EAC7-0619A7DC6A26}"/>
                    </a:ext>
                  </a:extLst>
                </p:cNvPr>
                <p:cNvSpPr txBox="1"/>
                <p:nvPr/>
              </p:nvSpPr>
              <p:spPr>
                <a:xfrm>
                  <a:off x="7997566" y="4883105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  <p:grpSp>
            <p:nvGrpSpPr>
              <p:cNvPr id="906" name="グループ化 905">
                <a:extLst>
                  <a:ext uri="{FF2B5EF4-FFF2-40B4-BE49-F238E27FC236}">
                    <a16:creationId xmlns:a16="http://schemas.microsoft.com/office/drawing/2014/main" id="{1C6033D5-8A65-F75A-EBE8-99F1283BAADD}"/>
                  </a:ext>
                </a:extLst>
              </p:cNvPr>
              <p:cNvGrpSpPr/>
              <p:nvPr/>
            </p:nvGrpSpPr>
            <p:grpSpPr>
              <a:xfrm>
                <a:off x="9538054" y="4036220"/>
                <a:ext cx="211596" cy="1118065"/>
                <a:chOff x="9538054" y="4036220"/>
                <a:chExt cx="211596" cy="1118065"/>
              </a:xfrm>
            </p:grpSpPr>
            <p:grpSp>
              <p:nvGrpSpPr>
                <p:cNvPr id="568" name="グループ化 567">
                  <a:extLst>
                    <a:ext uri="{FF2B5EF4-FFF2-40B4-BE49-F238E27FC236}">
                      <a16:creationId xmlns:a16="http://schemas.microsoft.com/office/drawing/2014/main" id="{4FEE0C9B-6A6D-51F5-B016-AE68A850FDC0}"/>
                    </a:ext>
                  </a:extLst>
                </p:cNvPr>
                <p:cNvGrpSpPr/>
                <p:nvPr/>
              </p:nvGrpSpPr>
              <p:grpSpPr>
                <a:xfrm>
                  <a:off x="9639333" y="4036220"/>
                  <a:ext cx="108000" cy="909638"/>
                  <a:chOff x="3181267" y="2597151"/>
                  <a:chExt cx="108000" cy="2157062"/>
                </a:xfrm>
              </p:grpSpPr>
              <p:cxnSp>
                <p:nvCxnSpPr>
                  <p:cNvPr id="570" name="直線コネクタ 569">
                    <a:extLst>
                      <a:ext uri="{FF2B5EF4-FFF2-40B4-BE49-F238E27FC236}">
                        <a16:creationId xmlns:a16="http://schemas.microsoft.com/office/drawing/2014/main" id="{B71483E1-C34C-10F4-5330-8BC1BE7500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5267" y="2597151"/>
                    <a:ext cx="0" cy="2157062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1" name="直線コネクタ 570">
                    <a:extLst>
                      <a:ext uri="{FF2B5EF4-FFF2-40B4-BE49-F238E27FC236}">
                        <a16:creationId xmlns:a16="http://schemas.microsoft.com/office/drawing/2014/main" id="{AB2534F3-25D6-F50D-8AE2-34FFC52603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4754213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2" name="直線コネクタ 571">
                    <a:extLst>
                      <a:ext uri="{FF2B5EF4-FFF2-40B4-BE49-F238E27FC236}">
                        <a16:creationId xmlns:a16="http://schemas.microsoft.com/office/drawing/2014/main" id="{62588957-EF99-F436-3C09-F53649B28F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81267" y="2597151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69" name="テキスト ボックス 568">
                  <a:extLst>
                    <a:ext uri="{FF2B5EF4-FFF2-40B4-BE49-F238E27FC236}">
                      <a16:creationId xmlns:a16="http://schemas.microsoft.com/office/drawing/2014/main" id="{1BED7059-9573-6BC0-990C-BE2294DCE067}"/>
                    </a:ext>
                  </a:extLst>
                </p:cNvPr>
                <p:cNvSpPr txBox="1"/>
                <p:nvPr/>
              </p:nvSpPr>
              <p:spPr>
                <a:xfrm>
                  <a:off x="9538054" y="4902490"/>
                  <a:ext cx="211596" cy="25179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lIns="0" tIns="36000" rIns="0" bIns="0" anchor="t">
                  <a:spAutoFit/>
                </a:bodyPr>
                <a:lstStyle>
                  <a:defPPr>
                    <a:defRPr lang="ja-JP"/>
                  </a:defPPr>
                  <a:lvl1pPr lvl="0" indent="0" algn="ctr">
                    <a:spcBef>
                      <a:spcPct val="0"/>
                    </a:spcBef>
                    <a:buNone/>
                    <a:defRPr sz="900" b="1" kern="0">
                      <a:solidFill>
                        <a:prstClr val="black"/>
                      </a:solidFill>
                      <a:latin typeface="Arial" panose="020B0604020202020204" pitchFamily="34" charset="0"/>
                      <a:ea typeface="Meiryo UI"/>
                      <a:cs typeface="Arial" panose="020B0604020202020204" pitchFamily="34" charset="0"/>
                    </a:defRPr>
                  </a:lvl1pPr>
                  <a:lvl2pPr indent="0">
                    <a:defRPr sz="1100"/>
                  </a:lvl2pPr>
                  <a:lvl3pPr indent="0">
                    <a:defRPr sz="1100"/>
                  </a:lvl3pPr>
                  <a:lvl4pPr indent="0">
                    <a:defRPr sz="1100"/>
                  </a:lvl4pPr>
                  <a:lvl5pPr indent="0">
                    <a:defRPr sz="1100"/>
                  </a:lvl5pPr>
                  <a:lvl6pPr indent="0">
                    <a:defRPr sz="1100"/>
                  </a:lvl6pPr>
                  <a:lvl7pPr indent="0">
                    <a:defRPr sz="1100"/>
                  </a:lvl7pPr>
                  <a:lvl8pPr indent="0">
                    <a:defRPr sz="1100"/>
                  </a:lvl8pPr>
                  <a:lvl9pPr indent="0">
                    <a:defRPr sz="1100"/>
                  </a:lvl9pPr>
                </a:lstStyle>
                <a:p>
                  <a:r>
                    <a:rPr lang="en-US" altLang="ja-JP" sz="1400" dirty="0"/>
                    <a:t>***</a:t>
                  </a:r>
                </a:p>
              </p:txBody>
            </p:sp>
          </p:grpSp>
        </p:grpSp>
        <p:grpSp>
          <p:nvGrpSpPr>
            <p:cNvPr id="556" name="グループ化 555">
              <a:extLst>
                <a:ext uri="{FF2B5EF4-FFF2-40B4-BE49-F238E27FC236}">
                  <a16:creationId xmlns:a16="http://schemas.microsoft.com/office/drawing/2014/main" id="{058ED76C-F02A-10DB-F0C8-BE1465E6E23F}"/>
                </a:ext>
              </a:extLst>
            </p:cNvPr>
            <p:cNvGrpSpPr/>
            <p:nvPr/>
          </p:nvGrpSpPr>
          <p:grpSpPr>
            <a:xfrm>
              <a:off x="3221952" y="4224431"/>
              <a:ext cx="6543381" cy="351901"/>
              <a:chOff x="3212952" y="3440241"/>
              <a:chExt cx="6543381" cy="351901"/>
            </a:xfrm>
            <a:solidFill>
              <a:schemeClr val="tx1"/>
            </a:solidFill>
          </p:grpSpPr>
          <p:sp>
            <p:nvSpPr>
              <p:cNvPr id="558" name="楕円 557">
                <a:extLst>
                  <a:ext uri="{FF2B5EF4-FFF2-40B4-BE49-F238E27FC236}">
                    <a16:creationId xmlns:a16="http://schemas.microsoft.com/office/drawing/2014/main" id="{56978DDF-7028-706D-D200-3A36E9B0C5DB}"/>
                  </a:ext>
                </a:extLst>
              </p:cNvPr>
              <p:cNvSpPr/>
              <p:nvPr/>
            </p:nvSpPr>
            <p:spPr>
              <a:xfrm>
                <a:off x="3212952" y="3440241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59" name="楕円 558">
                <a:extLst>
                  <a:ext uri="{FF2B5EF4-FFF2-40B4-BE49-F238E27FC236}">
                    <a16:creationId xmlns:a16="http://schemas.microsoft.com/office/drawing/2014/main" id="{38A6C02C-1050-0A6A-50CB-B6C26EE8FA17}"/>
                  </a:ext>
                </a:extLst>
              </p:cNvPr>
              <p:cNvSpPr/>
              <p:nvPr/>
            </p:nvSpPr>
            <p:spPr>
              <a:xfrm>
                <a:off x="4811184" y="3648142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60" name="楕円 559">
                <a:extLst>
                  <a:ext uri="{FF2B5EF4-FFF2-40B4-BE49-F238E27FC236}">
                    <a16:creationId xmlns:a16="http://schemas.microsoft.com/office/drawing/2014/main" id="{9717AF55-BA29-D924-CFE2-3C765CACACB3}"/>
                  </a:ext>
                </a:extLst>
              </p:cNvPr>
              <p:cNvSpPr/>
              <p:nvPr/>
            </p:nvSpPr>
            <p:spPr>
              <a:xfrm>
                <a:off x="6407729" y="3603240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61" name="楕円 560">
                <a:extLst>
                  <a:ext uri="{FF2B5EF4-FFF2-40B4-BE49-F238E27FC236}">
                    <a16:creationId xmlns:a16="http://schemas.microsoft.com/office/drawing/2014/main" id="{F1C5CF07-542A-A395-36D5-39E06F8A7AE2}"/>
                  </a:ext>
                </a:extLst>
              </p:cNvPr>
              <p:cNvSpPr/>
              <p:nvPr/>
            </p:nvSpPr>
            <p:spPr>
              <a:xfrm>
                <a:off x="8019044" y="3626864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62" name="楕円 561">
                <a:extLst>
                  <a:ext uri="{FF2B5EF4-FFF2-40B4-BE49-F238E27FC236}">
                    <a16:creationId xmlns:a16="http://schemas.microsoft.com/office/drawing/2014/main" id="{AF82FA70-BF43-1689-51D0-EA42472DB667}"/>
                  </a:ext>
                </a:extLst>
              </p:cNvPr>
              <p:cNvSpPr/>
              <p:nvPr/>
            </p:nvSpPr>
            <p:spPr>
              <a:xfrm>
                <a:off x="9612333" y="3646230"/>
                <a:ext cx="144000" cy="144000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8" name="フリーフォーム: 図形 907">
              <a:extLst>
                <a:ext uri="{FF2B5EF4-FFF2-40B4-BE49-F238E27FC236}">
                  <a16:creationId xmlns:a16="http://schemas.microsoft.com/office/drawing/2014/main" id="{3F7B3B9D-835E-254D-23B6-5C4977378DA5}"/>
                </a:ext>
              </a:extLst>
            </p:cNvPr>
            <p:cNvSpPr/>
            <p:nvPr/>
          </p:nvSpPr>
          <p:spPr>
            <a:xfrm>
              <a:off x="3290888" y="4295775"/>
              <a:ext cx="4810125" cy="214313"/>
            </a:xfrm>
            <a:custGeom>
              <a:avLst/>
              <a:gdLst>
                <a:gd name="connsiteX0" fmla="*/ 0 w 4810125"/>
                <a:gd name="connsiteY0" fmla="*/ 0 h 214313"/>
                <a:gd name="connsiteX1" fmla="*/ 1600200 w 4810125"/>
                <a:gd name="connsiteY1" fmla="*/ 214313 h 214313"/>
                <a:gd name="connsiteX2" fmla="*/ 3190875 w 4810125"/>
                <a:gd name="connsiteY2" fmla="*/ 166688 h 214313"/>
                <a:gd name="connsiteX3" fmla="*/ 4810125 w 4810125"/>
                <a:gd name="connsiteY3" fmla="*/ 185738 h 2143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810125" h="214313">
                  <a:moveTo>
                    <a:pt x="0" y="0"/>
                  </a:moveTo>
                  <a:lnTo>
                    <a:pt x="1600200" y="214313"/>
                  </a:lnTo>
                  <a:lnTo>
                    <a:pt x="3190875" y="166688"/>
                  </a:lnTo>
                  <a:lnTo>
                    <a:pt x="4810125" y="185738"/>
                  </a:lnTo>
                </a:path>
              </a:pathLst>
            </a:custGeom>
            <a:noFill/>
            <a:ln w="381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297158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881CB0D-7A50-AAEA-EDD8-57617069D3CB}"/>
              </a:ext>
            </a:extLst>
          </p:cNvPr>
          <p:cNvGrpSpPr/>
          <p:nvPr/>
        </p:nvGrpSpPr>
        <p:grpSpPr>
          <a:xfrm>
            <a:off x="1657323" y="590780"/>
            <a:ext cx="8563602" cy="5951693"/>
            <a:chOff x="1657323" y="541353"/>
            <a:chExt cx="8563602" cy="5951693"/>
          </a:xfrm>
        </p:grpSpPr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187FD48B-64D6-103D-5641-335BF6934F35}"/>
                </a:ext>
              </a:extLst>
            </p:cNvPr>
            <p:cNvGrpSpPr/>
            <p:nvPr/>
          </p:nvGrpSpPr>
          <p:grpSpPr>
            <a:xfrm>
              <a:off x="1657323" y="541353"/>
              <a:ext cx="8563602" cy="2773066"/>
              <a:chOff x="1657323" y="541353"/>
              <a:chExt cx="8563602" cy="2773066"/>
            </a:xfrm>
          </p:grpSpPr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A355BA9E-8CC9-63AB-32B1-A01541FF72E1}"/>
                  </a:ext>
                </a:extLst>
              </p:cNvPr>
              <p:cNvSpPr txBox="1"/>
              <p:nvPr/>
            </p:nvSpPr>
            <p:spPr>
              <a:xfrm rot="16200000">
                <a:off x="981818" y="1569277"/>
                <a:ext cx="2182008" cy="83099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hange in office SBP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from baseline to EOT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(mmHg)</a:t>
                </a:r>
              </a:p>
            </p:txBody>
          </p:sp>
          <p:cxnSp>
            <p:nvCxnSpPr>
              <p:cNvPr id="7" name="直線コネクタ 6">
                <a:extLst>
                  <a:ext uri="{FF2B5EF4-FFF2-40B4-BE49-F238E27FC236}">
                    <a16:creationId xmlns:a16="http://schemas.microsoft.com/office/drawing/2014/main" id="{CFB5779E-55CD-A174-9BD2-A26229D13E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9338" y="869171"/>
                <a:ext cx="7201587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正方形/長方形 17">
                <a:extLst>
                  <a:ext uri="{FF2B5EF4-FFF2-40B4-BE49-F238E27FC236}">
                    <a16:creationId xmlns:a16="http://schemas.microsoft.com/office/drawing/2014/main" id="{2D6B3F3B-9237-D902-0545-7E2F41691869}"/>
                  </a:ext>
                </a:extLst>
              </p:cNvPr>
              <p:cNvSpPr/>
              <p:nvPr/>
            </p:nvSpPr>
            <p:spPr>
              <a:xfrm>
                <a:off x="2676199" y="744714"/>
                <a:ext cx="227627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10</a:t>
                </a:r>
              </a:p>
            </p:txBody>
          </p: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B52D96D2-241A-9144-E5F2-E82B1E6FD1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2937323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2C08581F-7B3D-6082-74D1-0FE905EA5F0B}"/>
                  </a:ext>
                </a:extLst>
              </p:cNvPr>
              <p:cNvSpPr/>
              <p:nvPr/>
            </p:nvSpPr>
            <p:spPr>
              <a:xfrm>
                <a:off x="2555974" y="2813186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3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753E7576-12EE-C320-4383-80B63794F5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2477736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EDB2BB10-7946-8421-1EA0-EED6A9FBF2CE}"/>
                  </a:ext>
                </a:extLst>
              </p:cNvPr>
              <p:cNvSpPr/>
              <p:nvPr/>
            </p:nvSpPr>
            <p:spPr>
              <a:xfrm>
                <a:off x="2555974" y="235352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2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9DEA0A6A-3742-4F75-9036-C4DCB42B97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178835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正方形/長方形 23">
                <a:extLst>
                  <a:ext uri="{FF2B5EF4-FFF2-40B4-BE49-F238E27FC236}">
                    <a16:creationId xmlns:a16="http://schemas.microsoft.com/office/drawing/2014/main" id="{DC890C53-F692-D75E-4D7F-F2D0039CBA0B}"/>
                  </a:ext>
                </a:extLst>
              </p:cNvPr>
              <p:cNvSpPr/>
              <p:nvPr/>
            </p:nvSpPr>
            <p:spPr>
              <a:xfrm>
                <a:off x="2555974" y="166403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6AFB161D-C8DB-A645-DF8E-9D1A4EA215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1098966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正方形/長方形 25">
                <a:extLst>
                  <a:ext uri="{FF2B5EF4-FFF2-40B4-BE49-F238E27FC236}">
                    <a16:creationId xmlns:a16="http://schemas.microsoft.com/office/drawing/2014/main" id="{26CB4A2A-1CCA-6FE5-30E5-E519BB884658}"/>
                  </a:ext>
                </a:extLst>
              </p:cNvPr>
              <p:cNvSpPr/>
              <p:nvPr/>
            </p:nvSpPr>
            <p:spPr>
              <a:xfrm>
                <a:off x="2790012" y="974544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</a:t>
                </a:r>
              </a:p>
            </p:txBody>
          </p: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4E66773B-A7BB-15DB-CA72-7335B21569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9338" y="870575"/>
                <a:ext cx="0" cy="22284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23E57B8C-4A0F-726D-006C-E830692BED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86917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3CA11995-AA76-643A-5ECF-E173DA2E318A}"/>
                  </a:ext>
                </a:extLst>
              </p:cNvPr>
              <p:cNvGrpSpPr/>
              <p:nvPr/>
            </p:nvGrpSpPr>
            <p:grpSpPr>
              <a:xfrm>
                <a:off x="4355927" y="3098975"/>
                <a:ext cx="4627795" cy="215444"/>
                <a:chOff x="4683258" y="2845511"/>
                <a:chExt cx="4627795" cy="215444"/>
              </a:xfrm>
            </p:grpSpPr>
            <p:grpSp>
              <p:nvGrpSpPr>
                <p:cNvPr id="215" name="グループ化 214">
                  <a:extLst>
                    <a:ext uri="{FF2B5EF4-FFF2-40B4-BE49-F238E27FC236}">
                      <a16:creationId xmlns:a16="http://schemas.microsoft.com/office/drawing/2014/main" id="{45D206C1-FD01-EF9C-06CD-E6436892E229}"/>
                    </a:ext>
                  </a:extLst>
                </p:cNvPr>
                <p:cNvGrpSpPr/>
                <p:nvPr/>
              </p:nvGrpSpPr>
              <p:grpSpPr>
                <a:xfrm>
                  <a:off x="6279513" y="2845511"/>
                  <a:ext cx="1463497" cy="215444"/>
                  <a:chOff x="4782318" y="3119831"/>
                  <a:chExt cx="1463497" cy="215444"/>
                </a:xfrm>
              </p:grpSpPr>
              <p:sp>
                <p:nvSpPr>
                  <p:cNvPr id="226" name="正方形/長方形 225">
                    <a:extLst>
                      <a:ext uri="{FF2B5EF4-FFF2-40B4-BE49-F238E27FC236}">
                        <a16:creationId xmlns:a16="http://schemas.microsoft.com/office/drawing/2014/main" id="{59FA8C45-BC1A-7686-C873-0F69F12E9F61}"/>
                      </a:ext>
                    </a:extLst>
                  </p:cNvPr>
                  <p:cNvSpPr/>
                  <p:nvPr/>
                </p:nvSpPr>
                <p:spPr>
                  <a:xfrm>
                    <a:off x="5169114" y="3119831"/>
                    <a:ext cx="1076701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AR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5)</a:t>
                    </a:r>
                  </a:p>
                </p:txBody>
              </p:sp>
              <p:grpSp>
                <p:nvGrpSpPr>
                  <p:cNvPr id="227" name="グループ化 226">
                    <a:extLst>
                      <a:ext uri="{FF2B5EF4-FFF2-40B4-BE49-F238E27FC236}">
                        <a16:creationId xmlns:a16="http://schemas.microsoft.com/office/drawing/2014/main" id="{ACE3DCB2-1ABF-226C-0016-1D652ADD016D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15555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8" name="直線コネクタ 227">
                      <a:extLst>
                        <a:ext uri="{FF2B5EF4-FFF2-40B4-BE49-F238E27FC236}">
                          <a16:creationId xmlns:a16="http://schemas.microsoft.com/office/drawing/2014/main" id="{3CA63D37-8D10-76F1-0A8E-1797C1FF275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rgbClr val="FF0000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29" name="楕円 228">
                      <a:extLst>
                        <a:ext uri="{FF2B5EF4-FFF2-40B4-BE49-F238E27FC236}">
                          <a16:creationId xmlns:a16="http://schemas.microsoft.com/office/drawing/2014/main" id="{033C5C23-7E76-7938-A8F1-D28DF527B8B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16" name="グループ化 215">
                  <a:extLst>
                    <a:ext uri="{FF2B5EF4-FFF2-40B4-BE49-F238E27FC236}">
                      <a16:creationId xmlns:a16="http://schemas.microsoft.com/office/drawing/2014/main" id="{DE0CA0B5-D15A-AFE8-0F72-E73328E22AD4}"/>
                    </a:ext>
                  </a:extLst>
                </p:cNvPr>
                <p:cNvGrpSpPr/>
                <p:nvPr/>
              </p:nvGrpSpPr>
              <p:grpSpPr>
                <a:xfrm>
                  <a:off x="7837938" y="2845511"/>
                  <a:ext cx="1473115" cy="215444"/>
                  <a:chOff x="4782318" y="3352318"/>
                  <a:chExt cx="1473115" cy="215444"/>
                </a:xfrm>
              </p:grpSpPr>
              <p:sp>
                <p:nvSpPr>
                  <p:cNvPr id="222" name="正方形/長方形 221">
                    <a:extLst>
                      <a:ext uri="{FF2B5EF4-FFF2-40B4-BE49-F238E27FC236}">
                        <a16:creationId xmlns:a16="http://schemas.microsoft.com/office/drawing/2014/main" id="{E1EE5615-B726-4E45-5B71-965CEC8C1E05}"/>
                      </a:ext>
                    </a:extLst>
                  </p:cNvPr>
                  <p:cNvSpPr/>
                  <p:nvPr/>
                </p:nvSpPr>
                <p:spPr>
                  <a:xfrm>
                    <a:off x="5169114" y="3352318"/>
                    <a:ext cx="1086319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CC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8)</a:t>
                    </a:r>
                  </a:p>
                </p:txBody>
              </p:sp>
              <p:grpSp>
                <p:nvGrpSpPr>
                  <p:cNvPr id="223" name="グループ化 222">
                    <a:extLst>
                      <a:ext uri="{FF2B5EF4-FFF2-40B4-BE49-F238E27FC236}">
                        <a16:creationId xmlns:a16="http://schemas.microsoft.com/office/drawing/2014/main" id="{2974A6AC-32E3-A5AA-E795-B387C5C49C68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388040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4" name="直線コネクタ 223">
                      <a:extLst>
                        <a:ext uri="{FF2B5EF4-FFF2-40B4-BE49-F238E27FC236}">
                          <a16:creationId xmlns:a16="http://schemas.microsoft.com/office/drawing/2014/main" id="{D9FADA4E-13B3-97CD-4FA9-D9A33284B98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solidFill>
                      <a:srgbClr val="00B050"/>
                    </a:solidFill>
                    <a:ln w="38100" cap="flat">
                      <a:solidFill>
                        <a:srgbClr val="0000FF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25" name="楕円 224">
                      <a:extLst>
                        <a:ext uri="{FF2B5EF4-FFF2-40B4-BE49-F238E27FC236}">
                          <a16:creationId xmlns:a16="http://schemas.microsoft.com/office/drawing/2014/main" id="{639AE82E-650B-C5ED-7DC8-7941BBE0735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217" name="グループ化 216">
                  <a:extLst>
                    <a:ext uri="{FF2B5EF4-FFF2-40B4-BE49-F238E27FC236}">
                      <a16:creationId xmlns:a16="http://schemas.microsoft.com/office/drawing/2014/main" id="{C4DF1081-DEBE-4173-2C53-BEF225AB61C7}"/>
                    </a:ext>
                  </a:extLst>
                </p:cNvPr>
                <p:cNvGrpSpPr/>
                <p:nvPr/>
              </p:nvGrpSpPr>
              <p:grpSpPr>
                <a:xfrm>
                  <a:off x="4683258" y="2845511"/>
                  <a:ext cx="1501328" cy="215444"/>
                  <a:chOff x="4782318" y="2845511"/>
                  <a:chExt cx="1501328" cy="215444"/>
                </a:xfrm>
              </p:grpSpPr>
              <p:sp>
                <p:nvSpPr>
                  <p:cNvPr id="218" name="正方形/長方形 217">
                    <a:extLst>
                      <a:ext uri="{FF2B5EF4-FFF2-40B4-BE49-F238E27FC236}">
                        <a16:creationId xmlns:a16="http://schemas.microsoft.com/office/drawing/2014/main" id="{91B7894A-6CF3-EC1B-A92C-7C74EFAA75AF}"/>
                      </a:ext>
                    </a:extLst>
                  </p:cNvPr>
                  <p:cNvSpPr/>
                  <p:nvPr/>
                </p:nvSpPr>
                <p:spPr>
                  <a:xfrm>
                    <a:off x="5169114" y="2845511"/>
                    <a:ext cx="1114532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Total</a:t>
                    </a:r>
                    <a:r>
                      <a:rPr lang="ja-JP" altLang="en-US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93)</a:t>
                    </a:r>
                  </a:p>
                </p:txBody>
              </p:sp>
              <p:grpSp>
                <p:nvGrpSpPr>
                  <p:cNvPr id="219" name="グループ化 218">
                    <a:extLst>
                      <a:ext uri="{FF2B5EF4-FFF2-40B4-BE49-F238E27FC236}">
                        <a16:creationId xmlns:a16="http://schemas.microsoft.com/office/drawing/2014/main" id="{F7B610EC-A289-E9D1-44A4-706C6CF1912D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288123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220" name="直線コネクタ 219">
                      <a:extLst>
                        <a:ext uri="{FF2B5EF4-FFF2-40B4-BE49-F238E27FC236}">
                          <a16:creationId xmlns:a16="http://schemas.microsoft.com/office/drawing/2014/main" id="{0CAC85D5-416B-1518-F448-980375CC45D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chemeClr val="tx1"/>
                      </a:solidFill>
                      <a:prstDash val="soli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221" name="楕円 220">
                      <a:extLst>
                        <a:ext uri="{FF2B5EF4-FFF2-40B4-BE49-F238E27FC236}">
                          <a16:creationId xmlns:a16="http://schemas.microsoft.com/office/drawing/2014/main" id="{80CF6357-EA55-E8D1-4C22-1AE4E8B73D0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E02716F4-DBD0-95B3-82B5-886964BA24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270753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正方形/長方形 30">
                <a:extLst>
                  <a:ext uri="{FF2B5EF4-FFF2-40B4-BE49-F238E27FC236}">
                    <a16:creationId xmlns:a16="http://schemas.microsoft.com/office/drawing/2014/main" id="{3747456D-D572-3A20-E1D7-C275F14642E5}"/>
                  </a:ext>
                </a:extLst>
              </p:cNvPr>
              <p:cNvSpPr/>
              <p:nvPr/>
            </p:nvSpPr>
            <p:spPr>
              <a:xfrm>
                <a:off x="2555974" y="258335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3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76405BC9-0C31-9B1B-EA44-797C9C9234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2247941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正方形/長方形 32">
                <a:extLst>
                  <a:ext uri="{FF2B5EF4-FFF2-40B4-BE49-F238E27FC236}">
                    <a16:creationId xmlns:a16="http://schemas.microsoft.com/office/drawing/2014/main" id="{B6688379-8FFC-C247-099C-74AB42F4AB38}"/>
                  </a:ext>
                </a:extLst>
              </p:cNvPr>
              <p:cNvSpPr/>
              <p:nvPr/>
            </p:nvSpPr>
            <p:spPr>
              <a:xfrm>
                <a:off x="2555974" y="212369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2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F7D36EAA-E726-6CB9-15CA-D324F49BC6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1330659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正方形/長方形 34">
                <a:extLst>
                  <a:ext uri="{FF2B5EF4-FFF2-40B4-BE49-F238E27FC236}">
                    <a16:creationId xmlns:a16="http://schemas.microsoft.com/office/drawing/2014/main" id="{DB2C71F9-AAC9-E51B-1573-8FF2DF8F5A7D}"/>
                  </a:ext>
                </a:extLst>
              </p:cNvPr>
              <p:cNvSpPr/>
              <p:nvPr/>
            </p:nvSpPr>
            <p:spPr>
              <a:xfrm>
                <a:off x="2790012" y="1207549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56" name="直線コネクタ 355">
                <a:extLst>
                  <a:ext uri="{FF2B5EF4-FFF2-40B4-BE49-F238E27FC236}">
                    <a16:creationId xmlns:a16="http://schemas.microsoft.com/office/drawing/2014/main" id="{1F0D2496-0225-748C-B653-F75E5248D3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1558556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7" name="正方形/長方形 356">
                <a:extLst>
                  <a:ext uri="{FF2B5EF4-FFF2-40B4-BE49-F238E27FC236}">
                    <a16:creationId xmlns:a16="http://schemas.microsoft.com/office/drawing/2014/main" id="{98C8E660-C727-AE7D-D625-23DE961E9D59}"/>
                  </a:ext>
                </a:extLst>
              </p:cNvPr>
              <p:cNvSpPr/>
              <p:nvPr/>
            </p:nvSpPr>
            <p:spPr>
              <a:xfrm>
                <a:off x="2669787" y="1434204"/>
                <a:ext cx="23403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58" name="直線コネクタ 357">
                <a:extLst>
                  <a:ext uri="{FF2B5EF4-FFF2-40B4-BE49-F238E27FC236}">
                    <a16:creationId xmlns:a16="http://schemas.microsoft.com/office/drawing/2014/main" id="{14561CBC-2EA1-0391-D4DF-46DF5E0E1A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2018146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9" name="正方形/長方形 358">
                <a:extLst>
                  <a:ext uri="{FF2B5EF4-FFF2-40B4-BE49-F238E27FC236}">
                    <a16:creationId xmlns:a16="http://schemas.microsoft.com/office/drawing/2014/main" id="{9C684F76-703E-61BA-7709-E7E48CFCE0CF}"/>
                  </a:ext>
                </a:extLst>
              </p:cNvPr>
              <p:cNvSpPr/>
              <p:nvPr/>
            </p:nvSpPr>
            <p:spPr>
              <a:xfrm>
                <a:off x="2555974" y="1893864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63A3033F-1EEF-6DA0-3FB0-D2558880217E}"/>
                  </a:ext>
                </a:extLst>
              </p:cNvPr>
              <p:cNvSpPr/>
              <p:nvPr/>
            </p:nvSpPr>
            <p:spPr>
              <a:xfrm>
                <a:off x="3097080" y="541353"/>
                <a:ext cx="78386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Baseline</a:t>
                </a:r>
              </a:p>
            </p:txBody>
          </p: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12027306-1A77-E580-A1DD-F2115B0614F7}"/>
                  </a:ext>
                </a:extLst>
              </p:cNvPr>
              <p:cNvSpPr/>
              <p:nvPr/>
            </p:nvSpPr>
            <p:spPr>
              <a:xfrm>
                <a:off x="4753339" y="541353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4</a:t>
                </a: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491AC346-69ED-593F-4E5D-62481EF7E2B3}"/>
                  </a:ext>
                </a:extLst>
              </p:cNvPr>
              <p:cNvSpPr/>
              <p:nvPr/>
            </p:nvSpPr>
            <p:spPr>
              <a:xfrm>
                <a:off x="6350257" y="541353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8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FBB8C590-1F71-F0F3-76C9-6612FC9FE3DF}"/>
                  </a:ext>
                </a:extLst>
              </p:cNvPr>
              <p:cNvSpPr/>
              <p:nvPr/>
            </p:nvSpPr>
            <p:spPr>
              <a:xfrm>
                <a:off x="7901621" y="541353"/>
                <a:ext cx="805798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12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7" name="正方形/長方形 36">
                <a:extLst>
                  <a:ext uri="{FF2B5EF4-FFF2-40B4-BE49-F238E27FC236}">
                    <a16:creationId xmlns:a16="http://schemas.microsoft.com/office/drawing/2014/main" id="{6834426A-9A0C-2E83-E615-61822CB08B03}"/>
                  </a:ext>
                </a:extLst>
              </p:cNvPr>
              <p:cNvSpPr/>
              <p:nvPr/>
            </p:nvSpPr>
            <p:spPr>
              <a:xfrm>
                <a:off x="9678810" y="541356"/>
                <a:ext cx="421590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EOT</a:t>
                </a:r>
              </a:p>
            </p:txBody>
          </p:sp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32BEEC42-FC15-7E6C-E094-DC21B67B47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9014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>
                <a:extLst>
                  <a:ext uri="{FF2B5EF4-FFF2-40B4-BE49-F238E27FC236}">
                    <a16:creationId xmlns:a16="http://schemas.microsoft.com/office/drawing/2014/main" id="{41A69A13-5482-D4E6-72DF-87E33782EA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96249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線コネクタ 39">
                <a:extLst>
                  <a:ext uri="{FF2B5EF4-FFF2-40B4-BE49-F238E27FC236}">
                    <a16:creationId xmlns:a16="http://schemas.microsoft.com/office/drawing/2014/main" id="{A75E46D1-E69B-DBFC-C22F-A5540240A7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04520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コネクタ 40">
                <a:extLst>
                  <a:ext uri="{FF2B5EF4-FFF2-40B4-BE49-F238E27FC236}">
                    <a16:creationId xmlns:a16="http://schemas.microsoft.com/office/drawing/2014/main" id="{5043FA50-202F-5E7E-7A8B-60A892D9D2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89605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0FF669B1-DD30-2B5B-841D-FB445553A2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99331" y="797690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90" name="グループ化 389">
                <a:extLst>
                  <a:ext uri="{FF2B5EF4-FFF2-40B4-BE49-F238E27FC236}">
                    <a16:creationId xmlns:a16="http://schemas.microsoft.com/office/drawing/2014/main" id="{8C7F2B6D-684F-DF66-70F7-F544FCA0BE57}"/>
                  </a:ext>
                </a:extLst>
              </p:cNvPr>
              <p:cNvGrpSpPr/>
              <p:nvPr/>
            </p:nvGrpSpPr>
            <p:grpSpPr>
              <a:xfrm>
                <a:off x="3578991" y="949690"/>
                <a:ext cx="6585760" cy="1777106"/>
                <a:chOff x="3581902" y="949690"/>
                <a:chExt cx="6585760" cy="1777106"/>
              </a:xfrm>
            </p:grpSpPr>
            <p:grpSp>
              <p:nvGrpSpPr>
                <p:cNvPr id="388" name="グループ化 387">
                  <a:extLst>
                    <a:ext uri="{FF2B5EF4-FFF2-40B4-BE49-F238E27FC236}">
                      <a16:creationId xmlns:a16="http://schemas.microsoft.com/office/drawing/2014/main" id="{888EF4E3-2A41-280C-BCEB-897C7AA818C2}"/>
                    </a:ext>
                  </a:extLst>
                </p:cNvPr>
                <p:cNvGrpSpPr/>
                <p:nvPr/>
              </p:nvGrpSpPr>
              <p:grpSpPr>
                <a:xfrm>
                  <a:off x="5207582" y="949690"/>
                  <a:ext cx="4960080" cy="1777106"/>
                  <a:chOff x="5207582" y="949690"/>
                  <a:chExt cx="4960080" cy="1777106"/>
                </a:xfrm>
              </p:grpSpPr>
              <p:grpSp>
                <p:nvGrpSpPr>
                  <p:cNvPr id="76" name="グループ化 75">
                    <a:extLst>
                      <a:ext uri="{FF2B5EF4-FFF2-40B4-BE49-F238E27FC236}">
                        <a16:creationId xmlns:a16="http://schemas.microsoft.com/office/drawing/2014/main" id="{9BAD5FEF-8784-0929-9F99-CE30AE1C99C3}"/>
                      </a:ext>
                    </a:extLst>
                  </p:cNvPr>
                  <p:cNvGrpSpPr/>
                  <p:nvPr/>
                </p:nvGrpSpPr>
                <p:grpSpPr>
                  <a:xfrm>
                    <a:off x="5207582" y="1019132"/>
                    <a:ext cx="108000" cy="1628818"/>
                    <a:chOff x="3181267" y="2597151"/>
                    <a:chExt cx="108000" cy="2157062"/>
                  </a:xfrm>
                </p:grpSpPr>
                <p:cxnSp>
                  <p:nvCxnSpPr>
                    <p:cNvPr id="91" name="直線コネクタ 90">
                      <a:extLst>
                        <a:ext uri="{FF2B5EF4-FFF2-40B4-BE49-F238E27FC236}">
                          <a16:creationId xmlns:a16="http://schemas.microsoft.com/office/drawing/2014/main" id="{F5BBE91F-6FEB-30C5-1764-85EE85FD163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2" name="直線コネクタ 91">
                      <a:extLst>
                        <a:ext uri="{FF2B5EF4-FFF2-40B4-BE49-F238E27FC236}">
                          <a16:creationId xmlns:a16="http://schemas.microsoft.com/office/drawing/2014/main" id="{94AABA7D-DDB0-EFF0-F23D-AF90FC3AFDB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" name="直線コネクタ 92">
                      <a:extLst>
                        <a:ext uri="{FF2B5EF4-FFF2-40B4-BE49-F238E27FC236}">
                          <a16:creationId xmlns:a16="http://schemas.microsoft.com/office/drawing/2014/main" id="{96437F36-C96C-2C96-D20D-3EEB08B92B1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7" name="グループ化 76">
                    <a:extLst>
                      <a:ext uri="{FF2B5EF4-FFF2-40B4-BE49-F238E27FC236}">
                        <a16:creationId xmlns:a16="http://schemas.microsoft.com/office/drawing/2014/main" id="{7B3620A5-F6F4-68D6-9E4D-60528D3FF454}"/>
                      </a:ext>
                    </a:extLst>
                  </p:cNvPr>
                  <p:cNvGrpSpPr/>
                  <p:nvPr/>
                </p:nvGrpSpPr>
                <p:grpSpPr>
                  <a:xfrm>
                    <a:off x="6806881" y="949690"/>
                    <a:ext cx="108000" cy="1595866"/>
                    <a:chOff x="3181267" y="2597151"/>
                    <a:chExt cx="108000" cy="2157062"/>
                  </a:xfrm>
                </p:grpSpPr>
                <p:cxnSp>
                  <p:nvCxnSpPr>
                    <p:cNvPr id="88" name="直線コネクタ 87">
                      <a:extLst>
                        <a:ext uri="{FF2B5EF4-FFF2-40B4-BE49-F238E27FC236}">
                          <a16:creationId xmlns:a16="http://schemas.microsoft.com/office/drawing/2014/main" id="{1FCC98B4-03CC-C47E-67E6-ECFBA5440DD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" name="直線コネクタ 88">
                      <a:extLst>
                        <a:ext uri="{FF2B5EF4-FFF2-40B4-BE49-F238E27FC236}">
                          <a16:creationId xmlns:a16="http://schemas.microsoft.com/office/drawing/2014/main" id="{25E1C74C-C34C-3462-E07A-8045CD6E31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" name="直線コネクタ 89">
                      <a:extLst>
                        <a:ext uri="{FF2B5EF4-FFF2-40B4-BE49-F238E27FC236}">
                          <a16:creationId xmlns:a16="http://schemas.microsoft.com/office/drawing/2014/main" id="{C5DBECCC-BE9F-07F4-16A8-54B6D26F359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86" name="グループ化 385">
                    <a:extLst>
                      <a:ext uri="{FF2B5EF4-FFF2-40B4-BE49-F238E27FC236}">
                        <a16:creationId xmlns:a16="http://schemas.microsoft.com/office/drawing/2014/main" id="{470DA52E-5943-5C6B-2D57-8F2042C9A4E2}"/>
                      </a:ext>
                    </a:extLst>
                  </p:cNvPr>
                  <p:cNvGrpSpPr/>
                  <p:nvPr/>
                </p:nvGrpSpPr>
                <p:grpSpPr>
                  <a:xfrm>
                    <a:off x="8360287" y="1019175"/>
                    <a:ext cx="211596" cy="1707621"/>
                    <a:chOff x="8360287" y="1019175"/>
                    <a:chExt cx="211596" cy="1707621"/>
                  </a:xfrm>
                </p:grpSpPr>
                <p:sp>
                  <p:nvSpPr>
                    <p:cNvPr id="36" name="テキスト ボックス 35">
                      <a:extLst>
                        <a:ext uri="{FF2B5EF4-FFF2-40B4-BE49-F238E27FC236}">
                          <a16:creationId xmlns:a16="http://schemas.microsoft.com/office/drawing/2014/main" id="{F6800CFA-E185-95EA-A87E-E3710822BA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60287" y="2475001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  <p:grpSp>
                  <p:nvGrpSpPr>
                    <p:cNvPr id="78" name="グループ化 77">
                      <a:extLst>
                        <a:ext uri="{FF2B5EF4-FFF2-40B4-BE49-F238E27FC236}">
                          <a16:creationId xmlns:a16="http://schemas.microsoft.com/office/drawing/2014/main" id="{3BAD8D94-D788-AE2D-F482-FA579C490DF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12352" y="1019175"/>
                      <a:ext cx="108000" cy="1440039"/>
                      <a:chOff x="9259442" y="1742178"/>
                      <a:chExt cx="108000" cy="310645"/>
                    </a:xfrm>
                  </p:grpSpPr>
                  <p:cxnSp>
                    <p:nvCxnSpPr>
                      <p:cNvPr id="85" name="直線コネクタ 84">
                        <a:extLst>
                          <a:ext uri="{FF2B5EF4-FFF2-40B4-BE49-F238E27FC236}">
                            <a16:creationId xmlns:a16="http://schemas.microsoft.com/office/drawing/2014/main" id="{0E1765E4-9BC6-2A66-DF7B-94312524EB4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313442" y="1742178"/>
                        <a:ext cx="0" cy="310645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6" name="直線コネクタ 85">
                        <a:extLst>
                          <a:ext uri="{FF2B5EF4-FFF2-40B4-BE49-F238E27FC236}">
                            <a16:creationId xmlns:a16="http://schemas.microsoft.com/office/drawing/2014/main" id="{DB897539-9348-9821-CE7D-DA6395AC5C8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205282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7" name="直線コネクタ 86">
                        <a:extLst>
                          <a:ext uri="{FF2B5EF4-FFF2-40B4-BE49-F238E27FC236}">
                            <a16:creationId xmlns:a16="http://schemas.microsoft.com/office/drawing/2014/main" id="{10C61692-29D3-8AB9-3EE3-3A702055BF8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1742178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87" name="グループ化 386">
                    <a:extLst>
                      <a:ext uri="{FF2B5EF4-FFF2-40B4-BE49-F238E27FC236}">
                        <a16:creationId xmlns:a16="http://schemas.microsoft.com/office/drawing/2014/main" id="{48161E8F-5C2A-DAC4-3391-E5B7136CB491}"/>
                      </a:ext>
                    </a:extLst>
                  </p:cNvPr>
                  <p:cNvGrpSpPr/>
                  <p:nvPr/>
                </p:nvGrpSpPr>
                <p:grpSpPr>
                  <a:xfrm>
                    <a:off x="9956066" y="1028700"/>
                    <a:ext cx="211596" cy="1694201"/>
                    <a:chOff x="9956066" y="1028700"/>
                    <a:chExt cx="211596" cy="1694201"/>
                  </a:xfrm>
                </p:grpSpPr>
                <p:grpSp>
                  <p:nvGrpSpPr>
                    <p:cNvPr id="80" name="グループ化 79">
                      <a:extLst>
                        <a:ext uri="{FF2B5EF4-FFF2-40B4-BE49-F238E27FC236}">
                          <a16:creationId xmlns:a16="http://schemas.microsoft.com/office/drawing/2014/main" id="{F43D89BB-2753-7BB1-9E63-C3B9EF8CF9D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07866" y="1028700"/>
                      <a:ext cx="108000" cy="1439105"/>
                      <a:chOff x="3181267" y="2597151"/>
                      <a:chExt cx="108000" cy="2157062"/>
                    </a:xfrm>
                  </p:grpSpPr>
                  <p:cxnSp>
                    <p:nvCxnSpPr>
                      <p:cNvPr id="82" name="直線コネクタ 81">
                        <a:extLst>
                          <a:ext uri="{FF2B5EF4-FFF2-40B4-BE49-F238E27FC236}">
                            <a16:creationId xmlns:a16="http://schemas.microsoft.com/office/drawing/2014/main" id="{77A879D0-4F9E-B883-D274-8F26ABA50AD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3" name="直線コネクタ 82">
                        <a:extLst>
                          <a:ext uri="{FF2B5EF4-FFF2-40B4-BE49-F238E27FC236}">
                            <a16:creationId xmlns:a16="http://schemas.microsoft.com/office/drawing/2014/main" id="{D221BFF0-9579-081A-4C11-446B3558D3B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4" name="直線コネクタ 83">
                        <a:extLst>
                          <a:ext uri="{FF2B5EF4-FFF2-40B4-BE49-F238E27FC236}">
                            <a16:creationId xmlns:a16="http://schemas.microsoft.com/office/drawing/2014/main" id="{CA4E7B90-E2B3-A66B-7B2E-8225B53211C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81" name="テキスト ボックス 80">
                      <a:extLst>
                        <a:ext uri="{FF2B5EF4-FFF2-40B4-BE49-F238E27FC236}">
                          <a16:creationId xmlns:a16="http://schemas.microsoft.com/office/drawing/2014/main" id="{60BA802E-AFF7-DB77-FD56-C0D451C1F7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56066" y="2471106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85" name="グループ化 384">
                  <a:extLst>
                    <a:ext uri="{FF2B5EF4-FFF2-40B4-BE49-F238E27FC236}">
                      <a16:creationId xmlns:a16="http://schemas.microsoft.com/office/drawing/2014/main" id="{E77DF35B-F10D-CBF0-0FAD-69EDB92DD7C3}"/>
                    </a:ext>
                  </a:extLst>
                </p:cNvPr>
                <p:cNvGrpSpPr/>
                <p:nvPr/>
              </p:nvGrpSpPr>
              <p:grpSpPr>
                <a:xfrm>
                  <a:off x="3581902" y="1258659"/>
                  <a:ext cx="6551963" cy="642463"/>
                  <a:chOff x="3581902" y="1258659"/>
                  <a:chExt cx="6551963" cy="642463"/>
                </a:xfrm>
              </p:grpSpPr>
              <p:sp>
                <p:nvSpPr>
                  <p:cNvPr id="71" name="楕円 70">
                    <a:extLst>
                      <a:ext uri="{FF2B5EF4-FFF2-40B4-BE49-F238E27FC236}">
                        <a16:creationId xmlns:a16="http://schemas.microsoft.com/office/drawing/2014/main" id="{31AE0682-B932-4737-991B-E3E84E05CDCC}"/>
                      </a:ext>
                    </a:extLst>
                  </p:cNvPr>
                  <p:cNvSpPr/>
                  <p:nvPr/>
                </p:nvSpPr>
                <p:spPr>
                  <a:xfrm>
                    <a:off x="3581902" y="1258659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楕円 71">
                    <a:extLst>
                      <a:ext uri="{FF2B5EF4-FFF2-40B4-BE49-F238E27FC236}">
                        <a16:creationId xmlns:a16="http://schemas.microsoft.com/office/drawing/2014/main" id="{4D97B4F2-E836-BDD9-B111-423D6ED721E6}"/>
                      </a:ext>
                    </a:extLst>
                  </p:cNvPr>
                  <p:cNvSpPr/>
                  <p:nvPr/>
                </p:nvSpPr>
                <p:spPr>
                  <a:xfrm>
                    <a:off x="5189581" y="1757122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楕円 72">
                    <a:extLst>
                      <a:ext uri="{FF2B5EF4-FFF2-40B4-BE49-F238E27FC236}">
                        <a16:creationId xmlns:a16="http://schemas.microsoft.com/office/drawing/2014/main" id="{8DB5A546-170E-5FA6-4E81-361A66A6E76A}"/>
                      </a:ext>
                    </a:extLst>
                  </p:cNvPr>
                  <p:cNvSpPr/>
                  <p:nvPr/>
                </p:nvSpPr>
                <p:spPr>
                  <a:xfrm>
                    <a:off x="6788880" y="1677079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楕円 73">
                    <a:extLst>
                      <a:ext uri="{FF2B5EF4-FFF2-40B4-BE49-F238E27FC236}">
                        <a16:creationId xmlns:a16="http://schemas.microsoft.com/office/drawing/2014/main" id="{8E28EC91-E581-47AF-4029-7F2D172AC01C}"/>
                      </a:ext>
                    </a:extLst>
                  </p:cNvPr>
                  <p:cNvSpPr/>
                  <p:nvPr/>
                </p:nvSpPr>
                <p:spPr>
                  <a:xfrm>
                    <a:off x="8394351" y="1665931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" name="楕円 74">
                    <a:extLst>
                      <a:ext uri="{FF2B5EF4-FFF2-40B4-BE49-F238E27FC236}">
                        <a16:creationId xmlns:a16="http://schemas.microsoft.com/office/drawing/2014/main" id="{6CC7C957-E903-0EFF-7C81-DDFC06A614AA}"/>
                      </a:ext>
                    </a:extLst>
                  </p:cNvPr>
                  <p:cNvSpPr/>
                  <p:nvPr/>
                </p:nvSpPr>
                <p:spPr>
                  <a:xfrm>
                    <a:off x="9989865" y="1677311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9" name="フリーフォーム: 図形 388">
                  <a:extLst>
                    <a:ext uri="{FF2B5EF4-FFF2-40B4-BE49-F238E27FC236}">
                      <a16:creationId xmlns:a16="http://schemas.microsoft.com/office/drawing/2014/main" id="{FA07C90C-3CB1-5C83-EADF-7607CAE7C001}"/>
                    </a:ext>
                  </a:extLst>
                </p:cNvPr>
                <p:cNvSpPr/>
                <p:nvPr/>
              </p:nvSpPr>
              <p:spPr>
                <a:xfrm>
                  <a:off x="3648075" y="1328738"/>
                  <a:ext cx="4819650" cy="504825"/>
                </a:xfrm>
                <a:custGeom>
                  <a:avLst/>
                  <a:gdLst>
                    <a:gd name="connsiteX0" fmla="*/ 0 w 4819650"/>
                    <a:gd name="connsiteY0" fmla="*/ 0 h 504825"/>
                    <a:gd name="connsiteX1" fmla="*/ 1609725 w 4819650"/>
                    <a:gd name="connsiteY1" fmla="*/ 504825 h 504825"/>
                    <a:gd name="connsiteX2" fmla="*/ 3209925 w 4819650"/>
                    <a:gd name="connsiteY2" fmla="*/ 423862 h 504825"/>
                    <a:gd name="connsiteX3" fmla="*/ 4819650 w 4819650"/>
                    <a:gd name="connsiteY3" fmla="*/ 409575 h 504825"/>
                    <a:gd name="connsiteX0" fmla="*/ 0 w 4819650"/>
                    <a:gd name="connsiteY0" fmla="*/ 0 h 504825"/>
                    <a:gd name="connsiteX1" fmla="*/ 1609725 w 4819650"/>
                    <a:gd name="connsiteY1" fmla="*/ 504825 h 504825"/>
                    <a:gd name="connsiteX2" fmla="*/ 3209925 w 4819650"/>
                    <a:gd name="connsiteY2" fmla="*/ 423862 h 504825"/>
                    <a:gd name="connsiteX3" fmla="*/ 4819650 w 4819650"/>
                    <a:gd name="connsiteY3" fmla="*/ 409575 h 5048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9650" h="504825">
                      <a:moveTo>
                        <a:pt x="0" y="0"/>
                      </a:moveTo>
                      <a:lnTo>
                        <a:pt x="1609725" y="504825"/>
                      </a:lnTo>
                      <a:lnTo>
                        <a:pt x="3209925" y="423862"/>
                      </a:lnTo>
                      <a:lnTo>
                        <a:pt x="4819650" y="409575"/>
                      </a:lnTo>
                    </a:path>
                  </a:pathLst>
                </a:custGeom>
                <a:noFill/>
                <a:ln w="3810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80" name="グループ化 379">
                <a:extLst>
                  <a:ext uri="{FF2B5EF4-FFF2-40B4-BE49-F238E27FC236}">
                    <a16:creationId xmlns:a16="http://schemas.microsoft.com/office/drawing/2014/main" id="{B8042DF9-A380-941A-2A29-A8CBBA79F328}"/>
                  </a:ext>
                </a:extLst>
              </p:cNvPr>
              <p:cNvGrpSpPr/>
              <p:nvPr/>
            </p:nvGrpSpPr>
            <p:grpSpPr>
              <a:xfrm>
                <a:off x="3417010" y="962025"/>
                <a:ext cx="6595289" cy="2135470"/>
                <a:chOff x="3419921" y="962025"/>
                <a:chExt cx="6595289" cy="2135470"/>
              </a:xfrm>
            </p:grpSpPr>
            <p:grpSp>
              <p:nvGrpSpPr>
                <p:cNvPr id="378" name="グループ化 377">
                  <a:extLst>
                    <a:ext uri="{FF2B5EF4-FFF2-40B4-BE49-F238E27FC236}">
                      <a16:creationId xmlns:a16="http://schemas.microsoft.com/office/drawing/2014/main" id="{5C572911-7BC3-8C4C-E233-43EFDF59059F}"/>
                    </a:ext>
                  </a:extLst>
                </p:cNvPr>
                <p:cNvGrpSpPr/>
                <p:nvPr/>
              </p:nvGrpSpPr>
              <p:grpSpPr>
                <a:xfrm>
                  <a:off x="5045601" y="962025"/>
                  <a:ext cx="4969609" cy="2135470"/>
                  <a:chOff x="5045601" y="962025"/>
                  <a:chExt cx="4969609" cy="2135470"/>
                </a:xfrm>
              </p:grpSpPr>
              <p:grpSp>
                <p:nvGrpSpPr>
                  <p:cNvPr id="48" name="グループ化 47">
                    <a:extLst>
                      <a:ext uri="{FF2B5EF4-FFF2-40B4-BE49-F238E27FC236}">
                        <a16:creationId xmlns:a16="http://schemas.microsoft.com/office/drawing/2014/main" id="{5A69ECAB-AEB5-D412-E859-5037B847BD80}"/>
                      </a:ext>
                    </a:extLst>
                  </p:cNvPr>
                  <p:cNvGrpSpPr/>
                  <p:nvPr/>
                </p:nvGrpSpPr>
                <p:grpSpPr>
                  <a:xfrm>
                    <a:off x="5045601" y="1154906"/>
                    <a:ext cx="108000" cy="1622902"/>
                    <a:chOff x="3181267" y="2597151"/>
                    <a:chExt cx="108000" cy="2157062"/>
                  </a:xfrm>
                </p:grpSpPr>
                <p:cxnSp>
                  <p:nvCxnSpPr>
                    <p:cNvPr id="65" name="直線コネクタ 64">
                      <a:extLst>
                        <a:ext uri="{FF2B5EF4-FFF2-40B4-BE49-F238E27FC236}">
                          <a16:creationId xmlns:a16="http://schemas.microsoft.com/office/drawing/2014/main" id="{DBC5F772-EFB1-A66A-D9B2-A91756CEC6F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6" name="直線コネクタ 65">
                      <a:extLst>
                        <a:ext uri="{FF2B5EF4-FFF2-40B4-BE49-F238E27FC236}">
                          <a16:creationId xmlns:a16="http://schemas.microsoft.com/office/drawing/2014/main" id="{C3FF6F27-8394-8CFC-8241-18F822F790C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7" name="直線コネクタ 66">
                      <a:extLst>
                        <a:ext uri="{FF2B5EF4-FFF2-40B4-BE49-F238E27FC236}">
                          <a16:creationId xmlns:a16="http://schemas.microsoft.com/office/drawing/2014/main" id="{D4998012-7AD5-F55C-369F-1EF5D01FBFF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9" name="グループ化 48">
                    <a:extLst>
                      <a:ext uri="{FF2B5EF4-FFF2-40B4-BE49-F238E27FC236}">
                        <a16:creationId xmlns:a16="http://schemas.microsoft.com/office/drawing/2014/main" id="{AFBF6EBB-522E-7D74-BE29-262598C6565D}"/>
                      </a:ext>
                    </a:extLst>
                  </p:cNvPr>
                  <p:cNvGrpSpPr/>
                  <p:nvPr/>
                </p:nvGrpSpPr>
                <p:grpSpPr>
                  <a:xfrm>
                    <a:off x="6644900" y="1184751"/>
                    <a:ext cx="108000" cy="1475105"/>
                    <a:chOff x="3181267" y="2597151"/>
                    <a:chExt cx="108000" cy="2157062"/>
                  </a:xfrm>
                </p:grpSpPr>
                <p:cxnSp>
                  <p:nvCxnSpPr>
                    <p:cNvPr id="62" name="直線コネクタ 61">
                      <a:extLst>
                        <a:ext uri="{FF2B5EF4-FFF2-40B4-BE49-F238E27FC236}">
                          <a16:creationId xmlns:a16="http://schemas.microsoft.com/office/drawing/2014/main" id="{9D4E9D51-4489-216E-AFEE-DB6BF7EE76C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" name="直線コネクタ 62">
                      <a:extLst>
                        <a:ext uri="{FF2B5EF4-FFF2-40B4-BE49-F238E27FC236}">
                          <a16:creationId xmlns:a16="http://schemas.microsoft.com/office/drawing/2014/main" id="{0A8D0B54-1CE5-3C4E-8948-C6CFD6EB009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" name="直線コネクタ 63">
                      <a:extLst>
                        <a:ext uri="{FF2B5EF4-FFF2-40B4-BE49-F238E27FC236}">
                          <a16:creationId xmlns:a16="http://schemas.microsoft.com/office/drawing/2014/main" id="{318A6386-5E4F-0859-4C64-EFDCBEF312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76" name="グループ化 375">
                    <a:extLst>
                      <a:ext uri="{FF2B5EF4-FFF2-40B4-BE49-F238E27FC236}">
                        <a16:creationId xmlns:a16="http://schemas.microsoft.com/office/drawing/2014/main" id="{0C6962AB-8518-E7FD-C762-8FC7A09392AB}"/>
                      </a:ext>
                    </a:extLst>
                  </p:cNvPr>
                  <p:cNvGrpSpPr/>
                  <p:nvPr/>
                </p:nvGrpSpPr>
                <p:grpSpPr>
                  <a:xfrm>
                    <a:off x="8198163" y="962025"/>
                    <a:ext cx="211596" cy="2100228"/>
                    <a:chOff x="8198163" y="962025"/>
                    <a:chExt cx="211596" cy="2100228"/>
                  </a:xfrm>
                </p:grpSpPr>
                <p:sp>
                  <p:nvSpPr>
                    <p:cNvPr id="57" name="テキスト ボックス 56">
                      <a:extLst>
                        <a:ext uri="{FF2B5EF4-FFF2-40B4-BE49-F238E27FC236}">
                          <a16:creationId xmlns:a16="http://schemas.microsoft.com/office/drawing/2014/main" id="{61C41824-40BB-7F13-0E74-93292478FC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98163" y="2810458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  <p:grpSp>
                  <p:nvGrpSpPr>
                    <p:cNvPr id="58" name="グループ化 57">
                      <a:extLst>
                        <a:ext uri="{FF2B5EF4-FFF2-40B4-BE49-F238E27FC236}">
                          <a16:creationId xmlns:a16="http://schemas.microsoft.com/office/drawing/2014/main" id="{FC9AA239-B8C7-D37B-D74D-3B71EAB3F73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50371" y="962025"/>
                      <a:ext cx="108000" cy="1846011"/>
                      <a:chOff x="3181267" y="2597151"/>
                      <a:chExt cx="108000" cy="2157062"/>
                    </a:xfrm>
                  </p:grpSpPr>
                  <p:cxnSp>
                    <p:nvCxnSpPr>
                      <p:cNvPr id="59" name="直線コネクタ 58">
                        <a:extLst>
                          <a:ext uri="{FF2B5EF4-FFF2-40B4-BE49-F238E27FC236}">
                            <a16:creationId xmlns:a16="http://schemas.microsoft.com/office/drawing/2014/main" id="{8D00F0B6-8644-2013-A2AB-78DE2438457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0" name="直線コネクタ 59">
                        <a:extLst>
                          <a:ext uri="{FF2B5EF4-FFF2-40B4-BE49-F238E27FC236}">
                            <a16:creationId xmlns:a16="http://schemas.microsoft.com/office/drawing/2014/main" id="{10A8E9A8-AEC9-3A94-3350-E2AAD7DD7AF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1" name="直線コネクタ 60">
                        <a:extLst>
                          <a:ext uri="{FF2B5EF4-FFF2-40B4-BE49-F238E27FC236}">
                            <a16:creationId xmlns:a16="http://schemas.microsoft.com/office/drawing/2014/main" id="{5BCDE871-6C14-FEF3-F282-AA483AF4DA4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77" name="グループ化 376">
                    <a:extLst>
                      <a:ext uri="{FF2B5EF4-FFF2-40B4-BE49-F238E27FC236}">
                        <a16:creationId xmlns:a16="http://schemas.microsoft.com/office/drawing/2014/main" id="{C36997C1-6A25-68D1-57C9-A533DBD9584E}"/>
                      </a:ext>
                    </a:extLst>
                  </p:cNvPr>
                  <p:cNvGrpSpPr/>
                  <p:nvPr/>
                </p:nvGrpSpPr>
                <p:grpSpPr>
                  <a:xfrm>
                    <a:off x="9803614" y="1002506"/>
                    <a:ext cx="211596" cy="2094989"/>
                    <a:chOff x="9803614" y="1002506"/>
                    <a:chExt cx="211596" cy="2094989"/>
                  </a:xfrm>
                </p:grpSpPr>
                <p:grpSp>
                  <p:nvGrpSpPr>
                    <p:cNvPr id="52" name="グループ化 51">
                      <a:extLst>
                        <a:ext uri="{FF2B5EF4-FFF2-40B4-BE49-F238E27FC236}">
                          <a16:creationId xmlns:a16="http://schemas.microsoft.com/office/drawing/2014/main" id="{CF5AFAC8-65A1-8346-E157-4D979E18E3F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845885" y="1002506"/>
                      <a:ext cx="108000" cy="1857558"/>
                      <a:chOff x="3181267" y="2597151"/>
                      <a:chExt cx="108000" cy="2157062"/>
                    </a:xfrm>
                  </p:grpSpPr>
                  <p:cxnSp>
                    <p:nvCxnSpPr>
                      <p:cNvPr id="54" name="直線コネクタ 53">
                        <a:extLst>
                          <a:ext uri="{FF2B5EF4-FFF2-40B4-BE49-F238E27FC236}">
                            <a16:creationId xmlns:a16="http://schemas.microsoft.com/office/drawing/2014/main" id="{90E9DB95-1D2D-1816-8759-D3CEEB5141B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" name="直線コネクタ 54">
                        <a:extLst>
                          <a:ext uri="{FF2B5EF4-FFF2-40B4-BE49-F238E27FC236}">
                            <a16:creationId xmlns:a16="http://schemas.microsoft.com/office/drawing/2014/main" id="{00A786A3-E754-CA02-8E36-0BF7B1028A6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" name="直線コネクタ 55">
                        <a:extLst>
                          <a:ext uri="{FF2B5EF4-FFF2-40B4-BE49-F238E27FC236}">
                            <a16:creationId xmlns:a16="http://schemas.microsoft.com/office/drawing/2014/main" id="{1DEE940F-A08E-3FDD-C4AA-34A841A7FE0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3" name="テキスト ボックス 52">
                      <a:extLst>
                        <a:ext uri="{FF2B5EF4-FFF2-40B4-BE49-F238E27FC236}">
                          <a16:creationId xmlns:a16="http://schemas.microsoft.com/office/drawing/2014/main" id="{F6669159-340C-3A66-CCA5-23A6729FBF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03614" y="2845700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74" name="グループ化 373">
                  <a:extLst>
                    <a:ext uri="{FF2B5EF4-FFF2-40B4-BE49-F238E27FC236}">
                      <a16:creationId xmlns:a16="http://schemas.microsoft.com/office/drawing/2014/main" id="{F51E95E4-FCBA-1A06-44C8-9F36F5C93E9A}"/>
                    </a:ext>
                  </a:extLst>
                </p:cNvPr>
                <p:cNvGrpSpPr/>
                <p:nvPr/>
              </p:nvGrpSpPr>
              <p:grpSpPr>
                <a:xfrm>
                  <a:off x="3419921" y="1258659"/>
                  <a:ext cx="6551963" cy="778398"/>
                  <a:chOff x="3419921" y="1258659"/>
                  <a:chExt cx="6551963" cy="778398"/>
                </a:xfrm>
              </p:grpSpPr>
              <p:sp>
                <p:nvSpPr>
                  <p:cNvPr id="43" name="楕円 42">
                    <a:extLst>
                      <a:ext uri="{FF2B5EF4-FFF2-40B4-BE49-F238E27FC236}">
                        <a16:creationId xmlns:a16="http://schemas.microsoft.com/office/drawing/2014/main" id="{B7195E4D-C2A6-3273-59EE-29FACC110E81}"/>
                      </a:ext>
                    </a:extLst>
                  </p:cNvPr>
                  <p:cNvSpPr/>
                  <p:nvPr/>
                </p:nvSpPr>
                <p:spPr>
                  <a:xfrm>
                    <a:off x="3419921" y="1258659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楕円 43">
                    <a:extLst>
                      <a:ext uri="{FF2B5EF4-FFF2-40B4-BE49-F238E27FC236}">
                        <a16:creationId xmlns:a16="http://schemas.microsoft.com/office/drawing/2014/main" id="{45C94564-D1AB-A973-FD6C-F4EFFF1155B8}"/>
                      </a:ext>
                    </a:extLst>
                  </p:cNvPr>
                  <p:cNvSpPr/>
                  <p:nvPr/>
                </p:nvSpPr>
                <p:spPr>
                  <a:xfrm>
                    <a:off x="5027600" y="1893057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楕円 44">
                    <a:extLst>
                      <a:ext uri="{FF2B5EF4-FFF2-40B4-BE49-F238E27FC236}">
                        <a16:creationId xmlns:a16="http://schemas.microsoft.com/office/drawing/2014/main" id="{60EC7EEB-A253-A996-C197-628592EB53BA}"/>
                      </a:ext>
                    </a:extLst>
                  </p:cNvPr>
                  <p:cNvSpPr/>
                  <p:nvPr/>
                </p:nvSpPr>
                <p:spPr>
                  <a:xfrm>
                    <a:off x="6626899" y="1849717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" name="楕円 45">
                    <a:extLst>
                      <a:ext uri="{FF2B5EF4-FFF2-40B4-BE49-F238E27FC236}">
                        <a16:creationId xmlns:a16="http://schemas.microsoft.com/office/drawing/2014/main" id="{CAFA2666-0A84-24E2-1015-7E5647D17284}"/>
                      </a:ext>
                    </a:extLst>
                  </p:cNvPr>
                  <p:cNvSpPr/>
                  <p:nvPr/>
                </p:nvSpPr>
                <p:spPr>
                  <a:xfrm>
                    <a:off x="8232370" y="1807019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楕円 46">
                    <a:extLst>
                      <a:ext uri="{FF2B5EF4-FFF2-40B4-BE49-F238E27FC236}">
                        <a16:creationId xmlns:a16="http://schemas.microsoft.com/office/drawing/2014/main" id="{282FF87E-85BD-16EB-BD6B-A9DD5AA8BD3B}"/>
                      </a:ext>
                    </a:extLst>
                  </p:cNvPr>
                  <p:cNvSpPr/>
                  <p:nvPr/>
                </p:nvSpPr>
                <p:spPr>
                  <a:xfrm>
                    <a:off x="9827884" y="1858000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9" name="フリーフォーム: 図形 378">
                  <a:extLst>
                    <a:ext uri="{FF2B5EF4-FFF2-40B4-BE49-F238E27FC236}">
                      <a16:creationId xmlns:a16="http://schemas.microsoft.com/office/drawing/2014/main" id="{20B761D7-6BF9-8207-45A4-07692CE9813F}"/>
                    </a:ext>
                  </a:extLst>
                </p:cNvPr>
                <p:cNvSpPr/>
                <p:nvPr/>
              </p:nvSpPr>
              <p:spPr>
                <a:xfrm>
                  <a:off x="3487738" y="1328738"/>
                  <a:ext cx="4818062" cy="638175"/>
                </a:xfrm>
                <a:custGeom>
                  <a:avLst/>
                  <a:gdLst>
                    <a:gd name="connsiteX0" fmla="*/ 0 w 4824412"/>
                    <a:gd name="connsiteY0" fmla="*/ 0 h 638175"/>
                    <a:gd name="connsiteX1" fmla="*/ 1619250 w 4824412"/>
                    <a:gd name="connsiteY1" fmla="*/ 638175 h 638175"/>
                    <a:gd name="connsiteX2" fmla="*/ 3209925 w 4824412"/>
                    <a:gd name="connsiteY2" fmla="*/ 595312 h 638175"/>
                    <a:gd name="connsiteX3" fmla="*/ 4824412 w 4824412"/>
                    <a:gd name="connsiteY3" fmla="*/ 552450 h 638175"/>
                    <a:gd name="connsiteX0" fmla="*/ 0 w 4824412"/>
                    <a:gd name="connsiteY0" fmla="*/ 0 h 638175"/>
                    <a:gd name="connsiteX1" fmla="*/ 1619250 w 4824412"/>
                    <a:gd name="connsiteY1" fmla="*/ 638175 h 638175"/>
                    <a:gd name="connsiteX2" fmla="*/ 3219450 w 4824412"/>
                    <a:gd name="connsiteY2" fmla="*/ 595312 h 638175"/>
                    <a:gd name="connsiteX3" fmla="*/ 4824412 w 4824412"/>
                    <a:gd name="connsiteY3" fmla="*/ 552450 h 638175"/>
                    <a:gd name="connsiteX0" fmla="*/ 0 w 4818062"/>
                    <a:gd name="connsiteY0" fmla="*/ 0 h 638175"/>
                    <a:gd name="connsiteX1" fmla="*/ 1612900 w 4818062"/>
                    <a:gd name="connsiteY1" fmla="*/ 638175 h 638175"/>
                    <a:gd name="connsiteX2" fmla="*/ 3213100 w 4818062"/>
                    <a:gd name="connsiteY2" fmla="*/ 595312 h 638175"/>
                    <a:gd name="connsiteX3" fmla="*/ 4818062 w 4818062"/>
                    <a:gd name="connsiteY3" fmla="*/ 552450 h 6381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8062" h="638175">
                      <a:moveTo>
                        <a:pt x="0" y="0"/>
                      </a:moveTo>
                      <a:lnTo>
                        <a:pt x="1612900" y="638175"/>
                      </a:lnTo>
                      <a:lnTo>
                        <a:pt x="3213100" y="595312"/>
                      </a:lnTo>
                      <a:lnTo>
                        <a:pt x="4818062" y="552450"/>
                      </a:lnTo>
                    </a:path>
                  </a:pathLst>
                </a:custGeom>
                <a:noFill/>
                <a:ln w="381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72" name="グループ化 371">
                <a:extLst>
                  <a:ext uri="{FF2B5EF4-FFF2-40B4-BE49-F238E27FC236}">
                    <a16:creationId xmlns:a16="http://schemas.microsoft.com/office/drawing/2014/main" id="{E97C621A-AB44-E999-87FD-4DA136F15964}"/>
                  </a:ext>
                </a:extLst>
              </p:cNvPr>
              <p:cNvGrpSpPr/>
              <p:nvPr/>
            </p:nvGrpSpPr>
            <p:grpSpPr>
              <a:xfrm>
                <a:off x="3255028" y="987425"/>
                <a:ext cx="6584981" cy="1976958"/>
                <a:chOff x="3257939" y="987425"/>
                <a:chExt cx="6584981" cy="1976958"/>
              </a:xfrm>
            </p:grpSpPr>
            <p:grpSp>
              <p:nvGrpSpPr>
                <p:cNvPr id="366" name="グループ化 365">
                  <a:extLst>
                    <a:ext uri="{FF2B5EF4-FFF2-40B4-BE49-F238E27FC236}">
                      <a16:creationId xmlns:a16="http://schemas.microsoft.com/office/drawing/2014/main" id="{A3B6FB33-3FB5-6E7A-382E-18F3584968C1}"/>
                    </a:ext>
                  </a:extLst>
                </p:cNvPr>
                <p:cNvGrpSpPr/>
                <p:nvPr/>
              </p:nvGrpSpPr>
              <p:grpSpPr>
                <a:xfrm>
                  <a:off x="4883619" y="987425"/>
                  <a:ext cx="4959301" cy="1976958"/>
                  <a:chOff x="4883619" y="987425"/>
                  <a:chExt cx="4959301" cy="1976958"/>
                </a:xfrm>
              </p:grpSpPr>
              <p:grpSp>
                <p:nvGrpSpPr>
                  <p:cNvPr id="184" name="グループ化 183">
                    <a:extLst>
                      <a:ext uri="{FF2B5EF4-FFF2-40B4-BE49-F238E27FC236}">
                        <a16:creationId xmlns:a16="http://schemas.microsoft.com/office/drawing/2014/main" id="{C9473EEB-3B3F-6259-5694-4530FFC5D20F}"/>
                      </a:ext>
                    </a:extLst>
                  </p:cNvPr>
                  <p:cNvGrpSpPr/>
                  <p:nvPr/>
                </p:nvGrpSpPr>
                <p:grpSpPr>
                  <a:xfrm>
                    <a:off x="4883619" y="1093635"/>
                    <a:ext cx="108000" cy="1620990"/>
                    <a:chOff x="3181267" y="2597151"/>
                    <a:chExt cx="108000" cy="2157062"/>
                  </a:xfrm>
                </p:grpSpPr>
                <p:cxnSp>
                  <p:nvCxnSpPr>
                    <p:cNvPr id="212" name="直線コネクタ 211">
                      <a:extLst>
                        <a:ext uri="{FF2B5EF4-FFF2-40B4-BE49-F238E27FC236}">
                          <a16:creationId xmlns:a16="http://schemas.microsoft.com/office/drawing/2014/main" id="{8332FBC5-3BE6-BF20-6BBD-25AB3D8A67B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3" name="直線コネクタ 212">
                      <a:extLst>
                        <a:ext uri="{FF2B5EF4-FFF2-40B4-BE49-F238E27FC236}">
                          <a16:creationId xmlns:a16="http://schemas.microsoft.com/office/drawing/2014/main" id="{8459A54D-32A8-BFCE-2BC0-607791B6766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4" name="直線コネクタ 213">
                      <a:extLst>
                        <a:ext uri="{FF2B5EF4-FFF2-40B4-BE49-F238E27FC236}">
                          <a16:creationId xmlns:a16="http://schemas.microsoft.com/office/drawing/2014/main" id="{AFBE806F-801C-DF3F-F53B-175C6969F27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85" name="グループ化 184">
                    <a:extLst>
                      <a:ext uri="{FF2B5EF4-FFF2-40B4-BE49-F238E27FC236}">
                        <a16:creationId xmlns:a16="http://schemas.microsoft.com/office/drawing/2014/main" id="{B5248150-1DDC-E666-ED4F-ABAAA325D3F8}"/>
                      </a:ext>
                    </a:extLst>
                  </p:cNvPr>
                  <p:cNvGrpSpPr/>
                  <p:nvPr/>
                </p:nvGrpSpPr>
                <p:grpSpPr>
                  <a:xfrm>
                    <a:off x="6482918" y="1069180"/>
                    <a:ext cx="108000" cy="1540670"/>
                    <a:chOff x="3181267" y="2597151"/>
                    <a:chExt cx="108000" cy="2157062"/>
                  </a:xfrm>
                </p:grpSpPr>
                <p:cxnSp>
                  <p:nvCxnSpPr>
                    <p:cNvPr id="209" name="直線コネクタ 208">
                      <a:extLst>
                        <a:ext uri="{FF2B5EF4-FFF2-40B4-BE49-F238E27FC236}">
                          <a16:creationId xmlns:a16="http://schemas.microsoft.com/office/drawing/2014/main" id="{314BD134-E248-8645-7CD8-A5E49E349B0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0" name="直線コネクタ 209">
                      <a:extLst>
                        <a:ext uri="{FF2B5EF4-FFF2-40B4-BE49-F238E27FC236}">
                          <a16:creationId xmlns:a16="http://schemas.microsoft.com/office/drawing/2014/main" id="{BECBDE5C-5E1B-51E3-66D5-286FADF5204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1" name="直線コネクタ 210">
                      <a:extLst>
                        <a:ext uri="{FF2B5EF4-FFF2-40B4-BE49-F238E27FC236}">
                          <a16:creationId xmlns:a16="http://schemas.microsoft.com/office/drawing/2014/main" id="{0E6F9C8C-36BE-3F8E-F21D-D5E9558FCDE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64" name="グループ化 363">
                    <a:extLst>
                      <a:ext uri="{FF2B5EF4-FFF2-40B4-BE49-F238E27FC236}">
                        <a16:creationId xmlns:a16="http://schemas.microsoft.com/office/drawing/2014/main" id="{91D2F9D7-FC1B-E7FF-2109-AAA9FBC92D7B}"/>
                      </a:ext>
                    </a:extLst>
                  </p:cNvPr>
                  <p:cNvGrpSpPr/>
                  <p:nvPr/>
                </p:nvGrpSpPr>
                <p:grpSpPr>
                  <a:xfrm>
                    <a:off x="8036031" y="987425"/>
                    <a:ext cx="211596" cy="1976958"/>
                    <a:chOff x="8036031" y="987425"/>
                    <a:chExt cx="211596" cy="1976958"/>
                  </a:xfrm>
                </p:grpSpPr>
                <p:grpSp>
                  <p:nvGrpSpPr>
                    <p:cNvPr id="204" name="グループ化 203">
                      <a:extLst>
                        <a:ext uri="{FF2B5EF4-FFF2-40B4-BE49-F238E27FC236}">
                          <a16:creationId xmlns:a16="http://schemas.microsoft.com/office/drawing/2014/main" id="{08767E0C-06DA-AF61-D4EA-E80F56C189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88389" y="987425"/>
                      <a:ext cx="108000" cy="1640506"/>
                      <a:chOff x="3181267" y="2597151"/>
                      <a:chExt cx="108000" cy="2157062"/>
                    </a:xfrm>
                  </p:grpSpPr>
                  <p:cxnSp>
                    <p:nvCxnSpPr>
                      <p:cNvPr id="206" name="直線コネクタ 205">
                        <a:extLst>
                          <a:ext uri="{FF2B5EF4-FFF2-40B4-BE49-F238E27FC236}">
                            <a16:creationId xmlns:a16="http://schemas.microsoft.com/office/drawing/2014/main" id="{01D2D8B9-E12C-9815-9E87-BD7435CFCE9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7" name="直線コネクタ 206">
                        <a:extLst>
                          <a:ext uri="{FF2B5EF4-FFF2-40B4-BE49-F238E27FC236}">
                            <a16:creationId xmlns:a16="http://schemas.microsoft.com/office/drawing/2014/main" id="{4AE9869C-078A-F448-7EF5-B13DBCAE51B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8" name="直線コネクタ 207">
                        <a:extLst>
                          <a:ext uri="{FF2B5EF4-FFF2-40B4-BE49-F238E27FC236}">
                            <a16:creationId xmlns:a16="http://schemas.microsoft.com/office/drawing/2014/main" id="{B15838CD-9843-0064-C5DC-397757A8B9F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5" name="テキスト ボックス 204">
                      <a:extLst>
                        <a:ext uri="{FF2B5EF4-FFF2-40B4-BE49-F238E27FC236}">
                          <a16:creationId xmlns:a16="http://schemas.microsoft.com/office/drawing/2014/main" id="{366EFA30-2696-A6F0-6687-5ACDF98565F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36031" y="2632110"/>
                      <a:ext cx="211596" cy="3322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  <p:grpSp>
                <p:nvGrpSpPr>
                  <p:cNvPr id="365" name="グループ化 364">
                    <a:extLst>
                      <a:ext uri="{FF2B5EF4-FFF2-40B4-BE49-F238E27FC236}">
                        <a16:creationId xmlns:a16="http://schemas.microsoft.com/office/drawing/2014/main" id="{AEA4A00C-5668-63E6-02FB-235B52AD152E}"/>
                      </a:ext>
                    </a:extLst>
                  </p:cNvPr>
                  <p:cNvGrpSpPr/>
                  <p:nvPr/>
                </p:nvGrpSpPr>
                <p:grpSpPr>
                  <a:xfrm>
                    <a:off x="9631324" y="1022350"/>
                    <a:ext cx="211596" cy="1932966"/>
                    <a:chOff x="9631324" y="1022350"/>
                    <a:chExt cx="211596" cy="1932966"/>
                  </a:xfrm>
                </p:grpSpPr>
                <p:grpSp>
                  <p:nvGrpSpPr>
                    <p:cNvPr id="188" name="グループ化 187">
                      <a:extLst>
                        <a:ext uri="{FF2B5EF4-FFF2-40B4-BE49-F238E27FC236}">
                          <a16:creationId xmlns:a16="http://schemas.microsoft.com/office/drawing/2014/main" id="{0B7B2CF2-AA61-836E-AD5C-C95E9AA0A75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683903" y="1022350"/>
                      <a:ext cx="108000" cy="1642752"/>
                      <a:chOff x="3181267" y="2597151"/>
                      <a:chExt cx="108000" cy="2157062"/>
                    </a:xfrm>
                  </p:grpSpPr>
                  <p:cxnSp>
                    <p:nvCxnSpPr>
                      <p:cNvPr id="201" name="直線コネクタ 200">
                        <a:extLst>
                          <a:ext uri="{FF2B5EF4-FFF2-40B4-BE49-F238E27FC236}">
                            <a16:creationId xmlns:a16="http://schemas.microsoft.com/office/drawing/2014/main" id="{FF7A936E-52A9-79A4-72E7-E069D983E2A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2" name="直線コネクタ 201">
                        <a:extLst>
                          <a:ext uri="{FF2B5EF4-FFF2-40B4-BE49-F238E27FC236}">
                            <a16:creationId xmlns:a16="http://schemas.microsoft.com/office/drawing/2014/main" id="{8C525C68-E68B-A435-8F53-B600D9DB28F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3" name="直線コネクタ 202">
                        <a:extLst>
                          <a:ext uri="{FF2B5EF4-FFF2-40B4-BE49-F238E27FC236}">
                            <a16:creationId xmlns:a16="http://schemas.microsoft.com/office/drawing/2014/main" id="{6CDCFDAE-0E79-0B61-27D7-D5EB80E7073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0" name="テキスト ボックス 199">
                      <a:extLst>
                        <a:ext uri="{FF2B5EF4-FFF2-40B4-BE49-F238E27FC236}">
                          <a16:creationId xmlns:a16="http://schemas.microsoft.com/office/drawing/2014/main" id="{57A70C3F-6BFC-B505-4943-9B35615F97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31324" y="2667032"/>
                      <a:ext cx="211596" cy="28828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71" name="グループ化 370">
                  <a:extLst>
                    <a:ext uri="{FF2B5EF4-FFF2-40B4-BE49-F238E27FC236}">
                      <a16:creationId xmlns:a16="http://schemas.microsoft.com/office/drawing/2014/main" id="{72965CC8-7F5F-44AC-9DC1-1DE6A18B2BF8}"/>
                    </a:ext>
                  </a:extLst>
                </p:cNvPr>
                <p:cNvGrpSpPr/>
                <p:nvPr/>
              </p:nvGrpSpPr>
              <p:grpSpPr>
                <a:xfrm>
                  <a:off x="3257939" y="1258659"/>
                  <a:ext cx="6551963" cy="713650"/>
                  <a:chOff x="3257939" y="1258659"/>
                  <a:chExt cx="6551963" cy="713650"/>
                </a:xfrm>
              </p:grpSpPr>
              <p:sp>
                <p:nvSpPr>
                  <p:cNvPr id="97" name="楕円 96">
                    <a:extLst>
                      <a:ext uri="{FF2B5EF4-FFF2-40B4-BE49-F238E27FC236}">
                        <a16:creationId xmlns:a16="http://schemas.microsoft.com/office/drawing/2014/main" id="{96247161-28ED-6366-9C39-DC91D0C14D7A}"/>
                      </a:ext>
                    </a:extLst>
                  </p:cNvPr>
                  <p:cNvSpPr/>
                  <p:nvPr/>
                </p:nvSpPr>
                <p:spPr>
                  <a:xfrm>
                    <a:off x="3257939" y="1258659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8" name="楕円 97">
                    <a:extLst>
                      <a:ext uri="{FF2B5EF4-FFF2-40B4-BE49-F238E27FC236}">
                        <a16:creationId xmlns:a16="http://schemas.microsoft.com/office/drawing/2014/main" id="{BEDB589C-BF75-2921-F1C6-5FB4C6F1B755}"/>
                      </a:ext>
                    </a:extLst>
                  </p:cNvPr>
                  <p:cNvSpPr/>
                  <p:nvPr/>
                </p:nvSpPr>
                <p:spPr>
                  <a:xfrm>
                    <a:off x="4865618" y="1828309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9" name="楕円 98">
                    <a:extLst>
                      <a:ext uri="{FF2B5EF4-FFF2-40B4-BE49-F238E27FC236}">
                        <a16:creationId xmlns:a16="http://schemas.microsoft.com/office/drawing/2014/main" id="{C43B9509-8BEC-132D-76F2-C595C3EBC238}"/>
                      </a:ext>
                    </a:extLst>
                  </p:cNvPr>
                  <p:cNvSpPr/>
                  <p:nvPr/>
                </p:nvSpPr>
                <p:spPr>
                  <a:xfrm>
                    <a:off x="6464917" y="176680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楕円 99">
                    <a:extLst>
                      <a:ext uri="{FF2B5EF4-FFF2-40B4-BE49-F238E27FC236}">
                        <a16:creationId xmlns:a16="http://schemas.microsoft.com/office/drawing/2014/main" id="{E3A95924-C43B-DDE2-0E8C-FAEED9B227C8}"/>
                      </a:ext>
                    </a:extLst>
                  </p:cNvPr>
                  <p:cNvSpPr/>
                  <p:nvPr/>
                </p:nvSpPr>
                <p:spPr>
                  <a:xfrm>
                    <a:off x="8070388" y="1736803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3" name="楕円 182">
                    <a:extLst>
                      <a:ext uri="{FF2B5EF4-FFF2-40B4-BE49-F238E27FC236}">
                        <a16:creationId xmlns:a16="http://schemas.microsoft.com/office/drawing/2014/main" id="{65FDDFED-4AFE-981E-DDC2-0840D7198117}"/>
                      </a:ext>
                    </a:extLst>
                  </p:cNvPr>
                  <p:cNvSpPr/>
                  <p:nvPr/>
                </p:nvSpPr>
                <p:spPr>
                  <a:xfrm>
                    <a:off x="9665902" y="1764852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67" name="フリーフォーム: 図形 366">
                  <a:extLst>
                    <a:ext uri="{FF2B5EF4-FFF2-40B4-BE49-F238E27FC236}">
                      <a16:creationId xmlns:a16="http://schemas.microsoft.com/office/drawing/2014/main" id="{A5FF82C3-7703-8452-5428-A2F61A58B1FD}"/>
                    </a:ext>
                  </a:extLst>
                </p:cNvPr>
                <p:cNvSpPr/>
                <p:nvPr/>
              </p:nvSpPr>
              <p:spPr>
                <a:xfrm>
                  <a:off x="3324225" y="1328738"/>
                  <a:ext cx="4818063" cy="577850"/>
                </a:xfrm>
                <a:custGeom>
                  <a:avLst/>
                  <a:gdLst>
                    <a:gd name="connsiteX0" fmla="*/ 0 w 5334000"/>
                    <a:gd name="connsiteY0" fmla="*/ 0 h 576262"/>
                    <a:gd name="connsiteX1" fmla="*/ 1614488 w 5334000"/>
                    <a:gd name="connsiteY1" fmla="*/ 571500 h 576262"/>
                    <a:gd name="connsiteX2" fmla="*/ 3209925 w 5334000"/>
                    <a:gd name="connsiteY2" fmla="*/ 509587 h 576262"/>
                    <a:gd name="connsiteX3" fmla="*/ 4814888 w 5334000"/>
                    <a:gd name="connsiteY3" fmla="*/ 485775 h 576262"/>
                    <a:gd name="connsiteX4" fmla="*/ 5334000 w 5334000"/>
                    <a:gd name="connsiteY4" fmla="*/ 576262 h 576262"/>
                    <a:gd name="connsiteX0" fmla="*/ 0 w 4814888"/>
                    <a:gd name="connsiteY0" fmla="*/ 0 h 571500"/>
                    <a:gd name="connsiteX1" fmla="*/ 1614488 w 4814888"/>
                    <a:gd name="connsiteY1" fmla="*/ 571500 h 571500"/>
                    <a:gd name="connsiteX2" fmla="*/ 3209925 w 4814888"/>
                    <a:gd name="connsiteY2" fmla="*/ 509587 h 571500"/>
                    <a:gd name="connsiteX3" fmla="*/ 4814888 w 4814888"/>
                    <a:gd name="connsiteY3" fmla="*/ 485775 h 571500"/>
                    <a:gd name="connsiteX0" fmla="*/ 0 w 4818063"/>
                    <a:gd name="connsiteY0" fmla="*/ 0 h 571500"/>
                    <a:gd name="connsiteX1" fmla="*/ 1614488 w 4818063"/>
                    <a:gd name="connsiteY1" fmla="*/ 571500 h 571500"/>
                    <a:gd name="connsiteX2" fmla="*/ 3209925 w 4818063"/>
                    <a:gd name="connsiteY2" fmla="*/ 509587 h 571500"/>
                    <a:gd name="connsiteX3" fmla="*/ 4818063 w 4818063"/>
                    <a:gd name="connsiteY3" fmla="*/ 482600 h 571500"/>
                    <a:gd name="connsiteX0" fmla="*/ 0 w 4818063"/>
                    <a:gd name="connsiteY0" fmla="*/ 0 h 577850"/>
                    <a:gd name="connsiteX1" fmla="*/ 1614488 w 4818063"/>
                    <a:gd name="connsiteY1" fmla="*/ 577850 h 577850"/>
                    <a:gd name="connsiteX2" fmla="*/ 3209925 w 4818063"/>
                    <a:gd name="connsiteY2" fmla="*/ 509587 h 577850"/>
                    <a:gd name="connsiteX3" fmla="*/ 4818063 w 4818063"/>
                    <a:gd name="connsiteY3" fmla="*/ 482600 h 5778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8063" h="577850">
                      <a:moveTo>
                        <a:pt x="0" y="0"/>
                      </a:moveTo>
                      <a:lnTo>
                        <a:pt x="1614488" y="577850"/>
                      </a:lnTo>
                      <a:lnTo>
                        <a:pt x="3209925" y="509587"/>
                      </a:lnTo>
                      <a:lnTo>
                        <a:pt x="4818063" y="482600"/>
                      </a:ln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6C88E427-BCC8-A5D1-0848-9A19C75FFB82}"/>
                </a:ext>
              </a:extLst>
            </p:cNvPr>
            <p:cNvGrpSpPr/>
            <p:nvPr/>
          </p:nvGrpSpPr>
          <p:grpSpPr>
            <a:xfrm>
              <a:off x="1657323" y="3718665"/>
              <a:ext cx="8563602" cy="2774381"/>
              <a:chOff x="1657323" y="3718665"/>
              <a:chExt cx="8563602" cy="2774381"/>
            </a:xfrm>
          </p:grpSpPr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70F8F0E3-4E8F-C06C-2461-BE6325DB8EAF}"/>
                  </a:ext>
                </a:extLst>
              </p:cNvPr>
              <p:cNvSpPr txBox="1"/>
              <p:nvPr/>
            </p:nvSpPr>
            <p:spPr>
              <a:xfrm rot="16200000">
                <a:off x="981818" y="4747904"/>
                <a:ext cx="2182008" cy="83099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Change in office DBP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from baseline to EOT</a:t>
                </a:r>
                <a:b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</a:b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 (mmHg)</a:t>
                </a:r>
              </a:p>
            </p:txBody>
          </p:sp>
          <p:cxnSp>
            <p:nvCxnSpPr>
              <p:cNvPr id="232" name="直線コネクタ 231">
                <a:extLst>
                  <a:ext uri="{FF2B5EF4-FFF2-40B4-BE49-F238E27FC236}">
                    <a16:creationId xmlns:a16="http://schemas.microsoft.com/office/drawing/2014/main" id="{0B53AB25-559A-6ECC-D6E3-3C63E5BF0D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9338" y="4047798"/>
                <a:ext cx="7201587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正方形/長方形 242">
                <a:extLst>
                  <a:ext uri="{FF2B5EF4-FFF2-40B4-BE49-F238E27FC236}">
                    <a16:creationId xmlns:a16="http://schemas.microsoft.com/office/drawing/2014/main" id="{90A928EF-D4D0-03BD-247C-5539F5170A2C}"/>
                  </a:ext>
                </a:extLst>
              </p:cNvPr>
              <p:cNvSpPr/>
              <p:nvPr/>
            </p:nvSpPr>
            <p:spPr>
              <a:xfrm>
                <a:off x="2790012" y="3923341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44" name="直線コネクタ 243">
                <a:extLst>
                  <a:ext uri="{FF2B5EF4-FFF2-40B4-BE49-F238E27FC236}">
                    <a16:creationId xmlns:a16="http://schemas.microsoft.com/office/drawing/2014/main" id="{B18996CF-A3A0-564D-7C36-B4BE8EE093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6115950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正方形/長方形 244">
                <a:extLst>
                  <a:ext uri="{FF2B5EF4-FFF2-40B4-BE49-F238E27FC236}">
                    <a16:creationId xmlns:a16="http://schemas.microsoft.com/office/drawing/2014/main" id="{EF9705A4-FED6-D4E9-5DAB-9CAEC99689DB}"/>
                  </a:ext>
                </a:extLst>
              </p:cNvPr>
              <p:cNvSpPr/>
              <p:nvPr/>
            </p:nvSpPr>
            <p:spPr>
              <a:xfrm>
                <a:off x="2555974" y="5991813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2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46" name="直線コネクタ 245">
                <a:extLst>
                  <a:ext uri="{FF2B5EF4-FFF2-40B4-BE49-F238E27FC236}">
                    <a16:creationId xmlns:a16="http://schemas.microsoft.com/office/drawing/2014/main" id="{C8815933-A8F5-F5FD-CA9D-9B2DBBCAFE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5702318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7" name="正方形/長方形 246">
                <a:extLst>
                  <a:ext uri="{FF2B5EF4-FFF2-40B4-BE49-F238E27FC236}">
                    <a16:creationId xmlns:a16="http://schemas.microsoft.com/office/drawing/2014/main" id="{9DCD9B6D-39B3-6CD3-1FB3-980FBAE437C9}"/>
                  </a:ext>
                </a:extLst>
              </p:cNvPr>
              <p:cNvSpPr/>
              <p:nvPr/>
            </p:nvSpPr>
            <p:spPr>
              <a:xfrm>
                <a:off x="2555974" y="5578117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48" name="直線コネクタ 247">
                <a:extLst>
                  <a:ext uri="{FF2B5EF4-FFF2-40B4-BE49-F238E27FC236}">
                    <a16:creationId xmlns:a16="http://schemas.microsoft.com/office/drawing/2014/main" id="{5C507B52-6EDB-4C37-3D27-E206165285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4460145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9" name="正方形/長方形 248">
                <a:extLst>
                  <a:ext uri="{FF2B5EF4-FFF2-40B4-BE49-F238E27FC236}">
                    <a16:creationId xmlns:a16="http://schemas.microsoft.com/office/drawing/2014/main" id="{63FE4393-CFA1-9437-C69A-F91E2F8FA748}"/>
                  </a:ext>
                </a:extLst>
              </p:cNvPr>
              <p:cNvSpPr/>
              <p:nvPr/>
            </p:nvSpPr>
            <p:spPr>
              <a:xfrm>
                <a:off x="2790012" y="4337035"/>
                <a:ext cx="11381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50" name="直線コネクタ 249">
                <a:extLst>
                  <a:ext uri="{FF2B5EF4-FFF2-40B4-BE49-F238E27FC236}">
                    <a16:creationId xmlns:a16="http://schemas.microsoft.com/office/drawing/2014/main" id="{1A17EC3F-417F-E995-5974-155AD584B0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9338" y="4049202"/>
                <a:ext cx="0" cy="22284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直線コネクタ 250">
                <a:extLst>
                  <a:ext uri="{FF2B5EF4-FFF2-40B4-BE49-F238E27FC236}">
                    <a16:creationId xmlns:a16="http://schemas.microsoft.com/office/drawing/2014/main" id="{1F6371BB-C8F4-FD7A-A791-92BC80EB4F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4047798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2" name="グループ化 251">
                <a:extLst>
                  <a:ext uri="{FF2B5EF4-FFF2-40B4-BE49-F238E27FC236}">
                    <a16:creationId xmlns:a16="http://schemas.microsoft.com/office/drawing/2014/main" id="{2AC4854A-58D4-4E5D-9865-EE3A35F2241A}"/>
                  </a:ext>
                </a:extLst>
              </p:cNvPr>
              <p:cNvGrpSpPr/>
              <p:nvPr/>
            </p:nvGrpSpPr>
            <p:grpSpPr>
              <a:xfrm>
                <a:off x="4355927" y="6277602"/>
                <a:ext cx="4627795" cy="215444"/>
                <a:chOff x="4683258" y="2845511"/>
                <a:chExt cx="4627795" cy="215444"/>
              </a:xfrm>
            </p:grpSpPr>
            <p:grpSp>
              <p:nvGrpSpPr>
                <p:cNvPr id="341" name="グループ化 340">
                  <a:extLst>
                    <a:ext uri="{FF2B5EF4-FFF2-40B4-BE49-F238E27FC236}">
                      <a16:creationId xmlns:a16="http://schemas.microsoft.com/office/drawing/2014/main" id="{0E7DCC80-0349-9B1E-2AF9-7C0881878197}"/>
                    </a:ext>
                  </a:extLst>
                </p:cNvPr>
                <p:cNvGrpSpPr/>
                <p:nvPr/>
              </p:nvGrpSpPr>
              <p:grpSpPr>
                <a:xfrm>
                  <a:off x="6279513" y="2845511"/>
                  <a:ext cx="1463497" cy="215444"/>
                  <a:chOff x="4782318" y="3119831"/>
                  <a:chExt cx="1463497" cy="215444"/>
                </a:xfrm>
              </p:grpSpPr>
              <p:sp>
                <p:nvSpPr>
                  <p:cNvPr id="352" name="正方形/長方形 351">
                    <a:extLst>
                      <a:ext uri="{FF2B5EF4-FFF2-40B4-BE49-F238E27FC236}">
                        <a16:creationId xmlns:a16="http://schemas.microsoft.com/office/drawing/2014/main" id="{4702CA21-9CA4-0218-C509-B4CBFAFDD45A}"/>
                      </a:ext>
                    </a:extLst>
                  </p:cNvPr>
                  <p:cNvSpPr/>
                  <p:nvPr/>
                </p:nvSpPr>
                <p:spPr>
                  <a:xfrm>
                    <a:off x="5169114" y="3119831"/>
                    <a:ext cx="1076701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AR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5)</a:t>
                    </a:r>
                  </a:p>
                </p:txBody>
              </p:sp>
              <p:grpSp>
                <p:nvGrpSpPr>
                  <p:cNvPr id="353" name="グループ化 352">
                    <a:extLst>
                      <a:ext uri="{FF2B5EF4-FFF2-40B4-BE49-F238E27FC236}">
                        <a16:creationId xmlns:a16="http://schemas.microsoft.com/office/drawing/2014/main" id="{63B5FB12-AF02-EA6C-F392-0571F38737DF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15555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54" name="直線コネクタ 353">
                      <a:extLst>
                        <a:ext uri="{FF2B5EF4-FFF2-40B4-BE49-F238E27FC236}">
                          <a16:creationId xmlns:a16="http://schemas.microsoft.com/office/drawing/2014/main" id="{D2CE83D1-D2D7-5330-D1C1-FDB647A978B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rgbClr val="FF0000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55" name="楕円 354">
                      <a:extLst>
                        <a:ext uri="{FF2B5EF4-FFF2-40B4-BE49-F238E27FC236}">
                          <a16:creationId xmlns:a16="http://schemas.microsoft.com/office/drawing/2014/main" id="{48057CC1-7329-425D-9957-87A90EBD871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42" name="グループ化 341">
                  <a:extLst>
                    <a:ext uri="{FF2B5EF4-FFF2-40B4-BE49-F238E27FC236}">
                      <a16:creationId xmlns:a16="http://schemas.microsoft.com/office/drawing/2014/main" id="{A0FBC42F-5722-AF0F-E0D1-A5350C8DF882}"/>
                    </a:ext>
                  </a:extLst>
                </p:cNvPr>
                <p:cNvGrpSpPr/>
                <p:nvPr/>
              </p:nvGrpSpPr>
              <p:grpSpPr>
                <a:xfrm>
                  <a:off x="7837938" y="2845511"/>
                  <a:ext cx="1473115" cy="215444"/>
                  <a:chOff x="4782318" y="3352318"/>
                  <a:chExt cx="1473115" cy="215444"/>
                </a:xfrm>
              </p:grpSpPr>
              <p:sp>
                <p:nvSpPr>
                  <p:cNvPr id="348" name="正方形/長方形 347">
                    <a:extLst>
                      <a:ext uri="{FF2B5EF4-FFF2-40B4-BE49-F238E27FC236}">
                        <a16:creationId xmlns:a16="http://schemas.microsoft.com/office/drawing/2014/main" id="{0D23E5D7-B900-D371-2F1E-FA3D15D021EE}"/>
                      </a:ext>
                    </a:extLst>
                  </p:cNvPr>
                  <p:cNvSpPr/>
                  <p:nvPr/>
                </p:nvSpPr>
                <p:spPr>
                  <a:xfrm>
                    <a:off x="5169114" y="3352318"/>
                    <a:ext cx="1086319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CCB 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48)</a:t>
                    </a:r>
                  </a:p>
                </p:txBody>
              </p:sp>
              <p:grpSp>
                <p:nvGrpSpPr>
                  <p:cNvPr id="349" name="グループ化 348">
                    <a:extLst>
                      <a:ext uri="{FF2B5EF4-FFF2-40B4-BE49-F238E27FC236}">
                        <a16:creationId xmlns:a16="http://schemas.microsoft.com/office/drawing/2014/main" id="{33E0CEDB-2C83-33E8-83A9-6A0603F453F1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3388040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50" name="直線コネクタ 349">
                      <a:extLst>
                        <a:ext uri="{FF2B5EF4-FFF2-40B4-BE49-F238E27FC236}">
                          <a16:creationId xmlns:a16="http://schemas.microsoft.com/office/drawing/2014/main" id="{1AD78910-D3FA-C158-DE25-1D4C0633C77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solidFill>
                      <a:srgbClr val="00B050"/>
                    </a:solidFill>
                    <a:ln w="38100" cap="flat">
                      <a:solidFill>
                        <a:srgbClr val="0000FF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51" name="楕円 350">
                      <a:extLst>
                        <a:ext uri="{FF2B5EF4-FFF2-40B4-BE49-F238E27FC236}">
                          <a16:creationId xmlns:a16="http://schemas.microsoft.com/office/drawing/2014/main" id="{E91EB30C-A96F-CCE3-C4E8-9231DEB7885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43" name="グループ化 342">
                  <a:extLst>
                    <a:ext uri="{FF2B5EF4-FFF2-40B4-BE49-F238E27FC236}">
                      <a16:creationId xmlns:a16="http://schemas.microsoft.com/office/drawing/2014/main" id="{90DF9AA7-B88B-10A1-0D1C-59D05D264BD2}"/>
                    </a:ext>
                  </a:extLst>
                </p:cNvPr>
                <p:cNvGrpSpPr/>
                <p:nvPr/>
              </p:nvGrpSpPr>
              <p:grpSpPr>
                <a:xfrm>
                  <a:off x="4683258" y="2845511"/>
                  <a:ext cx="1501328" cy="215444"/>
                  <a:chOff x="4782318" y="2845511"/>
                  <a:chExt cx="1501328" cy="215444"/>
                </a:xfrm>
              </p:grpSpPr>
              <p:sp>
                <p:nvSpPr>
                  <p:cNvPr id="344" name="正方形/長方形 343">
                    <a:extLst>
                      <a:ext uri="{FF2B5EF4-FFF2-40B4-BE49-F238E27FC236}">
                        <a16:creationId xmlns:a16="http://schemas.microsoft.com/office/drawing/2014/main" id="{2C039535-4EC9-803B-8846-141DCEFC9C6C}"/>
                      </a:ext>
                    </a:extLst>
                  </p:cNvPr>
                  <p:cNvSpPr/>
                  <p:nvPr/>
                </p:nvSpPr>
                <p:spPr>
                  <a:xfrm>
                    <a:off x="5169114" y="2845511"/>
                    <a:ext cx="1114532" cy="21544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0" rIns="0" bIns="0" anchor="ctr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Total</a:t>
                    </a:r>
                    <a:r>
                      <a:rPr lang="ja-JP" altLang="en-US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ja-JP" sz="1400" i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N </a:t>
                    </a:r>
                    <a:r>
                      <a:rPr lang="en-US" altLang="ja-JP" sz="14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rPr>
                      <a:t>= 93)</a:t>
                    </a:r>
                  </a:p>
                </p:txBody>
              </p:sp>
              <p:grpSp>
                <p:nvGrpSpPr>
                  <p:cNvPr id="345" name="グループ化 344">
                    <a:extLst>
                      <a:ext uri="{FF2B5EF4-FFF2-40B4-BE49-F238E27FC236}">
                        <a16:creationId xmlns:a16="http://schemas.microsoft.com/office/drawing/2014/main" id="{41C2F6D8-A3F1-8B8E-74DF-6F919C9F42EB}"/>
                      </a:ext>
                    </a:extLst>
                  </p:cNvPr>
                  <p:cNvGrpSpPr/>
                  <p:nvPr/>
                </p:nvGrpSpPr>
                <p:grpSpPr>
                  <a:xfrm>
                    <a:off x="4782318" y="2881233"/>
                    <a:ext cx="360000" cy="144000"/>
                    <a:chOff x="4090696" y="4907843"/>
                    <a:chExt cx="360000" cy="144000"/>
                  </a:xfrm>
                </p:grpSpPr>
                <p:cxnSp>
                  <p:nvCxnSpPr>
                    <p:cNvPr id="346" name="直線コネクタ 345">
                      <a:extLst>
                        <a:ext uri="{FF2B5EF4-FFF2-40B4-BE49-F238E27FC236}">
                          <a16:creationId xmlns:a16="http://schemas.microsoft.com/office/drawing/2014/main" id="{35C7DD2D-E22C-810E-8906-4E3BEB811E3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90696" y="4979843"/>
                      <a:ext cx="360000" cy="0"/>
                    </a:xfrm>
                    <a:prstGeom prst="line">
                      <a:avLst/>
                    </a:prstGeom>
                    <a:noFill/>
                    <a:ln w="38100" cap="flat">
                      <a:solidFill>
                        <a:schemeClr val="tx1"/>
                      </a:solidFill>
                      <a:prstDash val="sysDot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</p:cxnSp>
                <p:sp>
                  <p:nvSpPr>
                    <p:cNvPr id="347" name="楕円 346">
                      <a:extLst>
                        <a:ext uri="{FF2B5EF4-FFF2-40B4-BE49-F238E27FC236}">
                          <a16:creationId xmlns:a16="http://schemas.microsoft.com/office/drawing/2014/main" id="{E8ACD741-3C19-4A30-0610-CF4E54AE36F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8696" y="4907843"/>
                      <a:ext cx="144000" cy="144000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cxnSp>
            <p:nvCxnSpPr>
              <p:cNvPr id="253" name="直線コネクタ 252">
                <a:extLst>
                  <a:ext uri="{FF2B5EF4-FFF2-40B4-BE49-F238E27FC236}">
                    <a16:creationId xmlns:a16="http://schemas.microsoft.com/office/drawing/2014/main" id="{4193B56C-08E4-B78F-D5F4-0794D9282B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4875058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4" name="正方形/長方形 253">
                <a:extLst>
                  <a:ext uri="{FF2B5EF4-FFF2-40B4-BE49-F238E27FC236}">
                    <a16:creationId xmlns:a16="http://schemas.microsoft.com/office/drawing/2014/main" id="{17083BF0-A46B-CE4C-4FAB-5323668BDF16}"/>
                  </a:ext>
                </a:extLst>
              </p:cNvPr>
              <p:cNvSpPr/>
              <p:nvPr/>
            </p:nvSpPr>
            <p:spPr>
              <a:xfrm>
                <a:off x="2669787" y="4750729"/>
                <a:ext cx="23403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5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391" name="直線コネクタ 390">
                <a:extLst>
                  <a:ext uri="{FF2B5EF4-FFF2-40B4-BE49-F238E27FC236}">
                    <a16:creationId xmlns:a16="http://schemas.microsoft.com/office/drawing/2014/main" id="{3F759A87-95D6-CCB1-8BF6-04C78A3793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47339" y="5288688"/>
                <a:ext cx="7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2" name="正方形/長方形 391">
                <a:extLst>
                  <a:ext uri="{FF2B5EF4-FFF2-40B4-BE49-F238E27FC236}">
                    <a16:creationId xmlns:a16="http://schemas.microsoft.com/office/drawing/2014/main" id="{E9889E49-DA54-A831-646A-E60D9B151F3A}"/>
                  </a:ext>
                </a:extLst>
              </p:cNvPr>
              <p:cNvSpPr/>
              <p:nvPr/>
            </p:nvSpPr>
            <p:spPr>
              <a:xfrm>
                <a:off x="2555974" y="5164423"/>
                <a:ext cx="347852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ctr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−10</a:t>
                </a:r>
                <a:endPara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A607D793-BFB7-F40D-5FA3-E6D0A66F2F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9014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B222869C-D469-1242-F9C2-316864EEBB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96249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id="{3201E5E1-D284-CA07-E149-169ECEEDCE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02139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id="{39AE8576-797B-9807-6AC2-C53A384C0F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99129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線コネクタ 69">
                <a:extLst>
                  <a:ext uri="{FF2B5EF4-FFF2-40B4-BE49-F238E27FC236}">
                    <a16:creationId xmlns:a16="http://schemas.microsoft.com/office/drawing/2014/main" id="{677A3078-EECD-CD8F-B70D-6C839E5783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99331" y="3975798"/>
                <a:ext cx="0" cy="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正方形/長方形 78">
                <a:extLst>
                  <a:ext uri="{FF2B5EF4-FFF2-40B4-BE49-F238E27FC236}">
                    <a16:creationId xmlns:a16="http://schemas.microsoft.com/office/drawing/2014/main" id="{37B953A8-4B6A-BE5C-2F96-C53E13580027}"/>
                  </a:ext>
                </a:extLst>
              </p:cNvPr>
              <p:cNvSpPr/>
              <p:nvPr/>
            </p:nvSpPr>
            <p:spPr>
              <a:xfrm>
                <a:off x="3097080" y="3718665"/>
                <a:ext cx="783869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Baseline</a:t>
                </a:r>
              </a:p>
            </p:txBody>
          </p:sp>
          <p:sp>
            <p:nvSpPr>
              <p:cNvPr id="94" name="正方形/長方形 93">
                <a:extLst>
                  <a:ext uri="{FF2B5EF4-FFF2-40B4-BE49-F238E27FC236}">
                    <a16:creationId xmlns:a16="http://schemas.microsoft.com/office/drawing/2014/main" id="{8CF3369D-52F9-0F14-0930-AF690120096B}"/>
                  </a:ext>
                </a:extLst>
              </p:cNvPr>
              <p:cNvSpPr/>
              <p:nvPr/>
            </p:nvSpPr>
            <p:spPr>
              <a:xfrm>
                <a:off x="4753339" y="3718665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4</a:t>
                </a:r>
              </a:p>
            </p:txBody>
          </p:sp>
          <p:sp>
            <p:nvSpPr>
              <p:cNvPr id="95" name="正方形/長方形 94">
                <a:extLst>
                  <a:ext uri="{FF2B5EF4-FFF2-40B4-BE49-F238E27FC236}">
                    <a16:creationId xmlns:a16="http://schemas.microsoft.com/office/drawing/2014/main" id="{74AC69F1-2646-5968-B228-855F29B846BB}"/>
                  </a:ext>
                </a:extLst>
              </p:cNvPr>
              <p:cNvSpPr/>
              <p:nvPr/>
            </p:nvSpPr>
            <p:spPr>
              <a:xfrm>
                <a:off x="6350257" y="3718665"/>
                <a:ext cx="691984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8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6" name="正方形/長方形 95">
                <a:extLst>
                  <a:ext uri="{FF2B5EF4-FFF2-40B4-BE49-F238E27FC236}">
                    <a16:creationId xmlns:a16="http://schemas.microsoft.com/office/drawing/2014/main" id="{408B6C06-4FC4-736B-CF52-32D233D61278}"/>
                  </a:ext>
                </a:extLst>
              </p:cNvPr>
              <p:cNvSpPr/>
              <p:nvPr/>
            </p:nvSpPr>
            <p:spPr>
              <a:xfrm>
                <a:off x="7899240" y="3718665"/>
                <a:ext cx="805798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Week 12</a:t>
                </a:r>
                <a:endParaRPr kumimoji="1" lang="ja-JP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正方形/長方形 100">
                <a:extLst>
                  <a:ext uri="{FF2B5EF4-FFF2-40B4-BE49-F238E27FC236}">
                    <a16:creationId xmlns:a16="http://schemas.microsoft.com/office/drawing/2014/main" id="{40CEF4A7-B63B-12B6-E24F-AB5927697540}"/>
                  </a:ext>
                </a:extLst>
              </p:cNvPr>
              <p:cNvSpPr/>
              <p:nvPr/>
            </p:nvSpPr>
            <p:spPr>
              <a:xfrm>
                <a:off x="9688334" y="3718668"/>
                <a:ext cx="421590" cy="246221"/>
              </a:xfrm>
              <a:prstGeom prst="rect">
                <a:avLst/>
              </a:prstGeom>
              <a:noFill/>
            </p:spPr>
            <p:txBody>
              <a:bodyPr wrap="none" lIns="0" tIns="0" rIns="0" bIns="0" anchor="b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ja-JP" sz="1600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EOT</a:t>
                </a:r>
              </a:p>
            </p:txBody>
          </p:sp>
          <p:grpSp>
            <p:nvGrpSpPr>
              <p:cNvPr id="420" name="グループ化 419">
                <a:extLst>
                  <a:ext uri="{FF2B5EF4-FFF2-40B4-BE49-F238E27FC236}">
                    <a16:creationId xmlns:a16="http://schemas.microsoft.com/office/drawing/2014/main" id="{A3840B63-AB03-4E43-24B6-E05A99FFB9B4}"/>
                  </a:ext>
                </a:extLst>
              </p:cNvPr>
              <p:cNvGrpSpPr/>
              <p:nvPr/>
            </p:nvGrpSpPr>
            <p:grpSpPr>
              <a:xfrm>
                <a:off x="3578991" y="4146994"/>
                <a:ext cx="6585760" cy="1630360"/>
                <a:chOff x="3581902" y="4146994"/>
                <a:chExt cx="6585760" cy="1630360"/>
              </a:xfrm>
            </p:grpSpPr>
            <p:grpSp>
              <p:nvGrpSpPr>
                <p:cNvPr id="418" name="グループ化 417">
                  <a:extLst>
                    <a:ext uri="{FF2B5EF4-FFF2-40B4-BE49-F238E27FC236}">
                      <a16:creationId xmlns:a16="http://schemas.microsoft.com/office/drawing/2014/main" id="{A34A7B9B-4AEB-B08F-ED54-E754B7724B4E}"/>
                    </a:ext>
                  </a:extLst>
                </p:cNvPr>
                <p:cNvGrpSpPr/>
                <p:nvPr/>
              </p:nvGrpSpPr>
              <p:grpSpPr>
                <a:xfrm>
                  <a:off x="5207582" y="4146994"/>
                  <a:ext cx="4960080" cy="1630360"/>
                  <a:chOff x="5207582" y="4146994"/>
                  <a:chExt cx="4960080" cy="1630360"/>
                </a:xfrm>
              </p:grpSpPr>
              <p:grpSp>
                <p:nvGrpSpPr>
                  <p:cNvPr id="295" name="グループ化 294">
                    <a:extLst>
                      <a:ext uri="{FF2B5EF4-FFF2-40B4-BE49-F238E27FC236}">
                        <a16:creationId xmlns:a16="http://schemas.microsoft.com/office/drawing/2014/main" id="{0A712CDC-7412-84BB-416E-A36412FFCCB8}"/>
                      </a:ext>
                    </a:extLst>
                  </p:cNvPr>
                  <p:cNvGrpSpPr/>
                  <p:nvPr/>
                </p:nvGrpSpPr>
                <p:grpSpPr>
                  <a:xfrm>
                    <a:off x="5207582" y="4156518"/>
                    <a:ext cx="108000" cy="1401319"/>
                    <a:chOff x="3181267" y="2597151"/>
                    <a:chExt cx="108000" cy="2157062"/>
                  </a:xfrm>
                </p:grpSpPr>
                <p:cxnSp>
                  <p:nvCxnSpPr>
                    <p:cNvPr id="312" name="直線コネクタ 311">
                      <a:extLst>
                        <a:ext uri="{FF2B5EF4-FFF2-40B4-BE49-F238E27FC236}">
                          <a16:creationId xmlns:a16="http://schemas.microsoft.com/office/drawing/2014/main" id="{F0C872D7-9882-EBE2-6EEB-632F4B377C1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3" name="直線コネクタ 312">
                      <a:extLst>
                        <a:ext uri="{FF2B5EF4-FFF2-40B4-BE49-F238E27FC236}">
                          <a16:creationId xmlns:a16="http://schemas.microsoft.com/office/drawing/2014/main" id="{25AA8AA9-E271-BBCA-031E-1308F713BBB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4" name="直線コネクタ 313">
                      <a:extLst>
                        <a:ext uri="{FF2B5EF4-FFF2-40B4-BE49-F238E27FC236}">
                          <a16:creationId xmlns:a16="http://schemas.microsoft.com/office/drawing/2014/main" id="{96095955-FC63-F493-9EEE-D33E7AE6518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96" name="グループ化 295">
                    <a:extLst>
                      <a:ext uri="{FF2B5EF4-FFF2-40B4-BE49-F238E27FC236}">
                        <a16:creationId xmlns:a16="http://schemas.microsoft.com/office/drawing/2014/main" id="{67350B1A-F6CC-DB85-6C31-35F853D6A185}"/>
                      </a:ext>
                    </a:extLst>
                  </p:cNvPr>
                  <p:cNvGrpSpPr/>
                  <p:nvPr/>
                </p:nvGrpSpPr>
                <p:grpSpPr>
                  <a:xfrm>
                    <a:off x="6806881" y="4146994"/>
                    <a:ext cx="108000" cy="1282256"/>
                    <a:chOff x="3181267" y="2597151"/>
                    <a:chExt cx="108000" cy="2157062"/>
                  </a:xfrm>
                </p:grpSpPr>
                <p:cxnSp>
                  <p:nvCxnSpPr>
                    <p:cNvPr id="309" name="直線コネクタ 308">
                      <a:extLst>
                        <a:ext uri="{FF2B5EF4-FFF2-40B4-BE49-F238E27FC236}">
                          <a16:creationId xmlns:a16="http://schemas.microsoft.com/office/drawing/2014/main" id="{6B8F827C-C8F3-39C2-EF74-77FA4D2F889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0" name="直線コネクタ 309">
                      <a:extLst>
                        <a:ext uri="{FF2B5EF4-FFF2-40B4-BE49-F238E27FC236}">
                          <a16:creationId xmlns:a16="http://schemas.microsoft.com/office/drawing/2014/main" id="{826FFED6-9895-1BB3-AA8B-90E91CFE5A8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1" name="直線コネクタ 310">
                      <a:extLst>
                        <a:ext uri="{FF2B5EF4-FFF2-40B4-BE49-F238E27FC236}">
                          <a16:creationId xmlns:a16="http://schemas.microsoft.com/office/drawing/2014/main" id="{3DA2535E-B181-004D-78C4-BA121408376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17" name="グループ化 416">
                    <a:extLst>
                      <a:ext uri="{FF2B5EF4-FFF2-40B4-BE49-F238E27FC236}">
                        <a16:creationId xmlns:a16="http://schemas.microsoft.com/office/drawing/2014/main" id="{4245FBC7-6D22-DF35-193D-413F293343E2}"/>
                      </a:ext>
                    </a:extLst>
                  </p:cNvPr>
                  <p:cNvGrpSpPr/>
                  <p:nvPr/>
                </p:nvGrpSpPr>
                <p:grpSpPr>
                  <a:xfrm>
                    <a:off x="8360287" y="4193381"/>
                    <a:ext cx="211596" cy="1540533"/>
                    <a:chOff x="8360287" y="4193381"/>
                    <a:chExt cx="211596" cy="1540533"/>
                  </a:xfrm>
                </p:grpSpPr>
                <p:grpSp>
                  <p:nvGrpSpPr>
                    <p:cNvPr id="304" name="グループ化 303">
                      <a:extLst>
                        <a:ext uri="{FF2B5EF4-FFF2-40B4-BE49-F238E27FC236}">
                          <a16:creationId xmlns:a16="http://schemas.microsoft.com/office/drawing/2014/main" id="{24B559E5-FA1D-4338-4FAD-85BFBA48112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12352" y="4193381"/>
                      <a:ext cx="108000" cy="1285705"/>
                      <a:chOff x="9259442" y="1742178"/>
                      <a:chExt cx="108000" cy="310645"/>
                    </a:xfrm>
                  </p:grpSpPr>
                  <p:cxnSp>
                    <p:nvCxnSpPr>
                      <p:cNvPr id="306" name="直線コネクタ 305">
                        <a:extLst>
                          <a:ext uri="{FF2B5EF4-FFF2-40B4-BE49-F238E27FC236}">
                            <a16:creationId xmlns:a16="http://schemas.microsoft.com/office/drawing/2014/main" id="{74C3F844-16F9-92A9-33B1-F25B13871A5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313442" y="1742178"/>
                        <a:ext cx="0" cy="310645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7" name="直線コネクタ 306">
                        <a:extLst>
                          <a:ext uri="{FF2B5EF4-FFF2-40B4-BE49-F238E27FC236}">
                            <a16:creationId xmlns:a16="http://schemas.microsoft.com/office/drawing/2014/main" id="{DBDF3158-9BE9-824E-BE3D-C04612C0C3E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205282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8" name="直線コネクタ 307">
                        <a:extLst>
                          <a:ext uri="{FF2B5EF4-FFF2-40B4-BE49-F238E27FC236}">
                            <a16:creationId xmlns:a16="http://schemas.microsoft.com/office/drawing/2014/main" id="{0864A25C-814A-AA71-3611-E2A00D008CF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259442" y="1742178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05" name="テキスト ボックス 304">
                      <a:extLst>
                        <a:ext uri="{FF2B5EF4-FFF2-40B4-BE49-F238E27FC236}">
                          <a16:creationId xmlns:a16="http://schemas.microsoft.com/office/drawing/2014/main" id="{D4A9FE5F-F820-6C4B-0AFB-4A83A6BD9EF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60287" y="5482119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  <p:grpSp>
                <p:nvGrpSpPr>
                  <p:cNvPr id="415" name="グループ化 414">
                    <a:extLst>
                      <a:ext uri="{FF2B5EF4-FFF2-40B4-BE49-F238E27FC236}">
                        <a16:creationId xmlns:a16="http://schemas.microsoft.com/office/drawing/2014/main" id="{88D11546-783E-FE75-DEF4-8E647638F855}"/>
                      </a:ext>
                    </a:extLst>
                  </p:cNvPr>
                  <p:cNvGrpSpPr/>
                  <p:nvPr/>
                </p:nvGrpSpPr>
                <p:grpSpPr>
                  <a:xfrm>
                    <a:off x="9956066" y="4205288"/>
                    <a:ext cx="211596" cy="1572066"/>
                    <a:chOff x="9956066" y="4205288"/>
                    <a:chExt cx="211596" cy="1572066"/>
                  </a:xfrm>
                </p:grpSpPr>
                <p:grpSp>
                  <p:nvGrpSpPr>
                    <p:cNvPr id="299" name="グループ化 298">
                      <a:extLst>
                        <a:ext uri="{FF2B5EF4-FFF2-40B4-BE49-F238E27FC236}">
                          <a16:creationId xmlns:a16="http://schemas.microsoft.com/office/drawing/2014/main" id="{1F6822E7-2AB1-3137-091F-B5E76E7C747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007866" y="4205288"/>
                      <a:ext cx="108000" cy="1316971"/>
                      <a:chOff x="3181267" y="2597151"/>
                      <a:chExt cx="108000" cy="2157062"/>
                    </a:xfrm>
                  </p:grpSpPr>
                  <p:cxnSp>
                    <p:nvCxnSpPr>
                      <p:cNvPr id="301" name="直線コネクタ 300">
                        <a:extLst>
                          <a:ext uri="{FF2B5EF4-FFF2-40B4-BE49-F238E27FC236}">
                            <a16:creationId xmlns:a16="http://schemas.microsoft.com/office/drawing/2014/main" id="{E1F82E6B-36B1-5E36-4D1D-90ED178C105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2" name="直線コネクタ 301">
                        <a:extLst>
                          <a:ext uri="{FF2B5EF4-FFF2-40B4-BE49-F238E27FC236}">
                            <a16:creationId xmlns:a16="http://schemas.microsoft.com/office/drawing/2014/main" id="{40F6C342-89EB-8216-FF2A-79F9C7CF48B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3" name="直線コネクタ 302">
                        <a:extLst>
                          <a:ext uri="{FF2B5EF4-FFF2-40B4-BE49-F238E27FC236}">
                            <a16:creationId xmlns:a16="http://schemas.microsoft.com/office/drawing/2014/main" id="{793B4C9A-8CCD-91CD-C971-39408FE5F81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00" name="テキスト ボックス 299">
                      <a:extLst>
                        <a:ext uri="{FF2B5EF4-FFF2-40B4-BE49-F238E27FC236}">
                          <a16:creationId xmlns:a16="http://schemas.microsoft.com/office/drawing/2014/main" id="{27CEADCF-CF22-EAAC-1433-1EAA7DF9BDB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56066" y="5525559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414" name="グループ化 413">
                  <a:extLst>
                    <a:ext uri="{FF2B5EF4-FFF2-40B4-BE49-F238E27FC236}">
                      <a16:creationId xmlns:a16="http://schemas.microsoft.com/office/drawing/2014/main" id="{024FC120-67C3-3446-0237-B113C5C22D04}"/>
                    </a:ext>
                  </a:extLst>
                </p:cNvPr>
                <p:cNvGrpSpPr/>
                <p:nvPr/>
              </p:nvGrpSpPr>
              <p:grpSpPr>
                <a:xfrm>
                  <a:off x="3581902" y="4388145"/>
                  <a:ext cx="6551963" cy="544767"/>
                  <a:chOff x="3581902" y="4388145"/>
                  <a:chExt cx="6551963" cy="544767"/>
                </a:xfrm>
              </p:grpSpPr>
              <p:sp>
                <p:nvSpPr>
                  <p:cNvPr id="290" name="楕円 289">
                    <a:extLst>
                      <a:ext uri="{FF2B5EF4-FFF2-40B4-BE49-F238E27FC236}">
                        <a16:creationId xmlns:a16="http://schemas.microsoft.com/office/drawing/2014/main" id="{CEA2B6AF-4048-601E-2D33-984DFAACC197}"/>
                      </a:ext>
                    </a:extLst>
                  </p:cNvPr>
                  <p:cNvSpPr/>
                  <p:nvPr/>
                </p:nvSpPr>
                <p:spPr>
                  <a:xfrm>
                    <a:off x="3581902" y="4388145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1" name="楕円 290">
                    <a:extLst>
                      <a:ext uri="{FF2B5EF4-FFF2-40B4-BE49-F238E27FC236}">
                        <a16:creationId xmlns:a16="http://schemas.microsoft.com/office/drawing/2014/main" id="{56BA0A2A-0661-8765-6187-05D7727F73E6}"/>
                      </a:ext>
                    </a:extLst>
                  </p:cNvPr>
                  <p:cNvSpPr/>
                  <p:nvPr/>
                </p:nvSpPr>
                <p:spPr>
                  <a:xfrm>
                    <a:off x="5189581" y="4783797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2" name="楕円 291">
                    <a:extLst>
                      <a:ext uri="{FF2B5EF4-FFF2-40B4-BE49-F238E27FC236}">
                        <a16:creationId xmlns:a16="http://schemas.microsoft.com/office/drawing/2014/main" id="{2EC3F0C6-C2E9-50EC-89BA-0B2304931564}"/>
                      </a:ext>
                    </a:extLst>
                  </p:cNvPr>
                  <p:cNvSpPr/>
                  <p:nvPr/>
                </p:nvSpPr>
                <p:spPr>
                  <a:xfrm>
                    <a:off x="6788880" y="4717244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3" name="楕円 292">
                    <a:extLst>
                      <a:ext uri="{FF2B5EF4-FFF2-40B4-BE49-F238E27FC236}">
                        <a16:creationId xmlns:a16="http://schemas.microsoft.com/office/drawing/2014/main" id="{0CA178C8-7449-433C-ACC0-9F042E769606}"/>
                      </a:ext>
                    </a:extLst>
                  </p:cNvPr>
                  <p:cNvSpPr/>
                  <p:nvPr/>
                </p:nvSpPr>
                <p:spPr>
                  <a:xfrm>
                    <a:off x="8394351" y="4760868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4" name="楕円 293">
                    <a:extLst>
                      <a:ext uri="{FF2B5EF4-FFF2-40B4-BE49-F238E27FC236}">
                        <a16:creationId xmlns:a16="http://schemas.microsoft.com/office/drawing/2014/main" id="{D814B697-FF70-EEA5-26A7-29DFD3EAD1AB}"/>
                      </a:ext>
                    </a:extLst>
                  </p:cNvPr>
                  <p:cNvSpPr/>
                  <p:nvPr/>
                </p:nvSpPr>
                <p:spPr>
                  <a:xfrm>
                    <a:off x="9989865" y="4788912"/>
                    <a:ext cx="144000" cy="1440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19" name="フリーフォーム: 図形 418">
                  <a:extLst>
                    <a:ext uri="{FF2B5EF4-FFF2-40B4-BE49-F238E27FC236}">
                      <a16:creationId xmlns:a16="http://schemas.microsoft.com/office/drawing/2014/main" id="{C3E58E39-8C6F-48A0-5CAE-F276827B538D}"/>
                    </a:ext>
                  </a:extLst>
                </p:cNvPr>
                <p:cNvSpPr/>
                <p:nvPr/>
              </p:nvSpPr>
              <p:spPr>
                <a:xfrm>
                  <a:off x="3648075" y="4464050"/>
                  <a:ext cx="4818063" cy="393700"/>
                </a:xfrm>
                <a:custGeom>
                  <a:avLst/>
                  <a:gdLst>
                    <a:gd name="connsiteX0" fmla="*/ 0 w 4814888"/>
                    <a:gd name="connsiteY0" fmla="*/ 0 h 400050"/>
                    <a:gd name="connsiteX1" fmla="*/ 1614488 w 4814888"/>
                    <a:gd name="connsiteY1" fmla="*/ 400050 h 400050"/>
                    <a:gd name="connsiteX2" fmla="*/ 3214688 w 4814888"/>
                    <a:gd name="connsiteY2" fmla="*/ 333375 h 400050"/>
                    <a:gd name="connsiteX3" fmla="*/ 4814888 w 4814888"/>
                    <a:gd name="connsiteY3" fmla="*/ 381000 h 400050"/>
                    <a:gd name="connsiteX0" fmla="*/ 0 w 4818063"/>
                    <a:gd name="connsiteY0" fmla="*/ 0 h 400050"/>
                    <a:gd name="connsiteX1" fmla="*/ 1614488 w 4818063"/>
                    <a:gd name="connsiteY1" fmla="*/ 400050 h 400050"/>
                    <a:gd name="connsiteX2" fmla="*/ 3214688 w 4818063"/>
                    <a:gd name="connsiteY2" fmla="*/ 333375 h 400050"/>
                    <a:gd name="connsiteX3" fmla="*/ 4818063 w 4818063"/>
                    <a:gd name="connsiteY3" fmla="*/ 381000 h 400050"/>
                    <a:gd name="connsiteX0" fmla="*/ 0 w 4818063"/>
                    <a:gd name="connsiteY0" fmla="*/ 0 h 393700"/>
                    <a:gd name="connsiteX1" fmla="*/ 1614488 w 4818063"/>
                    <a:gd name="connsiteY1" fmla="*/ 393700 h 393700"/>
                    <a:gd name="connsiteX2" fmla="*/ 3214688 w 4818063"/>
                    <a:gd name="connsiteY2" fmla="*/ 327025 h 393700"/>
                    <a:gd name="connsiteX3" fmla="*/ 4818063 w 4818063"/>
                    <a:gd name="connsiteY3" fmla="*/ 374650 h 393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8063" h="393700">
                      <a:moveTo>
                        <a:pt x="0" y="0"/>
                      </a:moveTo>
                      <a:lnTo>
                        <a:pt x="1614488" y="393700"/>
                      </a:lnTo>
                      <a:lnTo>
                        <a:pt x="3214688" y="327025"/>
                      </a:lnTo>
                      <a:lnTo>
                        <a:pt x="4818063" y="374650"/>
                      </a:lnTo>
                    </a:path>
                  </a:pathLst>
                </a:custGeom>
                <a:noFill/>
                <a:ln w="38100">
                  <a:solidFill>
                    <a:srgbClr val="0000FF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410" name="グループ化 409">
                <a:extLst>
                  <a:ext uri="{FF2B5EF4-FFF2-40B4-BE49-F238E27FC236}">
                    <a16:creationId xmlns:a16="http://schemas.microsoft.com/office/drawing/2014/main" id="{27E5750F-68A1-1EF3-B1BC-A077BB3C01AA}"/>
                  </a:ext>
                </a:extLst>
              </p:cNvPr>
              <p:cNvGrpSpPr/>
              <p:nvPr/>
            </p:nvGrpSpPr>
            <p:grpSpPr>
              <a:xfrm>
                <a:off x="3417010" y="4043363"/>
                <a:ext cx="6585765" cy="2131602"/>
                <a:chOff x="3419921" y="4043363"/>
                <a:chExt cx="6585765" cy="2131602"/>
              </a:xfrm>
            </p:grpSpPr>
            <p:grpSp>
              <p:nvGrpSpPr>
                <p:cNvPr id="408" name="グループ化 407">
                  <a:extLst>
                    <a:ext uri="{FF2B5EF4-FFF2-40B4-BE49-F238E27FC236}">
                      <a16:creationId xmlns:a16="http://schemas.microsoft.com/office/drawing/2014/main" id="{272F47FA-6F2C-7414-5F62-D03821ED0FF8}"/>
                    </a:ext>
                  </a:extLst>
                </p:cNvPr>
                <p:cNvGrpSpPr/>
                <p:nvPr/>
              </p:nvGrpSpPr>
              <p:grpSpPr>
                <a:xfrm>
                  <a:off x="5045601" y="4043363"/>
                  <a:ext cx="4960085" cy="2131602"/>
                  <a:chOff x="5045601" y="4043363"/>
                  <a:chExt cx="4960085" cy="2131602"/>
                </a:xfrm>
              </p:grpSpPr>
              <p:grpSp>
                <p:nvGrpSpPr>
                  <p:cNvPr id="267" name="グループ化 266">
                    <a:extLst>
                      <a:ext uri="{FF2B5EF4-FFF2-40B4-BE49-F238E27FC236}">
                        <a16:creationId xmlns:a16="http://schemas.microsoft.com/office/drawing/2014/main" id="{C6D6FD21-9B91-AC4E-2DAA-7D2A3990856C}"/>
                      </a:ext>
                    </a:extLst>
                  </p:cNvPr>
                  <p:cNvGrpSpPr/>
                  <p:nvPr/>
                </p:nvGrpSpPr>
                <p:grpSpPr>
                  <a:xfrm>
                    <a:off x="5045601" y="4176840"/>
                    <a:ext cx="108000" cy="1611979"/>
                    <a:chOff x="3181267" y="2597151"/>
                    <a:chExt cx="108000" cy="2157062"/>
                  </a:xfrm>
                </p:grpSpPr>
                <p:cxnSp>
                  <p:nvCxnSpPr>
                    <p:cNvPr id="284" name="直線コネクタ 283">
                      <a:extLst>
                        <a:ext uri="{FF2B5EF4-FFF2-40B4-BE49-F238E27FC236}">
                          <a16:creationId xmlns:a16="http://schemas.microsoft.com/office/drawing/2014/main" id="{12D3BBAD-3FD4-19A1-B386-8BC7D976192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5" name="直線コネクタ 284">
                      <a:extLst>
                        <a:ext uri="{FF2B5EF4-FFF2-40B4-BE49-F238E27FC236}">
                          <a16:creationId xmlns:a16="http://schemas.microsoft.com/office/drawing/2014/main" id="{7909FC89-0A0C-2256-BD19-CFDF593E8D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6" name="直線コネクタ 285">
                      <a:extLst>
                        <a:ext uri="{FF2B5EF4-FFF2-40B4-BE49-F238E27FC236}">
                          <a16:creationId xmlns:a16="http://schemas.microsoft.com/office/drawing/2014/main" id="{0A17AF89-C899-BF57-0631-47A6DC9C378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68" name="グループ化 267">
                    <a:extLst>
                      <a:ext uri="{FF2B5EF4-FFF2-40B4-BE49-F238E27FC236}">
                        <a16:creationId xmlns:a16="http://schemas.microsoft.com/office/drawing/2014/main" id="{2450445D-72D2-2153-1B48-7F0F55BF46B0}"/>
                      </a:ext>
                    </a:extLst>
                  </p:cNvPr>
                  <p:cNvGrpSpPr/>
                  <p:nvPr/>
                </p:nvGrpSpPr>
                <p:grpSpPr>
                  <a:xfrm>
                    <a:off x="6644900" y="4317333"/>
                    <a:ext cx="108000" cy="1380998"/>
                    <a:chOff x="3181267" y="2597151"/>
                    <a:chExt cx="108000" cy="2157062"/>
                  </a:xfrm>
                </p:grpSpPr>
                <p:cxnSp>
                  <p:nvCxnSpPr>
                    <p:cNvPr id="281" name="直線コネクタ 280">
                      <a:extLst>
                        <a:ext uri="{FF2B5EF4-FFF2-40B4-BE49-F238E27FC236}">
                          <a16:creationId xmlns:a16="http://schemas.microsoft.com/office/drawing/2014/main" id="{C6D22802-A1DF-D219-973B-64B115F5EC2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2" name="直線コネクタ 281">
                      <a:extLst>
                        <a:ext uri="{FF2B5EF4-FFF2-40B4-BE49-F238E27FC236}">
                          <a16:creationId xmlns:a16="http://schemas.microsoft.com/office/drawing/2014/main" id="{A1C7036F-5AC5-5817-AB89-272060191B3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3" name="直線コネクタ 282">
                      <a:extLst>
                        <a:ext uri="{FF2B5EF4-FFF2-40B4-BE49-F238E27FC236}">
                          <a16:creationId xmlns:a16="http://schemas.microsoft.com/office/drawing/2014/main" id="{F63DBBCC-D2F9-21C1-17F6-38C56CC4295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07" name="グループ化 406">
                    <a:extLst>
                      <a:ext uri="{FF2B5EF4-FFF2-40B4-BE49-F238E27FC236}">
                        <a16:creationId xmlns:a16="http://schemas.microsoft.com/office/drawing/2014/main" id="{8DCA1460-509C-4D71-707E-17C609332259}"/>
                      </a:ext>
                    </a:extLst>
                  </p:cNvPr>
                  <p:cNvGrpSpPr/>
                  <p:nvPr/>
                </p:nvGrpSpPr>
                <p:grpSpPr>
                  <a:xfrm>
                    <a:off x="8233611" y="4043363"/>
                    <a:ext cx="141064" cy="1972961"/>
                    <a:chOff x="8233611" y="4043363"/>
                    <a:chExt cx="141064" cy="1972961"/>
                  </a:xfrm>
                </p:grpSpPr>
                <p:sp>
                  <p:nvSpPr>
                    <p:cNvPr id="276" name="テキスト ボックス 275">
                      <a:extLst>
                        <a:ext uri="{FF2B5EF4-FFF2-40B4-BE49-F238E27FC236}">
                          <a16:creationId xmlns:a16="http://schemas.microsoft.com/office/drawing/2014/main" id="{8D3B54A8-6A9F-18E8-B1B7-93678ABA1C5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233611" y="5764529"/>
                      <a:ext cx="141064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</a:t>
                      </a:r>
                    </a:p>
                  </p:txBody>
                </p:sp>
                <p:grpSp>
                  <p:nvGrpSpPr>
                    <p:cNvPr id="277" name="グループ化 276">
                      <a:extLst>
                        <a:ext uri="{FF2B5EF4-FFF2-40B4-BE49-F238E27FC236}">
                          <a16:creationId xmlns:a16="http://schemas.microsoft.com/office/drawing/2014/main" id="{37C56F97-7D51-085F-374C-5AEBFF6D879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50371" y="4043363"/>
                      <a:ext cx="108000" cy="1718320"/>
                      <a:chOff x="3181267" y="2597151"/>
                      <a:chExt cx="108000" cy="2157062"/>
                    </a:xfrm>
                  </p:grpSpPr>
                  <p:cxnSp>
                    <p:nvCxnSpPr>
                      <p:cNvPr id="278" name="直線コネクタ 277">
                        <a:extLst>
                          <a:ext uri="{FF2B5EF4-FFF2-40B4-BE49-F238E27FC236}">
                            <a16:creationId xmlns:a16="http://schemas.microsoft.com/office/drawing/2014/main" id="{9619AD78-1B17-45FA-A703-0A03ECDDEA9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9" name="直線コネクタ 278">
                        <a:extLst>
                          <a:ext uri="{FF2B5EF4-FFF2-40B4-BE49-F238E27FC236}">
                            <a16:creationId xmlns:a16="http://schemas.microsoft.com/office/drawing/2014/main" id="{75D08A66-4F8A-4026-1326-B77BF4DD980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406" name="グループ化 405">
                    <a:extLst>
                      <a:ext uri="{FF2B5EF4-FFF2-40B4-BE49-F238E27FC236}">
                        <a16:creationId xmlns:a16="http://schemas.microsoft.com/office/drawing/2014/main" id="{F1EF15EA-4C7F-86DB-29FF-5EB4D53AC22F}"/>
                      </a:ext>
                    </a:extLst>
                  </p:cNvPr>
                  <p:cNvGrpSpPr/>
                  <p:nvPr/>
                </p:nvGrpSpPr>
                <p:grpSpPr>
                  <a:xfrm>
                    <a:off x="9794090" y="4048125"/>
                    <a:ext cx="211596" cy="2126840"/>
                    <a:chOff x="9794090" y="4048125"/>
                    <a:chExt cx="211596" cy="2126840"/>
                  </a:xfrm>
                </p:grpSpPr>
                <p:grpSp>
                  <p:nvGrpSpPr>
                    <p:cNvPr id="271" name="グループ化 270">
                      <a:extLst>
                        <a:ext uri="{FF2B5EF4-FFF2-40B4-BE49-F238E27FC236}">
                          <a16:creationId xmlns:a16="http://schemas.microsoft.com/office/drawing/2014/main" id="{016FDFD0-934A-204D-C985-C5F84FFCD26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845885" y="4048125"/>
                      <a:ext cx="108000" cy="1872742"/>
                      <a:chOff x="3181267" y="2597151"/>
                      <a:chExt cx="108000" cy="2157062"/>
                    </a:xfrm>
                  </p:grpSpPr>
                  <p:cxnSp>
                    <p:nvCxnSpPr>
                      <p:cNvPr id="273" name="直線コネクタ 272">
                        <a:extLst>
                          <a:ext uri="{FF2B5EF4-FFF2-40B4-BE49-F238E27FC236}">
                            <a16:creationId xmlns:a16="http://schemas.microsoft.com/office/drawing/2014/main" id="{145D2603-0BF9-5EE4-F694-941E0248C48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4" name="直線コネクタ 273">
                        <a:extLst>
                          <a:ext uri="{FF2B5EF4-FFF2-40B4-BE49-F238E27FC236}">
                            <a16:creationId xmlns:a16="http://schemas.microsoft.com/office/drawing/2014/main" id="{28150BE6-46D3-B779-5DCA-E5E0C9F140B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72" name="テキスト ボックス 271">
                      <a:extLst>
                        <a:ext uri="{FF2B5EF4-FFF2-40B4-BE49-F238E27FC236}">
                          <a16:creationId xmlns:a16="http://schemas.microsoft.com/office/drawing/2014/main" id="{B0989CFF-C3E6-C62A-B5C3-8216E3CF15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94090" y="5923170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405" name="グループ化 404">
                  <a:extLst>
                    <a:ext uri="{FF2B5EF4-FFF2-40B4-BE49-F238E27FC236}">
                      <a16:creationId xmlns:a16="http://schemas.microsoft.com/office/drawing/2014/main" id="{C47E9110-ACBE-B937-E6AE-8226C0C47BDF}"/>
                    </a:ext>
                  </a:extLst>
                </p:cNvPr>
                <p:cNvGrpSpPr/>
                <p:nvPr/>
              </p:nvGrpSpPr>
              <p:grpSpPr>
                <a:xfrm>
                  <a:off x="3419921" y="4388145"/>
                  <a:ext cx="6551963" cy="691773"/>
                  <a:chOff x="3419921" y="4388145"/>
                  <a:chExt cx="6551963" cy="691773"/>
                </a:xfrm>
              </p:grpSpPr>
              <p:sp>
                <p:nvSpPr>
                  <p:cNvPr id="262" name="楕円 261">
                    <a:extLst>
                      <a:ext uri="{FF2B5EF4-FFF2-40B4-BE49-F238E27FC236}">
                        <a16:creationId xmlns:a16="http://schemas.microsoft.com/office/drawing/2014/main" id="{D4E7E839-32CB-016C-D7AB-9444F629E109}"/>
                      </a:ext>
                    </a:extLst>
                  </p:cNvPr>
                  <p:cNvSpPr/>
                  <p:nvPr/>
                </p:nvSpPr>
                <p:spPr>
                  <a:xfrm>
                    <a:off x="3419921" y="4388145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3" name="楕円 262">
                    <a:extLst>
                      <a:ext uri="{FF2B5EF4-FFF2-40B4-BE49-F238E27FC236}">
                        <a16:creationId xmlns:a16="http://schemas.microsoft.com/office/drawing/2014/main" id="{321F5F4B-8871-FEFE-F0CB-8B4BB1E9D9D0}"/>
                      </a:ext>
                    </a:extLst>
                  </p:cNvPr>
                  <p:cNvSpPr/>
                  <p:nvPr/>
                </p:nvSpPr>
                <p:spPr>
                  <a:xfrm>
                    <a:off x="5027600" y="4910204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4" name="楕円 263">
                    <a:extLst>
                      <a:ext uri="{FF2B5EF4-FFF2-40B4-BE49-F238E27FC236}">
                        <a16:creationId xmlns:a16="http://schemas.microsoft.com/office/drawing/2014/main" id="{D29A1BED-5100-6D76-C53A-132D76C5D252}"/>
                      </a:ext>
                    </a:extLst>
                  </p:cNvPr>
                  <p:cNvSpPr/>
                  <p:nvPr/>
                </p:nvSpPr>
                <p:spPr>
                  <a:xfrm>
                    <a:off x="6626899" y="4935918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5" name="楕円 264">
                    <a:extLst>
                      <a:ext uri="{FF2B5EF4-FFF2-40B4-BE49-F238E27FC236}">
                        <a16:creationId xmlns:a16="http://schemas.microsoft.com/office/drawing/2014/main" id="{9B85AA30-5C9D-57F6-FBEA-44056C8D332E}"/>
                      </a:ext>
                    </a:extLst>
                  </p:cNvPr>
                  <p:cNvSpPr/>
                  <p:nvPr/>
                </p:nvSpPr>
                <p:spPr>
                  <a:xfrm>
                    <a:off x="8232370" y="4831310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6" name="楕円 265">
                    <a:extLst>
                      <a:ext uri="{FF2B5EF4-FFF2-40B4-BE49-F238E27FC236}">
                        <a16:creationId xmlns:a16="http://schemas.microsoft.com/office/drawing/2014/main" id="{F2AF401C-6046-0163-0B16-832D685A41F6}"/>
                      </a:ext>
                    </a:extLst>
                  </p:cNvPr>
                  <p:cNvSpPr/>
                  <p:nvPr/>
                </p:nvSpPr>
                <p:spPr>
                  <a:xfrm>
                    <a:off x="9827884" y="4906102"/>
                    <a:ext cx="144000" cy="1440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09" name="フリーフォーム: 図形 408">
                  <a:extLst>
                    <a:ext uri="{FF2B5EF4-FFF2-40B4-BE49-F238E27FC236}">
                      <a16:creationId xmlns:a16="http://schemas.microsoft.com/office/drawing/2014/main" id="{14AB68DC-D9A7-5E0F-5F44-9C41637F4AF6}"/>
                    </a:ext>
                  </a:extLst>
                </p:cNvPr>
                <p:cNvSpPr/>
                <p:nvPr/>
              </p:nvSpPr>
              <p:spPr>
                <a:xfrm>
                  <a:off x="3492500" y="4457700"/>
                  <a:ext cx="4813300" cy="547688"/>
                </a:xfrm>
                <a:custGeom>
                  <a:avLst/>
                  <a:gdLst>
                    <a:gd name="connsiteX0" fmla="*/ 0 w 4819650"/>
                    <a:gd name="connsiteY0" fmla="*/ 0 h 547688"/>
                    <a:gd name="connsiteX1" fmla="*/ 1609725 w 4819650"/>
                    <a:gd name="connsiteY1" fmla="*/ 528638 h 547688"/>
                    <a:gd name="connsiteX2" fmla="*/ 3214688 w 4819650"/>
                    <a:gd name="connsiteY2" fmla="*/ 547688 h 547688"/>
                    <a:gd name="connsiteX3" fmla="*/ 4819650 w 4819650"/>
                    <a:gd name="connsiteY3" fmla="*/ 447675 h 547688"/>
                    <a:gd name="connsiteX0" fmla="*/ 0 w 4813300"/>
                    <a:gd name="connsiteY0" fmla="*/ 0 h 547688"/>
                    <a:gd name="connsiteX1" fmla="*/ 1603375 w 4813300"/>
                    <a:gd name="connsiteY1" fmla="*/ 528638 h 547688"/>
                    <a:gd name="connsiteX2" fmla="*/ 3208338 w 4813300"/>
                    <a:gd name="connsiteY2" fmla="*/ 547688 h 547688"/>
                    <a:gd name="connsiteX3" fmla="*/ 4813300 w 4813300"/>
                    <a:gd name="connsiteY3" fmla="*/ 447675 h 5476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3300" h="547688">
                      <a:moveTo>
                        <a:pt x="0" y="0"/>
                      </a:moveTo>
                      <a:lnTo>
                        <a:pt x="1603375" y="528638"/>
                      </a:lnTo>
                      <a:lnTo>
                        <a:pt x="3208338" y="547688"/>
                      </a:lnTo>
                      <a:lnTo>
                        <a:pt x="4813300" y="447675"/>
                      </a:lnTo>
                    </a:path>
                  </a:pathLst>
                </a:custGeom>
                <a:noFill/>
                <a:ln w="38100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401" name="グループ化 400">
                <a:extLst>
                  <a:ext uri="{FF2B5EF4-FFF2-40B4-BE49-F238E27FC236}">
                    <a16:creationId xmlns:a16="http://schemas.microsoft.com/office/drawing/2014/main" id="{2D5594BF-FF6E-B8A2-24AE-A2A0A7804D14}"/>
                  </a:ext>
                </a:extLst>
              </p:cNvPr>
              <p:cNvGrpSpPr/>
              <p:nvPr/>
            </p:nvGrpSpPr>
            <p:grpSpPr>
              <a:xfrm>
                <a:off x="3255028" y="4107656"/>
                <a:ext cx="6584981" cy="1871992"/>
                <a:chOff x="3257939" y="4107656"/>
                <a:chExt cx="6584981" cy="1871992"/>
              </a:xfrm>
            </p:grpSpPr>
            <p:grpSp>
              <p:nvGrpSpPr>
                <p:cNvPr id="399" name="グループ化 398">
                  <a:extLst>
                    <a:ext uri="{FF2B5EF4-FFF2-40B4-BE49-F238E27FC236}">
                      <a16:creationId xmlns:a16="http://schemas.microsoft.com/office/drawing/2014/main" id="{2480D180-4F5D-C136-E72E-15D92297EDD1}"/>
                    </a:ext>
                  </a:extLst>
                </p:cNvPr>
                <p:cNvGrpSpPr/>
                <p:nvPr/>
              </p:nvGrpSpPr>
              <p:grpSpPr>
                <a:xfrm>
                  <a:off x="4883619" y="4107656"/>
                  <a:ext cx="4959301" cy="1871992"/>
                  <a:chOff x="4883619" y="4107656"/>
                  <a:chExt cx="4959301" cy="1871992"/>
                </a:xfrm>
              </p:grpSpPr>
              <p:grpSp>
                <p:nvGrpSpPr>
                  <p:cNvPr id="323" name="グループ化 322">
                    <a:extLst>
                      <a:ext uri="{FF2B5EF4-FFF2-40B4-BE49-F238E27FC236}">
                        <a16:creationId xmlns:a16="http://schemas.microsoft.com/office/drawing/2014/main" id="{AA0A7326-1E8E-2B8A-F443-E0C73B8A2AFD}"/>
                      </a:ext>
                    </a:extLst>
                  </p:cNvPr>
                  <p:cNvGrpSpPr/>
                  <p:nvPr/>
                </p:nvGrpSpPr>
                <p:grpSpPr>
                  <a:xfrm>
                    <a:off x="4883619" y="4162424"/>
                    <a:ext cx="108000" cy="1507331"/>
                    <a:chOff x="3181267" y="2597151"/>
                    <a:chExt cx="108000" cy="2157062"/>
                  </a:xfrm>
                </p:grpSpPr>
                <p:cxnSp>
                  <p:nvCxnSpPr>
                    <p:cNvPr id="338" name="直線コネクタ 337">
                      <a:extLst>
                        <a:ext uri="{FF2B5EF4-FFF2-40B4-BE49-F238E27FC236}">
                          <a16:creationId xmlns:a16="http://schemas.microsoft.com/office/drawing/2014/main" id="{91832726-AA68-74F3-C8B7-3C203042127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9" name="直線コネクタ 338">
                      <a:extLst>
                        <a:ext uri="{FF2B5EF4-FFF2-40B4-BE49-F238E27FC236}">
                          <a16:creationId xmlns:a16="http://schemas.microsoft.com/office/drawing/2014/main" id="{8537396C-E254-3551-DFE8-9F70C7BD7D9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0" name="直線コネクタ 339">
                      <a:extLst>
                        <a:ext uri="{FF2B5EF4-FFF2-40B4-BE49-F238E27FC236}">
                          <a16:creationId xmlns:a16="http://schemas.microsoft.com/office/drawing/2014/main" id="{4F99B781-86CE-7B8B-EA60-438F1599532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24" name="グループ化 323">
                    <a:extLst>
                      <a:ext uri="{FF2B5EF4-FFF2-40B4-BE49-F238E27FC236}">
                        <a16:creationId xmlns:a16="http://schemas.microsoft.com/office/drawing/2014/main" id="{39E2F17E-CE11-8927-396E-CA1751AF02D7}"/>
                      </a:ext>
                    </a:extLst>
                  </p:cNvPr>
                  <p:cNvGrpSpPr/>
                  <p:nvPr/>
                </p:nvGrpSpPr>
                <p:grpSpPr>
                  <a:xfrm>
                    <a:off x="6482918" y="4229099"/>
                    <a:ext cx="108000" cy="1338263"/>
                    <a:chOff x="3181267" y="2597151"/>
                    <a:chExt cx="108000" cy="2157062"/>
                  </a:xfrm>
                </p:grpSpPr>
                <p:cxnSp>
                  <p:nvCxnSpPr>
                    <p:cNvPr id="335" name="直線コネクタ 334">
                      <a:extLst>
                        <a:ext uri="{FF2B5EF4-FFF2-40B4-BE49-F238E27FC236}">
                          <a16:creationId xmlns:a16="http://schemas.microsoft.com/office/drawing/2014/main" id="{CF1E9646-4899-2A6D-39CE-2AA63D942B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35267" y="2597151"/>
                      <a:ext cx="0" cy="215706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6" name="直線コネクタ 335">
                      <a:extLst>
                        <a:ext uri="{FF2B5EF4-FFF2-40B4-BE49-F238E27FC236}">
                          <a16:creationId xmlns:a16="http://schemas.microsoft.com/office/drawing/2014/main" id="{1E3F1739-9F7D-AF08-E735-161E6224C74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4754213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7" name="直線コネクタ 336">
                      <a:extLst>
                        <a:ext uri="{FF2B5EF4-FFF2-40B4-BE49-F238E27FC236}">
                          <a16:creationId xmlns:a16="http://schemas.microsoft.com/office/drawing/2014/main" id="{1C144AC7-1C7A-F933-2629-47C3E12FF1D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81267" y="2597151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98" name="グループ化 397">
                    <a:extLst>
                      <a:ext uri="{FF2B5EF4-FFF2-40B4-BE49-F238E27FC236}">
                        <a16:creationId xmlns:a16="http://schemas.microsoft.com/office/drawing/2014/main" id="{545A53E3-5601-6F9A-ED21-B42F26847481}"/>
                      </a:ext>
                    </a:extLst>
                  </p:cNvPr>
                  <p:cNvGrpSpPr/>
                  <p:nvPr/>
                </p:nvGrpSpPr>
                <p:grpSpPr>
                  <a:xfrm>
                    <a:off x="8036031" y="4114801"/>
                    <a:ext cx="211596" cy="1754851"/>
                    <a:chOff x="8036031" y="4114801"/>
                    <a:chExt cx="211596" cy="1754851"/>
                  </a:xfrm>
                </p:grpSpPr>
                <p:sp>
                  <p:nvSpPr>
                    <p:cNvPr id="255" name="テキスト ボックス 254">
                      <a:extLst>
                        <a:ext uri="{FF2B5EF4-FFF2-40B4-BE49-F238E27FC236}">
                          <a16:creationId xmlns:a16="http://schemas.microsoft.com/office/drawing/2014/main" id="{6B6CEFCD-27F2-0FD6-7868-4DD5F61840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36031" y="5617857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  <p:grpSp>
                  <p:nvGrpSpPr>
                    <p:cNvPr id="325" name="グループ化 324">
                      <a:extLst>
                        <a:ext uri="{FF2B5EF4-FFF2-40B4-BE49-F238E27FC236}">
                          <a16:creationId xmlns:a16="http://schemas.microsoft.com/office/drawing/2014/main" id="{62681249-5255-C0F0-49C3-9829D922B1F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88389" y="4114801"/>
                      <a:ext cx="108000" cy="1501258"/>
                      <a:chOff x="3181267" y="2597151"/>
                      <a:chExt cx="108000" cy="2157062"/>
                    </a:xfrm>
                  </p:grpSpPr>
                  <p:cxnSp>
                    <p:nvCxnSpPr>
                      <p:cNvPr id="332" name="直線コネクタ 331">
                        <a:extLst>
                          <a:ext uri="{FF2B5EF4-FFF2-40B4-BE49-F238E27FC236}">
                            <a16:creationId xmlns:a16="http://schemas.microsoft.com/office/drawing/2014/main" id="{F9397CE0-1649-31F4-E7E2-AD0154C800B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3" name="直線コネクタ 332">
                        <a:extLst>
                          <a:ext uri="{FF2B5EF4-FFF2-40B4-BE49-F238E27FC236}">
                            <a16:creationId xmlns:a16="http://schemas.microsoft.com/office/drawing/2014/main" id="{369772D5-4F8F-3F47-5BEB-4296DC9A8DC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4" name="直線コネクタ 333">
                        <a:extLst>
                          <a:ext uri="{FF2B5EF4-FFF2-40B4-BE49-F238E27FC236}">
                            <a16:creationId xmlns:a16="http://schemas.microsoft.com/office/drawing/2014/main" id="{F52008C1-2065-8077-1BDA-7B37EB3703B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97" name="グループ化 396">
                    <a:extLst>
                      <a:ext uri="{FF2B5EF4-FFF2-40B4-BE49-F238E27FC236}">
                        <a16:creationId xmlns:a16="http://schemas.microsoft.com/office/drawing/2014/main" id="{D0D6A9B7-5C8D-D411-6AD6-4CB7ACC73CEF}"/>
                      </a:ext>
                    </a:extLst>
                  </p:cNvPr>
                  <p:cNvGrpSpPr/>
                  <p:nvPr/>
                </p:nvGrpSpPr>
                <p:grpSpPr>
                  <a:xfrm>
                    <a:off x="9631324" y="4107656"/>
                    <a:ext cx="211596" cy="1871992"/>
                    <a:chOff x="9631324" y="4107656"/>
                    <a:chExt cx="211596" cy="1871992"/>
                  </a:xfrm>
                </p:grpSpPr>
                <p:grpSp>
                  <p:nvGrpSpPr>
                    <p:cNvPr id="327" name="グループ化 326">
                      <a:extLst>
                        <a:ext uri="{FF2B5EF4-FFF2-40B4-BE49-F238E27FC236}">
                          <a16:creationId xmlns:a16="http://schemas.microsoft.com/office/drawing/2014/main" id="{1545A189-3926-B991-EBDB-DECF262C4F6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683903" y="4107656"/>
                      <a:ext cx="108000" cy="1617970"/>
                      <a:chOff x="3181267" y="2597151"/>
                      <a:chExt cx="108000" cy="2157062"/>
                    </a:xfrm>
                  </p:grpSpPr>
                  <p:cxnSp>
                    <p:nvCxnSpPr>
                      <p:cNvPr id="329" name="直線コネクタ 328">
                        <a:extLst>
                          <a:ext uri="{FF2B5EF4-FFF2-40B4-BE49-F238E27FC236}">
                            <a16:creationId xmlns:a16="http://schemas.microsoft.com/office/drawing/2014/main" id="{38A10774-FFEC-EEE2-8C3B-757A2D1AAE2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235267" y="2597151"/>
                        <a:ext cx="0" cy="2157062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0" name="直線コネクタ 329">
                        <a:extLst>
                          <a:ext uri="{FF2B5EF4-FFF2-40B4-BE49-F238E27FC236}">
                            <a16:creationId xmlns:a16="http://schemas.microsoft.com/office/drawing/2014/main" id="{1C3E9F83-B836-894A-41F6-F03C43DD1D7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4754213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1" name="直線コネクタ 330">
                        <a:extLst>
                          <a:ext uri="{FF2B5EF4-FFF2-40B4-BE49-F238E27FC236}">
                            <a16:creationId xmlns:a16="http://schemas.microsoft.com/office/drawing/2014/main" id="{0E037C2E-4F1A-8D8B-952C-9896FE21C68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181267" y="2597151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28" name="テキスト ボックス 327">
                      <a:extLst>
                        <a:ext uri="{FF2B5EF4-FFF2-40B4-BE49-F238E27FC236}">
                          <a16:creationId xmlns:a16="http://schemas.microsoft.com/office/drawing/2014/main" id="{2B2CE5CF-520F-F2B7-B1EF-1ABD49914A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631324" y="5727853"/>
                      <a:ext cx="211596" cy="25179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none" lIns="0" tIns="36000" rIns="0" bIns="0" anchor="t">
                      <a:spAutoFit/>
                    </a:bodyPr>
                    <a:lstStyle>
                      <a:defPPr>
                        <a:defRPr lang="ja-JP"/>
                      </a:defPPr>
                      <a:lvl1pPr lvl="0" indent="0" algn="ctr">
                        <a:spcBef>
                          <a:spcPct val="0"/>
                        </a:spcBef>
                        <a:buNone/>
                        <a:defRPr sz="900" b="1" kern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Meiryo UI"/>
                          <a:cs typeface="Arial" panose="020B0604020202020204" pitchFamily="34" charset="0"/>
                        </a:defRPr>
                      </a:lvl1pPr>
                      <a:lvl2pPr indent="0">
                        <a:defRPr sz="1100"/>
                      </a:lvl2pPr>
                      <a:lvl3pPr indent="0">
                        <a:defRPr sz="1100"/>
                      </a:lvl3pPr>
                      <a:lvl4pPr indent="0">
                        <a:defRPr sz="1100"/>
                      </a:lvl4pPr>
                      <a:lvl5pPr indent="0">
                        <a:defRPr sz="1100"/>
                      </a:lvl5pPr>
                      <a:lvl6pPr indent="0">
                        <a:defRPr sz="1100"/>
                      </a:lvl6pPr>
                      <a:lvl7pPr indent="0">
                        <a:defRPr sz="1100"/>
                      </a:lvl7pPr>
                      <a:lvl8pPr indent="0">
                        <a:defRPr sz="1100"/>
                      </a:lvl8pPr>
                      <a:lvl9pPr indent="0">
                        <a:defRPr sz="1100"/>
                      </a:lvl9pPr>
                    </a:lstStyle>
                    <a:p>
                      <a:r>
                        <a:rPr lang="en-US" altLang="ja-JP" sz="1400" dirty="0"/>
                        <a:t>***</a:t>
                      </a:r>
                    </a:p>
                  </p:txBody>
                </p:sp>
              </p:grpSp>
            </p:grpSp>
            <p:grpSp>
              <p:nvGrpSpPr>
                <p:cNvPr id="396" name="グループ化 395">
                  <a:extLst>
                    <a:ext uri="{FF2B5EF4-FFF2-40B4-BE49-F238E27FC236}">
                      <a16:creationId xmlns:a16="http://schemas.microsoft.com/office/drawing/2014/main" id="{EB13C605-D187-A448-518A-E0C4FBF3B56D}"/>
                    </a:ext>
                  </a:extLst>
                </p:cNvPr>
                <p:cNvGrpSpPr/>
                <p:nvPr/>
              </p:nvGrpSpPr>
              <p:grpSpPr>
                <a:xfrm>
                  <a:off x="3257939" y="4388145"/>
                  <a:ext cx="6551963" cy="597734"/>
                  <a:chOff x="3257939" y="4388145"/>
                  <a:chExt cx="6551963" cy="597734"/>
                </a:xfrm>
              </p:grpSpPr>
              <p:sp>
                <p:nvSpPr>
                  <p:cNvPr id="318" name="楕円 317">
                    <a:extLst>
                      <a:ext uri="{FF2B5EF4-FFF2-40B4-BE49-F238E27FC236}">
                        <a16:creationId xmlns:a16="http://schemas.microsoft.com/office/drawing/2014/main" id="{6F6CE2A0-92F1-25DC-3CF0-A4B77A50E56F}"/>
                      </a:ext>
                    </a:extLst>
                  </p:cNvPr>
                  <p:cNvSpPr/>
                  <p:nvPr/>
                </p:nvSpPr>
                <p:spPr>
                  <a:xfrm>
                    <a:off x="3257939" y="4388145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9" name="楕円 318">
                    <a:extLst>
                      <a:ext uri="{FF2B5EF4-FFF2-40B4-BE49-F238E27FC236}">
                        <a16:creationId xmlns:a16="http://schemas.microsoft.com/office/drawing/2014/main" id="{F9718AAF-95D6-8FDA-5288-25A19D5CBCEC}"/>
                      </a:ext>
                    </a:extLst>
                  </p:cNvPr>
                  <p:cNvSpPr/>
                  <p:nvPr/>
                </p:nvSpPr>
                <p:spPr>
                  <a:xfrm>
                    <a:off x="4865618" y="4841836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0" name="楕円 319">
                    <a:extLst>
                      <a:ext uri="{FF2B5EF4-FFF2-40B4-BE49-F238E27FC236}">
                        <a16:creationId xmlns:a16="http://schemas.microsoft.com/office/drawing/2014/main" id="{0488D576-3202-2509-8E2E-8E833FA5B17C}"/>
                      </a:ext>
                    </a:extLst>
                  </p:cNvPr>
                  <p:cNvSpPr/>
                  <p:nvPr/>
                </p:nvSpPr>
                <p:spPr>
                  <a:xfrm>
                    <a:off x="6464917" y="4826369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1" name="楕円 320">
                    <a:extLst>
                      <a:ext uri="{FF2B5EF4-FFF2-40B4-BE49-F238E27FC236}">
                        <a16:creationId xmlns:a16="http://schemas.microsoft.com/office/drawing/2014/main" id="{90EF3F99-058C-F194-E495-BCDBF94038D2}"/>
                      </a:ext>
                    </a:extLst>
                  </p:cNvPr>
                  <p:cNvSpPr/>
                  <p:nvPr/>
                </p:nvSpPr>
                <p:spPr>
                  <a:xfrm>
                    <a:off x="8070388" y="4789224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2" name="楕円 321">
                    <a:extLst>
                      <a:ext uri="{FF2B5EF4-FFF2-40B4-BE49-F238E27FC236}">
                        <a16:creationId xmlns:a16="http://schemas.microsoft.com/office/drawing/2014/main" id="{78FE1B6A-CC80-258D-E9ED-40787703788D}"/>
                      </a:ext>
                    </a:extLst>
                  </p:cNvPr>
                  <p:cNvSpPr/>
                  <p:nvPr/>
                </p:nvSpPr>
                <p:spPr>
                  <a:xfrm>
                    <a:off x="9665902" y="4841879"/>
                    <a:ext cx="144000" cy="144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1" lang="ja-JP" alt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游ゴシック" panose="020B04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00" name="フリーフォーム: 図形 399">
                  <a:extLst>
                    <a:ext uri="{FF2B5EF4-FFF2-40B4-BE49-F238E27FC236}">
                      <a16:creationId xmlns:a16="http://schemas.microsoft.com/office/drawing/2014/main" id="{AC918C0D-3D61-B40E-FF82-2C97712E9C8F}"/>
                    </a:ext>
                  </a:extLst>
                </p:cNvPr>
                <p:cNvSpPr/>
                <p:nvPr/>
              </p:nvSpPr>
              <p:spPr>
                <a:xfrm>
                  <a:off x="3328988" y="4457700"/>
                  <a:ext cx="4814887" cy="460375"/>
                </a:xfrm>
                <a:custGeom>
                  <a:avLst/>
                  <a:gdLst>
                    <a:gd name="connsiteX0" fmla="*/ 0 w 6410325"/>
                    <a:gd name="connsiteY0" fmla="*/ 0 h 461963"/>
                    <a:gd name="connsiteX1" fmla="*/ 1609725 w 6410325"/>
                    <a:gd name="connsiteY1" fmla="*/ 457200 h 461963"/>
                    <a:gd name="connsiteX2" fmla="*/ 3205162 w 6410325"/>
                    <a:gd name="connsiteY2" fmla="*/ 447675 h 461963"/>
                    <a:gd name="connsiteX3" fmla="*/ 4814887 w 6410325"/>
                    <a:gd name="connsiteY3" fmla="*/ 409575 h 461963"/>
                    <a:gd name="connsiteX4" fmla="*/ 6410325 w 6410325"/>
                    <a:gd name="connsiteY4" fmla="*/ 461963 h 461963"/>
                    <a:gd name="connsiteX0" fmla="*/ 0 w 4814887"/>
                    <a:gd name="connsiteY0" fmla="*/ 0 h 457200"/>
                    <a:gd name="connsiteX1" fmla="*/ 1609725 w 4814887"/>
                    <a:gd name="connsiteY1" fmla="*/ 457200 h 457200"/>
                    <a:gd name="connsiteX2" fmla="*/ 3205162 w 4814887"/>
                    <a:gd name="connsiteY2" fmla="*/ 447675 h 457200"/>
                    <a:gd name="connsiteX3" fmla="*/ 4814887 w 4814887"/>
                    <a:gd name="connsiteY3" fmla="*/ 409575 h 457200"/>
                    <a:gd name="connsiteX0" fmla="*/ 0 w 4814887"/>
                    <a:gd name="connsiteY0" fmla="*/ 0 h 460375"/>
                    <a:gd name="connsiteX1" fmla="*/ 1609725 w 4814887"/>
                    <a:gd name="connsiteY1" fmla="*/ 460375 h 460375"/>
                    <a:gd name="connsiteX2" fmla="*/ 3205162 w 4814887"/>
                    <a:gd name="connsiteY2" fmla="*/ 447675 h 460375"/>
                    <a:gd name="connsiteX3" fmla="*/ 4814887 w 4814887"/>
                    <a:gd name="connsiteY3" fmla="*/ 409575 h 4603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814887" h="460375">
                      <a:moveTo>
                        <a:pt x="0" y="0"/>
                      </a:moveTo>
                      <a:lnTo>
                        <a:pt x="1609725" y="460375"/>
                      </a:lnTo>
                      <a:lnTo>
                        <a:pt x="3205162" y="447675"/>
                      </a:lnTo>
                      <a:lnTo>
                        <a:pt x="4814887" y="409575"/>
                      </a:ln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38F5539C-E796-7A11-3508-76679DD14A0D}"/>
              </a:ext>
            </a:extLst>
          </p:cNvPr>
          <p:cNvSpPr/>
          <p:nvPr/>
        </p:nvSpPr>
        <p:spPr>
          <a:xfrm>
            <a:off x="0" y="0"/>
            <a:ext cx="2993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2D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4279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70</TotalTime>
  <Words>498</Words>
  <Application>Microsoft Office PowerPoint</Application>
  <PresentationFormat>ワイド画面</PresentationFormat>
  <Paragraphs>216</Paragraphs>
  <Slides>5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YA SAIKA</dc:creator>
  <cp:lastModifiedBy>IMP</cp:lastModifiedBy>
  <cp:revision>210</cp:revision>
  <cp:lastPrinted>2023-02-09T08:59:55Z</cp:lastPrinted>
  <dcterms:created xsi:type="dcterms:W3CDTF">2022-06-17T02:36:28Z</dcterms:created>
  <dcterms:modified xsi:type="dcterms:W3CDTF">2023-05-03T01:10:13Z</dcterms:modified>
</cp:coreProperties>
</file>